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meng\Desktop\COMSOL\Hoesli\Kurtis-Laurier\KC029\2%25%20pronatal\CIHR%20Grant\20220912_2%25pronatal_profi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592494405535995E-2"/>
          <c:y val="3.2719832185906357E-2"/>
          <c:w val="0.90418760469011727"/>
          <c:h val="0.8187213089581747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B$1:$B$3401</c:f>
              <c:numCache>
                <c:formatCode>General</c:formatCode>
                <c:ptCount val="3401"/>
                <c:pt idx="0">
                  <c:v>-1</c:v>
                </c:pt>
                <c:pt idx="1">
                  <c:v>-0.999</c:v>
                </c:pt>
                <c:pt idx="2">
                  <c:v>-0.998</c:v>
                </c:pt>
                <c:pt idx="3">
                  <c:v>-0.997</c:v>
                </c:pt>
                <c:pt idx="4">
                  <c:v>-0.996</c:v>
                </c:pt>
                <c:pt idx="5">
                  <c:v>-0.995</c:v>
                </c:pt>
                <c:pt idx="6">
                  <c:v>-0.99399999999999999</c:v>
                </c:pt>
                <c:pt idx="7">
                  <c:v>-0.99299999999999999</c:v>
                </c:pt>
                <c:pt idx="8">
                  <c:v>-0.99199999999999999</c:v>
                </c:pt>
                <c:pt idx="9">
                  <c:v>-0.99099999999999999</c:v>
                </c:pt>
                <c:pt idx="10">
                  <c:v>-0.99</c:v>
                </c:pt>
                <c:pt idx="11">
                  <c:v>-0.98899999999999999</c:v>
                </c:pt>
                <c:pt idx="12">
                  <c:v>-0.98799999999999999</c:v>
                </c:pt>
                <c:pt idx="13">
                  <c:v>-0.98699999999999999</c:v>
                </c:pt>
                <c:pt idx="14">
                  <c:v>-0.98599999999999999</c:v>
                </c:pt>
                <c:pt idx="15">
                  <c:v>-0.98499999999999999</c:v>
                </c:pt>
                <c:pt idx="16">
                  <c:v>-0.98399999999999999</c:v>
                </c:pt>
                <c:pt idx="17">
                  <c:v>-0.98299999999999998</c:v>
                </c:pt>
                <c:pt idx="18">
                  <c:v>-0.98199999999999998</c:v>
                </c:pt>
                <c:pt idx="19">
                  <c:v>-0.98099999999999998</c:v>
                </c:pt>
                <c:pt idx="20">
                  <c:v>-0.98</c:v>
                </c:pt>
                <c:pt idx="21">
                  <c:v>-0.97899999999999998</c:v>
                </c:pt>
                <c:pt idx="22">
                  <c:v>-0.97799999999999998</c:v>
                </c:pt>
                <c:pt idx="23">
                  <c:v>-0.97699999999999998</c:v>
                </c:pt>
                <c:pt idx="24">
                  <c:v>-0.97599999999999998</c:v>
                </c:pt>
                <c:pt idx="25">
                  <c:v>-0.97499999999999998</c:v>
                </c:pt>
                <c:pt idx="26">
                  <c:v>-0.97399999999999998</c:v>
                </c:pt>
                <c:pt idx="27">
                  <c:v>-0.97299999999999998</c:v>
                </c:pt>
                <c:pt idx="28">
                  <c:v>-0.97199999999999998</c:v>
                </c:pt>
                <c:pt idx="29">
                  <c:v>-0.97099999999999997</c:v>
                </c:pt>
                <c:pt idx="30">
                  <c:v>-0.97</c:v>
                </c:pt>
                <c:pt idx="31">
                  <c:v>-0.96899999999999997</c:v>
                </c:pt>
                <c:pt idx="32">
                  <c:v>-0.96799999999999997</c:v>
                </c:pt>
                <c:pt idx="33">
                  <c:v>-0.96699999999999997</c:v>
                </c:pt>
                <c:pt idx="34">
                  <c:v>-0.96599999999999997</c:v>
                </c:pt>
                <c:pt idx="35">
                  <c:v>-0.96499999999999997</c:v>
                </c:pt>
                <c:pt idx="36">
                  <c:v>-0.96399999999999997</c:v>
                </c:pt>
                <c:pt idx="37">
                  <c:v>-0.96299999999999997</c:v>
                </c:pt>
                <c:pt idx="38">
                  <c:v>-0.96199999999999997</c:v>
                </c:pt>
                <c:pt idx="39">
                  <c:v>-0.96099999999999997</c:v>
                </c:pt>
                <c:pt idx="40">
                  <c:v>-0.96</c:v>
                </c:pt>
                <c:pt idx="41">
                  <c:v>-0.95899999999999996</c:v>
                </c:pt>
                <c:pt idx="42">
                  <c:v>-0.95799999999999996</c:v>
                </c:pt>
                <c:pt idx="43">
                  <c:v>-0.95699999999999996</c:v>
                </c:pt>
                <c:pt idx="44">
                  <c:v>-0.95599999999999996</c:v>
                </c:pt>
                <c:pt idx="45">
                  <c:v>-0.95499999999999996</c:v>
                </c:pt>
                <c:pt idx="46">
                  <c:v>-0.95399999999999996</c:v>
                </c:pt>
                <c:pt idx="47">
                  <c:v>-0.95299999999999996</c:v>
                </c:pt>
                <c:pt idx="48">
                  <c:v>-0.95199999999999996</c:v>
                </c:pt>
                <c:pt idx="49">
                  <c:v>-0.95099999999999996</c:v>
                </c:pt>
                <c:pt idx="50">
                  <c:v>-0.95</c:v>
                </c:pt>
                <c:pt idx="51">
                  <c:v>-0.94899999999999995</c:v>
                </c:pt>
                <c:pt idx="52">
                  <c:v>-0.94799999999999995</c:v>
                </c:pt>
                <c:pt idx="53">
                  <c:v>-0.94699999999999995</c:v>
                </c:pt>
                <c:pt idx="54">
                  <c:v>-0.94599999999999995</c:v>
                </c:pt>
                <c:pt idx="55">
                  <c:v>-0.94499999999999995</c:v>
                </c:pt>
                <c:pt idx="56">
                  <c:v>-0.94399999999999995</c:v>
                </c:pt>
                <c:pt idx="57">
                  <c:v>-0.94299999999999995</c:v>
                </c:pt>
                <c:pt idx="58">
                  <c:v>-0.94199999999999995</c:v>
                </c:pt>
                <c:pt idx="59">
                  <c:v>-0.94100000000000006</c:v>
                </c:pt>
                <c:pt idx="60">
                  <c:v>-0.94</c:v>
                </c:pt>
                <c:pt idx="61">
                  <c:v>-0.93900000000000006</c:v>
                </c:pt>
                <c:pt idx="62">
                  <c:v>-0.93799999999999994</c:v>
                </c:pt>
                <c:pt idx="63">
                  <c:v>-0.93700000000000006</c:v>
                </c:pt>
                <c:pt idx="64">
                  <c:v>-0.93599999999999994</c:v>
                </c:pt>
                <c:pt idx="65">
                  <c:v>-0.93500000000000005</c:v>
                </c:pt>
                <c:pt idx="66">
                  <c:v>-0.93399999999999994</c:v>
                </c:pt>
                <c:pt idx="67">
                  <c:v>-0.93300000000000005</c:v>
                </c:pt>
                <c:pt idx="68">
                  <c:v>-0.93199999999999994</c:v>
                </c:pt>
                <c:pt idx="69">
                  <c:v>-0.93100000000000005</c:v>
                </c:pt>
                <c:pt idx="70">
                  <c:v>-0.92999999999999994</c:v>
                </c:pt>
                <c:pt idx="71">
                  <c:v>-0.92900000000000005</c:v>
                </c:pt>
                <c:pt idx="72">
                  <c:v>-0.92800000000000005</c:v>
                </c:pt>
                <c:pt idx="73">
                  <c:v>-0.92700000000000005</c:v>
                </c:pt>
                <c:pt idx="74">
                  <c:v>-0.92600000000000005</c:v>
                </c:pt>
                <c:pt idx="75">
                  <c:v>-0.92500000000000004</c:v>
                </c:pt>
                <c:pt idx="76">
                  <c:v>-0.92400000000000004</c:v>
                </c:pt>
                <c:pt idx="77">
                  <c:v>-0.92300000000000004</c:v>
                </c:pt>
                <c:pt idx="78">
                  <c:v>-0.92200000000000004</c:v>
                </c:pt>
                <c:pt idx="79">
                  <c:v>-0.92100000000000004</c:v>
                </c:pt>
                <c:pt idx="80">
                  <c:v>-0.92</c:v>
                </c:pt>
                <c:pt idx="81">
                  <c:v>-0.91900000000000004</c:v>
                </c:pt>
                <c:pt idx="82">
                  <c:v>-0.91800000000000004</c:v>
                </c:pt>
                <c:pt idx="83">
                  <c:v>-0.91700000000000004</c:v>
                </c:pt>
                <c:pt idx="84">
                  <c:v>-0.91600000000000004</c:v>
                </c:pt>
                <c:pt idx="85">
                  <c:v>-0.91500000000000004</c:v>
                </c:pt>
                <c:pt idx="86">
                  <c:v>-0.91400000000000003</c:v>
                </c:pt>
                <c:pt idx="87">
                  <c:v>-0.91300000000000003</c:v>
                </c:pt>
                <c:pt idx="88">
                  <c:v>-0.91200000000000003</c:v>
                </c:pt>
                <c:pt idx="89">
                  <c:v>-0.91100000000000003</c:v>
                </c:pt>
                <c:pt idx="90">
                  <c:v>-0.91</c:v>
                </c:pt>
                <c:pt idx="91">
                  <c:v>-0.90900000000000003</c:v>
                </c:pt>
                <c:pt idx="92">
                  <c:v>-0.90800000000000003</c:v>
                </c:pt>
                <c:pt idx="93">
                  <c:v>-0.90700000000000003</c:v>
                </c:pt>
                <c:pt idx="94">
                  <c:v>-0.90600000000000003</c:v>
                </c:pt>
                <c:pt idx="95">
                  <c:v>-0.90500000000000003</c:v>
                </c:pt>
                <c:pt idx="96">
                  <c:v>-0.90400000000000003</c:v>
                </c:pt>
                <c:pt idx="97">
                  <c:v>-0.90300000000000002</c:v>
                </c:pt>
                <c:pt idx="98">
                  <c:v>-0.90200000000000002</c:v>
                </c:pt>
                <c:pt idx="99">
                  <c:v>-0.90100000000000002</c:v>
                </c:pt>
                <c:pt idx="100">
                  <c:v>-0.9</c:v>
                </c:pt>
                <c:pt idx="101">
                  <c:v>-0.89900000000000002</c:v>
                </c:pt>
                <c:pt idx="102">
                  <c:v>-0.89800000000000002</c:v>
                </c:pt>
                <c:pt idx="103">
                  <c:v>-0.89700000000000002</c:v>
                </c:pt>
                <c:pt idx="104">
                  <c:v>-0.89600000000000002</c:v>
                </c:pt>
                <c:pt idx="105">
                  <c:v>-0.89500000000000002</c:v>
                </c:pt>
                <c:pt idx="106">
                  <c:v>-0.89400000000000002</c:v>
                </c:pt>
                <c:pt idx="107">
                  <c:v>-0.89300000000000002</c:v>
                </c:pt>
                <c:pt idx="108">
                  <c:v>-0.89200000000000002</c:v>
                </c:pt>
                <c:pt idx="109">
                  <c:v>-0.89100000000000001</c:v>
                </c:pt>
                <c:pt idx="110">
                  <c:v>-0.89</c:v>
                </c:pt>
                <c:pt idx="111">
                  <c:v>-0.88900000000000001</c:v>
                </c:pt>
                <c:pt idx="112">
                  <c:v>-0.88800000000000001</c:v>
                </c:pt>
                <c:pt idx="113">
                  <c:v>-0.88700000000000001</c:v>
                </c:pt>
                <c:pt idx="114">
                  <c:v>-0.88600000000000001</c:v>
                </c:pt>
                <c:pt idx="115">
                  <c:v>-0.88500000000000001</c:v>
                </c:pt>
                <c:pt idx="116">
                  <c:v>-0.88400000000000001</c:v>
                </c:pt>
                <c:pt idx="117">
                  <c:v>-0.88300000000000001</c:v>
                </c:pt>
                <c:pt idx="118">
                  <c:v>-0.88200000000000001</c:v>
                </c:pt>
                <c:pt idx="119">
                  <c:v>-0.88100000000000001</c:v>
                </c:pt>
                <c:pt idx="120">
                  <c:v>-0.88</c:v>
                </c:pt>
                <c:pt idx="121">
                  <c:v>-0.879</c:v>
                </c:pt>
                <c:pt idx="122">
                  <c:v>-0.878</c:v>
                </c:pt>
                <c:pt idx="123">
                  <c:v>-0.877</c:v>
                </c:pt>
                <c:pt idx="124">
                  <c:v>-0.876</c:v>
                </c:pt>
                <c:pt idx="125">
                  <c:v>-0.875</c:v>
                </c:pt>
                <c:pt idx="126">
                  <c:v>-0.874</c:v>
                </c:pt>
                <c:pt idx="127">
                  <c:v>-0.873</c:v>
                </c:pt>
                <c:pt idx="128">
                  <c:v>-0.872</c:v>
                </c:pt>
                <c:pt idx="129">
                  <c:v>-0.871</c:v>
                </c:pt>
                <c:pt idx="130">
                  <c:v>-0.87</c:v>
                </c:pt>
                <c:pt idx="131">
                  <c:v>-0.86899999999999999</c:v>
                </c:pt>
                <c:pt idx="132">
                  <c:v>-0.86799999999999999</c:v>
                </c:pt>
                <c:pt idx="133">
                  <c:v>-0.86699999999999999</c:v>
                </c:pt>
                <c:pt idx="134">
                  <c:v>-0.86599999999999999</c:v>
                </c:pt>
                <c:pt idx="135">
                  <c:v>-0.86499999999999999</c:v>
                </c:pt>
                <c:pt idx="136">
                  <c:v>-0.86399999999999999</c:v>
                </c:pt>
                <c:pt idx="137">
                  <c:v>-0.86299999999999999</c:v>
                </c:pt>
                <c:pt idx="138">
                  <c:v>-0.86199999999999999</c:v>
                </c:pt>
                <c:pt idx="139">
                  <c:v>-0.86099999999999999</c:v>
                </c:pt>
                <c:pt idx="140">
                  <c:v>-0.86</c:v>
                </c:pt>
                <c:pt idx="141">
                  <c:v>-0.85899999999999999</c:v>
                </c:pt>
                <c:pt idx="142">
                  <c:v>-0.85799999999999998</c:v>
                </c:pt>
                <c:pt idx="143">
                  <c:v>-0.85699999999999998</c:v>
                </c:pt>
                <c:pt idx="144">
                  <c:v>-0.85599999999999998</c:v>
                </c:pt>
                <c:pt idx="145">
                  <c:v>-0.85499999999999998</c:v>
                </c:pt>
                <c:pt idx="146">
                  <c:v>-0.85399999999999998</c:v>
                </c:pt>
                <c:pt idx="147">
                  <c:v>-0.85299999999999998</c:v>
                </c:pt>
                <c:pt idx="148">
                  <c:v>-0.85199999999999998</c:v>
                </c:pt>
                <c:pt idx="149">
                  <c:v>-0.85099999999999998</c:v>
                </c:pt>
                <c:pt idx="150">
                  <c:v>-0.85</c:v>
                </c:pt>
                <c:pt idx="151">
                  <c:v>-0.84899999999999998</c:v>
                </c:pt>
                <c:pt idx="152">
                  <c:v>-0.84799999999999998</c:v>
                </c:pt>
                <c:pt idx="153">
                  <c:v>-0.84699999999999998</c:v>
                </c:pt>
                <c:pt idx="154">
                  <c:v>-0.84599999999999997</c:v>
                </c:pt>
                <c:pt idx="155">
                  <c:v>-0.84499999999999997</c:v>
                </c:pt>
                <c:pt idx="156">
                  <c:v>-0.84399999999999997</c:v>
                </c:pt>
                <c:pt idx="157">
                  <c:v>-0.84299999999999997</c:v>
                </c:pt>
                <c:pt idx="158">
                  <c:v>-0.84199999999999997</c:v>
                </c:pt>
                <c:pt idx="159">
                  <c:v>-0.84099999999999997</c:v>
                </c:pt>
                <c:pt idx="160">
                  <c:v>-0.84</c:v>
                </c:pt>
                <c:pt idx="161">
                  <c:v>-0.83899999999999997</c:v>
                </c:pt>
                <c:pt idx="162">
                  <c:v>-0.83799999999999997</c:v>
                </c:pt>
                <c:pt idx="163">
                  <c:v>-0.83699999999999997</c:v>
                </c:pt>
                <c:pt idx="164">
                  <c:v>-0.83599999999999997</c:v>
                </c:pt>
                <c:pt idx="165">
                  <c:v>-0.83499999999999996</c:v>
                </c:pt>
                <c:pt idx="166">
                  <c:v>-0.83399999999999996</c:v>
                </c:pt>
                <c:pt idx="167">
                  <c:v>-0.83299999999999996</c:v>
                </c:pt>
                <c:pt idx="168">
                  <c:v>-0.83199999999999996</c:v>
                </c:pt>
                <c:pt idx="169">
                  <c:v>-0.83099999999999996</c:v>
                </c:pt>
                <c:pt idx="170">
                  <c:v>-0.83</c:v>
                </c:pt>
                <c:pt idx="171">
                  <c:v>-0.82899999999999996</c:v>
                </c:pt>
                <c:pt idx="172">
                  <c:v>-0.82800000000000007</c:v>
                </c:pt>
                <c:pt idx="173">
                  <c:v>-0.82699999999999996</c:v>
                </c:pt>
                <c:pt idx="174">
                  <c:v>-0.82600000000000007</c:v>
                </c:pt>
                <c:pt idx="175">
                  <c:v>-0.82499999999999996</c:v>
                </c:pt>
                <c:pt idx="176">
                  <c:v>-0.82400000000000007</c:v>
                </c:pt>
                <c:pt idx="177">
                  <c:v>-0.82299999999999995</c:v>
                </c:pt>
                <c:pt idx="178">
                  <c:v>-0.82200000000000006</c:v>
                </c:pt>
                <c:pt idx="179">
                  <c:v>-0.82099999999999995</c:v>
                </c:pt>
                <c:pt idx="180">
                  <c:v>-0.82000000000000006</c:v>
                </c:pt>
                <c:pt idx="181">
                  <c:v>-0.81899999999999995</c:v>
                </c:pt>
                <c:pt idx="182">
                  <c:v>-0.81800000000000006</c:v>
                </c:pt>
                <c:pt idx="183">
                  <c:v>-0.81699999999999995</c:v>
                </c:pt>
                <c:pt idx="184">
                  <c:v>-0.81600000000000006</c:v>
                </c:pt>
                <c:pt idx="185">
                  <c:v>-0.81499999999999995</c:v>
                </c:pt>
                <c:pt idx="186">
                  <c:v>-0.81400000000000006</c:v>
                </c:pt>
                <c:pt idx="187">
                  <c:v>-0.81299999999999994</c:v>
                </c:pt>
                <c:pt idx="188">
                  <c:v>-0.81200000000000006</c:v>
                </c:pt>
                <c:pt idx="189">
                  <c:v>-0.81099999999999994</c:v>
                </c:pt>
                <c:pt idx="190">
                  <c:v>-0.81</c:v>
                </c:pt>
                <c:pt idx="191">
                  <c:v>-0.80899999999999994</c:v>
                </c:pt>
                <c:pt idx="192">
                  <c:v>-0.80800000000000005</c:v>
                </c:pt>
                <c:pt idx="193">
                  <c:v>-0.80699999999999994</c:v>
                </c:pt>
                <c:pt idx="194">
                  <c:v>-0.80600000000000005</c:v>
                </c:pt>
                <c:pt idx="195">
                  <c:v>-0.80499999999999994</c:v>
                </c:pt>
                <c:pt idx="196">
                  <c:v>-0.80400000000000005</c:v>
                </c:pt>
                <c:pt idx="197">
                  <c:v>-0.80299999999999994</c:v>
                </c:pt>
                <c:pt idx="198">
                  <c:v>-0.80200000000000005</c:v>
                </c:pt>
                <c:pt idx="199">
                  <c:v>-0.80099999999999993</c:v>
                </c:pt>
                <c:pt idx="200">
                  <c:v>-0.8</c:v>
                </c:pt>
                <c:pt idx="201">
                  <c:v>-0.79899999999999993</c:v>
                </c:pt>
                <c:pt idx="202">
                  <c:v>-0.79800000000000004</c:v>
                </c:pt>
                <c:pt idx="203">
                  <c:v>-0.79699999999999993</c:v>
                </c:pt>
                <c:pt idx="204">
                  <c:v>-0.79600000000000004</c:v>
                </c:pt>
                <c:pt idx="205">
                  <c:v>-0.79500000000000004</c:v>
                </c:pt>
                <c:pt idx="206">
                  <c:v>-0.79400000000000004</c:v>
                </c:pt>
                <c:pt idx="207">
                  <c:v>-0.79300000000000004</c:v>
                </c:pt>
                <c:pt idx="208">
                  <c:v>-0.79200000000000004</c:v>
                </c:pt>
                <c:pt idx="209">
                  <c:v>-0.79100000000000004</c:v>
                </c:pt>
                <c:pt idx="210">
                  <c:v>-0.79</c:v>
                </c:pt>
                <c:pt idx="211">
                  <c:v>-0.78900000000000003</c:v>
                </c:pt>
                <c:pt idx="212">
                  <c:v>-0.78800000000000003</c:v>
                </c:pt>
                <c:pt idx="213">
                  <c:v>-0.78700000000000003</c:v>
                </c:pt>
                <c:pt idx="214">
                  <c:v>-0.78600000000000003</c:v>
                </c:pt>
                <c:pt idx="215">
                  <c:v>-0.78500000000000003</c:v>
                </c:pt>
                <c:pt idx="216">
                  <c:v>-0.78400000000000003</c:v>
                </c:pt>
                <c:pt idx="217">
                  <c:v>-0.78300000000000003</c:v>
                </c:pt>
                <c:pt idx="218">
                  <c:v>-0.78200000000000003</c:v>
                </c:pt>
                <c:pt idx="219">
                  <c:v>-0.78100000000000003</c:v>
                </c:pt>
                <c:pt idx="220">
                  <c:v>-0.78</c:v>
                </c:pt>
                <c:pt idx="221">
                  <c:v>-0.77900000000000003</c:v>
                </c:pt>
                <c:pt idx="222">
                  <c:v>-0.77800000000000002</c:v>
                </c:pt>
                <c:pt idx="223">
                  <c:v>-0.77700000000000002</c:v>
                </c:pt>
                <c:pt idx="224">
                  <c:v>-0.77600000000000002</c:v>
                </c:pt>
                <c:pt idx="225">
                  <c:v>-0.77500000000000002</c:v>
                </c:pt>
                <c:pt idx="226">
                  <c:v>-0.77400000000000002</c:v>
                </c:pt>
                <c:pt idx="227">
                  <c:v>-0.77300000000000002</c:v>
                </c:pt>
                <c:pt idx="228">
                  <c:v>-0.77200000000000002</c:v>
                </c:pt>
                <c:pt idx="229">
                  <c:v>-0.77100000000000002</c:v>
                </c:pt>
                <c:pt idx="230">
                  <c:v>-0.77</c:v>
                </c:pt>
                <c:pt idx="231">
                  <c:v>-0.76900000000000002</c:v>
                </c:pt>
                <c:pt idx="232">
                  <c:v>-0.76800000000000002</c:v>
                </c:pt>
                <c:pt idx="233">
                  <c:v>-0.76700000000000002</c:v>
                </c:pt>
                <c:pt idx="234">
                  <c:v>-0.76600000000000001</c:v>
                </c:pt>
                <c:pt idx="235">
                  <c:v>-0.76500000000000001</c:v>
                </c:pt>
                <c:pt idx="236">
                  <c:v>-0.76400000000000001</c:v>
                </c:pt>
                <c:pt idx="237">
                  <c:v>-0.76300000000000001</c:v>
                </c:pt>
                <c:pt idx="238">
                  <c:v>-0.76200000000000001</c:v>
                </c:pt>
                <c:pt idx="239">
                  <c:v>-0.76100000000000001</c:v>
                </c:pt>
                <c:pt idx="240">
                  <c:v>-0.76</c:v>
                </c:pt>
                <c:pt idx="241">
                  <c:v>-0.75900000000000001</c:v>
                </c:pt>
                <c:pt idx="242">
                  <c:v>-0.75800000000000001</c:v>
                </c:pt>
                <c:pt idx="243">
                  <c:v>-0.75700000000000001</c:v>
                </c:pt>
                <c:pt idx="244">
                  <c:v>-0.75600000000000001</c:v>
                </c:pt>
                <c:pt idx="245">
                  <c:v>-0.755</c:v>
                </c:pt>
                <c:pt idx="246">
                  <c:v>-0.754</c:v>
                </c:pt>
                <c:pt idx="247">
                  <c:v>-0.753</c:v>
                </c:pt>
                <c:pt idx="248">
                  <c:v>-0.752</c:v>
                </c:pt>
                <c:pt idx="249">
                  <c:v>-0.751</c:v>
                </c:pt>
                <c:pt idx="250">
                  <c:v>-0.75</c:v>
                </c:pt>
                <c:pt idx="251">
                  <c:v>-0.749</c:v>
                </c:pt>
                <c:pt idx="252">
                  <c:v>-0.748</c:v>
                </c:pt>
                <c:pt idx="253">
                  <c:v>-0.747</c:v>
                </c:pt>
                <c:pt idx="254">
                  <c:v>-0.746</c:v>
                </c:pt>
                <c:pt idx="255">
                  <c:v>-0.745</c:v>
                </c:pt>
                <c:pt idx="256">
                  <c:v>-0.74399999999999999</c:v>
                </c:pt>
                <c:pt idx="257">
                  <c:v>-0.74299999999999999</c:v>
                </c:pt>
                <c:pt idx="258">
                  <c:v>-0.74199999999999999</c:v>
                </c:pt>
                <c:pt idx="259">
                  <c:v>-0.74099999999999999</c:v>
                </c:pt>
                <c:pt idx="260">
                  <c:v>-0.74</c:v>
                </c:pt>
                <c:pt idx="261">
                  <c:v>-0.73899999999999999</c:v>
                </c:pt>
                <c:pt idx="262">
                  <c:v>-0.73799999999999999</c:v>
                </c:pt>
                <c:pt idx="263">
                  <c:v>-0.73699999999999999</c:v>
                </c:pt>
                <c:pt idx="264">
                  <c:v>-0.73599999999999999</c:v>
                </c:pt>
                <c:pt idx="265">
                  <c:v>-0.73499999999999999</c:v>
                </c:pt>
                <c:pt idx="266">
                  <c:v>-0.73399999999999999</c:v>
                </c:pt>
                <c:pt idx="267">
                  <c:v>-0.73299999999999998</c:v>
                </c:pt>
                <c:pt idx="268">
                  <c:v>-0.73199999999999998</c:v>
                </c:pt>
                <c:pt idx="269">
                  <c:v>-0.73099999999999998</c:v>
                </c:pt>
                <c:pt idx="270">
                  <c:v>-0.73</c:v>
                </c:pt>
                <c:pt idx="271">
                  <c:v>-0.72899999999999998</c:v>
                </c:pt>
                <c:pt idx="272">
                  <c:v>-0.72799999999999998</c:v>
                </c:pt>
                <c:pt idx="273">
                  <c:v>-0.72699999999999998</c:v>
                </c:pt>
                <c:pt idx="274">
                  <c:v>-0.72599999999999998</c:v>
                </c:pt>
                <c:pt idx="275">
                  <c:v>-0.72499999999999998</c:v>
                </c:pt>
                <c:pt idx="276">
                  <c:v>-0.72399999999999998</c:v>
                </c:pt>
                <c:pt idx="277">
                  <c:v>-0.72299999999999998</c:v>
                </c:pt>
                <c:pt idx="278">
                  <c:v>-0.72199999999999998</c:v>
                </c:pt>
                <c:pt idx="279">
                  <c:v>-0.72099999999999997</c:v>
                </c:pt>
                <c:pt idx="280">
                  <c:v>-0.72</c:v>
                </c:pt>
                <c:pt idx="281">
                  <c:v>-0.71899999999999997</c:v>
                </c:pt>
                <c:pt idx="282">
                  <c:v>-0.71799999999999997</c:v>
                </c:pt>
                <c:pt idx="283">
                  <c:v>-0.71700000000000008</c:v>
                </c:pt>
                <c:pt idx="284">
                  <c:v>-0.71599999999999997</c:v>
                </c:pt>
                <c:pt idx="285">
                  <c:v>-0.71500000000000008</c:v>
                </c:pt>
                <c:pt idx="286">
                  <c:v>-0.71399999999999997</c:v>
                </c:pt>
                <c:pt idx="287">
                  <c:v>-0.71300000000000008</c:v>
                </c:pt>
                <c:pt idx="288">
                  <c:v>-0.71199999999999997</c:v>
                </c:pt>
                <c:pt idx="289">
                  <c:v>-0.71100000000000008</c:v>
                </c:pt>
                <c:pt idx="290">
                  <c:v>-0.71</c:v>
                </c:pt>
                <c:pt idx="291">
                  <c:v>-0.70900000000000007</c:v>
                </c:pt>
                <c:pt idx="292">
                  <c:v>-0.70799999999999996</c:v>
                </c:pt>
                <c:pt idx="293">
                  <c:v>-0.70700000000000007</c:v>
                </c:pt>
                <c:pt idx="294">
                  <c:v>-0.70599999999999996</c:v>
                </c:pt>
                <c:pt idx="295">
                  <c:v>-0.70500000000000007</c:v>
                </c:pt>
                <c:pt idx="296">
                  <c:v>-0.70399999999999996</c:v>
                </c:pt>
                <c:pt idx="297">
                  <c:v>-0.70300000000000007</c:v>
                </c:pt>
                <c:pt idx="298">
                  <c:v>-0.70199999999999996</c:v>
                </c:pt>
                <c:pt idx="299">
                  <c:v>-0.70100000000000007</c:v>
                </c:pt>
                <c:pt idx="300">
                  <c:v>-0.7</c:v>
                </c:pt>
                <c:pt idx="301">
                  <c:v>-0.69900000000000007</c:v>
                </c:pt>
                <c:pt idx="302">
                  <c:v>-0.69799999999999995</c:v>
                </c:pt>
                <c:pt idx="303">
                  <c:v>-0.69700000000000006</c:v>
                </c:pt>
                <c:pt idx="304">
                  <c:v>-0.69599999999999995</c:v>
                </c:pt>
                <c:pt idx="305">
                  <c:v>-0.69500000000000006</c:v>
                </c:pt>
                <c:pt idx="306">
                  <c:v>-0.69399999999999995</c:v>
                </c:pt>
                <c:pt idx="307">
                  <c:v>-0.69300000000000006</c:v>
                </c:pt>
                <c:pt idx="308">
                  <c:v>-0.69199999999999995</c:v>
                </c:pt>
                <c:pt idx="309">
                  <c:v>-0.69100000000000006</c:v>
                </c:pt>
                <c:pt idx="310">
                  <c:v>-0.69</c:v>
                </c:pt>
                <c:pt idx="311">
                  <c:v>-0.68900000000000006</c:v>
                </c:pt>
                <c:pt idx="312">
                  <c:v>-0.68799999999999994</c:v>
                </c:pt>
                <c:pt idx="313">
                  <c:v>-0.68700000000000006</c:v>
                </c:pt>
                <c:pt idx="314">
                  <c:v>-0.68599999999999994</c:v>
                </c:pt>
                <c:pt idx="315">
                  <c:v>-0.68500000000000005</c:v>
                </c:pt>
                <c:pt idx="316">
                  <c:v>-0.68399999999999994</c:v>
                </c:pt>
                <c:pt idx="317">
                  <c:v>-0.68300000000000005</c:v>
                </c:pt>
                <c:pt idx="318">
                  <c:v>-0.68199999999999994</c:v>
                </c:pt>
                <c:pt idx="319">
                  <c:v>-0.68100000000000005</c:v>
                </c:pt>
                <c:pt idx="320">
                  <c:v>-0.67999999999999994</c:v>
                </c:pt>
                <c:pt idx="321">
                  <c:v>-0.67900000000000005</c:v>
                </c:pt>
                <c:pt idx="322">
                  <c:v>-0.67799999999999994</c:v>
                </c:pt>
                <c:pt idx="323">
                  <c:v>-0.67700000000000005</c:v>
                </c:pt>
                <c:pt idx="324">
                  <c:v>-0.67599999999999993</c:v>
                </c:pt>
                <c:pt idx="325">
                  <c:v>-0.67500000000000004</c:v>
                </c:pt>
                <c:pt idx="326">
                  <c:v>-0.67399999999999993</c:v>
                </c:pt>
                <c:pt idx="327">
                  <c:v>-0.67300000000000004</c:v>
                </c:pt>
                <c:pt idx="328">
                  <c:v>-0.67199999999999993</c:v>
                </c:pt>
                <c:pt idx="329">
                  <c:v>-0.67100000000000004</c:v>
                </c:pt>
                <c:pt idx="330">
                  <c:v>-0.66999999999999993</c:v>
                </c:pt>
                <c:pt idx="331">
                  <c:v>-0.66900000000000004</c:v>
                </c:pt>
                <c:pt idx="332">
                  <c:v>-0.66799999999999993</c:v>
                </c:pt>
                <c:pt idx="333">
                  <c:v>-0.66700000000000004</c:v>
                </c:pt>
                <c:pt idx="334">
                  <c:v>-0.66599999999999993</c:v>
                </c:pt>
                <c:pt idx="335">
                  <c:v>-0.66500000000000004</c:v>
                </c:pt>
                <c:pt idx="336">
                  <c:v>-0.66399999999999992</c:v>
                </c:pt>
                <c:pt idx="337">
                  <c:v>-0.66300000000000003</c:v>
                </c:pt>
                <c:pt idx="338">
                  <c:v>-0.66199999999999992</c:v>
                </c:pt>
                <c:pt idx="339">
                  <c:v>-0.66100000000000003</c:v>
                </c:pt>
                <c:pt idx="340">
                  <c:v>-0.65999999999999992</c:v>
                </c:pt>
                <c:pt idx="341">
                  <c:v>-0.65900000000000003</c:v>
                </c:pt>
                <c:pt idx="342">
                  <c:v>-0.65799999999999992</c:v>
                </c:pt>
                <c:pt idx="343">
                  <c:v>-0.65700000000000003</c:v>
                </c:pt>
                <c:pt idx="344">
                  <c:v>-0.65600000000000003</c:v>
                </c:pt>
                <c:pt idx="345">
                  <c:v>-0.65500000000000003</c:v>
                </c:pt>
                <c:pt idx="346">
                  <c:v>-0.65400000000000003</c:v>
                </c:pt>
                <c:pt idx="347">
                  <c:v>-0.65300000000000002</c:v>
                </c:pt>
                <c:pt idx="348">
                  <c:v>-0.65200000000000002</c:v>
                </c:pt>
                <c:pt idx="349">
                  <c:v>-0.65100000000000002</c:v>
                </c:pt>
                <c:pt idx="350">
                  <c:v>-0.65</c:v>
                </c:pt>
                <c:pt idx="351">
                  <c:v>-0.64900000000000002</c:v>
                </c:pt>
                <c:pt idx="352">
                  <c:v>-0.64800000000000002</c:v>
                </c:pt>
                <c:pt idx="353">
                  <c:v>-0.64700000000000002</c:v>
                </c:pt>
                <c:pt idx="354">
                  <c:v>-0.64600000000000002</c:v>
                </c:pt>
                <c:pt idx="355">
                  <c:v>-0.64500000000000002</c:v>
                </c:pt>
                <c:pt idx="356">
                  <c:v>-0.64400000000000002</c:v>
                </c:pt>
                <c:pt idx="357">
                  <c:v>-0.64300000000000002</c:v>
                </c:pt>
                <c:pt idx="358">
                  <c:v>-0.64200000000000002</c:v>
                </c:pt>
                <c:pt idx="359">
                  <c:v>-0.64100000000000001</c:v>
                </c:pt>
                <c:pt idx="360">
                  <c:v>-0.64</c:v>
                </c:pt>
                <c:pt idx="361">
                  <c:v>-0.63900000000000001</c:v>
                </c:pt>
                <c:pt idx="362">
                  <c:v>-0.63800000000000001</c:v>
                </c:pt>
                <c:pt idx="363">
                  <c:v>-0.63700000000000001</c:v>
                </c:pt>
                <c:pt idx="364">
                  <c:v>-0.63600000000000001</c:v>
                </c:pt>
                <c:pt idx="365">
                  <c:v>-0.63500000000000001</c:v>
                </c:pt>
                <c:pt idx="366">
                  <c:v>-0.63400000000000001</c:v>
                </c:pt>
                <c:pt idx="367">
                  <c:v>-0.63300000000000001</c:v>
                </c:pt>
                <c:pt idx="368">
                  <c:v>-0.63200000000000001</c:v>
                </c:pt>
                <c:pt idx="369">
                  <c:v>-0.63100000000000001</c:v>
                </c:pt>
                <c:pt idx="370">
                  <c:v>-0.63</c:v>
                </c:pt>
                <c:pt idx="371">
                  <c:v>-0.629</c:v>
                </c:pt>
                <c:pt idx="372">
                  <c:v>-0.628</c:v>
                </c:pt>
                <c:pt idx="373">
                  <c:v>-0.627</c:v>
                </c:pt>
                <c:pt idx="374">
                  <c:v>-0.626</c:v>
                </c:pt>
                <c:pt idx="375">
                  <c:v>-0.625</c:v>
                </c:pt>
                <c:pt idx="376">
                  <c:v>-0.624</c:v>
                </c:pt>
                <c:pt idx="377">
                  <c:v>-0.623</c:v>
                </c:pt>
                <c:pt idx="378">
                  <c:v>-0.622</c:v>
                </c:pt>
                <c:pt idx="379">
                  <c:v>-0.621</c:v>
                </c:pt>
                <c:pt idx="380">
                  <c:v>-0.62</c:v>
                </c:pt>
                <c:pt idx="381">
                  <c:v>-0.61899999999999999</c:v>
                </c:pt>
                <c:pt idx="382">
                  <c:v>-0.61799999999999999</c:v>
                </c:pt>
                <c:pt idx="383">
                  <c:v>-0.61699999999999999</c:v>
                </c:pt>
                <c:pt idx="384">
                  <c:v>-0.61599999999999999</c:v>
                </c:pt>
                <c:pt idx="385">
                  <c:v>-0.61499999999999999</c:v>
                </c:pt>
                <c:pt idx="386">
                  <c:v>-0.61399999999999999</c:v>
                </c:pt>
                <c:pt idx="387">
                  <c:v>-0.61299999999999999</c:v>
                </c:pt>
                <c:pt idx="388">
                  <c:v>-0.61199999999999999</c:v>
                </c:pt>
                <c:pt idx="389">
                  <c:v>-0.61099999999999999</c:v>
                </c:pt>
                <c:pt idx="390">
                  <c:v>-0.61</c:v>
                </c:pt>
                <c:pt idx="391">
                  <c:v>-0.60899999999999999</c:v>
                </c:pt>
                <c:pt idx="392">
                  <c:v>-0.60799999999999998</c:v>
                </c:pt>
                <c:pt idx="393">
                  <c:v>-0.60699999999999998</c:v>
                </c:pt>
                <c:pt idx="394">
                  <c:v>-0.60599999999999998</c:v>
                </c:pt>
                <c:pt idx="395">
                  <c:v>-0.60499999999999998</c:v>
                </c:pt>
                <c:pt idx="396">
                  <c:v>-0.60399999999999998</c:v>
                </c:pt>
                <c:pt idx="397">
                  <c:v>-0.60299999999999998</c:v>
                </c:pt>
                <c:pt idx="398">
                  <c:v>-0.60199999999999998</c:v>
                </c:pt>
                <c:pt idx="399">
                  <c:v>-0.60099999999999998</c:v>
                </c:pt>
                <c:pt idx="400">
                  <c:v>-0.6</c:v>
                </c:pt>
                <c:pt idx="401">
                  <c:v>-0.59899999999999998</c:v>
                </c:pt>
                <c:pt idx="402">
                  <c:v>-0.59799999999999998</c:v>
                </c:pt>
                <c:pt idx="403">
                  <c:v>-0.59699999999999998</c:v>
                </c:pt>
                <c:pt idx="404">
                  <c:v>-0.59599999999999997</c:v>
                </c:pt>
                <c:pt idx="405">
                  <c:v>-0.59499999999999997</c:v>
                </c:pt>
                <c:pt idx="406">
                  <c:v>-0.59399999999999997</c:v>
                </c:pt>
                <c:pt idx="407">
                  <c:v>-0.59299999999999997</c:v>
                </c:pt>
                <c:pt idx="408">
                  <c:v>-0.59200000000000008</c:v>
                </c:pt>
                <c:pt idx="409">
                  <c:v>-0.59099999999999997</c:v>
                </c:pt>
                <c:pt idx="410">
                  <c:v>-0.59000000000000008</c:v>
                </c:pt>
                <c:pt idx="411">
                  <c:v>-0.58899999999999997</c:v>
                </c:pt>
                <c:pt idx="412">
                  <c:v>-0.58800000000000008</c:v>
                </c:pt>
                <c:pt idx="413">
                  <c:v>-0.58699999999999997</c:v>
                </c:pt>
                <c:pt idx="414">
                  <c:v>-0.58600000000000008</c:v>
                </c:pt>
                <c:pt idx="415">
                  <c:v>-0.58499999999999996</c:v>
                </c:pt>
                <c:pt idx="416">
                  <c:v>-0.58400000000000007</c:v>
                </c:pt>
                <c:pt idx="417">
                  <c:v>-0.58299999999999996</c:v>
                </c:pt>
                <c:pt idx="418">
                  <c:v>-0.58200000000000007</c:v>
                </c:pt>
                <c:pt idx="419">
                  <c:v>-0.58099999999999996</c:v>
                </c:pt>
                <c:pt idx="420">
                  <c:v>-0.58000000000000007</c:v>
                </c:pt>
                <c:pt idx="421">
                  <c:v>-0.57899999999999996</c:v>
                </c:pt>
                <c:pt idx="422">
                  <c:v>-0.57800000000000007</c:v>
                </c:pt>
                <c:pt idx="423">
                  <c:v>-0.57699999999999996</c:v>
                </c:pt>
                <c:pt idx="424">
                  <c:v>-0.57600000000000007</c:v>
                </c:pt>
                <c:pt idx="425">
                  <c:v>-0.57499999999999996</c:v>
                </c:pt>
                <c:pt idx="426">
                  <c:v>-0.57400000000000007</c:v>
                </c:pt>
                <c:pt idx="427">
                  <c:v>-0.57299999999999995</c:v>
                </c:pt>
                <c:pt idx="428">
                  <c:v>-0.57200000000000006</c:v>
                </c:pt>
                <c:pt idx="429">
                  <c:v>-0.57099999999999995</c:v>
                </c:pt>
                <c:pt idx="430">
                  <c:v>-0.57000000000000006</c:v>
                </c:pt>
                <c:pt idx="431">
                  <c:v>-0.56899999999999995</c:v>
                </c:pt>
                <c:pt idx="432">
                  <c:v>-0.56800000000000006</c:v>
                </c:pt>
                <c:pt idx="433">
                  <c:v>-0.56699999999999995</c:v>
                </c:pt>
                <c:pt idx="434">
                  <c:v>-0.56600000000000006</c:v>
                </c:pt>
                <c:pt idx="435">
                  <c:v>-0.56499999999999995</c:v>
                </c:pt>
                <c:pt idx="436">
                  <c:v>-0.56400000000000006</c:v>
                </c:pt>
                <c:pt idx="437">
                  <c:v>-0.56299999999999994</c:v>
                </c:pt>
                <c:pt idx="438">
                  <c:v>-0.56200000000000006</c:v>
                </c:pt>
                <c:pt idx="439">
                  <c:v>-0.56099999999999994</c:v>
                </c:pt>
                <c:pt idx="440">
                  <c:v>-0.56000000000000005</c:v>
                </c:pt>
                <c:pt idx="441">
                  <c:v>-0.55899999999999994</c:v>
                </c:pt>
                <c:pt idx="442">
                  <c:v>-0.55800000000000005</c:v>
                </c:pt>
                <c:pt idx="443">
                  <c:v>-0.55699999999999994</c:v>
                </c:pt>
                <c:pt idx="444">
                  <c:v>-0.55600000000000005</c:v>
                </c:pt>
                <c:pt idx="445">
                  <c:v>-0.55499999999999994</c:v>
                </c:pt>
                <c:pt idx="446">
                  <c:v>-0.55400000000000005</c:v>
                </c:pt>
                <c:pt idx="447">
                  <c:v>-0.55299999999999994</c:v>
                </c:pt>
                <c:pt idx="448">
                  <c:v>-0.55200000000000005</c:v>
                </c:pt>
                <c:pt idx="449">
                  <c:v>-0.55099999999999993</c:v>
                </c:pt>
                <c:pt idx="450">
                  <c:v>-0.55000000000000004</c:v>
                </c:pt>
                <c:pt idx="451">
                  <c:v>-0.54899999999999993</c:v>
                </c:pt>
                <c:pt idx="452">
                  <c:v>-0.54800000000000004</c:v>
                </c:pt>
                <c:pt idx="453">
                  <c:v>-0.54699999999999993</c:v>
                </c:pt>
                <c:pt idx="454">
                  <c:v>-0.54600000000000004</c:v>
                </c:pt>
                <c:pt idx="455">
                  <c:v>-0.54499999999999993</c:v>
                </c:pt>
                <c:pt idx="456">
                  <c:v>-0.54400000000000004</c:v>
                </c:pt>
                <c:pt idx="457">
                  <c:v>-0.54299999999999993</c:v>
                </c:pt>
                <c:pt idx="458">
                  <c:v>-0.54200000000000004</c:v>
                </c:pt>
                <c:pt idx="459">
                  <c:v>-0.54099999999999993</c:v>
                </c:pt>
                <c:pt idx="460">
                  <c:v>-0.54</c:v>
                </c:pt>
                <c:pt idx="461">
                  <c:v>-0.53899999999999992</c:v>
                </c:pt>
                <c:pt idx="462">
                  <c:v>-0.53800000000000003</c:v>
                </c:pt>
                <c:pt idx="463">
                  <c:v>-0.53699999999999992</c:v>
                </c:pt>
                <c:pt idx="464">
                  <c:v>-0.53600000000000003</c:v>
                </c:pt>
                <c:pt idx="465">
                  <c:v>-0.53499999999999992</c:v>
                </c:pt>
                <c:pt idx="466">
                  <c:v>-0.53400000000000003</c:v>
                </c:pt>
                <c:pt idx="467">
                  <c:v>-0.53299999999999992</c:v>
                </c:pt>
                <c:pt idx="468">
                  <c:v>-0.53200000000000003</c:v>
                </c:pt>
                <c:pt idx="469">
                  <c:v>-0.53100000000000003</c:v>
                </c:pt>
                <c:pt idx="470">
                  <c:v>-0.53</c:v>
                </c:pt>
                <c:pt idx="471">
                  <c:v>-0.52900000000000003</c:v>
                </c:pt>
                <c:pt idx="472">
                  <c:v>-0.52800000000000002</c:v>
                </c:pt>
                <c:pt idx="473">
                  <c:v>-0.52700000000000002</c:v>
                </c:pt>
                <c:pt idx="474">
                  <c:v>-0.52600000000000002</c:v>
                </c:pt>
                <c:pt idx="475">
                  <c:v>-0.52500000000000002</c:v>
                </c:pt>
                <c:pt idx="476">
                  <c:v>-0.52400000000000002</c:v>
                </c:pt>
                <c:pt idx="477">
                  <c:v>-0.52300000000000002</c:v>
                </c:pt>
                <c:pt idx="478">
                  <c:v>-0.52200000000000002</c:v>
                </c:pt>
                <c:pt idx="479">
                  <c:v>-0.52100000000000002</c:v>
                </c:pt>
                <c:pt idx="480">
                  <c:v>-0.52</c:v>
                </c:pt>
                <c:pt idx="481">
                  <c:v>-0.51900000000000002</c:v>
                </c:pt>
                <c:pt idx="482">
                  <c:v>-0.51800000000000002</c:v>
                </c:pt>
                <c:pt idx="483">
                  <c:v>-0.51700000000000002</c:v>
                </c:pt>
                <c:pt idx="484">
                  <c:v>-0.51600000000000001</c:v>
                </c:pt>
                <c:pt idx="485">
                  <c:v>-0.51500000000000001</c:v>
                </c:pt>
                <c:pt idx="486">
                  <c:v>-0.51400000000000001</c:v>
                </c:pt>
                <c:pt idx="487">
                  <c:v>-0.51300000000000001</c:v>
                </c:pt>
                <c:pt idx="488">
                  <c:v>-0.51200000000000001</c:v>
                </c:pt>
                <c:pt idx="489">
                  <c:v>-0.51100000000000001</c:v>
                </c:pt>
                <c:pt idx="490">
                  <c:v>-0.51</c:v>
                </c:pt>
                <c:pt idx="491">
                  <c:v>-0.50900000000000001</c:v>
                </c:pt>
                <c:pt idx="492">
                  <c:v>-0.50800000000000001</c:v>
                </c:pt>
                <c:pt idx="493">
                  <c:v>-0.50700000000000001</c:v>
                </c:pt>
                <c:pt idx="494">
                  <c:v>-0.50600000000000001</c:v>
                </c:pt>
                <c:pt idx="495">
                  <c:v>-0.505</c:v>
                </c:pt>
                <c:pt idx="496">
                  <c:v>-0.504</c:v>
                </c:pt>
                <c:pt idx="497">
                  <c:v>-0.503</c:v>
                </c:pt>
                <c:pt idx="498">
                  <c:v>-0.502</c:v>
                </c:pt>
                <c:pt idx="499">
                  <c:v>-0.501</c:v>
                </c:pt>
                <c:pt idx="500">
                  <c:v>-0.5</c:v>
                </c:pt>
                <c:pt idx="501">
                  <c:v>-0.499</c:v>
                </c:pt>
                <c:pt idx="502">
                  <c:v>-0.498</c:v>
                </c:pt>
                <c:pt idx="503">
                  <c:v>-0.497</c:v>
                </c:pt>
                <c:pt idx="504">
                  <c:v>-0.496</c:v>
                </c:pt>
                <c:pt idx="505">
                  <c:v>-0.495</c:v>
                </c:pt>
                <c:pt idx="506">
                  <c:v>-0.49399999999999999</c:v>
                </c:pt>
                <c:pt idx="507">
                  <c:v>-0.49299999999999999</c:v>
                </c:pt>
                <c:pt idx="508">
                  <c:v>-0.49199999999999999</c:v>
                </c:pt>
                <c:pt idx="509">
                  <c:v>-0.49099999999999999</c:v>
                </c:pt>
                <c:pt idx="510">
                  <c:v>-0.49</c:v>
                </c:pt>
                <c:pt idx="511">
                  <c:v>-0.48899999999999999</c:v>
                </c:pt>
                <c:pt idx="512">
                  <c:v>-0.48799999999999999</c:v>
                </c:pt>
                <c:pt idx="513">
                  <c:v>-0.48699999999999999</c:v>
                </c:pt>
                <c:pt idx="514">
                  <c:v>-0.48599999999999999</c:v>
                </c:pt>
                <c:pt idx="515">
                  <c:v>-0.48499999999999999</c:v>
                </c:pt>
                <c:pt idx="516">
                  <c:v>-0.48399999999999999</c:v>
                </c:pt>
                <c:pt idx="517">
                  <c:v>-0.48299999999999998</c:v>
                </c:pt>
                <c:pt idx="518">
                  <c:v>-0.48199999999999998</c:v>
                </c:pt>
                <c:pt idx="519">
                  <c:v>-0.48099999999999998</c:v>
                </c:pt>
                <c:pt idx="520">
                  <c:v>-0.48</c:v>
                </c:pt>
                <c:pt idx="521">
                  <c:v>-0.47899999999999998</c:v>
                </c:pt>
                <c:pt idx="522">
                  <c:v>-0.47799999999999998</c:v>
                </c:pt>
                <c:pt idx="523">
                  <c:v>-0.47699999999999998</c:v>
                </c:pt>
                <c:pt idx="524">
                  <c:v>-0.47599999999999998</c:v>
                </c:pt>
                <c:pt idx="525">
                  <c:v>-0.47499999999999998</c:v>
                </c:pt>
                <c:pt idx="526">
                  <c:v>-0.47399999999999998</c:v>
                </c:pt>
                <c:pt idx="527">
                  <c:v>-0.47299999999999998</c:v>
                </c:pt>
                <c:pt idx="528">
                  <c:v>-0.47199999999999998</c:v>
                </c:pt>
                <c:pt idx="529">
                  <c:v>-0.47099999999999997</c:v>
                </c:pt>
                <c:pt idx="530">
                  <c:v>-0.47</c:v>
                </c:pt>
                <c:pt idx="531">
                  <c:v>-0.46899999999999997</c:v>
                </c:pt>
                <c:pt idx="532">
                  <c:v>-0.46799999999999997</c:v>
                </c:pt>
                <c:pt idx="533">
                  <c:v>-0.46699999999999997</c:v>
                </c:pt>
                <c:pt idx="534">
                  <c:v>-0.46599999999999997</c:v>
                </c:pt>
                <c:pt idx="535">
                  <c:v>-0.46499999999999997</c:v>
                </c:pt>
                <c:pt idx="536">
                  <c:v>-0.46399999999999997</c:v>
                </c:pt>
                <c:pt idx="537">
                  <c:v>-0.46299999999999997</c:v>
                </c:pt>
                <c:pt idx="538">
                  <c:v>-0.46199999999999997</c:v>
                </c:pt>
                <c:pt idx="539">
                  <c:v>-0.46099999999999997</c:v>
                </c:pt>
                <c:pt idx="540">
                  <c:v>-0.45999999999999996</c:v>
                </c:pt>
                <c:pt idx="541">
                  <c:v>-0.45899999999999996</c:v>
                </c:pt>
                <c:pt idx="542">
                  <c:v>-0.45799999999999996</c:v>
                </c:pt>
                <c:pt idx="543">
                  <c:v>-0.45699999999999996</c:v>
                </c:pt>
                <c:pt idx="544">
                  <c:v>-0.45599999999999996</c:v>
                </c:pt>
                <c:pt idx="545">
                  <c:v>-0.45499999999999996</c:v>
                </c:pt>
                <c:pt idx="546">
                  <c:v>-0.45399999999999996</c:v>
                </c:pt>
                <c:pt idx="547">
                  <c:v>-0.45299999999999996</c:v>
                </c:pt>
                <c:pt idx="548">
                  <c:v>-0.45199999999999996</c:v>
                </c:pt>
                <c:pt idx="549">
                  <c:v>-0.45099999999999996</c:v>
                </c:pt>
                <c:pt idx="550">
                  <c:v>-0.44999999999999996</c:v>
                </c:pt>
                <c:pt idx="551">
                  <c:v>-0.44899999999999995</c:v>
                </c:pt>
                <c:pt idx="552">
                  <c:v>-0.44799999999999995</c:v>
                </c:pt>
                <c:pt idx="553">
                  <c:v>-0.44699999999999995</c:v>
                </c:pt>
                <c:pt idx="554">
                  <c:v>-0.44599999999999995</c:v>
                </c:pt>
                <c:pt idx="555">
                  <c:v>-0.44499999999999995</c:v>
                </c:pt>
                <c:pt idx="556">
                  <c:v>-0.44399999999999995</c:v>
                </c:pt>
                <c:pt idx="557">
                  <c:v>-0.44299999999999995</c:v>
                </c:pt>
                <c:pt idx="558">
                  <c:v>-0.44199999999999995</c:v>
                </c:pt>
                <c:pt idx="559">
                  <c:v>-0.44099999999999995</c:v>
                </c:pt>
                <c:pt idx="560">
                  <c:v>-0.43999999999999995</c:v>
                </c:pt>
                <c:pt idx="561">
                  <c:v>-0.43899999999999995</c:v>
                </c:pt>
                <c:pt idx="562">
                  <c:v>-0.43799999999999994</c:v>
                </c:pt>
                <c:pt idx="563">
                  <c:v>-0.43700000000000006</c:v>
                </c:pt>
                <c:pt idx="564">
                  <c:v>-0.43600000000000005</c:v>
                </c:pt>
                <c:pt idx="565">
                  <c:v>-0.43500000000000005</c:v>
                </c:pt>
                <c:pt idx="566">
                  <c:v>-0.43400000000000005</c:v>
                </c:pt>
                <c:pt idx="567">
                  <c:v>-0.43300000000000005</c:v>
                </c:pt>
                <c:pt idx="568">
                  <c:v>-0.43200000000000005</c:v>
                </c:pt>
                <c:pt idx="569">
                  <c:v>-0.43100000000000005</c:v>
                </c:pt>
                <c:pt idx="570">
                  <c:v>-0.43000000000000005</c:v>
                </c:pt>
                <c:pt idx="571">
                  <c:v>-0.42900000000000005</c:v>
                </c:pt>
                <c:pt idx="572">
                  <c:v>-0.42800000000000005</c:v>
                </c:pt>
                <c:pt idx="573">
                  <c:v>-0.42700000000000005</c:v>
                </c:pt>
                <c:pt idx="574">
                  <c:v>-0.42600000000000005</c:v>
                </c:pt>
                <c:pt idx="575">
                  <c:v>-0.42500000000000004</c:v>
                </c:pt>
                <c:pt idx="576">
                  <c:v>-0.42400000000000004</c:v>
                </c:pt>
                <c:pt idx="577">
                  <c:v>-0.42300000000000004</c:v>
                </c:pt>
                <c:pt idx="578">
                  <c:v>-0.42200000000000004</c:v>
                </c:pt>
                <c:pt idx="579">
                  <c:v>-0.42100000000000004</c:v>
                </c:pt>
                <c:pt idx="580">
                  <c:v>-0.42000000000000004</c:v>
                </c:pt>
                <c:pt idx="581">
                  <c:v>-0.41900000000000004</c:v>
                </c:pt>
                <c:pt idx="582">
                  <c:v>-0.41800000000000004</c:v>
                </c:pt>
                <c:pt idx="583">
                  <c:v>-0.41700000000000004</c:v>
                </c:pt>
                <c:pt idx="584">
                  <c:v>-0.41600000000000004</c:v>
                </c:pt>
                <c:pt idx="585">
                  <c:v>-0.41500000000000004</c:v>
                </c:pt>
                <c:pt idx="586">
                  <c:v>-0.41400000000000003</c:v>
                </c:pt>
                <c:pt idx="587">
                  <c:v>-0.41300000000000003</c:v>
                </c:pt>
                <c:pt idx="588">
                  <c:v>-0.41200000000000003</c:v>
                </c:pt>
                <c:pt idx="589">
                  <c:v>-0.41100000000000003</c:v>
                </c:pt>
                <c:pt idx="590">
                  <c:v>-0.41000000000000003</c:v>
                </c:pt>
                <c:pt idx="591">
                  <c:v>-0.40900000000000003</c:v>
                </c:pt>
                <c:pt idx="592">
                  <c:v>-0.40800000000000003</c:v>
                </c:pt>
                <c:pt idx="593">
                  <c:v>-0.40700000000000003</c:v>
                </c:pt>
                <c:pt idx="594">
                  <c:v>-0.40600000000000003</c:v>
                </c:pt>
                <c:pt idx="595">
                  <c:v>-0.40500000000000003</c:v>
                </c:pt>
                <c:pt idx="596">
                  <c:v>-0.40400000000000003</c:v>
                </c:pt>
                <c:pt idx="597">
                  <c:v>-0.40300000000000002</c:v>
                </c:pt>
                <c:pt idx="598">
                  <c:v>-0.40200000000000002</c:v>
                </c:pt>
                <c:pt idx="599">
                  <c:v>-0.40100000000000002</c:v>
                </c:pt>
                <c:pt idx="600">
                  <c:v>-0.4</c:v>
                </c:pt>
                <c:pt idx="601">
                  <c:v>-0.39900000000000002</c:v>
                </c:pt>
                <c:pt idx="602">
                  <c:v>-0.39800000000000002</c:v>
                </c:pt>
                <c:pt idx="603">
                  <c:v>-0.39700000000000002</c:v>
                </c:pt>
                <c:pt idx="604">
                  <c:v>-0.39600000000000002</c:v>
                </c:pt>
                <c:pt idx="605">
                  <c:v>-0.39500000000000002</c:v>
                </c:pt>
                <c:pt idx="606">
                  <c:v>-0.39400000000000002</c:v>
                </c:pt>
                <c:pt idx="607">
                  <c:v>-0.39300000000000002</c:v>
                </c:pt>
                <c:pt idx="608">
                  <c:v>-0.39200000000000002</c:v>
                </c:pt>
                <c:pt idx="609">
                  <c:v>-0.39100000000000001</c:v>
                </c:pt>
                <c:pt idx="610">
                  <c:v>-0.39</c:v>
                </c:pt>
                <c:pt idx="611">
                  <c:v>-0.38900000000000001</c:v>
                </c:pt>
                <c:pt idx="612">
                  <c:v>-0.38800000000000001</c:v>
                </c:pt>
                <c:pt idx="613">
                  <c:v>-0.38700000000000001</c:v>
                </c:pt>
                <c:pt idx="614">
                  <c:v>-0.38600000000000001</c:v>
                </c:pt>
                <c:pt idx="615">
                  <c:v>-0.38500000000000001</c:v>
                </c:pt>
                <c:pt idx="616">
                  <c:v>-0.38400000000000001</c:v>
                </c:pt>
                <c:pt idx="617">
                  <c:v>-0.38300000000000001</c:v>
                </c:pt>
                <c:pt idx="618">
                  <c:v>-0.38200000000000001</c:v>
                </c:pt>
                <c:pt idx="619">
                  <c:v>-0.38100000000000001</c:v>
                </c:pt>
                <c:pt idx="620">
                  <c:v>-0.38</c:v>
                </c:pt>
                <c:pt idx="621">
                  <c:v>-0.379</c:v>
                </c:pt>
                <c:pt idx="622">
                  <c:v>-0.378</c:v>
                </c:pt>
                <c:pt idx="623">
                  <c:v>-0.377</c:v>
                </c:pt>
                <c:pt idx="624">
                  <c:v>-0.376</c:v>
                </c:pt>
                <c:pt idx="625">
                  <c:v>-0.375</c:v>
                </c:pt>
                <c:pt idx="626">
                  <c:v>-0.374</c:v>
                </c:pt>
                <c:pt idx="627">
                  <c:v>-0.373</c:v>
                </c:pt>
                <c:pt idx="628">
                  <c:v>-0.372</c:v>
                </c:pt>
                <c:pt idx="629">
                  <c:v>-0.371</c:v>
                </c:pt>
                <c:pt idx="630">
                  <c:v>-0.37</c:v>
                </c:pt>
                <c:pt idx="631">
                  <c:v>-0.36899999999999999</c:v>
                </c:pt>
                <c:pt idx="632">
                  <c:v>-0.36799999999999999</c:v>
                </c:pt>
                <c:pt idx="633">
                  <c:v>-0.36699999999999999</c:v>
                </c:pt>
                <c:pt idx="634">
                  <c:v>-0.36599999999999999</c:v>
                </c:pt>
                <c:pt idx="635">
                  <c:v>-0.36499999999999999</c:v>
                </c:pt>
                <c:pt idx="636">
                  <c:v>-0.36399999999999999</c:v>
                </c:pt>
                <c:pt idx="637">
                  <c:v>-0.36299999999999999</c:v>
                </c:pt>
                <c:pt idx="638">
                  <c:v>-0.36199999999999999</c:v>
                </c:pt>
                <c:pt idx="639">
                  <c:v>-0.36099999999999999</c:v>
                </c:pt>
                <c:pt idx="640">
                  <c:v>-0.36</c:v>
                </c:pt>
                <c:pt idx="641">
                  <c:v>-0.35899999999999999</c:v>
                </c:pt>
                <c:pt idx="642">
                  <c:v>-0.35799999999999998</c:v>
                </c:pt>
                <c:pt idx="643">
                  <c:v>-0.35699999999999998</c:v>
                </c:pt>
                <c:pt idx="644">
                  <c:v>-0.35599999999999998</c:v>
                </c:pt>
                <c:pt idx="645">
                  <c:v>-0.35499999999999998</c:v>
                </c:pt>
                <c:pt idx="646">
                  <c:v>-0.35399999999999998</c:v>
                </c:pt>
                <c:pt idx="647">
                  <c:v>-0.35299999999999998</c:v>
                </c:pt>
                <c:pt idx="648">
                  <c:v>-0.35199999999999998</c:v>
                </c:pt>
                <c:pt idx="649">
                  <c:v>-0.35099999999999998</c:v>
                </c:pt>
                <c:pt idx="650">
                  <c:v>-0.35</c:v>
                </c:pt>
                <c:pt idx="651">
                  <c:v>-0.34899999999999998</c:v>
                </c:pt>
                <c:pt idx="652">
                  <c:v>-0.34799999999999998</c:v>
                </c:pt>
                <c:pt idx="653">
                  <c:v>-0.34699999999999998</c:v>
                </c:pt>
                <c:pt idx="654">
                  <c:v>-0.34599999999999997</c:v>
                </c:pt>
                <c:pt idx="655">
                  <c:v>-0.34499999999999997</c:v>
                </c:pt>
                <c:pt idx="656">
                  <c:v>-0.34399999999999997</c:v>
                </c:pt>
                <c:pt idx="657">
                  <c:v>-0.34299999999999997</c:v>
                </c:pt>
                <c:pt idx="658">
                  <c:v>-0.34199999999999997</c:v>
                </c:pt>
                <c:pt idx="659">
                  <c:v>-0.34099999999999997</c:v>
                </c:pt>
                <c:pt idx="660">
                  <c:v>-0.33999999999999997</c:v>
                </c:pt>
                <c:pt idx="661">
                  <c:v>-0.33899999999999997</c:v>
                </c:pt>
                <c:pt idx="662">
                  <c:v>-0.33799999999999997</c:v>
                </c:pt>
                <c:pt idx="663">
                  <c:v>-0.33699999999999997</c:v>
                </c:pt>
                <c:pt idx="664">
                  <c:v>-0.33599999999999997</c:v>
                </c:pt>
                <c:pt idx="665">
                  <c:v>-0.33499999999999996</c:v>
                </c:pt>
                <c:pt idx="666">
                  <c:v>-0.33399999999999996</c:v>
                </c:pt>
                <c:pt idx="667">
                  <c:v>-0.33299999999999996</c:v>
                </c:pt>
                <c:pt idx="668">
                  <c:v>-0.33199999999999996</c:v>
                </c:pt>
                <c:pt idx="669">
                  <c:v>-0.33099999999999996</c:v>
                </c:pt>
                <c:pt idx="670">
                  <c:v>-0.32999999999999996</c:v>
                </c:pt>
                <c:pt idx="671">
                  <c:v>-0.32899999999999996</c:v>
                </c:pt>
                <c:pt idx="672">
                  <c:v>-0.32799999999999996</c:v>
                </c:pt>
                <c:pt idx="673">
                  <c:v>-0.32699999999999996</c:v>
                </c:pt>
                <c:pt idx="674">
                  <c:v>-0.32599999999999996</c:v>
                </c:pt>
                <c:pt idx="675">
                  <c:v>-0.32499999999999996</c:v>
                </c:pt>
                <c:pt idx="676">
                  <c:v>-0.32399999999999995</c:v>
                </c:pt>
                <c:pt idx="677">
                  <c:v>-0.32299999999999995</c:v>
                </c:pt>
                <c:pt idx="678">
                  <c:v>-0.32199999999999995</c:v>
                </c:pt>
                <c:pt idx="679">
                  <c:v>-0.32099999999999995</c:v>
                </c:pt>
                <c:pt idx="680">
                  <c:v>-0.31999999999999995</c:v>
                </c:pt>
                <c:pt idx="681">
                  <c:v>-0.31899999999999995</c:v>
                </c:pt>
                <c:pt idx="682">
                  <c:v>-0.31799999999999995</c:v>
                </c:pt>
                <c:pt idx="683">
                  <c:v>-0.31699999999999995</c:v>
                </c:pt>
                <c:pt idx="684">
                  <c:v>-0.31599999999999995</c:v>
                </c:pt>
                <c:pt idx="685">
                  <c:v>-0.31499999999999995</c:v>
                </c:pt>
                <c:pt idx="686">
                  <c:v>-0.31399999999999995</c:v>
                </c:pt>
                <c:pt idx="687">
                  <c:v>-0.31299999999999994</c:v>
                </c:pt>
                <c:pt idx="688">
                  <c:v>-0.31200000000000006</c:v>
                </c:pt>
                <c:pt idx="689">
                  <c:v>-0.31100000000000005</c:v>
                </c:pt>
                <c:pt idx="690">
                  <c:v>-0.31000000000000005</c:v>
                </c:pt>
                <c:pt idx="691">
                  <c:v>-0.30900000000000005</c:v>
                </c:pt>
                <c:pt idx="692">
                  <c:v>-0.30800000000000005</c:v>
                </c:pt>
                <c:pt idx="693">
                  <c:v>-0.30700000000000005</c:v>
                </c:pt>
                <c:pt idx="694">
                  <c:v>-0.30600000000000005</c:v>
                </c:pt>
                <c:pt idx="695">
                  <c:v>-0.30500000000000005</c:v>
                </c:pt>
                <c:pt idx="696">
                  <c:v>-0.30400000000000005</c:v>
                </c:pt>
                <c:pt idx="697">
                  <c:v>-0.30300000000000005</c:v>
                </c:pt>
                <c:pt idx="698">
                  <c:v>-0.30200000000000005</c:v>
                </c:pt>
                <c:pt idx="699">
                  <c:v>-0.30100000000000005</c:v>
                </c:pt>
                <c:pt idx="700">
                  <c:v>-0.30000000000000004</c:v>
                </c:pt>
                <c:pt idx="701">
                  <c:v>-0.29900000000000004</c:v>
                </c:pt>
                <c:pt idx="702">
                  <c:v>-0.29800000000000004</c:v>
                </c:pt>
                <c:pt idx="703">
                  <c:v>-0.29700000000000004</c:v>
                </c:pt>
                <c:pt idx="704">
                  <c:v>-0.29600000000000004</c:v>
                </c:pt>
                <c:pt idx="705">
                  <c:v>-0.29500000000000004</c:v>
                </c:pt>
                <c:pt idx="706">
                  <c:v>-0.29400000000000004</c:v>
                </c:pt>
                <c:pt idx="707">
                  <c:v>-0.29300000000000004</c:v>
                </c:pt>
                <c:pt idx="708">
                  <c:v>-0.29200000000000004</c:v>
                </c:pt>
                <c:pt idx="709">
                  <c:v>-0.29100000000000004</c:v>
                </c:pt>
                <c:pt idx="710">
                  <c:v>-0.29000000000000004</c:v>
                </c:pt>
                <c:pt idx="711">
                  <c:v>-0.28900000000000003</c:v>
                </c:pt>
                <c:pt idx="712">
                  <c:v>-0.28800000000000003</c:v>
                </c:pt>
                <c:pt idx="713">
                  <c:v>-0.28700000000000003</c:v>
                </c:pt>
                <c:pt idx="714">
                  <c:v>-0.28600000000000003</c:v>
                </c:pt>
                <c:pt idx="715">
                  <c:v>-0.28500000000000003</c:v>
                </c:pt>
                <c:pt idx="716">
                  <c:v>-0.28400000000000003</c:v>
                </c:pt>
                <c:pt idx="717">
                  <c:v>-0.28300000000000003</c:v>
                </c:pt>
                <c:pt idx="718">
                  <c:v>-0.28200000000000003</c:v>
                </c:pt>
                <c:pt idx="719">
                  <c:v>-0.28100000000000003</c:v>
                </c:pt>
                <c:pt idx="720">
                  <c:v>-0.28000000000000003</c:v>
                </c:pt>
                <c:pt idx="721">
                  <c:v>-0.27900000000000003</c:v>
                </c:pt>
                <c:pt idx="722">
                  <c:v>-0.27800000000000002</c:v>
                </c:pt>
                <c:pt idx="723">
                  <c:v>-0.27700000000000002</c:v>
                </c:pt>
                <c:pt idx="724">
                  <c:v>-0.27600000000000002</c:v>
                </c:pt>
                <c:pt idx="725">
                  <c:v>-0.27500000000000002</c:v>
                </c:pt>
                <c:pt idx="726">
                  <c:v>-0.27400000000000002</c:v>
                </c:pt>
                <c:pt idx="727">
                  <c:v>-0.27300000000000002</c:v>
                </c:pt>
                <c:pt idx="728">
                  <c:v>-0.27200000000000002</c:v>
                </c:pt>
                <c:pt idx="729">
                  <c:v>-0.27100000000000002</c:v>
                </c:pt>
                <c:pt idx="730">
                  <c:v>-0.27</c:v>
                </c:pt>
                <c:pt idx="731">
                  <c:v>-0.26900000000000002</c:v>
                </c:pt>
                <c:pt idx="732">
                  <c:v>-0.26800000000000002</c:v>
                </c:pt>
                <c:pt idx="733">
                  <c:v>-0.26700000000000002</c:v>
                </c:pt>
                <c:pt idx="734">
                  <c:v>-0.26600000000000001</c:v>
                </c:pt>
                <c:pt idx="735">
                  <c:v>-0.26500000000000001</c:v>
                </c:pt>
                <c:pt idx="736">
                  <c:v>-0.26400000000000001</c:v>
                </c:pt>
                <c:pt idx="737">
                  <c:v>-0.26300000000000001</c:v>
                </c:pt>
                <c:pt idx="738">
                  <c:v>-0.26200000000000001</c:v>
                </c:pt>
                <c:pt idx="739">
                  <c:v>-0.26100000000000001</c:v>
                </c:pt>
                <c:pt idx="740">
                  <c:v>-0.26</c:v>
                </c:pt>
                <c:pt idx="741">
                  <c:v>-0.25900000000000001</c:v>
                </c:pt>
                <c:pt idx="742">
                  <c:v>-0.25800000000000001</c:v>
                </c:pt>
                <c:pt idx="743">
                  <c:v>-0.25700000000000001</c:v>
                </c:pt>
                <c:pt idx="744">
                  <c:v>-0.25600000000000001</c:v>
                </c:pt>
                <c:pt idx="745">
                  <c:v>-0.255</c:v>
                </c:pt>
                <c:pt idx="746">
                  <c:v>-0.254</c:v>
                </c:pt>
                <c:pt idx="747">
                  <c:v>-0.253</c:v>
                </c:pt>
                <c:pt idx="748">
                  <c:v>-0.252</c:v>
                </c:pt>
                <c:pt idx="749">
                  <c:v>-0.251</c:v>
                </c:pt>
                <c:pt idx="750">
                  <c:v>-0.25</c:v>
                </c:pt>
                <c:pt idx="751">
                  <c:v>-0.249</c:v>
                </c:pt>
                <c:pt idx="752">
                  <c:v>-0.248</c:v>
                </c:pt>
                <c:pt idx="753">
                  <c:v>-0.247</c:v>
                </c:pt>
                <c:pt idx="754">
                  <c:v>-0.246</c:v>
                </c:pt>
                <c:pt idx="755">
                  <c:v>-0.245</c:v>
                </c:pt>
                <c:pt idx="756">
                  <c:v>-0.24399999999999999</c:v>
                </c:pt>
                <c:pt idx="757">
                  <c:v>-0.24299999999999999</c:v>
                </c:pt>
                <c:pt idx="758">
                  <c:v>-0.24199999999999999</c:v>
                </c:pt>
                <c:pt idx="759">
                  <c:v>-0.24099999999999999</c:v>
                </c:pt>
                <c:pt idx="760">
                  <c:v>-0.24</c:v>
                </c:pt>
                <c:pt idx="761">
                  <c:v>-0.23899999999999999</c:v>
                </c:pt>
                <c:pt idx="762">
                  <c:v>-0.23799999999999999</c:v>
                </c:pt>
                <c:pt idx="763">
                  <c:v>-0.23699999999999999</c:v>
                </c:pt>
                <c:pt idx="764">
                  <c:v>-0.23599999999999999</c:v>
                </c:pt>
                <c:pt idx="765">
                  <c:v>-0.23499999999999999</c:v>
                </c:pt>
                <c:pt idx="766">
                  <c:v>-0.23399999999999999</c:v>
                </c:pt>
                <c:pt idx="767">
                  <c:v>-0.23299999999999998</c:v>
                </c:pt>
                <c:pt idx="768">
                  <c:v>-0.23199999999999998</c:v>
                </c:pt>
                <c:pt idx="769">
                  <c:v>-0.23099999999999998</c:v>
                </c:pt>
                <c:pt idx="770">
                  <c:v>-0.22999999999999998</c:v>
                </c:pt>
                <c:pt idx="771">
                  <c:v>-0.22899999999999998</c:v>
                </c:pt>
                <c:pt idx="772">
                  <c:v>-0.22799999999999998</c:v>
                </c:pt>
                <c:pt idx="773">
                  <c:v>-0.22699999999999998</c:v>
                </c:pt>
                <c:pt idx="774">
                  <c:v>-0.22599999999999998</c:v>
                </c:pt>
                <c:pt idx="775">
                  <c:v>-0.22499999999999998</c:v>
                </c:pt>
                <c:pt idx="776">
                  <c:v>-0.22399999999999998</c:v>
                </c:pt>
                <c:pt idx="777">
                  <c:v>-0.22299999999999998</c:v>
                </c:pt>
                <c:pt idx="778">
                  <c:v>-0.22199999999999998</c:v>
                </c:pt>
                <c:pt idx="779">
                  <c:v>-0.22099999999999997</c:v>
                </c:pt>
                <c:pt idx="780">
                  <c:v>-0.21999999999999997</c:v>
                </c:pt>
                <c:pt idx="781">
                  <c:v>-0.21899999999999997</c:v>
                </c:pt>
                <c:pt idx="782">
                  <c:v>-0.21799999999999997</c:v>
                </c:pt>
                <c:pt idx="783">
                  <c:v>-0.21699999999999997</c:v>
                </c:pt>
                <c:pt idx="784">
                  <c:v>-0.21599999999999997</c:v>
                </c:pt>
                <c:pt idx="785">
                  <c:v>-0.21499999999999997</c:v>
                </c:pt>
                <c:pt idx="786">
                  <c:v>-0.21399999999999997</c:v>
                </c:pt>
                <c:pt idx="787">
                  <c:v>-0.21299999999999997</c:v>
                </c:pt>
                <c:pt idx="788">
                  <c:v>-0.21199999999999997</c:v>
                </c:pt>
                <c:pt idx="789">
                  <c:v>-0.21099999999999997</c:v>
                </c:pt>
                <c:pt idx="790">
                  <c:v>-0.20999999999999996</c:v>
                </c:pt>
                <c:pt idx="791">
                  <c:v>-0.20899999999999996</c:v>
                </c:pt>
                <c:pt idx="792">
                  <c:v>-0.20799999999999996</c:v>
                </c:pt>
                <c:pt idx="793">
                  <c:v>-0.20699999999999996</c:v>
                </c:pt>
                <c:pt idx="794">
                  <c:v>-0.20599999999999996</c:v>
                </c:pt>
                <c:pt idx="795">
                  <c:v>-0.20499999999999996</c:v>
                </c:pt>
                <c:pt idx="796">
                  <c:v>-0.20399999999999996</c:v>
                </c:pt>
                <c:pt idx="797">
                  <c:v>-0.20299999999999996</c:v>
                </c:pt>
                <c:pt idx="798">
                  <c:v>-0.20199999999999996</c:v>
                </c:pt>
                <c:pt idx="799">
                  <c:v>-0.20099999999999996</c:v>
                </c:pt>
                <c:pt idx="800">
                  <c:v>-0.19999999999999996</c:v>
                </c:pt>
                <c:pt idx="801">
                  <c:v>-0.19899999999999995</c:v>
                </c:pt>
                <c:pt idx="802">
                  <c:v>-0.19799999999999995</c:v>
                </c:pt>
                <c:pt idx="803">
                  <c:v>-0.19699999999999995</c:v>
                </c:pt>
                <c:pt idx="804">
                  <c:v>-0.19599999999999995</c:v>
                </c:pt>
                <c:pt idx="805">
                  <c:v>-0.19499999999999995</c:v>
                </c:pt>
                <c:pt idx="806">
                  <c:v>-0.19399999999999995</c:v>
                </c:pt>
                <c:pt idx="807">
                  <c:v>-0.19299999999999995</c:v>
                </c:pt>
                <c:pt idx="808">
                  <c:v>-0.19199999999999995</c:v>
                </c:pt>
                <c:pt idx="809">
                  <c:v>-0.19099999999999995</c:v>
                </c:pt>
                <c:pt idx="810">
                  <c:v>-0.18999999999999995</c:v>
                </c:pt>
                <c:pt idx="811">
                  <c:v>-0.18899999999999995</c:v>
                </c:pt>
                <c:pt idx="812">
                  <c:v>-0.18799999999999994</c:v>
                </c:pt>
                <c:pt idx="813">
                  <c:v>-0.18700000000000006</c:v>
                </c:pt>
                <c:pt idx="814">
                  <c:v>-0.18600000000000005</c:v>
                </c:pt>
                <c:pt idx="815">
                  <c:v>-0.18500000000000005</c:v>
                </c:pt>
                <c:pt idx="816">
                  <c:v>-0.18400000000000005</c:v>
                </c:pt>
                <c:pt idx="817">
                  <c:v>-0.18300000000000005</c:v>
                </c:pt>
                <c:pt idx="818">
                  <c:v>-0.18200000000000005</c:v>
                </c:pt>
                <c:pt idx="819">
                  <c:v>-0.18100000000000005</c:v>
                </c:pt>
                <c:pt idx="820">
                  <c:v>-0.18000000000000005</c:v>
                </c:pt>
                <c:pt idx="821">
                  <c:v>-0.17900000000000005</c:v>
                </c:pt>
                <c:pt idx="822">
                  <c:v>-0.17800000000000005</c:v>
                </c:pt>
                <c:pt idx="823">
                  <c:v>-0.17700000000000005</c:v>
                </c:pt>
                <c:pt idx="824">
                  <c:v>-0.17600000000000005</c:v>
                </c:pt>
                <c:pt idx="825">
                  <c:v>-0.17500000000000004</c:v>
                </c:pt>
                <c:pt idx="826">
                  <c:v>-0.17400000000000004</c:v>
                </c:pt>
                <c:pt idx="827">
                  <c:v>-0.17300000000000004</c:v>
                </c:pt>
                <c:pt idx="828">
                  <c:v>-0.17200000000000004</c:v>
                </c:pt>
                <c:pt idx="829">
                  <c:v>-0.17100000000000004</c:v>
                </c:pt>
                <c:pt idx="830">
                  <c:v>-0.17000000000000004</c:v>
                </c:pt>
                <c:pt idx="831">
                  <c:v>-0.16900000000000004</c:v>
                </c:pt>
                <c:pt idx="832">
                  <c:v>-0.16800000000000004</c:v>
                </c:pt>
                <c:pt idx="833">
                  <c:v>-0.16700000000000004</c:v>
                </c:pt>
                <c:pt idx="834">
                  <c:v>-0.16600000000000004</c:v>
                </c:pt>
                <c:pt idx="835">
                  <c:v>-0.16500000000000004</c:v>
                </c:pt>
                <c:pt idx="836">
                  <c:v>-0.16400000000000003</c:v>
                </c:pt>
                <c:pt idx="837">
                  <c:v>-0.16300000000000003</c:v>
                </c:pt>
                <c:pt idx="838">
                  <c:v>-0.16200000000000003</c:v>
                </c:pt>
                <c:pt idx="839">
                  <c:v>-0.16100000000000003</c:v>
                </c:pt>
                <c:pt idx="840">
                  <c:v>-0.16000000000000003</c:v>
                </c:pt>
                <c:pt idx="841">
                  <c:v>-0.15900000000000003</c:v>
                </c:pt>
                <c:pt idx="842">
                  <c:v>-0.15800000000000003</c:v>
                </c:pt>
                <c:pt idx="843">
                  <c:v>-0.15700000000000003</c:v>
                </c:pt>
                <c:pt idx="844">
                  <c:v>-0.15600000000000003</c:v>
                </c:pt>
                <c:pt idx="845">
                  <c:v>-0.15500000000000003</c:v>
                </c:pt>
                <c:pt idx="846">
                  <c:v>-0.15400000000000003</c:v>
                </c:pt>
                <c:pt idx="847">
                  <c:v>-0.15300000000000002</c:v>
                </c:pt>
                <c:pt idx="848">
                  <c:v>-0.15200000000000002</c:v>
                </c:pt>
                <c:pt idx="849">
                  <c:v>-0.15100000000000002</c:v>
                </c:pt>
                <c:pt idx="850">
                  <c:v>-0.15000000000000002</c:v>
                </c:pt>
                <c:pt idx="851">
                  <c:v>-0.14900000000000002</c:v>
                </c:pt>
                <c:pt idx="852">
                  <c:v>-0.14800000000000002</c:v>
                </c:pt>
                <c:pt idx="853">
                  <c:v>-0.14700000000000002</c:v>
                </c:pt>
                <c:pt idx="854">
                  <c:v>-0.14600000000000002</c:v>
                </c:pt>
                <c:pt idx="855">
                  <c:v>-0.14500000000000002</c:v>
                </c:pt>
                <c:pt idx="856">
                  <c:v>-0.14400000000000002</c:v>
                </c:pt>
                <c:pt idx="857">
                  <c:v>-0.14300000000000002</c:v>
                </c:pt>
                <c:pt idx="858">
                  <c:v>-0.14200000000000002</c:v>
                </c:pt>
                <c:pt idx="859">
                  <c:v>-0.14100000000000001</c:v>
                </c:pt>
                <c:pt idx="860">
                  <c:v>-0.14000000000000001</c:v>
                </c:pt>
                <c:pt idx="861">
                  <c:v>-0.13900000000000001</c:v>
                </c:pt>
                <c:pt idx="862">
                  <c:v>-0.13800000000000001</c:v>
                </c:pt>
                <c:pt idx="863">
                  <c:v>-0.13700000000000001</c:v>
                </c:pt>
                <c:pt idx="864">
                  <c:v>-0.13600000000000001</c:v>
                </c:pt>
                <c:pt idx="865">
                  <c:v>-0.13500000000000001</c:v>
                </c:pt>
                <c:pt idx="866">
                  <c:v>-0.13400000000000001</c:v>
                </c:pt>
                <c:pt idx="867">
                  <c:v>-0.13300000000000001</c:v>
                </c:pt>
                <c:pt idx="868">
                  <c:v>-0.13200000000000001</c:v>
                </c:pt>
                <c:pt idx="869">
                  <c:v>-0.13100000000000001</c:v>
                </c:pt>
                <c:pt idx="870">
                  <c:v>-0.13</c:v>
                </c:pt>
                <c:pt idx="871">
                  <c:v>-0.129</c:v>
                </c:pt>
                <c:pt idx="872">
                  <c:v>-0.128</c:v>
                </c:pt>
                <c:pt idx="873">
                  <c:v>-0.127</c:v>
                </c:pt>
                <c:pt idx="874">
                  <c:v>-0.126</c:v>
                </c:pt>
                <c:pt idx="875">
                  <c:v>-0.125</c:v>
                </c:pt>
                <c:pt idx="876">
                  <c:v>-0.124</c:v>
                </c:pt>
                <c:pt idx="877">
                  <c:v>-0.123</c:v>
                </c:pt>
                <c:pt idx="878">
                  <c:v>-0.122</c:v>
                </c:pt>
                <c:pt idx="879">
                  <c:v>-0.121</c:v>
                </c:pt>
                <c:pt idx="880">
                  <c:v>-0.12</c:v>
                </c:pt>
                <c:pt idx="881">
                  <c:v>-0.11899999999999999</c:v>
                </c:pt>
                <c:pt idx="882">
                  <c:v>-0.11799999999999999</c:v>
                </c:pt>
                <c:pt idx="883">
                  <c:v>-0.11699999999999999</c:v>
                </c:pt>
                <c:pt idx="884">
                  <c:v>-0.11599999999999999</c:v>
                </c:pt>
                <c:pt idx="885">
                  <c:v>-0.11499999999999999</c:v>
                </c:pt>
                <c:pt idx="886">
                  <c:v>-0.11399999999999999</c:v>
                </c:pt>
                <c:pt idx="887">
                  <c:v>-0.11299999999999999</c:v>
                </c:pt>
                <c:pt idx="888">
                  <c:v>-0.11199999999999999</c:v>
                </c:pt>
                <c:pt idx="889">
                  <c:v>-0.11099999999999999</c:v>
                </c:pt>
                <c:pt idx="890">
                  <c:v>-0.10999999999999999</c:v>
                </c:pt>
                <c:pt idx="891">
                  <c:v>-0.10899999999999999</c:v>
                </c:pt>
                <c:pt idx="892">
                  <c:v>-0.10799999999999998</c:v>
                </c:pt>
                <c:pt idx="893">
                  <c:v>-0.10699999999999998</c:v>
                </c:pt>
                <c:pt idx="894">
                  <c:v>-0.10599999999999998</c:v>
                </c:pt>
                <c:pt idx="895">
                  <c:v>-0.10499999999999998</c:v>
                </c:pt>
                <c:pt idx="896">
                  <c:v>-0.10399999999999998</c:v>
                </c:pt>
                <c:pt idx="897">
                  <c:v>-0.10299999999999998</c:v>
                </c:pt>
                <c:pt idx="898">
                  <c:v>-0.10199999999999998</c:v>
                </c:pt>
                <c:pt idx="899">
                  <c:v>-0.10099999999999998</c:v>
                </c:pt>
                <c:pt idx="900">
                  <c:v>-9.9999999999999978E-2</c:v>
                </c:pt>
                <c:pt idx="901">
                  <c:v>-9.8999999999999977E-2</c:v>
                </c:pt>
                <c:pt idx="902">
                  <c:v>-9.7999999999999976E-2</c:v>
                </c:pt>
                <c:pt idx="903">
                  <c:v>-9.6999999999999975E-2</c:v>
                </c:pt>
                <c:pt idx="904">
                  <c:v>-9.5999999999999974E-2</c:v>
                </c:pt>
                <c:pt idx="905">
                  <c:v>-9.4999999999999973E-2</c:v>
                </c:pt>
                <c:pt idx="906">
                  <c:v>-9.3999999999999972E-2</c:v>
                </c:pt>
                <c:pt idx="907">
                  <c:v>-9.2999999999999972E-2</c:v>
                </c:pt>
                <c:pt idx="908">
                  <c:v>-9.1999999999999971E-2</c:v>
                </c:pt>
                <c:pt idx="909">
                  <c:v>-9.099999999999997E-2</c:v>
                </c:pt>
                <c:pt idx="910">
                  <c:v>-8.9999999999999969E-2</c:v>
                </c:pt>
                <c:pt idx="911">
                  <c:v>-8.8999999999999968E-2</c:v>
                </c:pt>
                <c:pt idx="912">
                  <c:v>-8.7999999999999967E-2</c:v>
                </c:pt>
                <c:pt idx="913">
                  <c:v>-8.6999999999999966E-2</c:v>
                </c:pt>
                <c:pt idx="914">
                  <c:v>-8.5999999999999965E-2</c:v>
                </c:pt>
                <c:pt idx="915">
                  <c:v>-8.4999999999999964E-2</c:v>
                </c:pt>
                <c:pt idx="916">
                  <c:v>-8.3999999999999964E-2</c:v>
                </c:pt>
                <c:pt idx="917">
                  <c:v>-8.2999999999999963E-2</c:v>
                </c:pt>
                <c:pt idx="918">
                  <c:v>-8.1999999999999962E-2</c:v>
                </c:pt>
                <c:pt idx="919">
                  <c:v>-8.0999999999999961E-2</c:v>
                </c:pt>
                <c:pt idx="920">
                  <c:v>-7.999999999999996E-2</c:v>
                </c:pt>
                <c:pt idx="921">
                  <c:v>-7.8999999999999959E-2</c:v>
                </c:pt>
                <c:pt idx="922">
                  <c:v>-7.7999999999999958E-2</c:v>
                </c:pt>
                <c:pt idx="923">
                  <c:v>-7.6999999999999957E-2</c:v>
                </c:pt>
                <c:pt idx="924">
                  <c:v>-7.5999999999999956E-2</c:v>
                </c:pt>
                <c:pt idx="925">
                  <c:v>-7.4999999999999956E-2</c:v>
                </c:pt>
                <c:pt idx="926">
                  <c:v>-7.3999999999999955E-2</c:v>
                </c:pt>
                <c:pt idx="927">
                  <c:v>-7.2999999999999954E-2</c:v>
                </c:pt>
                <c:pt idx="928">
                  <c:v>-7.1999999999999953E-2</c:v>
                </c:pt>
                <c:pt idx="929">
                  <c:v>-7.0999999999999952E-2</c:v>
                </c:pt>
                <c:pt idx="930">
                  <c:v>-6.9999999999999951E-2</c:v>
                </c:pt>
                <c:pt idx="931">
                  <c:v>-6.899999999999995E-2</c:v>
                </c:pt>
                <c:pt idx="932">
                  <c:v>-6.7999999999999949E-2</c:v>
                </c:pt>
                <c:pt idx="933">
                  <c:v>-6.6999999999999948E-2</c:v>
                </c:pt>
                <c:pt idx="934">
                  <c:v>-6.5999999999999948E-2</c:v>
                </c:pt>
                <c:pt idx="935">
                  <c:v>-6.4999999999999947E-2</c:v>
                </c:pt>
                <c:pt idx="936">
                  <c:v>-6.3999999999999946E-2</c:v>
                </c:pt>
                <c:pt idx="937">
                  <c:v>-6.2999999999999945E-2</c:v>
                </c:pt>
                <c:pt idx="938">
                  <c:v>-6.2000000000000055E-2</c:v>
                </c:pt>
                <c:pt idx="939">
                  <c:v>-6.1000000000000054E-2</c:v>
                </c:pt>
                <c:pt idx="940">
                  <c:v>-6.0000000000000053E-2</c:v>
                </c:pt>
                <c:pt idx="941">
                  <c:v>-5.9000000000000052E-2</c:v>
                </c:pt>
                <c:pt idx="942">
                  <c:v>-5.8000000000000052E-2</c:v>
                </c:pt>
                <c:pt idx="943">
                  <c:v>-5.7000000000000051E-2</c:v>
                </c:pt>
                <c:pt idx="944">
                  <c:v>-5.600000000000005E-2</c:v>
                </c:pt>
                <c:pt idx="945">
                  <c:v>-5.5000000000000049E-2</c:v>
                </c:pt>
                <c:pt idx="946">
                  <c:v>-5.4000000000000048E-2</c:v>
                </c:pt>
                <c:pt idx="947">
                  <c:v>-5.3000000000000047E-2</c:v>
                </c:pt>
                <c:pt idx="948">
                  <c:v>-5.2000000000000046E-2</c:v>
                </c:pt>
                <c:pt idx="949">
                  <c:v>-5.1000000000000045E-2</c:v>
                </c:pt>
                <c:pt idx="950">
                  <c:v>-5.0000000000000044E-2</c:v>
                </c:pt>
                <c:pt idx="951">
                  <c:v>-4.9000000000000044E-2</c:v>
                </c:pt>
                <c:pt idx="952">
                  <c:v>-4.8000000000000043E-2</c:v>
                </c:pt>
                <c:pt idx="953">
                  <c:v>-4.7000000000000042E-2</c:v>
                </c:pt>
                <c:pt idx="954">
                  <c:v>-4.6000000000000041E-2</c:v>
                </c:pt>
                <c:pt idx="955">
                  <c:v>-4.500000000000004E-2</c:v>
                </c:pt>
                <c:pt idx="956">
                  <c:v>-4.4000000000000039E-2</c:v>
                </c:pt>
                <c:pt idx="957">
                  <c:v>-4.3000000000000038E-2</c:v>
                </c:pt>
                <c:pt idx="958">
                  <c:v>-4.2000000000000037E-2</c:v>
                </c:pt>
                <c:pt idx="959">
                  <c:v>-4.1000000000000036E-2</c:v>
                </c:pt>
                <c:pt idx="960">
                  <c:v>-4.0000000000000036E-2</c:v>
                </c:pt>
                <c:pt idx="961">
                  <c:v>-3.9000000000000035E-2</c:v>
                </c:pt>
                <c:pt idx="962">
                  <c:v>-3.8000000000000034E-2</c:v>
                </c:pt>
                <c:pt idx="963">
                  <c:v>-3.7000000000000033E-2</c:v>
                </c:pt>
                <c:pt idx="964">
                  <c:v>-3.6000000000000032E-2</c:v>
                </c:pt>
                <c:pt idx="965">
                  <c:v>-3.5000000000000031E-2</c:v>
                </c:pt>
                <c:pt idx="966">
                  <c:v>-3.400000000000003E-2</c:v>
                </c:pt>
                <c:pt idx="967">
                  <c:v>-3.3000000000000029E-2</c:v>
                </c:pt>
                <c:pt idx="968">
                  <c:v>-3.2000000000000028E-2</c:v>
                </c:pt>
                <c:pt idx="969">
                  <c:v>-3.1000000000000028E-2</c:v>
                </c:pt>
                <c:pt idx="970">
                  <c:v>-3.0000000000000027E-2</c:v>
                </c:pt>
                <c:pt idx="971">
                  <c:v>-2.9000000000000026E-2</c:v>
                </c:pt>
                <c:pt idx="972">
                  <c:v>-2.8000000000000025E-2</c:v>
                </c:pt>
                <c:pt idx="973">
                  <c:v>-2.7000000000000024E-2</c:v>
                </c:pt>
                <c:pt idx="974">
                  <c:v>-2.6000000000000023E-2</c:v>
                </c:pt>
                <c:pt idx="975">
                  <c:v>-2.5000000000000022E-2</c:v>
                </c:pt>
                <c:pt idx="976">
                  <c:v>-2.4000000000000021E-2</c:v>
                </c:pt>
                <c:pt idx="977">
                  <c:v>-2.300000000000002E-2</c:v>
                </c:pt>
                <c:pt idx="978">
                  <c:v>-2.200000000000002E-2</c:v>
                </c:pt>
                <c:pt idx="979">
                  <c:v>-2.1000000000000019E-2</c:v>
                </c:pt>
                <c:pt idx="980">
                  <c:v>-2.0000000000000018E-2</c:v>
                </c:pt>
                <c:pt idx="981">
                  <c:v>-1.9000000000000017E-2</c:v>
                </c:pt>
                <c:pt idx="982">
                  <c:v>-1.8000000000000016E-2</c:v>
                </c:pt>
                <c:pt idx="983">
                  <c:v>-1.7000000000000015E-2</c:v>
                </c:pt>
                <c:pt idx="984">
                  <c:v>-1.6000000000000014E-2</c:v>
                </c:pt>
                <c:pt idx="985">
                  <c:v>-1.5000000000000013E-2</c:v>
                </c:pt>
                <c:pt idx="986">
                  <c:v>-1.4000000000000012E-2</c:v>
                </c:pt>
                <c:pt idx="987">
                  <c:v>-1.3000000000000012E-2</c:v>
                </c:pt>
                <c:pt idx="988">
                  <c:v>-1.2000000000000011E-2</c:v>
                </c:pt>
                <c:pt idx="989">
                  <c:v>-1.100000000000001E-2</c:v>
                </c:pt>
                <c:pt idx="990">
                  <c:v>-1.0000000000000009E-2</c:v>
                </c:pt>
                <c:pt idx="991">
                  <c:v>-9.000000000000008E-3</c:v>
                </c:pt>
                <c:pt idx="992">
                  <c:v>-8.0000000000000071E-3</c:v>
                </c:pt>
                <c:pt idx="993">
                  <c:v>-7.0000000000000062E-3</c:v>
                </c:pt>
                <c:pt idx="994">
                  <c:v>-6.0000000000000053E-3</c:v>
                </c:pt>
                <c:pt idx="995">
                  <c:v>-5.0000000000000044E-3</c:v>
                </c:pt>
                <c:pt idx="996">
                  <c:v>-4.0000000000000036E-3</c:v>
                </c:pt>
                <c:pt idx="997">
                  <c:v>-3.0000000000000027E-3</c:v>
                </c:pt>
                <c:pt idx="998">
                  <c:v>-2.0000000000000018E-3</c:v>
                </c:pt>
                <c:pt idx="999">
                  <c:v>-1.0000000000000009E-3</c:v>
                </c:pt>
                <c:pt idx="1000">
                  <c:v>0</c:v>
                </c:pt>
                <c:pt idx="1001">
                  <c:v>9.9999999999988987E-4</c:v>
                </c:pt>
                <c:pt idx="1002">
                  <c:v>2.0000000000000018E-3</c:v>
                </c:pt>
                <c:pt idx="1003">
                  <c:v>2.9999999999998916E-3</c:v>
                </c:pt>
                <c:pt idx="1004">
                  <c:v>4.0000000000000036E-3</c:v>
                </c:pt>
                <c:pt idx="1005">
                  <c:v>4.9999999999998934E-3</c:v>
                </c:pt>
                <c:pt idx="1006">
                  <c:v>6.0000000000000053E-3</c:v>
                </c:pt>
                <c:pt idx="1007">
                  <c:v>6.9999999999998952E-3</c:v>
                </c:pt>
                <c:pt idx="1008">
                  <c:v>8.0000000000000071E-3</c:v>
                </c:pt>
                <c:pt idx="1009">
                  <c:v>8.999999999999897E-3</c:v>
                </c:pt>
                <c:pt idx="1010">
                  <c:v>1.0000000000000009E-2</c:v>
                </c:pt>
                <c:pt idx="1011">
                  <c:v>1.0999999999999899E-2</c:v>
                </c:pt>
                <c:pt idx="1012">
                  <c:v>1.2000000000000011E-2</c:v>
                </c:pt>
                <c:pt idx="1013">
                  <c:v>1.2999999999999901E-2</c:v>
                </c:pt>
                <c:pt idx="1014">
                  <c:v>1.4000000000000012E-2</c:v>
                </c:pt>
                <c:pt idx="1015">
                  <c:v>1.4999999999999902E-2</c:v>
                </c:pt>
                <c:pt idx="1016">
                  <c:v>1.6000000000000014E-2</c:v>
                </c:pt>
                <c:pt idx="1017">
                  <c:v>1.6999999999999904E-2</c:v>
                </c:pt>
                <c:pt idx="1018">
                  <c:v>1.8000000000000016E-2</c:v>
                </c:pt>
                <c:pt idx="1019">
                  <c:v>1.8999999999999906E-2</c:v>
                </c:pt>
                <c:pt idx="1020">
                  <c:v>2.0000000000000018E-2</c:v>
                </c:pt>
                <c:pt idx="1021">
                  <c:v>2.0999999999999908E-2</c:v>
                </c:pt>
                <c:pt idx="1022">
                  <c:v>2.200000000000002E-2</c:v>
                </c:pt>
                <c:pt idx="1023">
                  <c:v>2.2999999999999909E-2</c:v>
                </c:pt>
                <c:pt idx="1024">
                  <c:v>2.4000000000000021E-2</c:v>
                </c:pt>
                <c:pt idx="1025">
                  <c:v>2.4999999999999911E-2</c:v>
                </c:pt>
                <c:pt idx="1026">
                  <c:v>2.6000000000000023E-2</c:v>
                </c:pt>
                <c:pt idx="1027">
                  <c:v>2.6999999999999913E-2</c:v>
                </c:pt>
                <c:pt idx="1028">
                  <c:v>2.8000000000000025E-2</c:v>
                </c:pt>
                <c:pt idx="1029">
                  <c:v>2.8999999999999915E-2</c:v>
                </c:pt>
                <c:pt idx="1030">
                  <c:v>3.0000000000000027E-2</c:v>
                </c:pt>
                <c:pt idx="1031">
                  <c:v>3.0999999999999917E-2</c:v>
                </c:pt>
                <c:pt idx="1032">
                  <c:v>3.2000000000000028E-2</c:v>
                </c:pt>
                <c:pt idx="1033">
                  <c:v>3.2999999999999918E-2</c:v>
                </c:pt>
                <c:pt idx="1034">
                  <c:v>3.400000000000003E-2</c:v>
                </c:pt>
                <c:pt idx="1035">
                  <c:v>3.499999999999992E-2</c:v>
                </c:pt>
                <c:pt idx="1036">
                  <c:v>3.6000000000000032E-2</c:v>
                </c:pt>
                <c:pt idx="1037">
                  <c:v>3.6999999999999922E-2</c:v>
                </c:pt>
                <c:pt idx="1038">
                  <c:v>3.8000000000000034E-2</c:v>
                </c:pt>
                <c:pt idx="1039">
                  <c:v>3.8999999999999924E-2</c:v>
                </c:pt>
                <c:pt idx="1040">
                  <c:v>4.0000000000000036E-2</c:v>
                </c:pt>
                <c:pt idx="1041">
                  <c:v>4.0999999999999925E-2</c:v>
                </c:pt>
                <c:pt idx="1042">
                  <c:v>4.2000000000000037E-2</c:v>
                </c:pt>
                <c:pt idx="1043">
                  <c:v>4.2999999999999927E-2</c:v>
                </c:pt>
                <c:pt idx="1044">
                  <c:v>4.4000000000000039E-2</c:v>
                </c:pt>
                <c:pt idx="1045">
                  <c:v>4.4999999999999929E-2</c:v>
                </c:pt>
                <c:pt idx="1046">
                  <c:v>4.6000000000000041E-2</c:v>
                </c:pt>
                <c:pt idx="1047">
                  <c:v>4.6999999999999931E-2</c:v>
                </c:pt>
                <c:pt idx="1048">
                  <c:v>4.8000000000000043E-2</c:v>
                </c:pt>
                <c:pt idx="1049">
                  <c:v>4.8999999999999932E-2</c:v>
                </c:pt>
                <c:pt idx="1050">
                  <c:v>5.0000000000000044E-2</c:v>
                </c:pt>
                <c:pt idx="1051">
                  <c:v>5.0999999999999934E-2</c:v>
                </c:pt>
                <c:pt idx="1052">
                  <c:v>5.2000000000000046E-2</c:v>
                </c:pt>
                <c:pt idx="1053">
                  <c:v>5.2999999999999936E-2</c:v>
                </c:pt>
                <c:pt idx="1054">
                  <c:v>5.4000000000000048E-2</c:v>
                </c:pt>
                <c:pt idx="1055">
                  <c:v>5.4999999999999938E-2</c:v>
                </c:pt>
                <c:pt idx="1056">
                  <c:v>5.600000000000005E-2</c:v>
                </c:pt>
                <c:pt idx="1057">
                  <c:v>5.699999999999994E-2</c:v>
                </c:pt>
                <c:pt idx="1058">
                  <c:v>5.8000000000000052E-2</c:v>
                </c:pt>
                <c:pt idx="1059">
                  <c:v>5.8999999999999941E-2</c:v>
                </c:pt>
                <c:pt idx="1060">
                  <c:v>6.0000000000000053E-2</c:v>
                </c:pt>
                <c:pt idx="1061">
                  <c:v>6.0999999999999943E-2</c:v>
                </c:pt>
                <c:pt idx="1062">
                  <c:v>6.2000000000000055E-2</c:v>
                </c:pt>
                <c:pt idx="1063">
                  <c:v>6.2999999999999945E-2</c:v>
                </c:pt>
                <c:pt idx="1064">
                  <c:v>6.4000000000000057E-2</c:v>
                </c:pt>
                <c:pt idx="1065">
                  <c:v>6.4999999999999947E-2</c:v>
                </c:pt>
                <c:pt idx="1066">
                  <c:v>6.6000000000000059E-2</c:v>
                </c:pt>
                <c:pt idx="1067">
                  <c:v>6.6999999999999948E-2</c:v>
                </c:pt>
                <c:pt idx="1068">
                  <c:v>6.800000000000006E-2</c:v>
                </c:pt>
                <c:pt idx="1069">
                  <c:v>6.899999999999995E-2</c:v>
                </c:pt>
                <c:pt idx="1070">
                  <c:v>7.0000000000000062E-2</c:v>
                </c:pt>
                <c:pt idx="1071">
                  <c:v>7.0999999999999952E-2</c:v>
                </c:pt>
                <c:pt idx="1072">
                  <c:v>7.2000000000000064E-2</c:v>
                </c:pt>
                <c:pt idx="1073">
                  <c:v>7.2999999999999954E-2</c:v>
                </c:pt>
                <c:pt idx="1074">
                  <c:v>7.4000000000000066E-2</c:v>
                </c:pt>
                <c:pt idx="1075">
                  <c:v>7.4999999999999956E-2</c:v>
                </c:pt>
                <c:pt idx="1076">
                  <c:v>7.6000000000000068E-2</c:v>
                </c:pt>
                <c:pt idx="1077">
                  <c:v>7.6999999999999957E-2</c:v>
                </c:pt>
                <c:pt idx="1078">
                  <c:v>7.8000000000000069E-2</c:v>
                </c:pt>
                <c:pt idx="1079">
                  <c:v>7.8999999999999959E-2</c:v>
                </c:pt>
                <c:pt idx="1080">
                  <c:v>8.0000000000000071E-2</c:v>
                </c:pt>
                <c:pt idx="1081">
                  <c:v>8.0999999999999961E-2</c:v>
                </c:pt>
                <c:pt idx="1082">
                  <c:v>8.2000000000000073E-2</c:v>
                </c:pt>
                <c:pt idx="1083">
                  <c:v>8.2999999999999963E-2</c:v>
                </c:pt>
                <c:pt idx="1084">
                  <c:v>8.4000000000000075E-2</c:v>
                </c:pt>
                <c:pt idx="1085">
                  <c:v>8.4999999999999964E-2</c:v>
                </c:pt>
                <c:pt idx="1086">
                  <c:v>8.6000000000000076E-2</c:v>
                </c:pt>
                <c:pt idx="1087">
                  <c:v>8.6999999999999966E-2</c:v>
                </c:pt>
                <c:pt idx="1088">
                  <c:v>8.8000000000000078E-2</c:v>
                </c:pt>
                <c:pt idx="1089">
                  <c:v>8.8999999999999968E-2</c:v>
                </c:pt>
                <c:pt idx="1090">
                  <c:v>9.000000000000008E-2</c:v>
                </c:pt>
                <c:pt idx="1091">
                  <c:v>9.099999999999997E-2</c:v>
                </c:pt>
                <c:pt idx="1092">
                  <c:v>9.2000000000000082E-2</c:v>
                </c:pt>
                <c:pt idx="1093">
                  <c:v>9.2999999999999972E-2</c:v>
                </c:pt>
                <c:pt idx="1094">
                  <c:v>9.4000000000000083E-2</c:v>
                </c:pt>
                <c:pt idx="1095">
                  <c:v>9.4999999999999973E-2</c:v>
                </c:pt>
                <c:pt idx="1096">
                  <c:v>9.6000000000000085E-2</c:v>
                </c:pt>
                <c:pt idx="1097">
                  <c:v>9.6999999999999975E-2</c:v>
                </c:pt>
                <c:pt idx="1098">
                  <c:v>9.8000000000000087E-2</c:v>
                </c:pt>
                <c:pt idx="1099">
                  <c:v>9.8999999999999977E-2</c:v>
                </c:pt>
                <c:pt idx="1100">
                  <c:v>0.10000000000000009</c:v>
                </c:pt>
                <c:pt idx="1101">
                  <c:v>0.10099999999999998</c:v>
                </c:pt>
                <c:pt idx="1102">
                  <c:v>0.10200000000000009</c:v>
                </c:pt>
                <c:pt idx="1103">
                  <c:v>0.10299999999999998</c:v>
                </c:pt>
                <c:pt idx="1104">
                  <c:v>0.10400000000000009</c:v>
                </c:pt>
                <c:pt idx="1105">
                  <c:v>0.10499999999999998</c:v>
                </c:pt>
                <c:pt idx="1106">
                  <c:v>0.10600000000000009</c:v>
                </c:pt>
                <c:pt idx="1107">
                  <c:v>0.10699999999999998</c:v>
                </c:pt>
                <c:pt idx="1108">
                  <c:v>0.1080000000000001</c:v>
                </c:pt>
                <c:pt idx="1109">
                  <c:v>0.10899999999999999</c:v>
                </c:pt>
                <c:pt idx="1110">
                  <c:v>0.1100000000000001</c:v>
                </c:pt>
                <c:pt idx="1111">
                  <c:v>0.11099999999999999</c:v>
                </c:pt>
                <c:pt idx="1112">
                  <c:v>0.1120000000000001</c:v>
                </c:pt>
                <c:pt idx="1113">
                  <c:v>0.11299999999999999</c:v>
                </c:pt>
                <c:pt idx="1114">
                  <c:v>0.1140000000000001</c:v>
                </c:pt>
                <c:pt idx="1115">
                  <c:v>0.11499999999999999</c:v>
                </c:pt>
                <c:pt idx="1116">
                  <c:v>0.1160000000000001</c:v>
                </c:pt>
                <c:pt idx="1117">
                  <c:v>0.11699999999999999</c:v>
                </c:pt>
                <c:pt idx="1118">
                  <c:v>0.1180000000000001</c:v>
                </c:pt>
                <c:pt idx="1119">
                  <c:v>0.11899999999999999</c:v>
                </c:pt>
                <c:pt idx="1120">
                  <c:v>0.12000000000000011</c:v>
                </c:pt>
                <c:pt idx="1121">
                  <c:v>0.121</c:v>
                </c:pt>
                <c:pt idx="1122">
                  <c:v>0.12200000000000011</c:v>
                </c:pt>
                <c:pt idx="1123">
                  <c:v>0.123</c:v>
                </c:pt>
                <c:pt idx="1124">
                  <c:v>0.12400000000000011</c:v>
                </c:pt>
                <c:pt idx="1125">
                  <c:v>0.125</c:v>
                </c:pt>
                <c:pt idx="1126">
                  <c:v>0.12599999999999989</c:v>
                </c:pt>
                <c:pt idx="1127">
                  <c:v>0.127</c:v>
                </c:pt>
                <c:pt idx="1128">
                  <c:v>0.12799999999999989</c:v>
                </c:pt>
                <c:pt idx="1129">
                  <c:v>0.129</c:v>
                </c:pt>
                <c:pt idx="1130">
                  <c:v>0.12999999999999989</c:v>
                </c:pt>
                <c:pt idx="1131">
                  <c:v>0.13100000000000001</c:v>
                </c:pt>
                <c:pt idx="1132">
                  <c:v>0.1319999999999999</c:v>
                </c:pt>
                <c:pt idx="1133">
                  <c:v>0.13300000000000001</c:v>
                </c:pt>
                <c:pt idx="1134">
                  <c:v>0.1339999999999999</c:v>
                </c:pt>
                <c:pt idx="1135">
                  <c:v>0.13500000000000001</c:v>
                </c:pt>
                <c:pt idx="1136">
                  <c:v>0.1359999999999999</c:v>
                </c:pt>
                <c:pt idx="1137">
                  <c:v>0.13700000000000001</c:v>
                </c:pt>
                <c:pt idx="1138">
                  <c:v>0.1379999999999999</c:v>
                </c:pt>
                <c:pt idx="1139">
                  <c:v>0.13900000000000001</c:v>
                </c:pt>
                <c:pt idx="1140">
                  <c:v>0.1399999999999999</c:v>
                </c:pt>
                <c:pt idx="1141">
                  <c:v>0.14100000000000001</c:v>
                </c:pt>
                <c:pt idx="1142">
                  <c:v>0.1419999999999999</c:v>
                </c:pt>
                <c:pt idx="1143">
                  <c:v>0.14300000000000002</c:v>
                </c:pt>
                <c:pt idx="1144">
                  <c:v>0.14399999999999991</c:v>
                </c:pt>
                <c:pt idx="1145">
                  <c:v>0.14500000000000002</c:v>
                </c:pt>
                <c:pt idx="1146">
                  <c:v>0.14599999999999991</c:v>
                </c:pt>
                <c:pt idx="1147">
                  <c:v>0.14700000000000002</c:v>
                </c:pt>
                <c:pt idx="1148">
                  <c:v>0.14799999999999991</c:v>
                </c:pt>
                <c:pt idx="1149">
                  <c:v>0.14900000000000002</c:v>
                </c:pt>
                <c:pt idx="1150">
                  <c:v>0.14999999999999991</c:v>
                </c:pt>
                <c:pt idx="1151">
                  <c:v>0.15100000000000002</c:v>
                </c:pt>
                <c:pt idx="1152">
                  <c:v>0.15199999999999991</c:v>
                </c:pt>
                <c:pt idx="1153">
                  <c:v>0.15300000000000002</c:v>
                </c:pt>
                <c:pt idx="1154">
                  <c:v>0.15399999999999991</c:v>
                </c:pt>
                <c:pt idx="1155">
                  <c:v>0.15500000000000003</c:v>
                </c:pt>
                <c:pt idx="1156">
                  <c:v>0.15599999999999992</c:v>
                </c:pt>
                <c:pt idx="1157">
                  <c:v>0.15700000000000003</c:v>
                </c:pt>
                <c:pt idx="1158">
                  <c:v>0.15799999999999992</c:v>
                </c:pt>
                <c:pt idx="1159">
                  <c:v>0.15900000000000003</c:v>
                </c:pt>
                <c:pt idx="1160">
                  <c:v>0.15999999999999992</c:v>
                </c:pt>
                <c:pt idx="1161">
                  <c:v>0.16100000000000003</c:v>
                </c:pt>
                <c:pt idx="1162">
                  <c:v>0.16199999999999992</c:v>
                </c:pt>
                <c:pt idx="1163">
                  <c:v>0.16300000000000003</c:v>
                </c:pt>
                <c:pt idx="1164">
                  <c:v>0.16399999999999992</c:v>
                </c:pt>
                <c:pt idx="1165">
                  <c:v>0.16500000000000004</c:v>
                </c:pt>
                <c:pt idx="1166">
                  <c:v>0.16599999999999993</c:v>
                </c:pt>
                <c:pt idx="1167">
                  <c:v>0.16700000000000004</c:v>
                </c:pt>
                <c:pt idx="1168">
                  <c:v>0.16799999999999993</c:v>
                </c:pt>
                <c:pt idx="1169">
                  <c:v>0.16900000000000004</c:v>
                </c:pt>
                <c:pt idx="1170">
                  <c:v>0.16999999999999993</c:v>
                </c:pt>
                <c:pt idx="1171">
                  <c:v>0.17100000000000004</c:v>
                </c:pt>
                <c:pt idx="1172">
                  <c:v>0.17199999999999993</c:v>
                </c:pt>
                <c:pt idx="1173">
                  <c:v>0.17300000000000004</c:v>
                </c:pt>
                <c:pt idx="1174">
                  <c:v>0.17399999999999993</c:v>
                </c:pt>
                <c:pt idx="1175">
                  <c:v>0.17500000000000004</c:v>
                </c:pt>
                <c:pt idx="1176">
                  <c:v>0.17599999999999993</c:v>
                </c:pt>
                <c:pt idx="1177">
                  <c:v>0.17700000000000005</c:v>
                </c:pt>
                <c:pt idx="1178">
                  <c:v>0.17799999999999994</c:v>
                </c:pt>
                <c:pt idx="1179">
                  <c:v>0.17900000000000005</c:v>
                </c:pt>
                <c:pt idx="1180">
                  <c:v>0.17999999999999994</c:v>
                </c:pt>
                <c:pt idx="1181">
                  <c:v>0.18100000000000005</c:v>
                </c:pt>
                <c:pt idx="1182">
                  <c:v>0.18199999999999994</c:v>
                </c:pt>
                <c:pt idx="1183">
                  <c:v>0.18300000000000005</c:v>
                </c:pt>
                <c:pt idx="1184">
                  <c:v>0.18399999999999994</c:v>
                </c:pt>
                <c:pt idx="1185">
                  <c:v>0.18500000000000005</c:v>
                </c:pt>
                <c:pt idx="1186">
                  <c:v>0.18599999999999994</c:v>
                </c:pt>
                <c:pt idx="1187">
                  <c:v>0.18700000000000006</c:v>
                </c:pt>
                <c:pt idx="1188">
                  <c:v>0.18799999999999994</c:v>
                </c:pt>
                <c:pt idx="1189">
                  <c:v>0.18900000000000006</c:v>
                </c:pt>
                <c:pt idx="1190">
                  <c:v>0.18999999999999995</c:v>
                </c:pt>
                <c:pt idx="1191">
                  <c:v>0.19100000000000006</c:v>
                </c:pt>
                <c:pt idx="1192">
                  <c:v>0.19199999999999995</c:v>
                </c:pt>
                <c:pt idx="1193">
                  <c:v>0.19300000000000006</c:v>
                </c:pt>
                <c:pt idx="1194">
                  <c:v>0.19399999999999995</c:v>
                </c:pt>
                <c:pt idx="1195">
                  <c:v>0.19500000000000006</c:v>
                </c:pt>
                <c:pt idx="1196">
                  <c:v>0.19599999999999995</c:v>
                </c:pt>
                <c:pt idx="1197">
                  <c:v>0.19700000000000006</c:v>
                </c:pt>
                <c:pt idx="1198">
                  <c:v>0.19799999999999995</c:v>
                </c:pt>
                <c:pt idx="1199">
                  <c:v>0.19900000000000007</c:v>
                </c:pt>
                <c:pt idx="1200">
                  <c:v>0.19999999999999996</c:v>
                </c:pt>
                <c:pt idx="1201">
                  <c:v>0.20100000000000007</c:v>
                </c:pt>
                <c:pt idx="1202">
                  <c:v>0.20199999999999996</c:v>
                </c:pt>
                <c:pt idx="1203">
                  <c:v>0.20300000000000007</c:v>
                </c:pt>
                <c:pt idx="1204">
                  <c:v>0.20399999999999996</c:v>
                </c:pt>
                <c:pt idx="1205">
                  <c:v>0.20500000000000007</c:v>
                </c:pt>
                <c:pt idx="1206">
                  <c:v>0.20599999999999996</c:v>
                </c:pt>
                <c:pt idx="1207">
                  <c:v>0.20700000000000007</c:v>
                </c:pt>
                <c:pt idx="1208">
                  <c:v>0.20799999999999996</c:v>
                </c:pt>
                <c:pt idx="1209">
                  <c:v>0.20900000000000007</c:v>
                </c:pt>
                <c:pt idx="1210">
                  <c:v>0.20999999999999996</c:v>
                </c:pt>
                <c:pt idx="1211">
                  <c:v>0.21100000000000008</c:v>
                </c:pt>
                <c:pt idx="1212">
                  <c:v>0.21199999999999997</c:v>
                </c:pt>
                <c:pt idx="1213">
                  <c:v>0.21300000000000008</c:v>
                </c:pt>
                <c:pt idx="1214">
                  <c:v>0.21399999999999997</c:v>
                </c:pt>
                <c:pt idx="1215">
                  <c:v>0.21500000000000008</c:v>
                </c:pt>
                <c:pt idx="1216">
                  <c:v>0.21599999999999997</c:v>
                </c:pt>
                <c:pt idx="1217">
                  <c:v>0.21700000000000008</c:v>
                </c:pt>
                <c:pt idx="1218">
                  <c:v>0.21799999999999997</c:v>
                </c:pt>
                <c:pt idx="1219">
                  <c:v>0.21900000000000008</c:v>
                </c:pt>
                <c:pt idx="1220">
                  <c:v>0.21999999999999997</c:v>
                </c:pt>
                <c:pt idx="1221">
                  <c:v>0.22100000000000009</c:v>
                </c:pt>
                <c:pt idx="1222">
                  <c:v>0.22199999999999998</c:v>
                </c:pt>
                <c:pt idx="1223">
                  <c:v>0.22300000000000009</c:v>
                </c:pt>
                <c:pt idx="1224">
                  <c:v>0.22399999999999998</c:v>
                </c:pt>
                <c:pt idx="1225">
                  <c:v>0.22500000000000009</c:v>
                </c:pt>
                <c:pt idx="1226">
                  <c:v>0.22599999999999998</c:v>
                </c:pt>
                <c:pt idx="1227">
                  <c:v>0.22700000000000009</c:v>
                </c:pt>
                <c:pt idx="1228">
                  <c:v>0.22799999999999998</c:v>
                </c:pt>
                <c:pt idx="1229">
                  <c:v>0.22900000000000009</c:v>
                </c:pt>
                <c:pt idx="1230">
                  <c:v>0.22999999999999998</c:v>
                </c:pt>
                <c:pt idx="1231">
                  <c:v>0.23100000000000009</c:v>
                </c:pt>
                <c:pt idx="1232">
                  <c:v>0.23199999999999998</c:v>
                </c:pt>
                <c:pt idx="1233">
                  <c:v>0.2330000000000001</c:v>
                </c:pt>
                <c:pt idx="1234">
                  <c:v>0.23399999999999999</c:v>
                </c:pt>
                <c:pt idx="1235">
                  <c:v>0.2350000000000001</c:v>
                </c:pt>
                <c:pt idx="1236">
                  <c:v>0.23599999999999999</c:v>
                </c:pt>
                <c:pt idx="1237">
                  <c:v>0.2370000000000001</c:v>
                </c:pt>
                <c:pt idx="1238">
                  <c:v>0.23799999999999999</c:v>
                </c:pt>
                <c:pt idx="1239">
                  <c:v>0.2390000000000001</c:v>
                </c:pt>
                <c:pt idx="1240">
                  <c:v>0.24</c:v>
                </c:pt>
                <c:pt idx="1241">
                  <c:v>0.2410000000000001</c:v>
                </c:pt>
                <c:pt idx="1242">
                  <c:v>0.24199999999999999</c:v>
                </c:pt>
                <c:pt idx="1243">
                  <c:v>0.2430000000000001</c:v>
                </c:pt>
                <c:pt idx="1244">
                  <c:v>0.24399999999999999</c:v>
                </c:pt>
                <c:pt idx="1245">
                  <c:v>0.24500000000000011</c:v>
                </c:pt>
                <c:pt idx="1246">
                  <c:v>0.246</c:v>
                </c:pt>
                <c:pt idx="1247">
                  <c:v>0.24700000000000011</c:v>
                </c:pt>
                <c:pt idx="1248">
                  <c:v>0.248</c:v>
                </c:pt>
                <c:pt idx="1249">
                  <c:v>0.24900000000000011</c:v>
                </c:pt>
                <c:pt idx="1250">
                  <c:v>0.25</c:v>
                </c:pt>
                <c:pt idx="1251">
                  <c:v>0.25099999999999989</c:v>
                </c:pt>
                <c:pt idx="1252">
                  <c:v>0.252</c:v>
                </c:pt>
                <c:pt idx="1253">
                  <c:v>0.25299999999999989</c:v>
                </c:pt>
                <c:pt idx="1254">
                  <c:v>0.254</c:v>
                </c:pt>
                <c:pt idx="1255">
                  <c:v>0.25499999999999989</c:v>
                </c:pt>
                <c:pt idx="1256">
                  <c:v>0.25600000000000001</c:v>
                </c:pt>
                <c:pt idx="1257">
                  <c:v>0.2569999999999999</c:v>
                </c:pt>
                <c:pt idx="1258">
                  <c:v>0.25800000000000001</c:v>
                </c:pt>
                <c:pt idx="1259">
                  <c:v>0.2589999999999999</c:v>
                </c:pt>
                <c:pt idx="1260">
                  <c:v>0.26</c:v>
                </c:pt>
                <c:pt idx="1261">
                  <c:v>0.2609999999999999</c:v>
                </c:pt>
                <c:pt idx="1262">
                  <c:v>0.26200000000000001</c:v>
                </c:pt>
                <c:pt idx="1263">
                  <c:v>0.2629999999999999</c:v>
                </c:pt>
                <c:pt idx="1264">
                  <c:v>0.26400000000000001</c:v>
                </c:pt>
                <c:pt idx="1265">
                  <c:v>0.2649999999999999</c:v>
                </c:pt>
                <c:pt idx="1266">
                  <c:v>0.26600000000000001</c:v>
                </c:pt>
                <c:pt idx="1267">
                  <c:v>0.2669999999999999</c:v>
                </c:pt>
                <c:pt idx="1268">
                  <c:v>0.26800000000000002</c:v>
                </c:pt>
                <c:pt idx="1269">
                  <c:v>0.26899999999999991</c:v>
                </c:pt>
                <c:pt idx="1270">
                  <c:v>0.27</c:v>
                </c:pt>
                <c:pt idx="1271">
                  <c:v>0.27099999999999991</c:v>
                </c:pt>
                <c:pt idx="1272">
                  <c:v>0.27200000000000002</c:v>
                </c:pt>
                <c:pt idx="1273">
                  <c:v>0.27299999999999991</c:v>
                </c:pt>
                <c:pt idx="1274">
                  <c:v>0.27400000000000002</c:v>
                </c:pt>
                <c:pt idx="1275">
                  <c:v>0.27499999999999991</c:v>
                </c:pt>
                <c:pt idx="1276">
                  <c:v>0.27600000000000002</c:v>
                </c:pt>
                <c:pt idx="1277">
                  <c:v>0.27699999999999991</c:v>
                </c:pt>
                <c:pt idx="1278">
                  <c:v>0.27800000000000002</c:v>
                </c:pt>
                <c:pt idx="1279">
                  <c:v>0.27899999999999991</c:v>
                </c:pt>
                <c:pt idx="1280">
                  <c:v>0.28000000000000003</c:v>
                </c:pt>
                <c:pt idx="1281">
                  <c:v>0.28099999999999992</c:v>
                </c:pt>
                <c:pt idx="1282">
                  <c:v>0.28200000000000003</c:v>
                </c:pt>
                <c:pt idx="1283">
                  <c:v>0.28299999999999992</c:v>
                </c:pt>
                <c:pt idx="1284">
                  <c:v>0.28400000000000003</c:v>
                </c:pt>
                <c:pt idx="1285">
                  <c:v>0.28499999999999992</c:v>
                </c:pt>
                <c:pt idx="1286">
                  <c:v>0.28600000000000003</c:v>
                </c:pt>
                <c:pt idx="1287">
                  <c:v>0.28699999999999992</c:v>
                </c:pt>
                <c:pt idx="1288">
                  <c:v>0.28800000000000003</c:v>
                </c:pt>
                <c:pt idx="1289">
                  <c:v>0.28899999999999992</c:v>
                </c:pt>
                <c:pt idx="1290">
                  <c:v>0.29000000000000004</c:v>
                </c:pt>
                <c:pt idx="1291">
                  <c:v>0.29099999999999993</c:v>
                </c:pt>
                <c:pt idx="1292">
                  <c:v>0.29200000000000004</c:v>
                </c:pt>
                <c:pt idx="1293">
                  <c:v>0.29299999999999993</c:v>
                </c:pt>
                <c:pt idx="1294">
                  <c:v>0.29400000000000004</c:v>
                </c:pt>
                <c:pt idx="1295">
                  <c:v>0.29499999999999993</c:v>
                </c:pt>
                <c:pt idx="1296">
                  <c:v>0.29600000000000004</c:v>
                </c:pt>
                <c:pt idx="1297">
                  <c:v>0.29699999999999993</c:v>
                </c:pt>
                <c:pt idx="1298">
                  <c:v>0.29800000000000004</c:v>
                </c:pt>
                <c:pt idx="1299">
                  <c:v>0.29899999999999993</c:v>
                </c:pt>
                <c:pt idx="1300">
                  <c:v>0.30000000000000004</c:v>
                </c:pt>
                <c:pt idx="1301">
                  <c:v>0.30099999999999993</c:v>
                </c:pt>
                <c:pt idx="1302">
                  <c:v>0.30200000000000005</c:v>
                </c:pt>
                <c:pt idx="1303">
                  <c:v>0.30299999999999994</c:v>
                </c:pt>
                <c:pt idx="1304">
                  <c:v>0.30400000000000005</c:v>
                </c:pt>
                <c:pt idx="1305">
                  <c:v>0.30499999999999994</c:v>
                </c:pt>
                <c:pt idx="1306">
                  <c:v>0.30600000000000005</c:v>
                </c:pt>
                <c:pt idx="1307">
                  <c:v>0.30699999999999994</c:v>
                </c:pt>
                <c:pt idx="1308">
                  <c:v>0.30800000000000005</c:v>
                </c:pt>
                <c:pt idx="1309">
                  <c:v>0.30899999999999994</c:v>
                </c:pt>
                <c:pt idx="1310">
                  <c:v>0.31000000000000005</c:v>
                </c:pt>
                <c:pt idx="1311">
                  <c:v>0.31099999999999994</c:v>
                </c:pt>
                <c:pt idx="1312">
                  <c:v>0.31200000000000006</c:v>
                </c:pt>
                <c:pt idx="1313">
                  <c:v>0.31299999999999994</c:v>
                </c:pt>
                <c:pt idx="1314">
                  <c:v>0.31400000000000006</c:v>
                </c:pt>
                <c:pt idx="1315">
                  <c:v>0.31499999999999995</c:v>
                </c:pt>
                <c:pt idx="1316">
                  <c:v>0.31600000000000006</c:v>
                </c:pt>
                <c:pt idx="1317">
                  <c:v>0.31699999999999995</c:v>
                </c:pt>
                <c:pt idx="1318">
                  <c:v>0.31800000000000006</c:v>
                </c:pt>
                <c:pt idx="1319">
                  <c:v>0.31899999999999995</c:v>
                </c:pt>
                <c:pt idx="1320">
                  <c:v>0.32000000000000006</c:v>
                </c:pt>
                <c:pt idx="1321">
                  <c:v>0.32099999999999995</c:v>
                </c:pt>
                <c:pt idx="1322">
                  <c:v>0.32200000000000006</c:v>
                </c:pt>
                <c:pt idx="1323">
                  <c:v>0.32299999999999995</c:v>
                </c:pt>
                <c:pt idx="1324">
                  <c:v>0.32400000000000007</c:v>
                </c:pt>
                <c:pt idx="1325">
                  <c:v>0.32499999999999996</c:v>
                </c:pt>
                <c:pt idx="1326">
                  <c:v>0.32600000000000007</c:v>
                </c:pt>
                <c:pt idx="1327">
                  <c:v>0.32699999999999996</c:v>
                </c:pt>
                <c:pt idx="1328">
                  <c:v>0.32800000000000007</c:v>
                </c:pt>
                <c:pt idx="1329">
                  <c:v>0.32899999999999996</c:v>
                </c:pt>
                <c:pt idx="1330">
                  <c:v>0.33000000000000007</c:v>
                </c:pt>
                <c:pt idx="1331">
                  <c:v>0.33099999999999996</c:v>
                </c:pt>
                <c:pt idx="1332">
                  <c:v>0.33200000000000007</c:v>
                </c:pt>
                <c:pt idx="1333">
                  <c:v>0.33299999999999996</c:v>
                </c:pt>
                <c:pt idx="1334">
                  <c:v>0.33400000000000007</c:v>
                </c:pt>
                <c:pt idx="1335">
                  <c:v>0.33499999999999996</c:v>
                </c:pt>
                <c:pt idx="1336">
                  <c:v>0.33600000000000008</c:v>
                </c:pt>
                <c:pt idx="1337">
                  <c:v>0.33699999999999997</c:v>
                </c:pt>
                <c:pt idx="1338">
                  <c:v>0.33800000000000008</c:v>
                </c:pt>
                <c:pt idx="1339">
                  <c:v>0.33899999999999997</c:v>
                </c:pt>
                <c:pt idx="1340">
                  <c:v>0.34000000000000008</c:v>
                </c:pt>
                <c:pt idx="1341">
                  <c:v>0.34099999999999997</c:v>
                </c:pt>
                <c:pt idx="1342">
                  <c:v>0.34200000000000008</c:v>
                </c:pt>
                <c:pt idx="1343">
                  <c:v>0.34299999999999997</c:v>
                </c:pt>
                <c:pt idx="1344">
                  <c:v>0.34400000000000008</c:v>
                </c:pt>
                <c:pt idx="1345">
                  <c:v>0.34499999999999997</c:v>
                </c:pt>
                <c:pt idx="1346">
                  <c:v>0.34600000000000009</c:v>
                </c:pt>
                <c:pt idx="1347">
                  <c:v>0.34699999999999998</c:v>
                </c:pt>
                <c:pt idx="1348">
                  <c:v>0.34800000000000009</c:v>
                </c:pt>
                <c:pt idx="1349">
                  <c:v>0.34899999999999998</c:v>
                </c:pt>
                <c:pt idx="1350">
                  <c:v>0.35000000000000009</c:v>
                </c:pt>
                <c:pt idx="1351">
                  <c:v>0.35099999999999998</c:v>
                </c:pt>
                <c:pt idx="1352">
                  <c:v>0.35200000000000009</c:v>
                </c:pt>
                <c:pt idx="1353">
                  <c:v>0.35299999999999998</c:v>
                </c:pt>
                <c:pt idx="1354">
                  <c:v>0.35400000000000009</c:v>
                </c:pt>
                <c:pt idx="1355">
                  <c:v>0.35499999999999998</c:v>
                </c:pt>
                <c:pt idx="1356">
                  <c:v>0.35600000000000009</c:v>
                </c:pt>
                <c:pt idx="1357">
                  <c:v>0.35699999999999998</c:v>
                </c:pt>
                <c:pt idx="1358">
                  <c:v>0.3580000000000001</c:v>
                </c:pt>
                <c:pt idx="1359">
                  <c:v>0.35899999999999999</c:v>
                </c:pt>
                <c:pt idx="1360">
                  <c:v>0.3600000000000001</c:v>
                </c:pt>
                <c:pt idx="1361">
                  <c:v>0.36099999999999999</c:v>
                </c:pt>
                <c:pt idx="1362">
                  <c:v>0.3620000000000001</c:v>
                </c:pt>
                <c:pt idx="1363">
                  <c:v>0.36299999999999999</c:v>
                </c:pt>
                <c:pt idx="1364">
                  <c:v>0.3640000000000001</c:v>
                </c:pt>
                <c:pt idx="1365">
                  <c:v>0.36499999999999999</c:v>
                </c:pt>
                <c:pt idx="1366">
                  <c:v>0.3660000000000001</c:v>
                </c:pt>
                <c:pt idx="1367">
                  <c:v>0.36699999999999999</c:v>
                </c:pt>
                <c:pt idx="1368">
                  <c:v>0.3680000000000001</c:v>
                </c:pt>
                <c:pt idx="1369">
                  <c:v>0.36899999999999999</c:v>
                </c:pt>
                <c:pt idx="1370">
                  <c:v>0.37000000000000011</c:v>
                </c:pt>
                <c:pt idx="1371">
                  <c:v>0.371</c:v>
                </c:pt>
                <c:pt idx="1372">
                  <c:v>0.37200000000000011</c:v>
                </c:pt>
                <c:pt idx="1373">
                  <c:v>0.373</c:v>
                </c:pt>
                <c:pt idx="1374">
                  <c:v>0.37400000000000011</c:v>
                </c:pt>
                <c:pt idx="1375">
                  <c:v>0.375</c:v>
                </c:pt>
                <c:pt idx="1376">
                  <c:v>0.37599999999999989</c:v>
                </c:pt>
                <c:pt idx="1377">
                  <c:v>0.377</c:v>
                </c:pt>
                <c:pt idx="1378">
                  <c:v>0.37799999999999989</c:v>
                </c:pt>
                <c:pt idx="1379">
                  <c:v>0.379</c:v>
                </c:pt>
                <c:pt idx="1380">
                  <c:v>0.37999999999999989</c:v>
                </c:pt>
                <c:pt idx="1381">
                  <c:v>0.38100000000000001</c:v>
                </c:pt>
                <c:pt idx="1382">
                  <c:v>0.3819999999999999</c:v>
                </c:pt>
                <c:pt idx="1383">
                  <c:v>0.38300000000000001</c:v>
                </c:pt>
                <c:pt idx="1384">
                  <c:v>0.3839999999999999</c:v>
                </c:pt>
                <c:pt idx="1385">
                  <c:v>0.38500000000000001</c:v>
                </c:pt>
                <c:pt idx="1386">
                  <c:v>0.3859999999999999</c:v>
                </c:pt>
                <c:pt idx="1387">
                  <c:v>0.38700000000000001</c:v>
                </c:pt>
                <c:pt idx="1388">
                  <c:v>0.3879999999999999</c:v>
                </c:pt>
                <c:pt idx="1389">
                  <c:v>0.38900000000000001</c:v>
                </c:pt>
                <c:pt idx="1390">
                  <c:v>0.3899999999999999</c:v>
                </c:pt>
                <c:pt idx="1391">
                  <c:v>0.39100000000000001</c:v>
                </c:pt>
                <c:pt idx="1392">
                  <c:v>0.3919999999999999</c:v>
                </c:pt>
                <c:pt idx="1393">
                  <c:v>0.39300000000000002</c:v>
                </c:pt>
                <c:pt idx="1394">
                  <c:v>0.39399999999999991</c:v>
                </c:pt>
                <c:pt idx="1395">
                  <c:v>0.39500000000000002</c:v>
                </c:pt>
                <c:pt idx="1396">
                  <c:v>0.39599999999999991</c:v>
                </c:pt>
                <c:pt idx="1397">
                  <c:v>0.39700000000000002</c:v>
                </c:pt>
                <c:pt idx="1398">
                  <c:v>0.39799999999999991</c:v>
                </c:pt>
                <c:pt idx="1399">
                  <c:v>0.39900000000000002</c:v>
                </c:pt>
                <c:pt idx="1400">
                  <c:v>0.39999999999999991</c:v>
                </c:pt>
                <c:pt idx="1401">
                  <c:v>0.40100000000000002</c:v>
                </c:pt>
                <c:pt idx="1402">
                  <c:v>0.40199999999999991</c:v>
                </c:pt>
                <c:pt idx="1403">
                  <c:v>0.40300000000000002</c:v>
                </c:pt>
                <c:pt idx="1404">
                  <c:v>0.40399999999999991</c:v>
                </c:pt>
                <c:pt idx="1405">
                  <c:v>0.40500000000000003</c:v>
                </c:pt>
                <c:pt idx="1406">
                  <c:v>0.40599999999999992</c:v>
                </c:pt>
                <c:pt idx="1407">
                  <c:v>0.40700000000000003</c:v>
                </c:pt>
                <c:pt idx="1408">
                  <c:v>0.40799999999999992</c:v>
                </c:pt>
                <c:pt idx="1409">
                  <c:v>0.40900000000000003</c:v>
                </c:pt>
                <c:pt idx="1410">
                  <c:v>0.40999999999999992</c:v>
                </c:pt>
                <c:pt idx="1411">
                  <c:v>0.41100000000000003</c:v>
                </c:pt>
                <c:pt idx="1412">
                  <c:v>0.41199999999999992</c:v>
                </c:pt>
                <c:pt idx="1413">
                  <c:v>0.41300000000000003</c:v>
                </c:pt>
                <c:pt idx="1414">
                  <c:v>0.41399999999999992</c:v>
                </c:pt>
                <c:pt idx="1415">
                  <c:v>0.41500000000000004</c:v>
                </c:pt>
                <c:pt idx="1416">
                  <c:v>0.41599999999999993</c:v>
                </c:pt>
                <c:pt idx="1417">
                  <c:v>0.41700000000000004</c:v>
                </c:pt>
                <c:pt idx="1418">
                  <c:v>0.41799999999999993</c:v>
                </c:pt>
                <c:pt idx="1419">
                  <c:v>0.41900000000000004</c:v>
                </c:pt>
                <c:pt idx="1420">
                  <c:v>0.41999999999999993</c:v>
                </c:pt>
                <c:pt idx="1421">
                  <c:v>0.42100000000000004</c:v>
                </c:pt>
                <c:pt idx="1422">
                  <c:v>0.42199999999999993</c:v>
                </c:pt>
                <c:pt idx="1423">
                  <c:v>0.42300000000000004</c:v>
                </c:pt>
                <c:pt idx="1424">
                  <c:v>0.42399999999999993</c:v>
                </c:pt>
                <c:pt idx="1425">
                  <c:v>0.42500000000000004</c:v>
                </c:pt>
                <c:pt idx="1426">
                  <c:v>0.42599999999999993</c:v>
                </c:pt>
                <c:pt idx="1427">
                  <c:v>0.42700000000000005</c:v>
                </c:pt>
                <c:pt idx="1428">
                  <c:v>0.42799999999999994</c:v>
                </c:pt>
                <c:pt idx="1429">
                  <c:v>0.42900000000000005</c:v>
                </c:pt>
                <c:pt idx="1430">
                  <c:v>0.42999999999999994</c:v>
                </c:pt>
                <c:pt idx="1431">
                  <c:v>0.43100000000000005</c:v>
                </c:pt>
                <c:pt idx="1432">
                  <c:v>0.43199999999999994</c:v>
                </c:pt>
                <c:pt idx="1433">
                  <c:v>0.43300000000000005</c:v>
                </c:pt>
                <c:pt idx="1434">
                  <c:v>0.43399999999999994</c:v>
                </c:pt>
                <c:pt idx="1435">
                  <c:v>0.43500000000000005</c:v>
                </c:pt>
                <c:pt idx="1436">
                  <c:v>0.43599999999999994</c:v>
                </c:pt>
                <c:pt idx="1437">
                  <c:v>0.43700000000000006</c:v>
                </c:pt>
                <c:pt idx="1438">
                  <c:v>0.43799999999999994</c:v>
                </c:pt>
                <c:pt idx="1439">
                  <c:v>0.43900000000000006</c:v>
                </c:pt>
                <c:pt idx="1440">
                  <c:v>0.43999999999999995</c:v>
                </c:pt>
                <c:pt idx="1441">
                  <c:v>0.44100000000000006</c:v>
                </c:pt>
                <c:pt idx="1442">
                  <c:v>0.44199999999999995</c:v>
                </c:pt>
                <c:pt idx="1443">
                  <c:v>0.44300000000000006</c:v>
                </c:pt>
                <c:pt idx="1444">
                  <c:v>0.44399999999999995</c:v>
                </c:pt>
                <c:pt idx="1445">
                  <c:v>0.44500000000000006</c:v>
                </c:pt>
                <c:pt idx="1446">
                  <c:v>0.44599999999999995</c:v>
                </c:pt>
                <c:pt idx="1447">
                  <c:v>0.44700000000000006</c:v>
                </c:pt>
                <c:pt idx="1448">
                  <c:v>0.44799999999999995</c:v>
                </c:pt>
                <c:pt idx="1449">
                  <c:v>0.44900000000000007</c:v>
                </c:pt>
                <c:pt idx="1450">
                  <c:v>0.44999999999999996</c:v>
                </c:pt>
                <c:pt idx="1451">
                  <c:v>0.45100000000000007</c:v>
                </c:pt>
                <c:pt idx="1452">
                  <c:v>0.45199999999999996</c:v>
                </c:pt>
                <c:pt idx="1453">
                  <c:v>0.45300000000000007</c:v>
                </c:pt>
                <c:pt idx="1454">
                  <c:v>0.45399999999999996</c:v>
                </c:pt>
                <c:pt idx="1455">
                  <c:v>0.45500000000000007</c:v>
                </c:pt>
                <c:pt idx="1456">
                  <c:v>0.45599999999999996</c:v>
                </c:pt>
                <c:pt idx="1457">
                  <c:v>0.45700000000000007</c:v>
                </c:pt>
                <c:pt idx="1458">
                  <c:v>0.45799999999999996</c:v>
                </c:pt>
                <c:pt idx="1459">
                  <c:v>0.45900000000000007</c:v>
                </c:pt>
                <c:pt idx="1460">
                  <c:v>0.45999999999999996</c:v>
                </c:pt>
                <c:pt idx="1461">
                  <c:v>0.46100000000000008</c:v>
                </c:pt>
                <c:pt idx="1462">
                  <c:v>0.46199999999999997</c:v>
                </c:pt>
                <c:pt idx="1463">
                  <c:v>0.46300000000000008</c:v>
                </c:pt>
                <c:pt idx="1464">
                  <c:v>0.46399999999999997</c:v>
                </c:pt>
                <c:pt idx="1465">
                  <c:v>0.46500000000000008</c:v>
                </c:pt>
                <c:pt idx="1466">
                  <c:v>0.46599999999999997</c:v>
                </c:pt>
                <c:pt idx="1467">
                  <c:v>0.46700000000000008</c:v>
                </c:pt>
                <c:pt idx="1468">
                  <c:v>0.46799999999999997</c:v>
                </c:pt>
                <c:pt idx="1469">
                  <c:v>0.46900000000000008</c:v>
                </c:pt>
                <c:pt idx="1470">
                  <c:v>0.47</c:v>
                </c:pt>
                <c:pt idx="1471">
                  <c:v>0.47100000000000009</c:v>
                </c:pt>
                <c:pt idx="1472">
                  <c:v>0.47199999999999998</c:v>
                </c:pt>
                <c:pt idx="1473">
                  <c:v>0.47300000000000009</c:v>
                </c:pt>
                <c:pt idx="1474">
                  <c:v>0.47399999999999998</c:v>
                </c:pt>
                <c:pt idx="1475">
                  <c:v>0.47500000000000009</c:v>
                </c:pt>
                <c:pt idx="1476">
                  <c:v>0.47599999999999998</c:v>
                </c:pt>
                <c:pt idx="1477">
                  <c:v>0.47700000000000009</c:v>
                </c:pt>
                <c:pt idx="1478">
                  <c:v>0.47799999999999998</c:v>
                </c:pt>
                <c:pt idx="1479">
                  <c:v>0.47900000000000009</c:v>
                </c:pt>
                <c:pt idx="1480">
                  <c:v>0.48</c:v>
                </c:pt>
                <c:pt idx="1481">
                  <c:v>0.48100000000000009</c:v>
                </c:pt>
                <c:pt idx="1482">
                  <c:v>0.48199999999999998</c:v>
                </c:pt>
                <c:pt idx="1483">
                  <c:v>0.4830000000000001</c:v>
                </c:pt>
                <c:pt idx="1484">
                  <c:v>0.48399999999999999</c:v>
                </c:pt>
                <c:pt idx="1485">
                  <c:v>0.4850000000000001</c:v>
                </c:pt>
                <c:pt idx="1486">
                  <c:v>0.48599999999999999</c:v>
                </c:pt>
                <c:pt idx="1487">
                  <c:v>0.4870000000000001</c:v>
                </c:pt>
                <c:pt idx="1488">
                  <c:v>0.48799999999999999</c:v>
                </c:pt>
                <c:pt idx="1489">
                  <c:v>0.4890000000000001</c:v>
                </c:pt>
                <c:pt idx="1490">
                  <c:v>0.49</c:v>
                </c:pt>
                <c:pt idx="1491">
                  <c:v>0.4910000000000001</c:v>
                </c:pt>
                <c:pt idx="1492">
                  <c:v>0.49199999999999999</c:v>
                </c:pt>
                <c:pt idx="1493">
                  <c:v>0.4930000000000001</c:v>
                </c:pt>
                <c:pt idx="1494">
                  <c:v>0.49399999999999999</c:v>
                </c:pt>
                <c:pt idx="1495">
                  <c:v>0.49500000000000011</c:v>
                </c:pt>
                <c:pt idx="1496">
                  <c:v>0.496</c:v>
                </c:pt>
                <c:pt idx="1497">
                  <c:v>0.49700000000000011</c:v>
                </c:pt>
                <c:pt idx="1498">
                  <c:v>0.498</c:v>
                </c:pt>
                <c:pt idx="1499">
                  <c:v>0.49900000000000011</c:v>
                </c:pt>
                <c:pt idx="1500">
                  <c:v>0.5</c:v>
                </c:pt>
                <c:pt idx="1501">
                  <c:v>0.50099999999999989</c:v>
                </c:pt>
                <c:pt idx="1502">
                  <c:v>0.502</c:v>
                </c:pt>
                <c:pt idx="1503">
                  <c:v>0.50299999999999989</c:v>
                </c:pt>
                <c:pt idx="1504">
                  <c:v>0.504</c:v>
                </c:pt>
                <c:pt idx="1505">
                  <c:v>0.50499999999999989</c:v>
                </c:pt>
                <c:pt idx="1506">
                  <c:v>0.50600000000000001</c:v>
                </c:pt>
                <c:pt idx="1507">
                  <c:v>0.5069999999999999</c:v>
                </c:pt>
                <c:pt idx="1508">
                  <c:v>0.50800000000000001</c:v>
                </c:pt>
                <c:pt idx="1509">
                  <c:v>0.5089999999999999</c:v>
                </c:pt>
                <c:pt idx="1510">
                  <c:v>0.51</c:v>
                </c:pt>
                <c:pt idx="1511">
                  <c:v>0.5109999999999999</c:v>
                </c:pt>
                <c:pt idx="1512">
                  <c:v>0.51200000000000001</c:v>
                </c:pt>
                <c:pt idx="1513">
                  <c:v>0.5129999999999999</c:v>
                </c:pt>
                <c:pt idx="1514">
                  <c:v>0.51400000000000001</c:v>
                </c:pt>
                <c:pt idx="1515">
                  <c:v>0.5149999999999999</c:v>
                </c:pt>
                <c:pt idx="1516">
                  <c:v>0.51600000000000001</c:v>
                </c:pt>
                <c:pt idx="1517">
                  <c:v>0.5169999999999999</c:v>
                </c:pt>
                <c:pt idx="1518">
                  <c:v>0.51800000000000002</c:v>
                </c:pt>
                <c:pt idx="1519">
                  <c:v>0.51899999999999991</c:v>
                </c:pt>
                <c:pt idx="1520">
                  <c:v>0.52</c:v>
                </c:pt>
                <c:pt idx="1521">
                  <c:v>0.52099999999999991</c:v>
                </c:pt>
                <c:pt idx="1522">
                  <c:v>0.52200000000000002</c:v>
                </c:pt>
                <c:pt idx="1523">
                  <c:v>0.52299999999999991</c:v>
                </c:pt>
                <c:pt idx="1524">
                  <c:v>0.52400000000000002</c:v>
                </c:pt>
                <c:pt idx="1525">
                  <c:v>0.52499999999999991</c:v>
                </c:pt>
                <c:pt idx="1526">
                  <c:v>0.52600000000000002</c:v>
                </c:pt>
                <c:pt idx="1527">
                  <c:v>0.52699999999999991</c:v>
                </c:pt>
                <c:pt idx="1528">
                  <c:v>0.52800000000000002</c:v>
                </c:pt>
                <c:pt idx="1529">
                  <c:v>0.52899999999999991</c:v>
                </c:pt>
                <c:pt idx="1530">
                  <c:v>0.53</c:v>
                </c:pt>
                <c:pt idx="1531">
                  <c:v>0.53099999999999992</c:v>
                </c:pt>
                <c:pt idx="1532">
                  <c:v>0.53200000000000003</c:v>
                </c:pt>
                <c:pt idx="1533">
                  <c:v>0.53299999999999992</c:v>
                </c:pt>
                <c:pt idx="1534">
                  <c:v>0.53400000000000003</c:v>
                </c:pt>
                <c:pt idx="1535">
                  <c:v>0.53499999999999992</c:v>
                </c:pt>
                <c:pt idx="1536">
                  <c:v>0.53600000000000003</c:v>
                </c:pt>
                <c:pt idx="1537">
                  <c:v>0.53699999999999992</c:v>
                </c:pt>
                <c:pt idx="1538">
                  <c:v>0.53800000000000003</c:v>
                </c:pt>
                <c:pt idx="1539">
                  <c:v>0.53899999999999992</c:v>
                </c:pt>
                <c:pt idx="1540">
                  <c:v>0.54</c:v>
                </c:pt>
                <c:pt idx="1541">
                  <c:v>0.54099999999999993</c:v>
                </c:pt>
                <c:pt idx="1542">
                  <c:v>0.54200000000000004</c:v>
                </c:pt>
                <c:pt idx="1543">
                  <c:v>0.54299999999999993</c:v>
                </c:pt>
                <c:pt idx="1544">
                  <c:v>0.54400000000000004</c:v>
                </c:pt>
                <c:pt idx="1545">
                  <c:v>0.54499999999999993</c:v>
                </c:pt>
                <c:pt idx="1546">
                  <c:v>0.54600000000000004</c:v>
                </c:pt>
                <c:pt idx="1547">
                  <c:v>0.54699999999999993</c:v>
                </c:pt>
                <c:pt idx="1548">
                  <c:v>0.54800000000000004</c:v>
                </c:pt>
                <c:pt idx="1549">
                  <c:v>0.54899999999999993</c:v>
                </c:pt>
                <c:pt idx="1550">
                  <c:v>0.55000000000000004</c:v>
                </c:pt>
                <c:pt idx="1551">
                  <c:v>0.55099999999999993</c:v>
                </c:pt>
                <c:pt idx="1552">
                  <c:v>0.55200000000000005</c:v>
                </c:pt>
                <c:pt idx="1553">
                  <c:v>0.55299999999999994</c:v>
                </c:pt>
                <c:pt idx="1554">
                  <c:v>0.55400000000000005</c:v>
                </c:pt>
                <c:pt idx="1555">
                  <c:v>0.55499999999999994</c:v>
                </c:pt>
                <c:pt idx="1556">
                  <c:v>0.55600000000000005</c:v>
                </c:pt>
                <c:pt idx="1557">
                  <c:v>0.55699999999999994</c:v>
                </c:pt>
                <c:pt idx="1558">
                  <c:v>0.55800000000000005</c:v>
                </c:pt>
                <c:pt idx="1559">
                  <c:v>0.55899999999999994</c:v>
                </c:pt>
                <c:pt idx="1560">
                  <c:v>0.56000000000000005</c:v>
                </c:pt>
                <c:pt idx="1561">
                  <c:v>0.56099999999999994</c:v>
                </c:pt>
                <c:pt idx="1562">
                  <c:v>0.56200000000000006</c:v>
                </c:pt>
                <c:pt idx="1563">
                  <c:v>0.56299999999999994</c:v>
                </c:pt>
                <c:pt idx="1564">
                  <c:v>0.56400000000000006</c:v>
                </c:pt>
                <c:pt idx="1565">
                  <c:v>0.56499999999999995</c:v>
                </c:pt>
                <c:pt idx="1566">
                  <c:v>0.56600000000000006</c:v>
                </c:pt>
                <c:pt idx="1567">
                  <c:v>0.56699999999999995</c:v>
                </c:pt>
                <c:pt idx="1568">
                  <c:v>0.56800000000000006</c:v>
                </c:pt>
                <c:pt idx="1569">
                  <c:v>0.56899999999999995</c:v>
                </c:pt>
                <c:pt idx="1570">
                  <c:v>0.57000000000000006</c:v>
                </c:pt>
                <c:pt idx="1571">
                  <c:v>0.57099999999999995</c:v>
                </c:pt>
                <c:pt idx="1572">
                  <c:v>0.57200000000000006</c:v>
                </c:pt>
                <c:pt idx="1573">
                  <c:v>0.57299999999999995</c:v>
                </c:pt>
                <c:pt idx="1574">
                  <c:v>0.57400000000000007</c:v>
                </c:pt>
                <c:pt idx="1575">
                  <c:v>0.57499999999999996</c:v>
                </c:pt>
                <c:pt idx="1576">
                  <c:v>0.57600000000000007</c:v>
                </c:pt>
                <c:pt idx="1577">
                  <c:v>0.57699999999999996</c:v>
                </c:pt>
                <c:pt idx="1578">
                  <c:v>0.57800000000000007</c:v>
                </c:pt>
                <c:pt idx="1579">
                  <c:v>0.57899999999999996</c:v>
                </c:pt>
                <c:pt idx="1580">
                  <c:v>0.58000000000000007</c:v>
                </c:pt>
                <c:pt idx="1581">
                  <c:v>0.58099999999999996</c:v>
                </c:pt>
                <c:pt idx="1582">
                  <c:v>0.58200000000000007</c:v>
                </c:pt>
                <c:pt idx="1583">
                  <c:v>0.58299999999999996</c:v>
                </c:pt>
                <c:pt idx="1584">
                  <c:v>0.58400000000000007</c:v>
                </c:pt>
                <c:pt idx="1585">
                  <c:v>0.58499999999999996</c:v>
                </c:pt>
                <c:pt idx="1586">
                  <c:v>0.58600000000000008</c:v>
                </c:pt>
                <c:pt idx="1587">
                  <c:v>0.58699999999999997</c:v>
                </c:pt>
                <c:pt idx="1588">
                  <c:v>0.58800000000000008</c:v>
                </c:pt>
                <c:pt idx="1589">
                  <c:v>0.58899999999999997</c:v>
                </c:pt>
                <c:pt idx="1590">
                  <c:v>0.59000000000000008</c:v>
                </c:pt>
                <c:pt idx="1591">
                  <c:v>0.59099999999999997</c:v>
                </c:pt>
                <c:pt idx="1592">
                  <c:v>0.59200000000000008</c:v>
                </c:pt>
                <c:pt idx="1593">
                  <c:v>0.59299999999999997</c:v>
                </c:pt>
                <c:pt idx="1594">
                  <c:v>0.59400000000000008</c:v>
                </c:pt>
                <c:pt idx="1595">
                  <c:v>0.59499999999999997</c:v>
                </c:pt>
                <c:pt idx="1596">
                  <c:v>0.59600000000000009</c:v>
                </c:pt>
                <c:pt idx="1597">
                  <c:v>0.59699999999999998</c:v>
                </c:pt>
                <c:pt idx="1598">
                  <c:v>0.59800000000000009</c:v>
                </c:pt>
                <c:pt idx="1599">
                  <c:v>0.59899999999999998</c:v>
                </c:pt>
                <c:pt idx="1600">
                  <c:v>0.60000000000000009</c:v>
                </c:pt>
                <c:pt idx="1601">
                  <c:v>0.60099999999999998</c:v>
                </c:pt>
                <c:pt idx="1602">
                  <c:v>0.60200000000000009</c:v>
                </c:pt>
                <c:pt idx="1603">
                  <c:v>0.60299999999999998</c:v>
                </c:pt>
                <c:pt idx="1604">
                  <c:v>0.60400000000000009</c:v>
                </c:pt>
                <c:pt idx="1605">
                  <c:v>0.60499999999999998</c:v>
                </c:pt>
                <c:pt idx="1606">
                  <c:v>0.60600000000000009</c:v>
                </c:pt>
                <c:pt idx="1607">
                  <c:v>0.60699999999999998</c:v>
                </c:pt>
                <c:pt idx="1608">
                  <c:v>0.6080000000000001</c:v>
                </c:pt>
                <c:pt idx="1609">
                  <c:v>0.60899999999999999</c:v>
                </c:pt>
                <c:pt idx="1610">
                  <c:v>0.6100000000000001</c:v>
                </c:pt>
                <c:pt idx="1611">
                  <c:v>0.61099999999999999</c:v>
                </c:pt>
                <c:pt idx="1612">
                  <c:v>0.6120000000000001</c:v>
                </c:pt>
                <c:pt idx="1613">
                  <c:v>0.61299999999999999</c:v>
                </c:pt>
                <c:pt idx="1614">
                  <c:v>0.6140000000000001</c:v>
                </c:pt>
                <c:pt idx="1615">
                  <c:v>0.61499999999999999</c:v>
                </c:pt>
                <c:pt idx="1616">
                  <c:v>0.6160000000000001</c:v>
                </c:pt>
                <c:pt idx="1617">
                  <c:v>0.61699999999999999</c:v>
                </c:pt>
                <c:pt idx="1618">
                  <c:v>0.6180000000000001</c:v>
                </c:pt>
                <c:pt idx="1619">
                  <c:v>0.61899999999999999</c:v>
                </c:pt>
                <c:pt idx="1620">
                  <c:v>0.62000000000000011</c:v>
                </c:pt>
                <c:pt idx="1621">
                  <c:v>0.621</c:v>
                </c:pt>
                <c:pt idx="1622">
                  <c:v>0.62200000000000011</c:v>
                </c:pt>
                <c:pt idx="1623">
                  <c:v>0.623</c:v>
                </c:pt>
                <c:pt idx="1624">
                  <c:v>0.62400000000000011</c:v>
                </c:pt>
                <c:pt idx="1625">
                  <c:v>0.625</c:v>
                </c:pt>
                <c:pt idx="1626">
                  <c:v>0.62599999999999989</c:v>
                </c:pt>
                <c:pt idx="1627">
                  <c:v>0.627</c:v>
                </c:pt>
                <c:pt idx="1628">
                  <c:v>0.62799999999999989</c:v>
                </c:pt>
                <c:pt idx="1629">
                  <c:v>0.629</c:v>
                </c:pt>
                <c:pt idx="1630">
                  <c:v>0.62999999999999989</c:v>
                </c:pt>
                <c:pt idx="1631">
                  <c:v>0.63100000000000001</c:v>
                </c:pt>
                <c:pt idx="1632">
                  <c:v>0.6319999999999999</c:v>
                </c:pt>
                <c:pt idx="1633">
                  <c:v>0.63300000000000001</c:v>
                </c:pt>
                <c:pt idx="1634">
                  <c:v>0.6339999999999999</c:v>
                </c:pt>
                <c:pt idx="1635">
                  <c:v>0.63500000000000001</c:v>
                </c:pt>
                <c:pt idx="1636">
                  <c:v>0.6359999999999999</c:v>
                </c:pt>
                <c:pt idx="1637">
                  <c:v>0.63700000000000001</c:v>
                </c:pt>
                <c:pt idx="1638">
                  <c:v>0.6379999999999999</c:v>
                </c:pt>
                <c:pt idx="1639">
                  <c:v>0.63900000000000001</c:v>
                </c:pt>
                <c:pt idx="1640">
                  <c:v>0.6399999999999999</c:v>
                </c:pt>
                <c:pt idx="1641">
                  <c:v>0.64100000000000001</c:v>
                </c:pt>
                <c:pt idx="1642">
                  <c:v>0.6419999999999999</c:v>
                </c:pt>
                <c:pt idx="1643">
                  <c:v>0.64300000000000002</c:v>
                </c:pt>
                <c:pt idx="1644">
                  <c:v>0.64399999999999991</c:v>
                </c:pt>
                <c:pt idx="1645">
                  <c:v>0.64500000000000002</c:v>
                </c:pt>
                <c:pt idx="1646">
                  <c:v>0.64599999999999991</c:v>
                </c:pt>
                <c:pt idx="1647">
                  <c:v>0.64700000000000002</c:v>
                </c:pt>
                <c:pt idx="1648">
                  <c:v>0.64799999999999991</c:v>
                </c:pt>
                <c:pt idx="1649">
                  <c:v>0.64900000000000002</c:v>
                </c:pt>
                <c:pt idx="1650">
                  <c:v>0.64999999999999991</c:v>
                </c:pt>
                <c:pt idx="1651">
                  <c:v>0.65100000000000002</c:v>
                </c:pt>
                <c:pt idx="1652">
                  <c:v>0.65199999999999991</c:v>
                </c:pt>
                <c:pt idx="1653">
                  <c:v>0.65300000000000002</c:v>
                </c:pt>
                <c:pt idx="1654">
                  <c:v>0.65399999999999991</c:v>
                </c:pt>
                <c:pt idx="1655">
                  <c:v>0.65500000000000003</c:v>
                </c:pt>
                <c:pt idx="1656">
                  <c:v>0.65599999999999992</c:v>
                </c:pt>
                <c:pt idx="1657">
                  <c:v>0.65700000000000003</c:v>
                </c:pt>
                <c:pt idx="1658">
                  <c:v>0.65799999999999992</c:v>
                </c:pt>
                <c:pt idx="1659">
                  <c:v>0.65900000000000003</c:v>
                </c:pt>
                <c:pt idx="1660">
                  <c:v>0.65999999999999992</c:v>
                </c:pt>
                <c:pt idx="1661">
                  <c:v>0.66100000000000003</c:v>
                </c:pt>
                <c:pt idx="1662">
                  <c:v>0.66199999999999992</c:v>
                </c:pt>
                <c:pt idx="1663">
                  <c:v>0.66300000000000003</c:v>
                </c:pt>
                <c:pt idx="1664">
                  <c:v>0.66399999999999992</c:v>
                </c:pt>
                <c:pt idx="1665">
                  <c:v>0.66500000000000004</c:v>
                </c:pt>
                <c:pt idx="1666">
                  <c:v>0.66599999999999993</c:v>
                </c:pt>
                <c:pt idx="1667">
                  <c:v>0.66700000000000004</c:v>
                </c:pt>
                <c:pt idx="1668">
                  <c:v>0.66799999999999993</c:v>
                </c:pt>
                <c:pt idx="1669">
                  <c:v>0.66900000000000004</c:v>
                </c:pt>
                <c:pt idx="1670">
                  <c:v>0.66999999999999993</c:v>
                </c:pt>
                <c:pt idx="1671">
                  <c:v>0.67100000000000004</c:v>
                </c:pt>
                <c:pt idx="1672">
                  <c:v>0.67199999999999993</c:v>
                </c:pt>
                <c:pt idx="1673">
                  <c:v>0.67300000000000004</c:v>
                </c:pt>
                <c:pt idx="1674">
                  <c:v>0.67399999999999993</c:v>
                </c:pt>
                <c:pt idx="1675">
                  <c:v>0.67500000000000004</c:v>
                </c:pt>
                <c:pt idx="1676">
                  <c:v>0.67599999999999993</c:v>
                </c:pt>
                <c:pt idx="1677">
                  <c:v>0.67700000000000005</c:v>
                </c:pt>
                <c:pt idx="1678">
                  <c:v>0.67799999999999994</c:v>
                </c:pt>
                <c:pt idx="1679">
                  <c:v>0.67900000000000005</c:v>
                </c:pt>
                <c:pt idx="1680">
                  <c:v>0.67999999999999994</c:v>
                </c:pt>
                <c:pt idx="1681">
                  <c:v>0.68100000000000005</c:v>
                </c:pt>
                <c:pt idx="1682">
                  <c:v>0.68199999999999994</c:v>
                </c:pt>
                <c:pt idx="1683">
                  <c:v>0.68300000000000005</c:v>
                </c:pt>
                <c:pt idx="1684">
                  <c:v>0.68399999999999994</c:v>
                </c:pt>
                <c:pt idx="1685">
                  <c:v>0.68500000000000005</c:v>
                </c:pt>
                <c:pt idx="1686">
                  <c:v>0.68599999999999994</c:v>
                </c:pt>
                <c:pt idx="1687">
                  <c:v>0.68700000000000006</c:v>
                </c:pt>
                <c:pt idx="1688">
                  <c:v>0.68799999999999994</c:v>
                </c:pt>
                <c:pt idx="1689">
                  <c:v>0.68900000000000006</c:v>
                </c:pt>
                <c:pt idx="1690">
                  <c:v>0.69</c:v>
                </c:pt>
                <c:pt idx="1691">
                  <c:v>0.69100000000000006</c:v>
                </c:pt>
                <c:pt idx="1692">
                  <c:v>0.69199999999999995</c:v>
                </c:pt>
                <c:pt idx="1693">
                  <c:v>0.69300000000000006</c:v>
                </c:pt>
                <c:pt idx="1694">
                  <c:v>0.69399999999999995</c:v>
                </c:pt>
                <c:pt idx="1695">
                  <c:v>0.69500000000000006</c:v>
                </c:pt>
                <c:pt idx="1696">
                  <c:v>0.69599999999999995</c:v>
                </c:pt>
                <c:pt idx="1697">
                  <c:v>0.69700000000000006</c:v>
                </c:pt>
                <c:pt idx="1698">
                  <c:v>0.69799999999999995</c:v>
                </c:pt>
                <c:pt idx="1699">
                  <c:v>0.69900000000000007</c:v>
                </c:pt>
                <c:pt idx="1700">
                  <c:v>0.7</c:v>
                </c:pt>
                <c:pt idx="1701">
                  <c:v>0.70100000000000007</c:v>
                </c:pt>
                <c:pt idx="1702">
                  <c:v>0.70199999999999996</c:v>
                </c:pt>
                <c:pt idx="1703">
                  <c:v>0.70300000000000007</c:v>
                </c:pt>
                <c:pt idx="1704">
                  <c:v>0.70399999999999996</c:v>
                </c:pt>
                <c:pt idx="1705">
                  <c:v>0.70500000000000007</c:v>
                </c:pt>
                <c:pt idx="1706">
                  <c:v>0.70599999999999996</c:v>
                </c:pt>
                <c:pt idx="1707">
                  <c:v>0.70700000000000007</c:v>
                </c:pt>
                <c:pt idx="1708">
                  <c:v>0.70799999999999996</c:v>
                </c:pt>
                <c:pt idx="1709">
                  <c:v>0.70900000000000007</c:v>
                </c:pt>
                <c:pt idx="1710">
                  <c:v>0.71</c:v>
                </c:pt>
                <c:pt idx="1711">
                  <c:v>0.71100000000000008</c:v>
                </c:pt>
                <c:pt idx="1712">
                  <c:v>0.71199999999999997</c:v>
                </c:pt>
                <c:pt idx="1713">
                  <c:v>0.71300000000000008</c:v>
                </c:pt>
                <c:pt idx="1714">
                  <c:v>0.71399999999999997</c:v>
                </c:pt>
                <c:pt idx="1715">
                  <c:v>0.71500000000000008</c:v>
                </c:pt>
                <c:pt idx="1716">
                  <c:v>0.71599999999999997</c:v>
                </c:pt>
                <c:pt idx="1717">
                  <c:v>0.71700000000000008</c:v>
                </c:pt>
                <c:pt idx="1718">
                  <c:v>0.71799999999999997</c:v>
                </c:pt>
                <c:pt idx="1719">
                  <c:v>0.71900000000000008</c:v>
                </c:pt>
                <c:pt idx="1720">
                  <c:v>0.72</c:v>
                </c:pt>
                <c:pt idx="1721">
                  <c:v>0.72100000000000009</c:v>
                </c:pt>
                <c:pt idx="1722">
                  <c:v>0.72199999999999998</c:v>
                </c:pt>
                <c:pt idx="1723">
                  <c:v>0.72300000000000009</c:v>
                </c:pt>
                <c:pt idx="1724">
                  <c:v>0.72399999999999998</c:v>
                </c:pt>
                <c:pt idx="1725">
                  <c:v>0.72500000000000009</c:v>
                </c:pt>
                <c:pt idx="1726">
                  <c:v>0.72599999999999998</c:v>
                </c:pt>
                <c:pt idx="1727">
                  <c:v>0.72700000000000009</c:v>
                </c:pt>
                <c:pt idx="1728">
                  <c:v>0.72799999999999998</c:v>
                </c:pt>
                <c:pt idx="1729">
                  <c:v>0.72900000000000009</c:v>
                </c:pt>
                <c:pt idx="1730">
                  <c:v>0.73</c:v>
                </c:pt>
                <c:pt idx="1731">
                  <c:v>0.73100000000000009</c:v>
                </c:pt>
                <c:pt idx="1732">
                  <c:v>0.73199999999999998</c:v>
                </c:pt>
                <c:pt idx="1733">
                  <c:v>0.7330000000000001</c:v>
                </c:pt>
                <c:pt idx="1734">
                  <c:v>0.73399999999999999</c:v>
                </c:pt>
                <c:pt idx="1735">
                  <c:v>0.7350000000000001</c:v>
                </c:pt>
                <c:pt idx="1736">
                  <c:v>0.73599999999999999</c:v>
                </c:pt>
                <c:pt idx="1737">
                  <c:v>0.7370000000000001</c:v>
                </c:pt>
                <c:pt idx="1738">
                  <c:v>0.73799999999999999</c:v>
                </c:pt>
                <c:pt idx="1739">
                  <c:v>0.7390000000000001</c:v>
                </c:pt>
                <c:pt idx="1740">
                  <c:v>0.74</c:v>
                </c:pt>
                <c:pt idx="1741">
                  <c:v>0.7410000000000001</c:v>
                </c:pt>
                <c:pt idx="1742">
                  <c:v>0.74199999999999999</c:v>
                </c:pt>
                <c:pt idx="1743">
                  <c:v>0.7430000000000001</c:v>
                </c:pt>
                <c:pt idx="1744">
                  <c:v>0.74399999999999999</c:v>
                </c:pt>
                <c:pt idx="1745">
                  <c:v>0.74500000000000011</c:v>
                </c:pt>
                <c:pt idx="1746">
                  <c:v>0.746</c:v>
                </c:pt>
                <c:pt idx="1747">
                  <c:v>0.74700000000000011</c:v>
                </c:pt>
                <c:pt idx="1748">
                  <c:v>0.748</c:v>
                </c:pt>
                <c:pt idx="1749">
                  <c:v>0.74900000000000011</c:v>
                </c:pt>
                <c:pt idx="1750">
                  <c:v>0.75</c:v>
                </c:pt>
                <c:pt idx="1751">
                  <c:v>0.75099999999999989</c:v>
                </c:pt>
                <c:pt idx="1752">
                  <c:v>0.752</c:v>
                </c:pt>
                <c:pt idx="1753">
                  <c:v>0.75299999999999989</c:v>
                </c:pt>
                <c:pt idx="1754">
                  <c:v>0.754</c:v>
                </c:pt>
                <c:pt idx="1755">
                  <c:v>0.75499999999999989</c:v>
                </c:pt>
                <c:pt idx="1756">
                  <c:v>0.75600000000000001</c:v>
                </c:pt>
                <c:pt idx="1757">
                  <c:v>0.7569999999999999</c:v>
                </c:pt>
                <c:pt idx="1758">
                  <c:v>0.75800000000000001</c:v>
                </c:pt>
                <c:pt idx="1759">
                  <c:v>0.7589999999999999</c:v>
                </c:pt>
                <c:pt idx="1760">
                  <c:v>0.76</c:v>
                </c:pt>
                <c:pt idx="1761">
                  <c:v>0.7609999999999999</c:v>
                </c:pt>
                <c:pt idx="1762">
                  <c:v>0.76200000000000001</c:v>
                </c:pt>
                <c:pt idx="1763">
                  <c:v>0.7629999999999999</c:v>
                </c:pt>
                <c:pt idx="1764">
                  <c:v>0.76400000000000001</c:v>
                </c:pt>
                <c:pt idx="1765">
                  <c:v>0.7649999999999999</c:v>
                </c:pt>
                <c:pt idx="1766">
                  <c:v>0.76600000000000001</c:v>
                </c:pt>
                <c:pt idx="1767">
                  <c:v>0.7669999999999999</c:v>
                </c:pt>
                <c:pt idx="1768">
                  <c:v>0.76800000000000002</c:v>
                </c:pt>
                <c:pt idx="1769">
                  <c:v>0.76899999999999991</c:v>
                </c:pt>
                <c:pt idx="1770">
                  <c:v>0.77</c:v>
                </c:pt>
                <c:pt idx="1771">
                  <c:v>0.77099999999999991</c:v>
                </c:pt>
                <c:pt idx="1772">
                  <c:v>0.77200000000000002</c:v>
                </c:pt>
                <c:pt idx="1773">
                  <c:v>0.77299999999999991</c:v>
                </c:pt>
                <c:pt idx="1774">
                  <c:v>0.77400000000000002</c:v>
                </c:pt>
                <c:pt idx="1775">
                  <c:v>0.77499999999999991</c:v>
                </c:pt>
                <c:pt idx="1776">
                  <c:v>0.77600000000000002</c:v>
                </c:pt>
                <c:pt idx="1777">
                  <c:v>0.77699999999999991</c:v>
                </c:pt>
                <c:pt idx="1778">
                  <c:v>0.77800000000000002</c:v>
                </c:pt>
                <c:pt idx="1779">
                  <c:v>0.77899999999999991</c:v>
                </c:pt>
                <c:pt idx="1780">
                  <c:v>0.78</c:v>
                </c:pt>
                <c:pt idx="1781">
                  <c:v>0.78099999999999992</c:v>
                </c:pt>
                <c:pt idx="1782">
                  <c:v>0.78200000000000003</c:v>
                </c:pt>
                <c:pt idx="1783">
                  <c:v>0.78299999999999992</c:v>
                </c:pt>
                <c:pt idx="1784">
                  <c:v>0.78400000000000003</c:v>
                </c:pt>
                <c:pt idx="1785">
                  <c:v>0.78499999999999992</c:v>
                </c:pt>
                <c:pt idx="1786">
                  <c:v>0.78600000000000003</c:v>
                </c:pt>
                <c:pt idx="1787">
                  <c:v>0.78699999999999992</c:v>
                </c:pt>
                <c:pt idx="1788">
                  <c:v>0.78800000000000003</c:v>
                </c:pt>
                <c:pt idx="1789">
                  <c:v>0.78899999999999992</c:v>
                </c:pt>
                <c:pt idx="1790">
                  <c:v>0.79</c:v>
                </c:pt>
                <c:pt idx="1791">
                  <c:v>0.79099999999999993</c:v>
                </c:pt>
                <c:pt idx="1792">
                  <c:v>0.79200000000000004</c:v>
                </c:pt>
                <c:pt idx="1793">
                  <c:v>0.79299999999999993</c:v>
                </c:pt>
                <c:pt idx="1794">
                  <c:v>0.79400000000000004</c:v>
                </c:pt>
                <c:pt idx="1795">
                  <c:v>0.79499999999999993</c:v>
                </c:pt>
                <c:pt idx="1796">
                  <c:v>0.79600000000000004</c:v>
                </c:pt>
                <c:pt idx="1797">
                  <c:v>0.79699999999999993</c:v>
                </c:pt>
                <c:pt idx="1798">
                  <c:v>0.79800000000000004</c:v>
                </c:pt>
                <c:pt idx="1799">
                  <c:v>0.79899999999999993</c:v>
                </c:pt>
                <c:pt idx="1800">
                  <c:v>0.8</c:v>
                </c:pt>
                <c:pt idx="1801">
                  <c:v>0.80099999999999993</c:v>
                </c:pt>
                <c:pt idx="1802">
                  <c:v>0.80200000000000005</c:v>
                </c:pt>
                <c:pt idx="1803">
                  <c:v>0.80299999999999994</c:v>
                </c:pt>
                <c:pt idx="1804">
                  <c:v>0.80400000000000005</c:v>
                </c:pt>
                <c:pt idx="1805">
                  <c:v>0.80499999999999994</c:v>
                </c:pt>
                <c:pt idx="1806">
                  <c:v>0.80600000000000005</c:v>
                </c:pt>
                <c:pt idx="1807">
                  <c:v>0.80699999999999994</c:v>
                </c:pt>
                <c:pt idx="1808">
                  <c:v>0.80800000000000005</c:v>
                </c:pt>
                <c:pt idx="1809">
                  <c:v>0.80899999999999994</c:v>
                </c:pt>
                <c:pt idx="1810">
                  <c:v>0.81</c:v>
                </c:pt>
                <c:pt idx="1811">
                  <c:v>0.81099999999999994</c:v>
                </c:pt>
                <c:pt idx="1812">
                  <c:v>0.81200000000000006</c:v>
                </c:pt>
                <c:pt idx="1813">
                  <c:v>0.81299999999999994</c:v>
                </c:pt>
                <c:pt idx="1814">
                  <c:v>0.81400000000000006</c:v>
                </c:pt>
                <c:pt idx="1815">
                  <c:v>0.81499999999999995</c:v>
                </c:pt>
                <c:pt idx="1816">
                  <c:v>0.81600000000000006</c:v>
                </c:pt>
                <c:pt idx="1817">
                  <c:v>0.81699999999999995</c:v>
                </c:pt>
                <c:pt idx="1818">
                  <c:v>0.81800000000000006</c:v>
                </c:pt>
                <c:pt idx="1819">
                  <c:v>0.81899999999999995</c:v>
                </c:pt>
                <c:pt idx="1820">
                  <c:v>0.82000000000000006</c:v>
                </c:pt>
                <c:pt idx="1821">
                  <c:v>0.82099999999999995</c:v>
                </c:pt>
                <c:pt idx="1822">
                  <c:v>0.82200000000000006</c:v>
                </c:pt>
                <c:pt idx="1823">
                  <c:v>0.82299999999999995</c:v>
                </c:pt>
                <c:pt idx="1824">
                  <c:v>0.82400000000000007</c:v>
                </c:pt>
                <c:pt idx="1825">
                  <c:v>0.82499999999999996</c:v>
                </c:pt>
                <c:pt idx="1826">
                  <c:v>0.82600000000000007</c:v>
                </c:pt>
                <c:pt idx="1827">
                  <c:v>0.82699999999999996</c:v>
                </c:pt>
                <c:pt idx="1828">
                  <c:v>0.82800000000000007</c:v>
                </c:pt>
                <c:pt idx="1829">
                  <c:v>0.82899999999999996</c:v>
                </c:pt>
                <c:pt idx="1830">
                  <c:v>0.83000000000000007</c:v>
                </c:pt>
                <c:pt idx="1831">
                  <c:v>0.83099999999999996</c:v>
                </c:pt>
                <c:pt idx="1832">
                  <c:v>0.83200000000000007</c:v>
                </c:pt>
                <c:pt idx="1833">
                  <c:v>0.83299999999999996</c:v>
                </c:pt>
                <c:pt idx="1834">
                  <c:v>0.83400000000000007</c:v>
                </c:pt>
                <c:pt idx="1835">
                  <c:v>0.83499999999999996</c:v>
                </c:pt>
                <c:pt idx="1836">
                  <c:v>0.83600000000000008</c:v>
                </c:pt>
                <c:pt idx="1837">
                  <c:v>0.83699999999999997</c:v>
                </c:pt>
                <c:pt idx="1838">
                  <c:v>0.83800000000000008</c:v>
                </c:pt>
                <c:pt idx="1839">
                  <c:v>0.83899999999999997</c:v>
                </c:pt>
                <c:pt idx="1840">
                  <c:v>0.84000000000000008</c:v>
                </c:pt>
                <c:pt idx="1841">
                  <c:v>0.84099999999999997</c:v>
                </c:pt>
                <c:pt idx="1842">
                  <c:v>0.84200000000000008</c:v>
                </c:pt>
                <c:pt idx="1843">
                  <c:v>0.84299999999999997</c:v>
                </c:pt>
                <c:pt idx="1844">
                  <c:v>0.84400000000000008</c:v>
                </c:pt>
                <c:pt idx="1845">
                  <c:v>0.84499999999999997</c:v>
                </c:pt>
                <c:pt idx="1846">
                  <c:v>0.84600000000000009</c:v>
                </c:pt>
                <c:pt idx="1847">
                  <c:v>0.84699999999999998</c:v>
                </c:pt>
                <c:pt idx="1848">
                  <c:v>0.84800000000000009</c:v>
                </c:pt>
                <c:pt idx="1849">
                  <c:v>0.84899999999999998</c:v>
                </c:pt>
                <c:pt idx="1850">
                  <c:v>0.85000000000000009</c:v>
                </c:pt>
                <c:pt idx="1851">
                  <c:v>0.85099999999999998</c:v>
                </c:pt>
                <c:pt idx="1852">
                  <c:v>0.85200000000000009</c:v>
                </c:pt>
                <c:pt idx="1853">
                  <c:v>0.85299999999999998</c:v>
                </c:pt>
                <c:pt idx="1854">
                  <c:v>0.85400000000000009</c:v>
                </c:pt>
                <c:pt idx="1855">
                  <c:v>0.85499999999999998</c:v>
                </c:pt>
                <c:pt idx="1856">
                  <c:v>0.85600000000000009</c:v>
                </c:pt>
                <c:pt idx="1857">
                  <c:v>0.85699999999999998</c:v>
                </c:pt>
                <c:pt idx="1858">
                  <c:v>0.8580000000000001</c:v>
                </c:pt>
                <c:pt idx="1859">
                  <c:v>0.85899999999999999</c:v>
                </c:pt>
                <c:pt idx="1860">
                  <c:v>0.8600000000000001</c:v>
                </c:pt>
                <c:pt idx="1861">
                  <c:v>0.86099999999999999</c:v>
                </c:pt>
                <c:pt idx="1862">
                  <c:v>0.8620000000000001</c:v>
                </c:pt>
                <c:pt idx="1863">
                  <c:v>0.86299999999999999</c:v>
                </c:pt>
                <c:pt idx="1864">
                  <c:v>0.8640000000000001</c:v>
                </c:pt>
                <c:pt idx="1865">
                  <c:v>0.86499999999999999</c:v>
                </c:pt>
                <c:pt idx="1866">
                  <c:v>0.8660000000000001</c:v>
                </c:pt>
                <c:pt idx="1867">
                  <c:v>0.86699999999999999</c:v>
                </c:pt>
                <c:pt idx="1868">
                  <c:v>0.8680000000000001</c:v>
                </c:pt>
                <c:pt idx="1869">
                  <c:v>0.86899999999999999</c:v>
                </c:pt>
                <c:pt idx="1870">
                  <c:v>0.87000000000000011</c:v>
                </c:pt>
                <c:pt idx="1871">
                  <c:v>0.871</c:v>
                </c:pt>
                <c:pt idx="1872">
                  <c:v>0.87200000000000011</c:v>
                </c:pt>
                <c:pt idx="1873">
                  <c:v>0.873</c:v>
                </c:pt>
                <c:pt idx="1874">
                  <c:v>0.87400000000000011</c:v>
                </c:pt>
                <c:pt idx="1875">
                  <c:v>0.875</c:v>
                </c:pt>
                <c:pt idx="1876">
                  <c:v>0.87599999999999989</c:v>
                </c:pt>
                <c:pt idx="1877">
                  <c:v>0.877</c:v>
                </c:pt>
                <c:pt idx="1878">
                  <c:v>0.87799999999999989</c:v>
                </c:pt>
                <c:pt idx="1879">
                  <c:v>0.879</c:v>
                </c:pt>
                <c:pt idx="1880">
                  <c:v>0.87999999999999989</c:v>
                </c:pt>
                <c:pt idx="1881">
                  <c:v>0.88100000000000001</c:v>
                </c:pt>
                <c:pt idx="1882">
                  <c:v>0.8819999999999999</c:v>
                </c:pt>
                <c:pt idx="1883">
                  <c:v>0.88300000000000001</c:v>
                </c:pt>
                <c:pt idx="1884">
                  <c:v>0.8839999999999999</c:v>
                </c:pt>
                <c:pt idx="1885">
                  <c:v>0.88500000000000001</c:v>
                </c:pt>
                <c:pt idx="1886">
                  <c:v>0.8859999999999999</c:v>
                </c:pt>
                <c:pt idx="1887">
                  <c:v>0.88700000000000001</c:v>
                </c:pt>
                <c:pt idx="1888">
                  <c:v>0.8879999999999999</c:v>
                </c:pt>
                <c:pt idx="1889">
                  <c:v>0.88900000000000001</c:v>
                </c:pt>
                <c:pt idx="1890">
                  <c:v>0.8899999999999999</c:v>
                </c:pt>
                <c:pt idx="1891">
                  <c:v>0.89100000000000001</c:v>
                </c:pt>
                <c:pt idx="1892">
                  <c:v>0.8919999999999999</c:v>
                </c:pt>
                <c:pt idx="1893">
                  <c:v>0.89300000000000002</c:v>
                </c:pt>
                <c:pt idx="1894">
                  <c:v>0.89399999999999991</c:v>
                </c:pt>
                <c:pt idx="1895">
                  <c:v>0.89500000000000002</c:v>
                </c:pt>
                <c:pt idx="1896">
                  <c:v>0.89599999999999991</c:v>
                </c:pt>
                <c:pt idx="1897">
                  <c:v>0.89700000000000002</c:v>
                </c:pt>
                <c:pt idx="1898">
                  <c:v>0.89799999999999991</c:v>
                </c:pt>
                <c:pt idx="1899">
                  <c:v>0.89900000000000002</c:v>
                </c:pt>
                <c:pt idx="1900">
                  <c:v>0.89999999999999991</c:v>
                </c:pt>
                <c:pt idx="1901">
                  <c:v>0.90100000000000002</c:v>
                </c:pt>
                <c:pt idx="1902">
                  <c:v>0.90199999999999991</c:v>
                </c:pt>
                <c:pt idx="1903">
                  <c:v>0.90300000000000002</c:v>
                </c:pt>
                <c:pt idx="1904">
                  <c:v>0.90399999999999991</c:v>
                </c:pt>
                <c:pt idx="1905">
                  <c:v>0.90500000000000003</c:v>
                </c:pt>
                <c:pt idx="1906">
                  <c:v>0.90599999999999992</c:v>
                </c:pt>
                <c:pt idx="1907">
                  <c:v>0.90700000000000003</c:v>
                </c:pt>
                <c:pt idx="1908">
                  <c:v>0.90799999999999992</c:v>
                </c:pt>
                <c:pt idx="1909">
                  <c:v>0.90900000000000003</c:v>
                </c:pt>
                <c:pt idx="1910">
                  <c:v>0.90999999999999992</c:v>
                </c:pt>
                <c:pt idx="1911">
                  <c:v>0.91100000000000003</c:v>
                </c:pt>
                <c:pt idx="1912">
                  <c:v>0.91199999999999992</c:v>
                </c:pt>
                <c:pt idx="1913">
                  <c:v>0.91300000000000003</c:v>
                </c:pt>
                <c:pt idx="1914">
                  <c:v>0.91399999999999992</c:v>
                </c:pt>
                <c:pt idx="1915">
                  <c:v>0.91500000000000004</c:v>
                </c:pt>
                <c:pt idx="1916">
                  <c:v>0.91599999999999993</c:v>
                </c:pt>
                <c:pt idx="1917">
                  <c:v>0.91700000000000004</c:v>
                </c:pt>
                <c:pt idx="1918">
                  <c:v>0.91799999999999993</c:v>
                </c:pt>
                <c:pt idx="1919">
                  <c:v>0.91900000000000004</c:v>
                </c:pt>
                <c:pt idx="1920">
                  <c:v>0.91999999999999993</c:v>
                </c:pt>
                <c:pt idx="1921">
                  <c:v>0.92100000000000004</c:v>
                </c:pt>
                <c:pt idx="1922">
                  <c:v>0.92199999999999993</c:v>
                </c:pt>
                <c:pt idx="1923">
                  <c:v>0.92300000000000004</c:v>
                </c:pt>
                <c:pt idx="1924">
                  <c:v>0.92399999999999993</c:v>
                </c:pt>
                <c:pt idx="1925">
                  <c:v>0.92500000000000004</c:v>
                </c:pt>
                <c:pt idx="1926">
                  <c:v>0.92599999999999993</c:v>
                </c:pt>
                <c:pt idx="1927">
                  <c:v>0.92700000000000005</c:v>
                </c:pt>
                <c:pt idx="1928">
                  <c:v>0.92799999999999994</c:v>
                </c:pt>
                <c:pt idx="1929">
                  <c:v>0.92900000000000005</c:v>
                </c:pt>
                <c:pt idx="1930">
                  <c:v>0.92999999999999994</c:v>
                </c:pt>
                <c:pt idx="1931">
                  <c:v>0.93100000000000005</c:v>
                </c:pt>
                <c:pt idx="1932">
                  <c:v>0.93199999999999994</c:v>
                </c:pt>
                <c:pt idx="1933">
                  <c:v>0.93300000000000005</c:v>
                </c:pt>
                <c:pt idx="1934">
                  <c:v>0.93399999999999994</c:v>
                </c:pt>
                <c:pt idx="1935">
                  <c:v>0.93500000000000005</c:v>
                </c:pt>
                <c:pt idx="1936">
                  <c:v>0.93599999999999994</c:v>
                </c:pt>
                <c:pt idx="1937">
                  <c:v>0.93700000000000006</c:v>
                </c:pt>
                <c:pt idx="1938">
                  <c:v>0.93799999999999994</c:v>
                </c:pt>
                <c:pt idx="1939">
                  <c:v>0.93900000000000006</c:v>
                </c:pt>
                <c:pt idx="1940">
                  <c:v>0.94</c:v>
                </c:pt>
                <c:pt idx="1941">
                  <c:v>0.94100000000000006</c:v>
                </c:pt>
                <c:pt idx="1942">
                  <c:v>0.94199999999999995</c:v>
                </c:pt>
                <c:pt idx="1943">
                  <c:v>0.94300000000000006</c:v>
                </c:pt>
                <c:pt idx="1944">
                  <c:v>0.94399999999999995</c:v>
                </c:pt>
                <c:pt idx="1945">
                  <c:v>0.94500000000000006</c:v>
                </c:pt>
                <c:pt idx="1946">
                  <c:v>0.94599999999999995</c:v>
                </c:pt>
                <c:pt idx="1947">
                  <c:v>0.94700000000000006</c:v>
                </c:pt>
                <c:pt idx="1948">
                  <c:v>0.94799999999999995</c:v>
                </c:pt>
                <c:pt idx="1949">
                  <c:v>0.94900000000000007</c:v>
                </c:pt>
                <c:pt idx="1950">
                  <c:v>0.95</c:v>
                </c:pt>
                <c:pt idx="1951">
                  <c:v>0.95100000000000007</c:v>
                </c:pt>
                <c:pt idx="1952">
                  <c:v>0.95199999999999996</c:v>
                </c:pt>
                <c:pt idx="1953">
                  <c:v>0.95300000000000007</c:v>
                </c:pt>
                <c:pt idx="1954">
                  <c:v>0.95399999999999996</c:v>
                </c:pt>
                <c:pt idx="1955">
                  <c:v>0.95500000000000007</c:v>
                </c:pt>
                <c:pt idx="1956">
                  <c:v>0.95599999999999996</c:v>
                </c:pt>
                <c:pt idx="1957">
                  <c:v>0.95700000000000007</c:v>
                </c:pt>
                <c:pt idx="1958">
                  <c:v>0.95799999999999996</c:v>
                </c:pt>
                <c:pt idx="1959">
                  <c:v>0.95900000000000007</c:v>
                </c:pt>
                <c:pt idx="1960">
                  <c:v>0.96</c:v>
                </c:pt>
                <c:pt idx="1961">
                  <c:v>0.96100000000000008</c:v>
                </c:pt>
                <c:pt idx="1962">
                  <c:v>0.96199999999999997</c:v>
                </c:pt>
                <c:pt idx="1963">
                  <c:v>0.96300000000000008</c:v>
                </c:pt>
                <c:pt idx="1964">
                  <c:v>0.96399999999999997</c:v>
                </c:pt>
                <c:pt idx="1965">
                  <c:v>0.96500000000000008</c:v>
                </c:pt>
                <c:pt idx="1966">
                  <c:v>0.96599999999999997</c:v>
                </c:pt>
                <c:pt idx="1967">
                  <c:v>0.96700000000000008</c:v>
                </c:pt>
                <c:pt idx="1968">
                  <c:v>0.96799999999999997</c:v>
                </c:pt>
                <c:pt idx="1969">
                  <c:v>0.96900000000000008</c:v>
                </c:pt>
                <c:pt idx="1970">
                  <c:v>0.97</c:v>
                </c:pt>
                <c:pt idx="1971">
                  <c:v>0.97100000000000009</c:v>
                </c:pt>
                <c:pt idx="1972">
                  <c:v>0.97199999999999998</c:v>
                </c:pt>
                <c:pt idx="1973">
                  <c:v>0.97300000000000009</c:v>
                </c:pt>
                <c:pt idx="1974">
                  <c:v>0.97399999999999998</c:v>
                </c:pt>
                <c:pt idx="1975">
                  <c:v>0.97500000000000009</c:v>
                </c:pt>
                <c:pt idx="1976">
                  <c:v>0.97599999999999998</c:v>
                </c:pt>
                <c:pt idx="1977">
                  <c:v>0.97700000000000009</c:v>
                </c:pt>
                <c:pt idx="1978">
                  <c:v>0.97799999999999998</c:v>
                </c:pt>
                <c:pt idx="1979">
                  <c:v>0.97900000000000009</c:v>
                </c:pt>
                <c:pt idx="1980">
                  <c:v>0.98</c:v>
                </c:pt>
                <c:pt idx="1981">
                  <c:v>0.98100000000000009</c:v>
                </c:pt>
                <c:pt idx="1982">
                  <c:v>0.98199999999999998</c:v>
                </c:pt>
                <c:pt idx="1983">
                  <c:v>0.9830000000000001</c:v>
                </c:pt>
                <c:pt idx="1984">
                  <c:v>0.98399999999999999</c:v>
                </c:pt>
                <c:pt idx="1985">
                  <c:v>0.9850000000000001</c:v>
                </c:pt>
                <c:pt idx="1986">
                  <c:v>0.98599999999999999</c:v>
                </c:pt>
                <c:pt idx="1987">
                  <c:v>0.9870000000000001</c:v>
                </c:pt>
                <c:pt idx="1988">
                  <c:v>0.98799999999999999</c:v>
                </c:pt>
                <c:pt idx="1989">
                  <c:v>0.9890000000000001</c:v>
                </c:pt>
                <c:pt idx="1990">
                  <c:v>0.99</c:v>
                </c:pt>
                <c:pt idx="1991">
                  <c:v>0.9910000000000001</c:v>
                </c:pt>
                <c:pt idx="1992">
                  <c:v>0.99199999999999999</c:v>
                </c:pt>
                <c:pt idx="1993">
                  <c:v>0.9930000000000001</c:v>
                </c:pt>
                <c:pt idx="1994">
                  <c:v>0.99399999999999999</c:v>
                </c:pt>
                <c:pt idx="1995">
                  <c:v>0.99500000000000011</c:v>
                </c:pt>
                <c:pt idx="1996">
                  <c:v>0.996</c:v>
                </c:pt>
                <c:pt idx="1997">
                  <c:v>0.99700000000000011</c:v>
                </c:pt>
                <c:pt idx="1998">
                  <c:v>0.998</c:v>
                </c:pt>
                <c:pt idx="1999">
                  <c:v>0.99900000000000011</c:v>
                </c:pt>
                <c:pt idx="2000">
                  <c:v>1</c:v>
                </c:pt>
                <c:pt idx="2001">
                  <c:v>1.0009999999999999</c:v>
                </c:pt>
                <c:pt idx="2002">
                  <c:v>1.0019999999999998</c:v>
                </c:pt>
                <c:pt idx="2003">
                  <c:v>1.0030000000000001</c:v>
                </c:pt>
                <c:pt idx="2004">
                  <c:v>1.004</c:v>
                </c:pt>
                <c:pt idx="2005">
                  <c:v>1.0049999999999999</c:v>
                </c:pt>
                <c:pt idx="2006">
                  <c:v>1.0059999999999998</c:v>
                </c:pt>
                <c:pt idx="2007">
                  <c:v>1.0070000000000001</c:v>
                </c:pt>
                <c:pt idx="2008">
                  <c:v>1.008</c:v>
                </c:pt>
                <c:pt idx="2009">
                  <c:v>1.0089999999999999</c:v>
                </c:pt>
                <c:pt idx="2010">
                  <c:v>1.0099999999999998</c:v>
                </c:pt>
                <c:pt idx="2011">
                  <c:v>1.0110000000000001</c:v>
                </c:pt>
                <c:pt idx="2012">
                  <c:v>1.012</c:v>
                </c:pt>
                <c:pt idx="2013">
                  <c:v>1.0129999999999999</c:v>
                </c:pt>
                <c:pt idx="2014">
                  <c:v>1.0139999999999998</c:v>
                </c:pt>
                <c:pt idx="2015">
                  <c:v>1.0150000000000001</c:v>
                </c:pt>
                <c:pt idx="2016">
                  <c:v>1.016</c:v>
                </c:pt>
                <c:pt idx="2017">
                  <c:v>1.0169999999999999</c:v>
                </c:pt>
                <c:pt idx="2018">
                  <c:v>1.0179999999999998</c:v>
                </c:pt>
                <c:pt idx="2019">
                  <c:v>1.0190000000000001</c:v>
                </c:pt>
                <c:pt idx="2020">
                  <c:v>1.02</c:v>
                </c:pt>
                <c:pt idx="2021">
                  <c:v>1.0209999999999999</c:v>
                </c:pt>
                <c:pt idx="2022">
                  <c:v>1.0219999999999998</c:v>
                </c:pt>
                <c:pt idx="2023">
                  <c:v>1.0230000000000001</c:v>
                </c:pt>
                <c:pt idx="2024">
                  <c:v>1.024</c:v>
                </c:pt>
                <c:pt idx="2025">
                  <c:v>1.0249999999999999</c:v>
                </c:pt>
                <c:pt idx="2026">
                  <c:v>1.0259999999999998</c:v>
                </c:pt>
                <c:pt idx="2027">
                  <c:v>1.0270000000000001</c:v>
                </c:pt>
                <c:pt idx="2028">
                  <c:v>1.028</c:v>
                </c:pt>
                <c:pt idx="2029">
                  <c:v>1.0289999999999999</c:v>
                </c:pt>
                <c:pt idx="2030">
                  <c:v>1.0299999999999998</c:v>
                </c:pt>
                <c:pt idx="2031">
                  <c:v>1.0310000000000001</c:v>
                </c:pt>
                <c:pt idx="2032">
                  <c:v>1.032</c:v>
                </c:pt>
                <c:pt idx="2033">
                  <c:v>1.0329999999999999</c:v>
                </c:pt>
                <c:pt idx="2034">
                  <c:v>1.0339999999999998</c:v>
                </c:pt>
                <c:pt idx="2035">
                  <c:v>1.0350000000000001</c:v>
                </c:pt>
                <c:pt idx="2036">
                  <c:v>1.036</c:v>
                </c:pt>
                <c:pt idx="2037">
                  <c:v>1.0369999999999999</c:v>
                </c:pt>
                <c:pt idx="2038">
                  <c:v>1.0379999999999998</c:v>
                </c:pt>
                <c:pt idx="2039">
                  <c:v>1.0390000000000001</c:v>
                </c:pt>
                <c:pt idx="2040">
                  <c:v>1.04</c:v>
                </c:pt>
                <c:pt idx="2041">
                  <c:v>1.0409999999999999</c:v>
                </c:pt>
                <c:pt idx="2042">
                  <c:v>1.0419999999999998</c:v>
                </c:pt>
                <c:pt idx="2043">
                  <c:v>1.0430000000000001</c:v>
                </c:pt>
                <c:pt idx="2044">
                  <c:v>1.044</c:v>
                </c:pt>
                <c:pt idx="2045">
                  <c:v>1.0449999999999999</c:v>
                </c:pt>
                <c:pt idx="2046">
                  <c:v>1.0459999999999998</c:v>
                </c:pt>
                <c:pt idx="2047">
                  <c:v>1.0470000000000002</c:v>
                </c:pt>
                <c:pt idx="2048">
                  <c:v>1.048</c:v>
                </c:pt>
                <c:pt idx="2049">
                  <c:v>1.0489999999999999</c:v>
                </c:pt>
                <c:pt idx="2050">
                  <c:v>1.0499999999999998</c:v>
                </c:pt>
                <c:pt idx="2051">
                  <c:v>1.0510000000000002</c:v>
                </c:pt>
                <c:pt idx="2052">
                  <c:v>1.052</c:v>
                </c:pt>
                <c:pt idx="2053">
                  <c:v>1.0529999999999999</c:v>
                </c:pt>
                <c:pt idx="2054">
                  <c:v>1.0539999999999998</c:v>
                </c:pt>
                <c:pt idx="2055">
                  <c:v>1.0550000000000002</c:v>
                </c:pt>
                <c:pt idx="2056">
                  <c:v>1.056</c:v>
                </c:pt>
                <c:pt idx="2057">
                  <c:v>1.0569999999999999</c:v>
                </c:pt>
                <c:pt idx="2058">
                  <c:v>1.0579999999999998</c:v>
                </c:pt>
                <c:pt idx="2059">
                  <c:v>1.0590000000000002</c:v>
                </c:pt>
                <c:pt idx="2060">
                  <c:v>1.06</c:v>
                </c:pt>
                <c:pt idx="2061">
                  <c:v>1.0609999999999999</c:v>
                </c:pt>
                <c:pt idx="2062">
                  <c:v>1.0619999999999998</c:v>
                </c:pt>
                <c:pt idx="2063">
                  <c:v>1.0630000000000002</c:v>
                </c:pt>
                <c:pt idx="2064">
                  <c:v>1.0640000000000001</c:v>
                </c:pt>
                <c:pt idx="2065">
                  <c:v>1.0649999999999999</c:v>
                </c:pt>
                <c:pt idx="2066">
                  <c:v>1.0659999999999998</c:v>
                </c:pt>
                <c:pt idx="2067">
                  <c:v>1.0670000000000002</c:v>
                </c:pt>
                <c:pt idx="2068">
                  <c:v>1.0680000000000001</c:v>
                </c:pt>
                <c:pt idx="2069">
                  <c:v>1.069</c:v>
                </c:pt>
                <c:pt idx="2070">
                  <c:v>1.0699999999999998</c:v>
                </c:pt>
                <c:pt idx="2071">
                  <c:v>1.0710000000000002</c:v>
                </c:pt>
                <c:pt idx="2072">
                  <c:v>1.0720000000000001</c:v>
                </c:pt>
                <c:pt idx="2073">
                  <c:v>1.073</c:v>
                </c:pt>
                <c:pt idx="2074">
                  <c:v>1.0739999999999998</c:v>
                </c:pt>
                <c:pt idx="2075">
                  <c:v>1.0750000000000002</c:v>
                </c:pt>
                <c:pt idx="2076">
                  <c:v>1.0760000000000001</c:v>
                </c:pt>
                <c:pt idx="2077">
                  <c:v>1.077</c:v>
                </c:pt>
                <c:pt idx="2078">
                  <c:v>1.0779999999999998</c:v>
                </c:pt>
                <c:pt idx="2079">
                  <c:v>1.0790000000000002</c:v>
                </c:pt>
                <c:pt idx="2080">
                  <c:v>1.08</c:v>
                </c:pt>
                <c:pt idx="2081">
                  <c:v>1.081</c:v>
                </c:pt>
                <c:pt idx="2082">
                  <c:v>1.0819999999999999</c:v>
                </c:pt>
                <c:pt idx="2083">
                  <c:v>1.0830000000000002</c:v>
                </c:pt>
                <c:pt idx="2084">
                  <c:v>1.0840000000000001</c:v>
                </c:pt>
                <c:pt idx="2085">
                  <c:v>1.085</c:v>
                </c:pt>
                <c:pt idx="2086">
                  <c:v>1.0859999999999999</c:v>
                </c:pt>
                <c:pt idx="2087">
                  <c:v>1.0870000000000002</c:v>
                </c:pt>
                <c:pt idx="2088">
                  <c:v>1.0880000000000001</c:v>
                </c:pt>
                <c:pt idx="2089">
                  <c:v>1.089</c:v>
                </c:pt>
                <c:pt idx="2090">
                  <c:v>1.0899999999999999</c:v>
                </c:pt>
                <c:pt idx="2091">
                  <c:v>1.0910000000000002</c:v>
                </c:pt>
                <c:pt idx="2092">
                  <c:v>1.0920000000000001</c:v>
                </c:pt>
                <c:pt idx="2093">
                  <c:v>1.093</c:v>
                </c:pt>
                <c:pt idx="2094">
                  <c:v>1.0939999999999999</c:v>
                </c:pt>
                <c:pt idx="2095">
                  <c:v>1.0950000000000002</c:v>
                </c:pt>
                <c:pt idx="2096">
                  <c:v>1.0960000000000001</c:v>
                </c:pt>
                <c:pt idx="2097">
                  <c:v>1.097</c:v>
                </c:pt>
                <c:pt idx="2098">
                  <c:v>1.0979999999999999</c:v>
                </c:pt>
                <c:pt idx="2099">
                  <c:v>1.0990000000000002</c:v>
                </c:pt>
                <c:pt idx="2100">
                  <c:v>1.1000000000000001</c:v>
                </c:pt>
                <c:pt idx="2101">
                  <c:v>1.101</c:v>
                </c:pt>
                <c:pt idx="2102">
                  <c:v>1.1019999999999999</c:v>
                </c:pt>
                <c:pt idx="2103">
                  <c:v>1.1030000000000002</c:v>
                </c:pt>
                <c:pt idx="2104">
                  <c:v>1.1040000000000001</c:v>
                </c:pt>
                <c:pt idx="2105">
                  <c:v>1.105</c:v>
                </c:pt>
                <c:pt idx="2106">
                  <c:v>1.1059999999999999</c:v>
                </c:pt>
                <c:pt idx="2107">
                  <c:v>1.1070000000000002</c:v>
                </c:pt>
                <c:pt idx="2108">
                  <c:v>1.1080000000000001</c:v>
                </c:pt>
                <c:pt idx="2109">
                  <c:v>1.109</c:v>
                </c:pt>
                <c:pt idx="2110">
                  <c:v>1.1099999999999999</c:v>
                </c:pt>
                <c:pt idx="2111">
                  <c:v>1.1110000000000002</c:v>
                </c:pt>
                <c:pt idx="2112">
                  <c:v>1.1120000000000001</c:v>
                </c:pt>
                <c:pt idx="2113">
                  <c:v>1.113</c:v>
                </c:pt>
                <c:pt idx="2114">
                  <c:v>1.1139999999999999</c:v>
                </c:pt>
                <c:pt idx="2115">
                  <c:v>1.1150000000000002</c:v>
                </c:pt>
                <c:pt idx="2116">
                  <c:v>1.1160000000000001</c:v>
                </c:pt>
                <c:pt idx="2117">
                  <c:v>1.117</c:v>
                </c:pt>
                <c:pt idx="2118">
                  <c:v>1.1179999999999999</c:v>
                </c:pt>
                <c:pt idx="2119">
                  <c:v>1.1190000000000002</c:v>
                </c:pt>
                <c:pt idx="2120">
                  <c:v>1.1200000000000001</c:v>
                </c:pt>
                <c:pt idx="2121">
                  <c:v>1.121</c:v>
                </c:pt>
                <c:pt idx="2122">
                  <c:v>1.1219999999999999</c:v>
                </c:pt>
                <c:pt idx="2123">
                  <c:v>1.1230000000000002</c:v>
                </c:pt>
                <c:pt idx="2124">
                  <c:v>1.1240000000000001</c:v>
                </c:pt>
                <c:pt idx="2125">
                  <c:v>1.125</c:v>
                </c:pt>
                <c:pt idx="2126">
                  <c:v>1.1259999999999999</c:v>
                </c:pt>
                <c:pt idx="2127">
                  <c:v>1.1269999999999998</c:v>
                </c:pt>
                <c:pt idx="2128">
                  <c:v>1.1280000000000001</c:v>
                </c:pt>
                <c:pt idx="2129">
                  <c:v>1.129</c:v>
                </c:pt>
                <c:pt idx="2130">
                  <c:v>1.1299999999999999</c:v>
                </c:pt>
                <c:pt idx="2131">
                  <c:v>1.1309999999999998</c:v>
                </c:pt>
                <c:pt idx="2132">
                  <c:v>1.1320000000000001</c:v>
                </c:pt>
                <c:pt idx="2133">
                  <c:v>1.133</c:v>
                </c:pt>
                <c:pt idx="2134">
                  <c:v>1.1339999999999999</c:v>
                </c:pt>
                <c:pt idx="2135">
                  <c:v>1.1349999999999998</c:v>
                </c:pt>
                <c:pt idx="2136">
                  <c:v>1.1360000000000001</c:v>
                </c:pt>
                <c:pt idx="2137">
                  <c:v>1.137</c:v>
                </c:pt>
                <c:pt idx="2138">
                  <c:v>1.1379999999999999</c:v>
                </c:pt>
                <c:pt idx="2139">
                  <c:v>1.1389999999999998</c:v>
                </c:pt>
                <c:pt idx="2140">
                  <c:v>1.1400000000000001</c:v>
                </c:pt>
                <c:pt idx="2141">
                  <c:v>1.141</c:v>
                </c:pt>
                <c:pt idx="2142">
                  <c:v>1.1419999999999999</c:v>
                </c:pt>
                <c:pt idx="2143">
                  <c:v>1.1429999999999998</c:v>
                </c:pt>
                <c:pt idx="2144">
                  <c:v>1.1440000000000001</c:v>
                </c:pt>
                <c:pt idx="2145">
                  <c:v>1.145</c:v>
                </c:pt>
                <c:pt idx="2146">
                  <c:v>1.1459999999999999</c:v>
                </c:pt>
                <c:pt idx="2147">
                  <c:v>1.1469999999999998</c:v>
                </c:pt>
                <c:pt idx="2148">
                  <c:v>1.1480000000000001</c:v>
                </c:pt>
                <c:pt idx="2149">
                  <c:v>1.149</c:v>
                </c:pt>
                <c:pt idx="2150">
                  <c:v>1.1499999999999999</c:v>
                </c:pt>
                <c:pt idx="2151">
                  <c:v>1.1509999999999998</c:v>
                </c:pt>
                <c:pt idx="2152">
                  <c:v>1.1520000000000001</c:v>
                </c:pt>
                <c:pt idx="2153">
                  <c:v>1.153</c:v>
                </c:pt>
                <c:pt idx="2154">
                  <c:v>1.1539999999999999</c:v>
                </c:pt>
                <c:pt idx="2155">
                  <c:v>1.1549999999999998</c:v>
                </c:pt>
                <c:pt idx="2156">
                  <c:v>1.1560000000000001</c:v>
                </c:pt>
                <c:pt idx="2157">
                  <c:v>1.157</c:v>
                </c:pt>
                <c:pt idx="2158">
                  <c:v>1.1579999999999999</c:v>
                </c:pt>
                <c:pt idx="2159">
                  <c:v>1.1589999999999998</c:v>
                </c:pt>
                <c:pt idx="2160">
                  <c:v>1.1600000000000001</c:v>
                </c:pt>
                <c:pt idx="2161">
                  <c:v>1.161</c:v>
                </c:pt>
                <c:pt idx="2162">
                  <c:v>1.1619999999999999</c:v>
                </c:pt>
                <c:pt idx="2163">
                  <c:v>1.1629999999999998</c:v>
                </c:pt>
                <c:pt idx="2164">
                  <c:v>1.1640000000000001</c:v>
                </c:pt>
                <c:pt idx="2165">
                  <c:v>1.165</c:v>
                </c:pt>
                <c:pt idx="2166">
                  <c:v>1.1659999999999999</c:v>
                </c:pt>
                <c:pt idx="2167">
                  <c:v>1.1669999999999998</c:v>
                </c:pt>
                <c:pt idx="2168">
                  <c:v>1.1680000000000001</c:v>
                </c:pt>
                <c:pt idx="2169">
                  <c:v>1.169</c:v>
                </c:pt>
                <c:pt idx="2170">
                  <c:v>1.17</c:v>
                </c:pt>
                <c:pt idx="2171">
                  <c:v>1.1709999999999998</c:v>
                </c:pt>
                <c:pt idx="2172">
                  <c:v>1.1720000000000002</c:v>
                </c:pt>
                <c:pt idx="2173">
                  <c:v>1.173</c:v>
                </c:pt>
                <c:pt idx="2174">
                  <c:v>1.1739999999999999</c:v>
                </c:pt>
                <c:pt idx="2175">
                  <c:v>1.1749999999999998</c:v>
                </c:pt>
                <c:pt idx="2176">
                  <c:v>1.1760000000000002</c:v>
                </c:pt>
                <c:pt idx="2177">
                  <c:v>1.177</c:v>
                </c:pt>
                <c:pt idx="2178">
                  <c:v>1.1779999999999999</c:v>
                </c:pt>
                <c:pt idx="2179">
                  <c:v>1.1789999999999998</c:v>
                </c:pt>
                <c:pt idx="2180">
                  <c:v>1.1800000000000002</c:v>
                </c:pt>
                <c:pt idx="2181">
                  <c:v>1.181</c:v>
                </c:pt>
                <c:pt idx="2182">
                  <c:v>1.1819999999999999</c:v>
                </c:pt>
                <c:pt idx="2183">
                  <c:v>1.1829999999999998</c:v>
                </c:pt>
                <c:pt idx="2184">
                  <c:v>1.1840000000000002</c:v>
                </c:pt>
                <c:pt idx="2185">
                  <c:v>1.1850000000000001</c:v>
                </c:pt>
                <c:pt idx="2186">
                  <c:v>1.1859999999999999</c:v>
                </c:pt>
                <c:pt idx="2187">
                  <c:v>1.1869999999999998</c:v>
                </c:pt>
                <c:pt idx="2188">
                  <c:v>1.1880000000000002</c:v>
                </c:pt>
                <c:pt idx="2189">
                  <c:v>1.1890000000000001</c:v>
                </c:pt>
                <c:pt idx="2190">
                  <c:v>1.19</c:v>
                </c:pt>
                <c:pt idx="2191">
                  <c:v>1.1909999999999998</c:v>
                </c:pt>
                <c:pt idx="2192">
                  <c:v>1.1920000000000002</c:v>
                </c:pt>
                <c:pt idx="2193">
                  <c:v>1.1930000000000001</c:v>
                </c:pt>
                <c:pt idx="2194">
                  <c:v>1.194</c:v>
                </c:pt>
                <c:pt idx="2195">
                  <c:v>1.1949999999999998</c:v>
                </c:pt>
                <c:pt idx="2196">
                  <c:v>1.1960000000000002</c:v>
                </c:pt>
                <c:pt idx="2197">
                  <c:v>1.1970000000000001</c:v>
                </c:pt>
                <c:pt idx="2198">
                  <c:v>1.198</c:v>
                </c:pt>
                <c:pt idx="2199">
                  <c:v>1.1989999999999998</c:v>
                </c:pt>
                <c:pt idx="2200">
                  <c:v>1.2000000000000002</c:v>
                </c:pt>
                <c:pt idx="2201">
                  <c:v>1.2010000000000001</c:v>
                </c:pt>
                <c:pt idx="2202">
                  <c:v>1.202</c:v>
                </c:pt>
                <c:pt idx="2203">
                  <c:v>1.2029999999999998</c:v>
                </c:pt>
                <c:pt idx="2204">
                  <c:v>1.2040000000000002</c:v>
                </c:pt>
                <c:pt idx="2205">
                  <c:v>1.2050000000000001</c:v>
                </c:pt>
                <c:pt idx="2206">
                  <c:v>1.206</c:v>
                </c:pt>
                <c:pt idx="2207">
                  <c:v>1.2069999999999999</c:v>
                </c:pt>
                <c:pt idx="2208">
                  <c:v>1.2080000000000002</c:v>
                </c:pt>
                <c:pt idx="2209">
                  <c:v>1.2090000000000001</c:v>
                </c:pt>
                <c:pt idx="2210">
                  <c:v>1.21</c:v>
                </c:pt>
                <c:pt idx="2211">
                  <c:v>1.2109999999999999</c:v>
                </c:pt>
                <c:pt idx="2212">
                  <c:v>1.2120000000000002</c:v>
                </c:pt>
                <c:pt idx="2213">
                  <c:v>1.2130000000000001</c:v>
                </c:pt>
                <c:pt idx="2214">
                  <c:v>1.214</c:v>
                </c:pt>
                <c:pt idx="2215">
                  <c:v>1.2149999999999999</c:v>
                </c:pt>
                <c:pt idx="2216">
                  <c:v>1.2160000000000002</c:v>
                </c:pt>
                <c:pt idx="2217">
                  <c:v>1.2170000000000001</c:v>
                </c:pt>
                <c:pt idx="2218">
                  <c:v>1.218</c:v>
                </c:pt>
                <c:pt idx="2219">
                  <c:v>1.2189999999999999</c:v>
                </c:pt>
                <c:pt idx="2220">
                  <c:v>1.2200000000000002</c:v>
                </c:pt>
                <c:pt idx="2221">
                  <c:v>1.2210000000000001</c:v>
                </c:pt>
                <c:pt idx="2222">
                  <c:v>1.222</c:v>
                </c:pt>
                <c:pt idx="2223">
                  <c:v>1.2229999999999999</c:v>
                </c:pt>
                <c:pt idx="2224">
                  <c:v>1.2240000000000002</c:v>
                </c:pt>
                <c:pt idx="2225">
                  <c:v>1.2250000000000001</c:v>
                </c:pt>
                <c:pt idx="2226">
                  <c:v>1.226</c:v>
                </c:pt>
                <c:pt idx="2227">
                  <c:v>1.2269999999999999</c:v>
                </c:pt>
                <c:pt idx="2228">
                  <c:v>1.2280000000000002</c:v>
                </c:pt>
                <c:pt idx="2229">
                  <c:v>1.2290000000000001</c:v>
                </c:pt>
                <c:pt idx="2230">
                  <c:v>1.23</c:v>
                </c:pt>
                <c:pt idx="2231">
                  <c:v>1.2309999999999999</c:v>
                </c:pt>
                <c:pt idx="2232">
                  <c:v>1.2320000000000002</c:v>
                </c:pt>
                <c:pt idx="2233">
                  <c:v>1.2330000000000001</c:v>
                </c:pt>
                <c:pt idx="2234">
                  <c:v>1.234</c:v>
                </c:pt>
                <c:pt idx="2235">
                  <c:v>1.2349999999999999</c:v>
                </c:pt>
                <c:pt idx="2236">
                  <c:v>1.2360000000000002</c:v>
                </c:pt>
                <c:pt idx="2237">
                  <c:v>1.2370000000000001</c:v>
                </c:pt>
                <c:pt idx="2238">
                  <c:v>1.238</c:v>
                </c:pt>
                <c:pt idx="2239">
                  <c:v>1.2389999999999999</c:v>
                </c:pt>
                <c:pt idx="2240">
                  <c:v>1.2400000000000002</c:v>
                </c:pt>
                <c:pt idx="2241">
                  <c:v>1.2410000000000001</c:v>
                </c:pt>
                <c:pt idx="2242">
                  <c:v>1.242</c:v>
                </c:pt>
                <c:pt idx="2243">
                  <c:v>1.2429999999999999</c:v>
                </c:pt>
                <c:pt idx="2244">
                  <c:v>1.2440000000000002</c:v>
                </c:pt>
                <c:pt idx="2245">
                  <c:v>1.2450000000000001</c:v>
                </c:pt>
                <c:pt idx="2246">
                  <c:v>1.246</c:v>
                </c:pt>
                <c:pt idx="2247">
                  <c:v>1.2469999999999999</c:v>
                </c:pt>
                <c:pt idx="2248">
                  <c:v>1.2480000000000002</c:v>
                </c:pt>
                <c:pt idx="2249">
                  <c:v>1.2490000000000001</c:v>
                </c:pt>
                <c:pt idx="2250">
                  <c:v>1.25</c:v>
                </c:pt>
                <c:pt idx="2251">
                  <c:v>1.2509999999999999</c:v>
                </c:pt>
                <c:pt idx="2252">
                  <c:v>1.2519999999999998</c:v>
                </c:pt>
                <c:pt idx="2253">
                  <c:v>1.2530000000000001</c:v>
                </c:pt>
                <c:pt idx="2254">
                  <c:v>1.254</c:v>
                </c:pt>
                <c:pt idx="2255">
                  <c:v>1.2549999999999999</c:v>
                </c:pt>
                <c:pt idx="2256">
                  <c:v>1.2559999999999998</c:v>
                </c:pt>
                <c:pt idx="2257">
                  <c:v>1.2570000000000001</c:v>
                </c:pt>
                <c:pt idx="2258">
                  <c:v>1.258</c:v>
                </c:pt>
                <c:pt idx="2259">
                  <c:v>1.2589999999999999</c:v>
                </c:pt>
                <c:pt idx="2260">
                  <c:v>1.2599999999999998</c:v>
                </c:pt>
                <c:pt idx="2261">
                  <c:v>1.2610000000000001</c:v>
                </c:pt>
                <c:pt idx="2262">
                  <c:v>1.262</c:v>
                </c:pt>
                <c:pt idx="2263">
                  <c:v>1.2629999999999999</c:v>
                </c:pt>
                <c:pt idx="2264">
                  <c:v>1.2639999999999998</c:v>
                </c:pt>
                <c:pt idx="2265">
                  <c:v>1.2650000000000001</c:v>
                </c:pt>
                <c:pt idx="2266">
                  <c:v>1.266</c:v>
                </c:pt>
                <c:pt idx="2267">
                  <c:v>1.2669999999999999</c:v>
                </c:pt>
                <c:pt idx="2268">
                  <c:v>1.2679999999999998</c:v>
                </c:pt>
                <c:pt idx="2269">
                  <c:v>1.2690000000000001</c:v>
                </c:pt>
                <c:pt idx="2270">
                  <c:v>1.27</c:v>
                </c:pt>
                <c:pt idx="2271">
                  <c:v>1.2709999999999999</c:v>
                </c:pt>
                <c:pt idx="2272">
                  <c:v>1.2719999999999998</c:v>
                </c:pt>
                <c:pt idx="2273">
                  <c:v>1.2730000000000001</c:v>
                </c:pt>
                <c:pt idx="2274">
                  <c:v>1.274</c:v>
                </c:pt>
                <c:pt idx="2275">
                  <c:v>1.2749999999999999</c:v>
                </c:pt>
                <c:pt idx="2276">
                  <c:v>1.2759999999999998</c:v>
                </c:pt>
                <c:pt idx="2277">
                  <c:v>1.2770000000000001</c:v>
                </c:pt>
                <c:pt idx="2278">
                  <c:v>1.278</c:v>
                </c:pt>
                <c:pt idx="2279">
                  <c:v>1.2789999999999999</c:v>
                </c:pt>
                <c:pt idx="2280">
                  <c:v>1.2799999999999998</c:v>
                </c:pt>
                <c:pt idx="2281">
                  <c:v>1.2810000000000001</c:v>
                </c:pt>
                <c:pt idx="2282">
                  <c:v>1.282</c:v>
                </c:pt>
                <c:pt idx="2283">
                  <c:v>1.2829999999999999</c:v>
                </c:pt>
                <c:pt idx="2284">
                  <c:v>1.2839999999999998</c:v>
                </c:pt>
                <c:pt idx="2285">
                  <c:v>1.2850000000000001</c:v>
                </c:pt>
                <c:pt idx="2286">
                  <c:v>1.286</c:v>
                </c:pt>
                <c:pt idx="2287">
                  <c:v>1.2869999999999999</c:v>
                </c:pt>
                <c:pt idx="2288">
                  <c:v>1.2879999999999998</c:v>
                </c:pt>
                <c:pt idx="2289">
                  <c:v>1.2890000000000001</c:v>
                </c:pt>
                <c:pt idx="2290">
                  <c:v>1.29</c:v>
                </c:pt>
                <c:pt idx="2291">
                  <c:v>1.2909999999999999</c:v>
                </c:pt>
                <c:pt idx="2292">
                  <c:v>1.2919999999999998</c:v>
                </c:pt>
                <c:pt idx="2293">
                  <c:v>1.2930000000000001</c:v>
                </c:pt>
                <c:pt idx="2294">
                  <c:v>1.294</c:v>
                </c:pt>
                <c:pt idx="2295">
                  <c:v>1.2949999999999999</c:v>
                </c:pt>
                <c:pt idx="2296">
                  <c:v>1.2959999999999998</c:v>
                </c:pt>
                <c:pt idx="2297">
                  <c:v>1.2970000000000002</c:v>
                </c:pt>
                <c:pt idx="2298">
                  <c:v>1.298</c:v>
                </c:pt>
                <c:pt idx="2299">
                  <c:v>1.2989999999999999</c:v>
                </c:pt>
                <c:pt idx="2300">
                  <c:v>1.2999999999999998</c:v>
                </c:pt>
                <c:pt idx="2301">
                  <c:v>1.3010000000000002</c:v>
                </c:pt>
                <c:pt idx="2302">
                  <c:v>1.302</c:v>
                </c:pt>
                <c:pt idx="2303">
                  <c:v>1.3029999999999999</c:v>
                </c:pt>
                <c:pt idx="2304">
                  <c:v>1.3039999999999998</c:v>
                </c:pt>
                <c:pt idx="2305">
                  <c:v>1.3050000000000002</c:v>
                </c:pt>
                <c:pt idx="2306">
                  <c:v>1.306</c:v>
                </c:pt>
                <c:pt idx="2307">
                  <c:v>1.3069999999999999</c:v>
                </c:pt>
                <c:pt idx="2308">
                  <c:v>1.3079999999999998</c:v>
                </c:pt>
                <c:pt idx="2309">
                  <c:v>1.3090000000000002</c:v>
                </c:pt>
                <c:pt idx="2310">
                  <c:v>1.31</c:v>
                </c:pt>
                <c:pt idx="2311">
                  <c:v>1.3109999999999999</c:v>
                </c:pt>
                <c:pt idx="2312">
                  <c:v>1.3119999999999998</c:v>
                </c:pt>
                <c:pt idx="2313">
                  <c:v>1.3130000000000002</c:v>
                </c:pt>
                <c:pt idx="2314">
                  <c:v>1.3140000000000001</c:v>
                </c:pt>
                <c:pt idx="2315">
                  <c:v>1.3149999999999999</c:v>
                </c:pt>
                <c:pt idx="2316">
                  <c:v>1.3159999999999998</c:v>
                </c:pt>
                <c:pt idx="2317">
                  <c:v>1.3170000000000002</c:v>
                </c:pt>
                <c:pt idx="2318">
                  <c:v>1.3180000000000001</c:v>
                </c:pt>
                <c:pt idx="2319">
                  <c:v>1.319</c:v>
                </c:pt>
                <c:pt idx="2320">
                  <c:v>1.3199999999999998</c:v>
                </c:pt>
                <c:pt idx="2321">
                  <c:v>1.3210000000000002</c:v>
                </c:pt>
                <c:pt idx="2322">
                  <c:v>1.3220000000000001</c:v>
                </c:pt>
                <c:pt idx="2323">
                  <c:v>1.323</c:v>
                </c:pt>
                <c:pt idx="2324">
                  <c:v>1.3239999999999998</c:v>
                </c:pt>
                <c:pt idx="2325">
                  <c:v>1.3250000000000002</c:v>
                </c:pt>
                <c:pt idx="2326">
                  <c:v>1.3260000000000001</c:v>
                </c:pt>
                <c:pt idx="2327">
                  <c:v>1.327</c:v>
                </c:pt>
                <c:pt idx="2328">
                  <c:v>1.3279999999999998</c:v>
                </c:pt>
                <c:pt idx="2329">
                  <c:v>1.3290000000000002</c:v>
                </c:pt>
                <c:pt idx="2330">
                  <c:v>1.33</c:v>
                </c:pt>
                <c:pt idx="2331">
                  <c:v>1.331</c:v>
                </c:pt>
                <c:pt idx="2332">
                  <c:v>1.3319999999999999</c:v>
                </c:pt>
                <c:pt idx="2333">
                  <c:v>1.3330000000000002</c:v>
                </c:pt>
                <c:pt idx="2334">
                  <c:v>1.3340000000000001</c:v>
                </c:pt>
                <c:pt idx="2335">
                  <c:v>1.335</c:v>
                </c:pt>
                <c:pt idx="2336">
                  <c:v>1.3359999999999999</c:v>
                </c:pt>
                <c:pt idx="2337">
                  <c:v>1.3370000000000002</c:v>
                </c:pt>
                <c:pt idx="2338">
                  <c:v>1.3380000000000001</c:v>
                </c:pt>
                <c:pt idx="2339">
                  <c:v>1.339</c:v>
                </c:pt>
                <c:pt idx="2340">
                  <c:v>1.3399999999999999</c:v>
                </c:pt>
                <c:pt idx="2341">
                  <c:v>1.3410000000000002</c:v>
                </c:pt>
                <c:pt idx="2342">
                  <c:v>1.3420000000000001</c:v>
                </c:pt>
                <c:pt idx="2343">
                  <c:v>1.343</c:v>
                </c:pt>
                <c:pt idx="2344">
                  <c:v>1.3439999999999999</c:v>
                </c:pt>
                <c:pt idx="2345">
                  <c:v>1.3450000000000002</c:v>
                </c:pt>
                <c:pt idx="2346">
                  <c:v>1.3460000000000001</c:v>
                </c:pt>
                <c:pt idx="2347">
                  <c:v>1.347</c:v>
                </c:pt>
                <c:pt idx="2348">
                  <c:v>1.3479999999999999</c:v>
                </c:pt>
                <c:pt idx="2349">
                  <c:v>1.3490000000000002</c:v>
                </c:pt>
                <c:pt idx="2350">
                  <c:v>1.35</c:v>
                </c:pt>
                <c:pt idx="2351">
                  <c:v>1.351</c:v>
                </c:pt>
                <c:pt idx="2352">
                  <c:v>1.3519999999999999</c:v>
                </c:pt>
                <c:pt idx="2353">
                  <c:v>1.3530000000000002</c:v>
                </c:pt>
                <c:pt idx="2354">
                  <c:v>1.3540000000000001</c:v>
                </c:pt>
                <c:pt idx="2355">
                  <c:v>1.355</c:v>
                </c:pt>
                <c:pt idx="2356">
                  <c:v>1.3559999999999999</c:v>
                </c:pt>
                <c:pt idx="2357">
                  <c:v>1.3570000000000002</c:v>
                </c:pt>
                <c:pt idx="2358">
                  <c:v>1.3580000000000001</c:v>
                </c:pt>
                <c:pt idx="2359">
                  <c:v>1.359</c:v>
                </c:pt>
                <c:pt idx="2360">
                  <c:v>1.3599999999999999</c:v>
                </c:pt>
                <c:pt idx="2361">
                  <c:v>1.3610000000000002</c:v>
                </c:pt>
                <c:pt idx="2362">
                  <c:v>1.3620000000000001</c:v>
                </c:pt>
                <c:pt idx="2363">
                  <c:v>1.363</c:v>
                </c:pt>
                <c:pt idx="2364">
                  <c:v>1.3639999999999999</c:v>
                </c:pt>
                <c:pt idx="2365">
                  <c:v>1.3650000000000002</c:v>
                </c:pt>
                <c:pt idx="2366">
                  <c:v>1.3660000000000001</c:v>
                </c:pt>
                <c:pt idx="2367">
                  <c:v>1.367</c:v>
                </c:pt>
                <c:pt idx="2368">
                  <c:v>1.3679999999999999</c:v>
                </c:pt>
                <c:pt idx="2369">
                  <c:v>1.3690000000000002</c:v>
                </c:pt>
                <c:pt idx="2370">
                  <c:v>1.37</c:v>
                </c:pt>
                <c:pt idx="2371">
                  <c:v>1.371</c:v>
                </c:pt>
                <c:pt idx="2372">
                  <c:v>1.3719999999999999</c:v>
                </c:pt>
                <c:pt idx="2373">
                  <c:v>1.3730000000000002</c:v>
                </c:pt>
                <c:pt idx="2374">
                  <c:v>1.3740000000000001</c:v>
                </c:pt>
                <c:pt idx="2375">
                  <c:v>1.375</c:v>
                </c:pt>
                <c:pt idx="2376">
                  <c:v>1.3759999999999999</c:v>
                </c:pt>
                <c:pt idx="2377">
                  <c:v>1.3769999999999998</c:v>
                </c:pt>
                <c:pt idx="2378">
                  <c:v>1.3780000000000001</c:v>
                </c:pt>
                <c:pt idx="2379">
                  <c:v>1.379</c:v>
                </c:pt>
                <c:pt idx="2380">
                  <c:v>1.38</c:v>
                </c:pt>
                <c:pt idx="2381">
                  <c:v>1.3809999999999998</c:v>
                </c:pt>
                <c:pt idx="2382">
                  <c:v>1.3820000000000001</c:v>
                </c:pt>
                <c:pt idx="2383">
                  <c:v>1.383</c:v>
                </c:pt>
                <c:pt idx="2384">
                  <c:v>1.3839999999999999</c:v>
                </c:pt>
                <c:pt idx="2385">
                  <c:v>1.3849999999999998</c:v>
                </c:pt>
                <c:pt idx="2386">
                  <c:v>1.3860000000000001</c:v>
                </c:pt>
                <c:pt idx="2387">
                  <c:v>1.387</c:v>
                </c:pt>
                <c:pt idx="2388">
                  <c:v>1.3879999999999999</c:v>
                </c:pt>
                <c:pt idx="2389">
                  <c:v>1.3889999999999998</c:v>
                </c:pt>
                <c:pt idx="2390">
                  <c:v>1.3900000000000001</c:v>
                </c:pt>
                <c:pt idx="2391">
                  <c:v>1.391</c:v>
                </c:pt>
                <c:pt idx="2392">
                  <c:v>1.3919999999999999</c:v>
                </c:pt>
                <c:pt idx="2393">
                  <c:v>1.3929999999999998</c:v>
                </c:pt>
                <c:pt idx="2394">
                  <c:v>1.3940000000000001</c:v>
                </c:pt>
                <c:pt idx="2395">
                  <c:v>1.395</c:v>
                </c:pt>
                <c:pt idx="2396">
                  <c:v>1.3959999999999999</c:v>
                </c:pt>
                <c:pt idx="2397">
                  <c:v>1.3969999999999998</c:v>
                </c:pt>
                <c:pt idx="2398">
                  <c:v>1.3980000000000001</c:v>
                </c:pt>
                <c:pt idx="2399">
                  <c:v>1.399</c:v>
                </c:pt>
                <c:pt idx="2400">
                  <c:v>1.4</c:v>
                </c:pt>
                <c:pt idx="2401">
                  <c:v>1.4009999999999998</c:v>
                </c:pt>
                <c:pt idx="2402">
                  <c:v>1.4020000000000001</c:v>
                </c:pt>
                <c:pt idx="2403">
                  <c:v>1.403</c:v>
                </c:pt>
                <c:pt idx="2404">
                  <c:v>1.4039999999999999</c:v>
                </c:pt>
                <c:pt idx="2405">
                  <c:v>1.4049999999999998</c:v>
                </c:pt>
                <c:pt idx="2406">
                  <c:v>1.4060000000000001</c:v>
                </c:pt>
                <c:pt idx="2407">
                  <c:v>1.407</c:v>
                </c:pt>
                <c:pt idx="2408">
                  <c:v>1.4079999999999999</c:v>
                </c:pt>
                <c:pt idx="2409">
                  <c:v>1.4089999999999998</c:v>
                </c:pt>
                <c:pt idx="2410">
                  <c:v>1.4100000000000001</c:v>
                </c:pt>
                <c:pt idx="2411">
                  <c:v>1.411</c:v>
                </c:pt>
                <c:pt idx="2412">
                  <c:v>1.4119999999999999</c:v>
                </c:pt>
                <c:pt idx="2413">
                  <c:v>1.4129999999999998</c:v>
                </c:pt>
                <c:pt idx="2414">
                  <c:v>1.4140000000000001</c:v>
                </c:pt>
                <c:pt idx="2415">
                  <c:v>1.415</c:v>
                </c:pt>
                <c:pt idx="2416">
                  <c:v>1.4159999999999999</c:v>
                </c:pt>
                <c:pt idx="2417">
                  <c:v>1.4169999999999998</c:v>
                </c:pt>
                <c:pt idx="2418">
                  <c:v>1.4180000000000001</c:v>
                </c:pt>
                <c:pt idx="2419">
                  <c:v>1.419</c:v>
                </c:pt>
                <c:pt idx="2420">
                  <c:v>1.42</c:v>
                </c:pt>
                <c:pt idx="2421">
                  <c:v>1.4209999999999998</c:v>
                </c:pt>
                <c:pt idx="2422">
                  <c:v>1.4220000000000002</c:v>
                </c:pt>
                <c:pt idx="2423">
                  <c:v>1.423</c:v>
                </c:pt>
                <c:pt idx="2424">
                  <c:v>1.4239999999999999</c:v>
                </c:pt>
                <c:pt idx="2425">
                  <c:v>1.4249999999999998</c:v>
                </c:pt>
                <c:pt idx="2426">
                  <c:v>1.4260000000000002</c:v>
                </c:pt>
                <c:pt idx="2427">
                  <c:v>1.427</c:v>
                </c:pt>
                <c:pt idx="2428">
                  <c:v>1.4279999999999999</c:v>
                </c:pt>
                <c:pt idx="2429">
                  <c:v>1.4289999999999998</c:v>
                </c:pt>
                <c:pt idx="2430">
                  <c:v>1.4300000000000002</c:v>
                </c:pt>
                <c:pt idx="2431">
                  <c:v>1.431</c:v>
                </c:pt>
                <c:pt idx="2432">
                  <c:v>1.4319999999999999</c:v>
                </c:pt>
                <c:pt idx="2433">
                  <c:v>1.4329999999999998</c:v>
                </c:pt>
                <c:pt idx="2434">
                  <c:v>1.4340000000000002</c:v>
                </c:pt>
                <c:pt idx="2435">
                  <c:v>1.4350000000000001</c:v>
                </c:pt>
                <c:pt idx="2436">
                  <c:v>1.4359999999999999</c:v>
                </c:pt>
                <c:pt idx="2437">
                  <c:v>1.4369999999999998</c:v>
                </c:pt>
                <c:pt idx="2438">
                  <c:v>1.4380000000000002</c:v>
                </c:pt>
                <c:pt idx="2439">
                  <c:v>1.4390000000000001</c:v>
                </c:pt>
                <c:pt idx="2440">
                  <c:v>1.44</c:v>
                </c:pt>
                <c:pt idx="2441">
                  <c:v>1.4409999999999998</c:v>
                </c:pt>
                <c:pt idx="2442">
                  <c:v>1.4420000000000002</c:v>
                </c:pt>
                <c:pt idx="2443">
                  <c:v>1.4430000000000001</c:v>
                </c:pt>
                <c:pt idx="2444">
                  <c:v>1.444</c:v>
                </c:pt>
                <c:pt idx="2445">
                  <c:v>1.4449999999999998</c:v>
                </c:pt>
                <c:pt idx="2446">
                  <c:v>1.4460000000000002</c:v>
                </c:pt>
                <c:pt idx="2447">
                  <c:v>1.4470000000000001</c:v>
                </c:pt>
                <c:pt idx="2448">
                  <c:v>1.448</c:v>
                </c:pt>
                <c:pt idx="2449">
                  <c:v>1.4489999999999998</c:v>
                </c:pt>
                <c:pt idx="2450">
                  <c:v>1.4500000000000002</c:v>
                </c:pt>
                <c:pt idx="2451">
                  <c:v>1.4510000000000001</c:v>
                </c:pt>
                <c:pt idx="2452">
                  <c:v>1.452</c:v>
                </c:pt>
                <c:pt idx="2453">
                  <c:v>1.4529999999999998</c:v>
                </c:pt>
                <c:pt idx="2454">
                  <c:v>1.4540000000000002</c:v>
                </c:pt>
                <c:pt idx="2455">
                  <c:v>1.4550000000000001</c:v>
                </c:pt>
                <c:pt idx="2456">
                  <c:v>1.456</c:v>
                </c:pt>
                <c:pt idx="2457">
                  <c:v>1.4569999999999999</c:v>
                </c:pt>
                <c:pt idx="2458">
                  <c:v>1.4580000000000002</c:v>
                </c:pt>
                <c:pt idx="2459">
                  <c:v>1.4590000000000001</c:v>
                </c:pt>
                <c:pt idx="2460">
                  <c:v>1.46</c:v>
                </c:pt>
                <c:pt idx="2461">
                  <c:v>1.4609999999999999</c:v>
                </c:pt>
                <c:pt idx="2462">
                  <c:v>1.4620000000000002</c:v>
                </c:pt>
                <c:pt idx="2463">
                  <c:v>1.4630000000000001</c:v>
                </c:pt>
                <c:pt idx="2464">
                  <c:v>1.464</c:v>
                </c:pt>
                <c:pt idx="2465">
                  <c:v>1.4649999999999999</c:v>
                </c:pt>
                <c:pt idx="2466">
                  <c:v>1.4660000000000002</c:v>
                </c:pt>
                <c:pt idx="2467">
                  <c:v>1.4670000000000001</c:v>
                </c:pt>
                <c:pt idx="2468">
                  <c:v>1.468</c:v>
                </c:pt>
                <c:pt idx="2469">
                  <c:v>1.4689999999999999</c:v>
                </c:pt>
                <c:pt idx="2470">
                  <c:v>1.4700000000000002</c:v>
                </c:pt>
                <c:pt idx="2471">
                  <c:v>1.4710000000000001</c:v>
                </c:pt>
                <c:pt idx="2472">
                  <c:v>1.472</c:v>
                </c:pt>
                <c:pt idx="2473">
                  <c:v>1.4729999999999999</c:v>
                </c:pt>
                <c:pt idx="2474">
                  <c:v>1.4740000000000002</c:v>
                </c:pt>
                <c:pt idx="2475">
                  <c:v>1.4750000000000001</c:v>
                </c:pt>
                <c:pt idx="2476">
                  <c:v>1.476</c:v>
                </c:pt>
                <c:pt idx="2477">
                  <c:v>1.4769999999999999</c:v>
                </c:pt>
                <c:pt idx="2478">
                  <c:v>1.4780000000000002</c:v>
                </c:pt>
                <c:pt idx="2479">
                  <c:v>1.4790000000000001</c:v>
                </c:pt>
                <c:pt idx="2480">
                  <c:v>1.48</c:v>
                </c:pt>
                <c:pt idx="2481">
                  <c:v>1.4809999999999999</c:v>
                </c:pt>
                <c:pt idx="2482">
                  <c:v>1.4820000000000002</c:v>
                </c:pt>
                <c:pt idx="2483">
                  <c:v>1.4830000000000001</c:v>
                </c:pt>
                <c:pt idx="2484">
                  <c:v>1.484</c:v>
                </c:pt>
                <c:pt idx="2485">
                  <c:v>1.4849999999999999</c:v>
                </c:pt>
                <c:pt idx="2486">
                  <c:v>1.4860000000000002</c:v>
                </c:pt>
                <c:pt idx="2487">
                  <c:v>1.4870000000000001</c:v>
                </c:pt>
                <c:pt idx="2488">
                  <c:v>1.488</c:v>
                </c:pt>
                <c:pt idx="2489">
                  <c:v>1.4889999999999999</c:v>
                </c:pt>
                <c:pt idx="2490">
                  <c:v>1.4900000000000002</c:v>
                </c:pt>
                <c:pt idx="2491">
                  <c:v>1.4910000000000001</c:v>
                </c:pt>
                <c:pt idx="2492">
                  <c:v>1.492</c:v>
                </c:pt>
                <c:pt idx="2493">
                  <c:v>1.4929999999999999</c:v>
                </c:pt>
                <c:pt idx="2494">
                  <c:v>1.4940000000000002</c:v>
                </c:pt>
                <c:pt idx="2495">
                  <c:v>1.4950000000000001</c:v>
                </c:pt>
                <c:pt idx="2496">
                  <c:v>1.496</c:v>
                </c:pt>
                <c:pt idx="2497">
                  <c:v>1.4969999999999999</c:v>
                </c:pt>
                <c:pt idx="2498">
                  <c:v>1.4980000000000002</c:v>
                </c:pt>
                <c:pt idx="2499">
                  <c:v>1.4990000000000001</c:v>
                </c:pt>
                <c:pt idx="2500">
                  <c:v>1.5</c:v>
                </c:pt>
                <c:pt idx="2501">
                  <c:v>1.5009999999999999</c:v>
                </c:pt>
                <c:pt idx="2502">
                  <c:v>1.5019999999999998</c:v>
                </c:pt>
                <c:pt idx="2503">
                  <c:v>1.5030000000000001</c:v>
                </c:pt>
                <c:pt idx="2504">
                  <c:v>1.504</c:v>
                </c:pt>
                <c:pt idx="2505">
                  <c:v>1.5049999999999999</c:v>
                </c:pt>
                <c:pt idx="2506">
                  <c:v>1.5059999999999998</c:v>
                </c:pt>
                <c:pt idx="2507">
                  <c:v>1.5070000000000001</c:v>
                </c:pt>
                <c:pt idx="2508">
                  <c:v>1.508</c:v>
                </c:pt>
                <c:pt idx="2509">
                  <c:v>1.5089999999999999</c:v>
                </c:pt>
                <c:pt idx="2510">
                  <c:v>1.5099999999999998</c:v>
                </c:pt>
                <c:pt idx="2511">
                  <c:v>1.5110000000000001</c:v>
                </c:pt>
                <c:pt idx="2512">
                  <c:v>1.512</c:v>
                </c:pt>
                <c:pt idx="2513">
                  <c:v>1.5129999999999999</c:v>
                </c:pt>
                <c:pt idx="2514">
                  <c:v>1.5139999999999998</c:v>
                </c:pt>
                <c:pt idx="2515">
                  <c:v>1.5150000000000001</c:v>
                </c:pt>
                <c:pt idx="2516">
                  <c:v>1.516</c:v>
                </c:pt>
                <c:pt idx="2517">
                  <c:v>1.5169999999999999</c:v>
                </c:pt>
                <c:pt idx="2518">
                  <c:v>1.5179999999999998</c:v>
                </c:pt>
                <c:pt idx="2519">
                  <c:v>1.5190000000000001</c:v>
                </c:pt>
                <c:pt idx="2520">
                  <c:v>1.52</c:v>
                </c:pt>
                <c:pt idx="2521">
                  <c:v>1.5209999999999999</c:v>
                </c:pt>
                <c:pt idx="2522">
                  <c:v>1.5219999999999998</c:v>
                </c:pt>
                <c:pt idx="2523">
                  <c:v>1.5230000000000001</c:v>
                </c:pt>
                <c:pt idx="2524">
                  <c:v>1.524</c:v>
                </c:pt>
                <c:pt idx="2525">
                  <c:v>1.5249999999999999</c:v>
                </c:pt>
                <c:pt idx="2526">
                  <c:v>1.5259999999999998</c:v>
                </c:pt>
                <c:pt idx="2527">
                  <c:v>1.5270000000000001</c:v>
                </c:pt>
                <c:pt idx="2528">
                  <c:v>1.528</c:v>
                </c:pt>
                <c:pt idx="2529">
                  <c:v>1.5289999999999999</c:v>
                </c:pt>
                <c:pt idx="2530">
                  <c:v>1.5299999999999998</c:v>
                </c:pt>
                <c:pt idx="2531">
                  <c:v>1.5310000000000001</c:v>
                </c:pt>
                <c:pt idx="2532">
                  <c:v>1.532</c:v>
                </c:pt>
                <c:pt idx="2533">
                  <c:v>1.5329999999999999</c:v>
                </c:pt>
                <c:pt idx="2534">
                  <c:v>1.5339999999999998</c:v>
                </c:pt>
                <c:pt idx="2535">
                  <c:v>1.5350000000000001</c:v>
                </c:pt>
                <c:pt idx="2536">
                  <c:v>1.536</c:v>
                </c:pt>
                <c:pt idx="2537">
                  <c:v>1.5369999999999999</c:v>
                </c:pt>
                <c:pt idx="2538">
                  <c:v>1.5379999999999998</c:v>
                </c:pt>
                <c:pt idx="2539">
                  <c:v>1.5390000000000001</c:v>
                </c:pt>
                <c:pt idx="2540">
                  <c:v>1.54</c:v>
                </c:pt>
                <c:pt idx="2541">
                  <c:v>1.5409999999999999</c:v>
                </c:pt>
                <c:pt idx="2542">
                  <c:v>1.5419999999999998</c:v>
                </c:pt>
                <c:pt idx="2543">
                  <c:v>1.5430000000000001</c:v>
                </c:pt>
                <c:pt idx="2544">
                  <c:v>1.544</c:v>
                </c:pt>
                <c:pt idx="2545">
                  <c:v>1.5449999999999999</c:v>
                </c:pt>
                <c:pt idx="2546">
                  <c:v>1.5459999999999998</c:v>
                </c:pt>
                <c:pt idx="2547">
                  <c:v>1.5470000000000002</c:v>
                </c:pt>
                <c:pt idx="2548">
                  <c:v>1.548</c:v>
                </c:pt>
                <c:pt idx="2549">
                  <c:v>1.5489999999999999</c:v>
                </c:pt>
                <c:pt idx="2550">
                  <c:v>1.5499999999999998</c:v>
                </c:pt>
                <c:pt idx="2551">
                  <c:v>1.5510000000000002</c:v>
                </c:pt>
                <c:pt idx="2552">
                  <c:v>1.552</c:v>
                </c:pt>
                <c:pt idx="2553">
                  <c:v>1.5529999999999999</c:v>
                </c:pt>
                <c:pt idx="2554">
                  <c:v>1.5539999999999998</c:v>
                </c:pt>
                <c:pt idx="2555">
                  <c:v>1.5550000000000002</c:v>
                </c:pt>
                <c:pt idx="2556">
                  <c:v>1.556</c:v>
                </c:pt>
                <c:pt idx="2557">
                  <c:v>1.5569999999999999</c:v>
                </c:pt>
                <c:pt idx="2558">
                  <c:v>1.5579999999999998</c:v>
                </c:pt>
                <c:pt idx="2559">
                  <c:v>1.5590000000000002</c:v>
                </c:pt>
                <c:pt idx="2560">
                  <c:v>1.56</c:v>
                </c:pt>
                <c:pt idx="2561">
                  <c:v>1.5609999999999999</c:v>
                </c:pt>
                <c:pt idx="2562">
                  <c:v>1.5619999999999998</c:v>
                </c:pt>
                <c:pt idx="2563">
                  <c:v>1.5630000000000002</c:v>
                </c:pt>
                <c:pt idx="2564">
                  <c:v>1.5640000000000001</c:v>
                </c:pt>
                <c:pt idx="2565">
                  <c:v>1.5649999999999999</c:v>
                </c:pt>
                <c:pt idx="2566">
                  <c:v>1.5659999999999998</c:v>
                </c:pt>
                <c:pt idx="2567">
                  <c:v>1.5670000000000002</c:v>
                </c:pt>
                <c:pt idx="2568">
                  <c:v>1.5680000000000001</c:v>
                </c:pt>
                <c:pt idx="2569">
                  <c:v>1.569</c:v>
                </c:pt>
                <c:pt idx="2570">
                  <c:v>1.5699999999999998</c:v>
                </c:pt>
                <c:pt idx="2571">
                  <c:v>1.5710000000000002</c:v>
                </c:pt>
                <c:pt idx="2572">
                  <c:v>1.5720000000000001</c:v>
                </c:pt>
                <c:pt idx="2573">
                  <c:v>1.573</c:v>
                </c:pt>
                <c:pt idx="2574">
                  <c:v>1.5739999999999998</c:v>
                </c:pt>
                <c:pt idx="2575">
                  <c:v>1.5750000000000002</c:v>
                </c:pt>
                <c:pt idx="2576">
                  <c:v>1.5760000000000001</c:v>
                </c:pt>
                <c:pt idx="2577">
                  <c:v>1.577</c:v>
                </c:pt>
                <c:pt idx="2578">
                  <c:v>1.5779999999999998</c:v>
                </c:pt>
                <c:pt idx="2579">
                  <c:v>1.5790000000000002</c:v>
                </c:pt>
                <c:pt idx="2580">
                  <c:v>1.58</c:v>
                </c:pt>
                <c:pt idx="2581">
                  <c:v>1.581</c:v>
                </c:pt>
                <c:pt idx="2582">
                  <c:v>1.5819999999999999</c:v>
                </c:pt>
                <c:pt idx="2583">
                  <c:v>1.5830000000000002</c:v>
                </c:pt>
                <c:pt idx="2584">
                  <c:v>1.5840000000000001</c:v>
                </c:pt>
                <c:pt idx="2585">
                  <c:v>1.585</c:v>
                </c:pt>
                <c:pt idx="2586">
                  <c:v>1.5859999999999999</c:v>
                </c:pt>
                <c:pt idx="2587">
                  <c:v>1.5870000000000002</c:v>
                </c:pt>
                <c:pt idx="2588">
                  <c:v>1.5880000000000001</c:v>
                </c:pt>
                <c:pt idx="2589">
                  <c:v>1.589</c:v>
                </c:pt>
                <c:pt idx="2590">
                  <c:v>1.5899999999999999</c:v>
                </c:pt>
                <c:pt idx="2591">
                  <c:v>1.5910000000000002</c:v>
                </c:pt>
                <c:pt idx="2592">
                  <c:v>1.5920000000000001</c:v>
                </c:pt>
                <c:pt idx="2593">
                  <c:v>1.593</c:v>
                </c:pt>
                <c:pt idx="2594">
                  <c:v>1.5939999999999999</c:v>
                </c:pt>
                <c:pt idx="2595">
                  <c:v>1.5950000000000002</c:v>
                </c:pt>
                <c:pt idx="2596">
                  <c:v>1.5960000000000001</c:v>
                </c:pt>
                <c:pt idx="2597">
                  <c:v>1.597</c:v>
                </c:pt>
                <c:pt idx="2598">
                  <c:v>1.5979999999999999</c:v>
                </c:pt>
                <c:pt idx="2599">
                  <c:v>1.5990000000000002</c:v>
                </c:pt>
                <c:pt idx="2600">
                  <c:v>1.6</c:v>
                </c:pt>
                <c:pt idx="2601">
                  <c:v>1.601</c:v>
                </c:pt>
                <c:pt idx="2602">
                  <c:v>1.6019999999999999</c:v>
                </c:pt>
                <c:pt idx="2603">
                  <c:v>1.6030000000000002</c:v>
                </c:pt>
                <c:pt idx="2604">
                  <c:v>1.6040000000000001</c:v>
                </c:pt>
                <c:pt idx="2605">
                  <c:v>1.605</c:v>
                </c:pt>
                <c:pt idx="2606">
                  <c:v>1.6059999999999999</c:v>
                </c:pt>
                <c:pt idx="2607">
                  <c:v>1.6070000000000002</c:v>
                </c:pt>
                <c:pt idx="2608">
                  <c:v>1.6080000000000001</c:v>
                </c:pt>
                <c:pt idx="2609">
                  <c:v>1.609</c:v>
                </c:pt>
                <c:pt idx="2610">
                  <c:v>1.6099999999999999</c:v>
                </c:pt>
                <c:pt idx="2611">
                  <c:v>1.6110000000000002</c:v>
                </c:pt>
                <c:pt idx="2612">
                  <c:v>1.6120000000000001</c:v>
                </c:pt>
                <c:pt idx="2613">
                  <c:v>1.613</c:v>
                </c:pt>
                <c:pt idx="2614">
                  <c:v>1.6139999999999999</c:v>
                </c:pt>
                <c:pt idx="2615">
                  <c:v>1.6150000000000002</c:v>
                </c:pt>
                <c:pt idx="2616">
                  <c:v>1.6160000000000001</c:v>
                </c:pt>
                <c:pt idx="2617">
                  <c:v>1.617</c:v>
                </c:pt>
                <c:pt idx="2618">
                  <c:v>1.6179999999999999</c:v>
                </c:pt>
                <c:pt idx="2619">
                  <c:v>1.6190000000000002</c:v>
                </c:pt>
                <c:pt idx="2620">
                  <c:v>1.62</c:v>
                </c:pt>
                <c:pt idx="2621">
                  <c:v>1.621</c:v>
                </c:pt>
                <c:pt idx="2622">
                  <c:v>1.6219999999999999</c:v>
                </c:pt>
                <c:pt idx="2623">
                  <c:v>1.6230000000000002</c:v>
                </c:pt>
                <c:pt idx="2624">
                  <c:v>1.6240000000000001</c:v>
                </c:pt>
                <c:pt idx="2625">
                  <c:v>1.625</c:v>
                </c:pt>
                <c:pt idx="2626">
                  <c:v>1.6259999999999999</c:v>
                </c:pt>
                <c:pt idx="2627">
                  <c:v>1.6269999999999998</c:v>
                </c:pt>
                <c:pt idx="2628">
                  <c:v>1.6280000000000001</c:v>
                </c:pt>
                <c:pt idx="2629">
                  <c:v>1.629</c:v>
                </c:pt>
                <c:pt idx="2630">
                  <c:v>1.63</c:v>
                </c:pt>
                <c:pt idx="2631">
                  <c:v>1.6309999999999998</c:v>
                </c:pt>
                <c:pt idx="2632">
                  <c:v>1.6320000000000001</c:v>
                </c:pt>
                <c:pt idx="2633">
                  <c:v>1.633</c:v>
                </c:pt>
                <c:pt idx="2634">
                  <c:v>1.6339999999999999</c:v>
                </c:pt>
                <c:pt idx="2635">
                  <c:v>1.6349999999999998</c:v>
                </c:pt>
                <c:pt idx="2636">
                  <c:v>1.6360000000000001</c:v>
                </c:pt>
                <c:pt idx="2637">
                  <c:v>1.637</c:v>
                </c:pt>
                <c:pt idx="2638">
                  <c:v>1.6379999999999999</c:v>
                </c:pt>
                <c:pt idx="2639">
                  <c:v>1.6389999999999998</c:v>
                </c:pt>
                <c:pt idx="2640">
                  <c:v>1.6400000000000001</c:v>
                </c:pt>
                <c:pt idx="2641">
                  <c:v>1.641</c:v>
                </c:pt>
                <c:pt idx="2642">
                  <c:v>1.6419999999999999</c:v>
                </c:pt>
                <c:pt idx="2643">
                  <c:v>1.6429999999999998</c:v>
                </c:pt>
                <c:pt idx="2644">
                  <c:v>1.6440000000000001</c:v>
                </c:pt>
                <c:pt idx="2645">
                  <c:v>1.645</c:v>
                </c:pt>
                <c:pt idx="2646">
                  <c:v>1.6459999999999999</c:v>
                </c:pt>
                <c:pt idx="2647">
                  <c:v>1.6469999999999998</c:v>
                </c:pt>
                <c:pt idx="2648">
                  <c:v>1.6480000000000001</c:v>
                </c:pt>
                <c:pt idx="2649">
                  <c:v>1.649</c:v>
                </c:pt>
                <c:pt idx="2650">
                  <c:v>1.65</c:v>
                </c:pt>
                <c:pt idx="2651">
                  <c:v>1.6509999999999998</c:v>
                </c:pt>
                <c:pt idx="2652">
                  <c:v>1.6520000000000001</c:v>
                </c:pt>
                <c:pt idx="2653">
                  <c:v>1.653</c:v>
                </c:pt>
                <c:pt idx="2654">
                  <c:v>1.6539999999999999</c:v>
                </c:pt>
                <c:pt idx="2655">
                  <c:v>1.6549999999999998</c:v>
                </c:pt>
                <c:pt idx="2656">
                  <c:v>1.6560000000000001</c:v>
                </c:pt>
                <c:pt idx="2657">
                  <c:v>1.657</c:v>
                </c:pt>
                <c:pt idx="2658">
                  <c:v>1.6579999999999999</c:v>
                </c:pt>
                <c:pt idx="2659">
                  <c:v>1.6589999999999998</c:v>
                </c:pt>
                <c:pt idx="2660">
                  <c:v>1.6600000000000001</c:v>
                </c:pt>
                <c:pt idx="2661">
                  <c:v>1.661</c:v>
                </c:pt>
                <c:pt idx="2662">
                  <c:v>1.6619999999999999</c:v>
                </c:pt>
                <c:pt idx="2663">
                  <c:v>1.6629999999999998</c:v>
                </c:pt>
                <c:pt idx="2664">
                  <c:v>1.6640000000000001</c:v>
                </c:pt>
                <c:pt idx="2665">
                  <c:v>1.665</c:v>
                </c:pt>
                <c:pt idx="2666">
                  <c:v>1.6659999999999999</c:v>
                </c:pt>
                <c:pt idx="2667">
                  <c:v>1.6669999999999998</c:v>
                </c:pt>
                <c:pt idx="2668">
                  <c:v>1.6680000000000001</c:v>
                </c:pt>
                <c:pt idx="2669">
                  <c:v>1.669</c:v>
                </c:pt>
                <c:pt idx="2670">
                  <c:v>1.67</c:v>
                </c:pt>
                <c:pt idx="2671">
                  <c:v>1.6709999999999998</c:v>
                </c:pt>
                <c:pt idx="2672">
                  <c:v>1.6720000000000002</c:v>
                </c:pt>
                <c:pt idx="2673">
                  <c:v>1.673</c:v>
                </c:pt>
                <c:pt idx="2674">
                  <c:v>1.6739999999999999</c:v>
                </c:pt>
                <c:pt idx="2675">
                  <c:v>1.6749999999999998</c:v>
                </c:pt>
                <c:pt idx="2676">
                  <c:v>1.6760000000000002</c:v>
                </c:pt>
                <c:pt idx="2677">
                  <c:v>1.677</c:v>
                </c:pt>
                <c:pt idx="2678">
                  <c:v>1.6779999999999999</c:v>
                </c:pt>
                <c:pt idx="2679">
                  <c:v>1.6789999999999998</c:v>
                </c:pt>
                <c:pt idx="2680">
                  <c:v>1.6800000000000002</c:v>
                </c:pt>
                <c:pt idx="2681">
                  <c:v>1.681</c:v>
                </c:pt>
                <c:pt idx="2682">
                  <c:v>1.6819999999999999</c:v>
                </c:pt>
                <c:pt idx="2683">
                  <c:v>1.6829999999999998</c:v>
                </c:pt>
                <c:pt idx="2684">
                  <c:v>1.6840000000000002</c:v>
                </c:pt>
                <c:pt idx="2685">
                  <c:v>1.6850000000000001</c:v>
                </c:pt>
                <c:pt idx="2686">
                  <c:v>1.6859999999999999</c:v>
                </c:pt>
                <c:pt idx="2687">
                  <c:v>1.6869999999999998</c:v>
                </c:pt>
                <c:pt idx="2688">
                  <c:v>1.6880000000000002</c:v>
                </c:pt>
                <c:pt idx="2689">
                  <c:v>1.6890000000000001</c:v>
                </c:pt>
                <c:pt idx="2690">
                  <c:v>1.69</c:v>
                </c:pt>
                <c:pt idx="2691">
                  <c:v>1.6909999999999998</c:v>
                </c:pt>
                <c:pt idx="2692">
                  <c:v>1.6920000000000002</c:v>
                </c:pt>
                <c:pt idx="2693">
                  <c:v>1.6930000000000001</c:v>
                </c:pt>
                <c:pt idx="2694">
                  <c:v>1.694</c:v>
                </c:pt>
                <c:pt idx="2695">
                  <c:v>1.6949999999999998</c:v>
                </c:pt>
                <c:pt idx="2696">
                  <c:v>1.6960000000000002</c:v>
                </c:pt>
                <c:pt idx="2697">
                  <c:v>1.6970000000000001</c:v>
                </c:pt>
                <c:pt idx="2698">
                  <c:v>1.698</c:v>
                </c:pt>
                <c:pt idx="2699">
                  <c:v>1.6989999999999998</c:v>
                </c:pt>
                <c:pt idx="2700">
                  <c:v>1.7000000000000002</c:v>
                </c:pt>
                <c:pt idx="2701">
                  <c:v>1.7010000000000001</c:v>
                </c:pt>
                <c:pt idx="2702">
                  <c:v>1.702</c:v>
                </c:pt>
                <c:pt idx="2703">
                  <c:v>1.7029999999999998</c:v>
                </c:pt>
                <c:pt idx="2704">
                  <c:v>1.7040000000000002</c:v>
                </c:pt>
                <c:pt idx="2705">
                  <c:v>1.7050000000000001</c:v>
                </c:pt>
                <c:pt idx="2706">
                  <c:v>1.706</c:v>
                </c:pt>
                <c:pt idx="2707">
                  <c:v>1.7069999999999999</c:v>
                </c:pt>
                <c:pt idx="2708">
                  <c:v>1.7080000000000002</c:v>
                </c:pt>
                <c:pt idx="2709">
                  <c:v>1.7090000000000001</c:v>
                </c:pt>
                <c:pt idx="2710">
                  <c:v>1.71</c:v>
                </c:pt>
                <c:pt idx="2711">
                  <c:v>1.7109999999999999</c:v>
                </c:pt>
                <c:pt idx="2712">
                  <c:v>1.7120000000000002</c:v>
                </c:pt>
                <c:pt idx="2713">
                  <c:v>1.7130000000000001</c:v>
                </c:pt>
                <c:pt idx="2714">
                  <c:v>1.714</c:v>
                </c:pt>
                <c:pt idx="2715">
                  <c:v>1.7149999999999999</c:v>
                </c:pt>
                <c:pt idx="2716">
                  <c:v>1.7160000000000002</c:v>
                </c:pt>
                <c:pt idx="2717">
                  <c:v>1.7170000000000001</c:v>
                </c:pt>
                <c:pt idx="2718">
                  <c:v>1.718</c:v>
                </c:pt>
                <c:pt idx="2719">
                  <c:v>1.7189999999999999</c:v>
                </c:pt>
                <c:pt idx="2720">
                  <c:v>1.7200000000000002</c:v>
                </c:pt>
                <c:pt idx="2721">
                  <c:v>1.7210000000000001</c:v>
                </c:pt>
                <c:pt idx="2722">
                  <c:v>1.722</c:v>
                </c:pt>
                <c:pt idx="2723">
                  <c:v>1.7229999999999999</c:v>
                </c:pt>
                <c:pt idx="2724">
                  <c:v>1.7240000000000002</c:v>
                </c:pt>
                <c:pt idx="2725">
                  <c:v>1.7250000000000001</c:v>
                </c:pt>
                <c:pt idx="2726">
                  <c:v>1.726</c:v>
                </c:pt>
                <c:pt idx="2727">
                  <c:v>1.7269999999999999</c:v>
                </c:pt>
                <c:pt idx="2728">
                  <c:v>1.7280000000000002</c:v>
                </c:pt>
                <c:pt idx="2729">
                  <c:v>1.7290000000000001</c:v>
                </c:pt>
                <c:pt idx="2730">
                  <c:v>1.73</c:v>
                </c:pt>
                <c:pt idx="2731">
                  <c:v>1.7309999999999999</c:v>
                </c:pt>
                <c:pt idx="2732">
                  <c:v>1.7320000000000002</c:v>
                </c:pt>
                <c:pt idx="2733">
                  <c:v>1.7330000000000001</c:v>
                </c:pt>
                <c:pt idx="2734">
                  <c:v>1.734</c:v>
                </c:pt>
                <c:pt idx="2735">
                  <c:v>1.7349999999999999</c:v>
                </c:pt>
                <c:pt idx="2736">
                  <c:v>1.7360000000000002</c:v>
                </c:pt>
                <c:pt idx="2737">
                  <c:v>1.7370000000000001</c:v>
                </c:pt>
                <c:pt idx="2738">
                  <c:v>1.738</c:v>
                </c:pt>
                <c:pt idx="2739">
                  <c:v>1.7389999999999999</c:v>
                </c:pt>
                <c:pt idx="2740">
                  <c:v>1.7400000000000002</c:v>
                </c:pt>
                <c:pt idx="2741">
                  <c:v>1.7410000000000001</c:v>
                </c:pt>
                <c:pt idx="2742">
                  <c:v>1.742</c:v>
                </c:pt>
                <c:pt idx="2743">
                  <c:v>1.7429999999999999</c:v>
                </c:pt>
                <c:pt idx="2744">
                  <c:v>1.7440000000000002</c:v>
                </c:pt>
                <c:pt idx="2745">
                  <c:v>1.7450000000000001</c:v>
                </c:pt>
                <c:pt idx="2746">
                  <c:v>1.746</c:v>
                </c:pt>
                <c:pt idx="2747">
                  <c:v>1.7469999999999999</c:v>
                </c:pt>
                <c:pt idx="2748">
                  <c:v>1.7480000000000002</c:v>
                </c:pt>
                <c:pt idx="2749">
                  <c:v>1.7490000000000001</c:v>
                </c:pt>
                <c:pt idx="2750">
                  <c:v>1.75</c:v>
                </c:pt>
                <c:pt idx="2751">
                  <c:v>1.7509999999999999</c:v>
                </c:pt>
                <c:pt idx="2752">
                  <c:v>1.7519999999999998</c:v>
                </c:pt>
                <c:pt idx="2753">
                  <c:v>1.7530000000000001</c:v>
                </c:pt>
                <c:pt idx="2754">
                  <c:v>1.754</c:v>
                </c:pt>
                <c:pt idx="2755">
                  <c:v>1.7549999999999999</c:v>
                </c:pt>
                <c:pt idx="2756">
                  <c:v>1.7559999999999998</c:v>
                </c:pt>
                <c:pt idx="2757">
                  <c:v>1.7570000000000001</c:v>
                </c:pt>
                <c:pt idx="2758">
                  <c:v>1.758</c:v>
                </c:pt>
                <c:pt idx="2759">
                  <c:v>1.7589999999999999</c:v>
                </c:pt>
                <c:pt idx="2760">
                  <c:v>1.7599999999999998</c:v>
                </c:pt>
                <c:pt idx="2761">
                  <c:v>1.7610000000000001</c:v>
                </c:pt>
                <c:pt idx="2762">
                  <c:v>1.762</c:v>
                </c:pt>
                <c:pt idx="2763">
                  <c:v>1.7629999999999999</c:v>
                </c:pt>
                <c:pt idx="2764">
                  <c:v>1.7639999999999998</c:v>
                </c:pt>
                <c:pt idx="2765">
                  <c:v>1.7650000000000001</c:v>
                </c:pt>
                <c:pt idx="2766">
                  <c:v>1.766</c:v>
                </c:pt>
                <c:pt idx="2767">
                  <c:v>1.7669999999999999</c:v>
                </c:pt>
                <c:pt idx="2768">
                  <c:v>1.7679999999999998</c:v>
                </c:pt>
                <c:pt idx="2769">
                  <c:v>1.7690000000000001</c:v>
                </c:pt>
                <c:pt idx="2770">
                  <c:v>1.77</c:v>
                </c:pt>
                <c:pt idx="2771">
                  <c:v>1.7709999999999999</c:v>
                </c:pt>
                <c:pt idx="2772">
                  <c:v>1.7719999999999998</c:v>
                </c:pt>
                <c:pt idx="2773">
                  <c:v>1.7730000000000001</c:v>
                </c:pt>
                <c:pt idx="2774">
                  <c:v>1.774</c:v>
                </c:pt>
                <c:pt idx="2775">
                  <c:v>1.7749999999999999</c:v>
                </c:pt>
                <c:pt idx="2776">
                  <c:v>1.7759999999999998</c:v>
                </c:pt>
                <c:pt idx="2777">
                  <c:v>1.7770000000000001</c:v>
                </c:pt>
                <c:pt idx="2778">
                  <c:v>1.778</c:v>
                </c:pt>
                <c:pt idx="2779">
                  <c:v>1.7789999999999999</c:v>
                </c:pt>
                <c:pt idx="2780">
                  <c:v>1.7799999999999998</c:v>
                </c:pt>
                <c:pt idx="2781">
                  <c:v>1.7810000000000001</c:v>
                </c:pt>
                <c:pt idx="2782">
                  <c:v>1.782</c:v>
                </c:pt>
                <c:pt idx="2783">
                  <c:v>1.7829999999999999</c:v>
                </c:pt>
                <c:pt idx="2784">
                  <c:v>1.7839999999999998</c:v>
                </c:pt>
                <c:pt idx="2785">
                  <c:v>1.7850000000000001</c:v>
                </c:pt>
                <c:pt idx="2786">
                  <c:v>1.786</c:v>
                </c:pt>
                <c:pt idx="2787">
                  <c:v>1.7869999999999999</c:v>
                </c:pt>
                <c:pt idx="2788">
                  <c:v>1.7879999999999998</c:v>
                </c:pt>
                <c:pt idx="2789">
                  <c:v>1.7890000000000001</c:v>
                </c:pt>
                <c:pt idx="2790">
                  <c:v>1.79</c:v>
                </c:pt>
                <c:pt idx="2791">
                  <c:v>1.7909999999999999</c:v>
                </c:pt>
                <c:pt idx="2792">
                  <c:v>1.7919999999999998</c:v>
                </c:pt>
                <c:pt idx="2793">
                  <c:v>1.7930000000000001</c:v>
                </c:pt>
                <c:pt idx="2794">
                  <c:v>1.794</c:v>
                </c:pt>
                <c:pt idx="2795">
                  <c:v>1.7949999999999999</c:v>
                </c:pt>
                <c:pt idx="2796">
                  <c:v>1.7959999999999998</c:v>
                </c:pt>
                <c:pt idx="2797">
                  <c:v>1.7970000000000002</c:v>
                </c:pt>
                <c:pt idx="2798">
                  <c:v>1.798</c:v>
                </c:pt>
                <c:pt idx="2799">
                  <c:v>1.7989999999999999</c:v>
                </c:pt>
                <c:pt idx="2800">
                  <c:v>1.7999999999999998</c:v>
                </c:pt>
                <c:pt idx="2801">
                  <c:v>1.8010000000000002</c:v>
                </c:pt>
                <c:pt idx="2802">
                  <c:v>1.802</c:v>
                </c:pt>
                <c:pt idx="2803">
                  <c:v>1.8029999999999999</c:v>
                </c:pt>
                <c:pt idx="2804">
                  <c:v>1.8039999999999998</c:v>
                </c:pt>
                <c:pt idx="2805">
                  <c:v>1.8050000000000002</c:v>
                </c:pt>
                <c:pt idx="2806">
                  <c:v>1.806</c:v>
                </c:pt>
                <c:pt idx="2807">
                  <c:v>1.8069999999999999</c:v>
                </c:pt>
                <c:pt idx="2808">
                  <c:v>1.8079999999999998</c:v>
                </c:pt>
                <c:pt idx="2809">
                  <c:v>1.8090000000000002</c:v>
                </c:pt>
                <c:pt idx="2810">
                  <c:v>1.81</c:v>
                </c:pt>
                <c:pt idx="2811">
                  <c:v>1.8109999999999999</c:v>
                </c:pt>
                <c:pt idx="2812">
                  <c:v>1.8119999999999998</c:v>
                </c:pt>
                <c:pt idx="2813">
                  <c:v>1.8130000000000002</c:v>
                </c:pt>
                <c:pt idx="2814">
                  <c:v>1.8140000000000001</c:v>
                </c:pt>
                <c:pt idx="2815">
                  <c:v>1.8149999999999999</c:v>
                </c:pt>
                <c:pt idx="2816">
                  <c:v>1.8159999999999998</c:v>
                </c:pt>
                <c:pt idx="2817">
                  <c:v>1.8170000000000002</c:v>
                </c:pt>
                <c:pt idx="2818">
                  <c:v>1.8180000000000001</c:v>
                </c:pt>
                <c:pt idx="2819">
                  <c:v>1.819</c:v>
                </c:pt>
                <c:pt idx="2820">
                  <c:v>1.8199999999999998</c:v>
                </c:pt>
                <c:pt idx="2821">
                  <c:v>1.8210000000000002</c:v>
                </c:pt>
                <c:pt idx="2822">
                  <c:v>1.8220000000000001</c:v>
                </c:pt>
                <c:pt idx="2823">
                  <c:v>1.823</c:v>
                </c:pt>
                <c:pt idx="2824">
                  <c:v>1.8239999999999998</c:v>
                </c:pt>
                <c:pt idx="2825">
                  <c:v>1.8250000000000002</c:v>
                </c:pt>
                <c:pt idx="2826">
                  <c:v>1.8260000000000001</c:v>
                </c:pt>
                <c:pt idx="2827">
                  <c:v>1.827</c:v>
                </c:pt>
                <c:pt idx="2828">
                  <c:v>1.8279999999999998</c:v>
                </c:pt>
                <c:pt idx="2829">
                  <c:v>1.8290000000000002</c:v>
                </c:pt>
                <c:pt idx="2830">
                  <c:v>1.83</c:v>
                </c:pt>
                <c:pt idx="2831">
                  <c:v>1.831</c:v>
                </c:pt>
                <c:pt idx="2832">
                  <c:v>1.8319999999999999</c:v>
                </c:pt>
                <c:pt idx="2833">
                  <c:v>1.8330000000000002</c:v>
                </c:pt>
                <c:pt idx="2834">
                  <c:v>1.8340000000000001</c:v>
                </c:pt>
                <c:pt idx="2835">
                  <c:v>1.835</c:v>
                </c:pt>
                <c:pt idx="2836">
                  <c:v>1.8359999999999999</c:v>
                </c:pt>
                <c:pt idx="2837">
                  <c:v>1.8370000000000002</c:v>
                </c:pt>
                <c:pt idx="2838">
                  <c:v>1.8380000000000001</c:v>
                </c:pt>
                <c:pt idx="2839">
                  <c:v>1.839</c:v>
                </c:pt>
                <c:pt idx="2840">
                  <c:v>1.8399999999999999</c:v>
                </c:pt>
                <c:pt idx="2841">
                  <c:v>1.8410000000000002</c:v>
                </c:pt>
                <c:pt idx="2842">
                  <c:v>1.8420000000000001</c:v>
                </c:pt>
                <c:pt idx="2843">
                  <c:v>1.843</c:v>
                </c:pt>
                <c:pt idx="2844">
                  <c:v>1.8439999999999999</c:v>
                </c:pt>
                <c:pt idx="2845">
                  <c:v>1.8450000000000002</c:v>
                </c:pt>
                <c:pt idx="2846">
                  <c:v>1.8460000000000001</c:v>
                </c:pt>
                <c:pt idx="2847">
                  <c:v>1.847</c:v>
                </c:pt>
                <c:pt idx="2848">
                  <c:v>1.8479999999999999</c:v>
                </c:pt>
                <c:pt idx="2849">
                  <c:v>1.8490000000000002</c:v>
                </c:pt>
                <c:pt idx="2850">
                  <c:v>1.85</c:v>
                </c:pt>
                <c:pt idx="2851">
                  <c:v>1.851</c:v>
                </c:pt>
                <c:pt idx="2852">
                  <c:v>1.8519999999999999</c:v>
                </c:pt>
                <c:pt idx="2853">
                  <c:v>1.8530000000000002</c:v>
                </c:pt>
                <c:pt idx="2854">
                  <c:v>1.8540000000000001</c:v>
                </c:pt>
                <c:pt idx="2855">
                  <c:v>1.855</c:v>
                </c:pt>
                <c:pt idx="2856">
                  <c:v>1.8559999999999999</c:v>
                </c:pt>
                <c:pt idx="2857">
                  <c:v>1.8570000000000002</c:v>
                </c:pt>
                <c:pt idx="2858">
                  <c:v>1.8580000000000001</c:v>
                </c:pt>
                <c:pt idx="2859">
                  <c:v>1.859</c:v>
                </c:pt>
                <c:pt idx="2860">
                  <c:v>1.8599999999999999</c:v>
                </c:pt>
                <c:pt idx="2861">
                  <c:v>1.8610000000000002</c:v>
                </c:pt>
                <c:pt idx="2862">
                  <c:v>1.8620000000000001</c:v>
                </c:pt>
                <c:pt idx="2863">
                  <c:v>1.863</c:v>
                </c:pt>
                <c:pt idx="2864">
                  <c:v>1.8639999999999999</c:v>
                </c:pt>
                <c:pt idx="2865">
                  <c:v>1.8650000000000002</c:v>
                </c:pt>
                <c:pt idx="2866">
                  <c:v>1.8660000000000001</c:v>
                </c:pt>
                <c:pt idx="2867">
                  <c:v>1.867</c:v>
                </c:pt>
                <c:pt idx="2868">
                  <c:v>1.8679999999999999</c:v>
                </c:pt>
                <c:pt idx="2869">
                  <c:v>1.8690000000000002</c:v>
                </c:pt>
                <c:pt idx="2870">
                  <c:v>1.87</c:v>
                </c:pt>
                <c:pt idx="2871">
                  <c:v>1.871</c:v>
                </c:pt>
                <c:pt idx="2872">
                  <c:v>1.8719999999999999</c:v>
                </c:pt>
                <c:pt idx="2873">
                  <c:v>1.8730000000000002</c:v>
                </c:pt>
                <c:pt idx="2874">
                  <c:v>1.8740000000000001</c:v>
                </c:pt>
                <c:pt idx="2875">
                  <c:v>1.875</c:v>
                </c:pt>
                <c:pt idx="2876">
                  <c:v>1.8759999999999999</c:v>
                </c:pt>
                <c:pt idx="2877">
                  <c:v>1.8769999999999998</c:v>
                </c:pt>
                <c:pt idx="2878">
                  <c:v>1.8780000000000001</c:v>
                </c:pt>
                <c:pt idx="2879">
                  <c:v>1.879</c:v>
                </c:pt>
                <c:pt idx="2880">
                  <c:v>1.88</c:v>
                </c:pt>
                <c:pt idx="2881">
                  <c:v>1.8809999999999998</c:v>
                </c:pt>
                <c:pt idx="2882">
                  <c:v>1.8820000000000001</c:v>
                </c:pt>
                <c:pt idx="2883">
                  <c:v>1.883</c:v>
                </c:pt>
                <c:pt idx="2884">
                  <c:v>1.8839999999999999</c:v>
                </c:pt>
                <c:pt idx="2885">
                  <c:v>1.8849999999999998</c:v>
                </c:pt>
                <c:pt idx="2886">
                  <c:v>1.8860000000000001</c:v>
                </c:pt>
                <c:pt idx="2887">
                  <c:v>1.887</c:v>
                </c:pt>
                <c:pt idx="2888">
                  <c:v>1.8879999999999999</c:v>
                </c:pt>
                <c:pt idx="2889">
                  <c:v>1.8889999999999998</c:v>
                </c:pt>
                <c:pt idx="2890">
                  <c:v>1.8900000000000001</c:v>
                </c:pt>
                <c:pt idx="2891">
                  <c:v>1.891</c:v>
                </c:pt>
                <c:pt idx="2892">
                  <c:v>1.8919999999999999</c:v>
                </c:pt>
                <c:pt idx="2893">
                  <c:v>1.8929999999999998</c:v>
                </c:pt>
                <c:pt idx="2894">
                  <c:v>1.8940000000000001</c:v>
                </c:pt>
                <c:pt idx="2895">
                  <c:v>1.895</c:v>
                </c:pt>
                <c:pt idx="2896">
                  <c:v>1.8959999999999999</c:v>
                </c:pt>
                <c:pt idx="2897">
                  <c:v>1.8969999999999998</c:v>
                </c:pt>
                <c:pt idx="2898">
                  <c:v>1.8980000000000001</c:v>
                </c:pt>
                <c:pt idx="2899">
                  <c:v>1.899</c:v>
                </c:pt>
                <c:pt idx="2900">
                  <c:v>1.9</c:v>
                </c:pt>
                <c:pt idx="2901">
                  <c:v>1.9009999999999998</c:v>
                </c:pt>
                <c:pt idx="2902">
                  <c:v>1.9020000000000001</c:v>
                </c:pt>
                <c:pt idx="2903">
                  <c:v>1.903</c:v>
                </c:pt>
                <c:pt idx="2904">
                  <c:v>1.9039999999999999</c:v>
                </c:pt>
                <c:pt idx="2905">
                  <c:v>1.9049999999999998</c:v>
                </c:pt>
                <c:pt idx="2906">
                  <c:v>1.9060000000000001</c:v>
                </c:pt>
                <c:pt idx="2907">
                  <c:v>1.907</c:v>
                </c:pt>
                <c:pt idx="2908">
                  <c:v>1.9079999999999999</c:v>
                </c:pt>
                <c:pt idx="2909">
                  <c:v>1.9089999999999998</c:v>
                </c:pt>
                <c:pt idx="2910">
                  <c:v>1.9100000000000001</c:v>
                </c:pt>
                <c:pt idx="2911">
                  <c:v>1.911</c:v>
                </c:pt>
                <c:pt idx="2912">
                  <c:v>1.9119999999999999</c:v>
                </c:pt>
                <c:pt idx="2913">
                  <c:v>1.9129999999999998</c:v>
                </c:pt>
                <c:pt idx="2914">
                  <c:v>1.9140000000000001</c:v>
                </c:pt>
                <c:pt idx="2915">
                  <c:v>1.915</c:v>
                </c:pt>
                <c:pt idx="2916">
                  <c:v>1.9159999999999999</c:v>
                </c:pt>
                <c:pt idx="2917">
                  <c:v>1.9169999999999998</c:v>
                </c:pt>
                <c:pt idx="2918">
                  <c:v>1.9180000000000001</c:v>
                </c:pt>
                <c:pt idx="2919">
                  <c:v>1.919</c:v>
                </c:pt>
                <c:pt idx="2920">
                  <c:v>1.92</c:v>
                </c:pt>
                <c:pt idx="2921">
                  <c:v>1.9209999999999998</c:v>
                </c:pt>
                <c:pt idx="2922">
                  <c:v>1.9220000000000002</c:v>
                </c:pt>
                <c:pt idx="2923">
                  <c:v>1.923</c:v>
                </c:pt>
                <c:pt idx="2924">
                  <c:v>1.9239999999999999</c:v>
                </c:pt>
                <c:pt idx="2925">
                  <c:v>1.9249999999999998</c:v>
                </c:pt>
                <c:pt idx="2926">
                  <c:v>1.9260000000000002</c:v>
                </c:pt>
                <c:pt idx="2927">
                  <c:v>1.927</c:v>
                </c:pt>
                <c:pt idx="2928">
                  <c:v>1.9279999999999999</c:v>
                </c:pt>
                <c:pt idx="2929">
                  <c:v>1.9289999999999998</c:v>
                </c:pt>
                <c:pt idx="2930">
                  <c:v>1.9300000000000002</c:v>
                </c:pt>
                <c:pt idx="2931">
                  <c:v>1.931</c:v>
                </c:pt>
                <c:pt idx="2932">
                  <c:v>1.9319999999999999</c:v>
                </c:pt>
                <c:pt idx="2933">
                  <c:v>1.9329999999999998</c:v>
                </c:pt>
                <c:pt idx="2934">
                  <c:v>1.9340000000000002</c:v>
                </c:pt>
                <c:pt idx="2935">
                  <c:v>1.9350000000000001</c:v>
                </c:pt>
                <c:pt idx="2936">
                  <c:v>1.9359999999999999</c:v>
                </c:pt>
                <c:pt idx="2937">
                  <c:v>1.9369999999999998</c:v>
                </c:pt>
                <c:pt idx="2938">
                  <c:v>1.9380000000000002</c:v>
                </c:pt>
                <c:pt idx="2939">
                  <c:v>1.9390000000000001</c:v>
                </c:pt>
                <c:pt idx="2940">
                  <c:v>1.94</c:v>
                </c:pt>
                <c:pt idx="2941">
                  <c:v>1.9409999999999998</c:v>
                </c:pt>
                <c:pt idx="2942">
                  <c:v>1.9420000000000002</c:v>
                </c:pt>
                <c:pt idx="2943">
                  <c:v>1.9430000000000001</c:v>
                </c:pt>
                <c:pt idx="2944">
                  <c:v>1.944</c:v>
                </c:pt>
                <c:pt idx="2945">
                  <c:v>1.9449999999999998</c:v>
                </c:pt>
                <c:pt idx="2946">
                  <c:v>1.9460000000000002</c:v>
                </c:pt>
                <c:pt idx="2947">
                  <c:v>1.9470000000000001</c:v>
                </c:pt>
                <c:pt idx="2948">
                  <c:v>1.948</c:v>
                </c:pt>
                <c:pt idx="2949">
                  <c:v>1.9489999999999998</c:v>
                </c:pt>
                <c:pt idx="2950">
                  <c:v>1.9500000000000002</c:v>
                </c:pt>
                <c:pt idx="2951">
                  <c:v>1.9510000000000001</c:v>
                </c:pt>
                <c:pt idx="2952">
                  <c:v>1.952</c:v>
                </c:pt>
                <c:pt idx="2953">
                  <c:v>1.9529999999999998</c:v>
                </c:pt>
                <c:pt idx="2954">
                  <c:v>1.9540000000000002</c:v>
                </c:pt>
                <c:pt idx="2955">
                  <c:v>1.9550000000000001</c:v>
                </c:pt>
                <c:pt idx="2956">
                  <c:v>1.956</c:v>
                </c:pt>
                <c:pt idx="2957">
                  <c:v>1.9569999999999999</c:v>
                </c:pt>
                <c:pt idx="2958">
                  <c:v>1.9580000000000002</c:v>
                </c:pt>
                <c:pt idx="2959">
                  <c:v>1.9590000000000001</c:v>
                </c:pt>
                <c:pt idx="2960">
                  <c:v>1.96</c:v>
                </c:pt>
                <c:pt idx="2961">
                  <c:v>1.9609999999999999</c:v>
                </c:pt>
                <c:pt idx="2962">
                  <c:v>1.9620000000000002</c:v>
                </c:pt>
                <c:pt idx="2963">
                  <c:v>1.9630000000000001</c:v>
                </c:pt>
                <c:pt idx="2964">
                  <c:v>1.964</c:v>
                </c:pt>
                <c:pt idx="2965">
                  <c:v>1.9649999999999999</c:v>
                </c:pt>
                <c:pt idx="2966">
                  <c:v>1.9660000000000002</c:v>
                </c:pt>
                <c:pt idx="2967">
                  <c:v>1.9670000000000001</c:v>
                </c:pt>
                <c:pt idx="2968">
                  <c:v>1.968</c:v>
                </c:pt>
                <c:pt idx="2969">
                  <c:v>1.9689999999999999</c:v>
                </c:pt>
                <c:pt idx="2970">
                  <c:v>1.9700000000000002</c:v>
                </c:pt>
                <c:pt idx="2971">
                  <c:v>1.9710000000000001</c:v>
                </c:pt>
                <c:pt idx="2972">
                  <c:v>1.972</c:v>
                </c:pt>
                <c:pt idx="2973">
                  <c:v>1.9729999999999999</c:v>
                </c:pt>
                <c:pt idx="2974">
                  <c:v>1.9740000000000002</c:v>
                </c:pt>
                <c:pt idx="2975">
                  <c:v>1.9750000000000001</c:v>
                </c:pt>
                <c:pt idx="2976">
                  <c:v>1.976</c:v>
                </c:pt>
                <c:pt idx="2977">
                  <c:v>1.9769999999999999</c:v>
                </c:pt>
                <c:pt idx="2978">
                  <c:v>1.9780000000000002</c:v>
                </c:pt>
                <c:pt idx="2979">
                  <c:v>1.9790000000000001</c:v>
                </c:pt>
                <c:pt idx="2980">
                  <c:v>1.98</c:v>
                </c:pt>
                <c:pt idx="2981">
                  <c:v>1.9809999999999999</c:v>
                </c:pt>
                <c:pt idx="2982">
                  <c:v>1.9820000000000002</c:v>
                </c:pt>
                <c:pt idx="2983">
                  <c:v>1.9830000000000001</c:v>
                </c:pt>
                <c:pt idx="2984">
                  <c:v>1.984</c:v>
                </c:pt>
                <c:pt idx="2985">
                  <c:v>1.9849999999999999</c:v>
                </c:pt>
                <c:pt idx="2986">
                  <c:v>1.9860000000000002</c:v>
                </c:pt>
                <c:pt idx="2987">
                  <c:v>1.9870000000000001</c:v>
                </c:pt>
                <c:pt idx="2988">
                  <c:v>1.988</c:v>
                </c:pt>
                <c:pt idx="2989">
                  <c:v>1.9889999999999999</c:v>
                </c:pt>
                <c:pt idx="2990">
                  <c:v>1.9900000000000002</c:v>
                </c:pt>
                <c:pt idx="2991">
                  <c:v>1.9910000000000001</c:v>
                </c:pt>
                <c:pt idx="2992">
                  <c:v>1.992</c:v>
                </c:pt>
                <c:pt idx="2993">
                  <c:v>1.9929999999999999</c:v>
                </c:pt>
                <c:pt idx="2994">
                  <c:v>1.9940000000000002</c:v>
                </c:pt>
                <c:pt idx="2995">
                  <c:v>1.9950000000000001</c:v>
                </c:pt>
                <c:pt idx="2996">
                  <c:v>1.996</c:v>
                </c:pt>
                <c:pt idx="2997">
                  <c:v>1.9969999999999999</c:v>
                </c:pt>
                <c:pt idx="2998">
                  <c:v>1.9980000000000002</c:v>
                </c:pt>
                <c:pt idx="2999">
                  <c:v>1.9990000000000001</c:v>
                </c:pt>
                <c:pt idx="3000">
                  <c:v>2</c:v>
                </c:pt>
                <c:pt idx="3001">
                  <c:v>2.0009999999999999</c:v>
                </c:pt>
                <c:pt idx="3002">
                  <c:v>2.0019999999999998</c:v>
                </c:pt>
                <c:pt idx="3003">
                  <c:v>2.0030000000000001</c:v>
                </c:pt>
                <c:pt idx="3004">
                  <c:v>2.004</c:v>
                </c:pt>
                <c:pt idx="3005">
                  <c:v>2.0049999999999999</c:v>
                </c:pt>
                <c:pt idx="3006">
                  <c:v>2.0059999999999998</c:v>
                </c:pt>
                <c:pt idx="3007">
                  <c:v>2.0070000000000001</c:v>
                </c:pt>
                <c:pt idx="3008">
                  <c:v>2.008</c:v>
                </c:pt>
                <c:pt idx="3009">
                  <c:v>2.0089999999999999</c:v>
                </c:pt>
                <c:pt idx="3010">
                  <c:v>2.0099999999999998</c:v>
                </c:pt>
                <c:pt idx="3011">
                  <c:v>2.0110000000000001</c:v>
                </c:pt>
                <c:pt idx="3012">
                  <c:v>2.012</c:v>
                </c:pt>
                <c:pt idx="3013">
                  <c:v>2.0129999999999999</c:v>
                </c:pt>
                <c:pt idx="3014">
                  <c:v>2.0139999999999998</c:v>
                </c:pt>
                <c:pt idx="3015">
                  <c:v>2.0150000000000001</c:v>
                </c:pt>
                <c:pt idx="3016">
                  <c:v>2.016</c:v>
                </c:pt>
                <c:pt idx="3017">
                  <c:v>2.0169999999999999</c:v>
                </c:pt>
                <c:pt idx="3018">
                  <c:v>2.0179999999999998</c:v>
                </c:pt>
                <c:pt idx="3019">
                  <c:v>2.0190000000000001</c:v>
                </c:pt>
                <c:pt idx="3020">
                  <c:v>2.02</c:v>
                </c:pt>
                <c:pt idx="3021">
                  <c:v>2.0209999999999999</c:v>
                </c:pt>
                <c:pt idx="3022">
                  <c:v>2.0219999999999998</c:v>
                </c:pt>
                <c:pt idx="3023">
                  <c:v>2.0230000000000001</c:v>
                </c:pt>
                <c:pt idx="3024">
                  <c:v>2.024</c:v>
                </c:pt>
                <c:pt idx="3025">
                  <c:v>2.0249999999999999</c:v>
                </c:pt>
                <c:pt idx="3026">
                  <c:v>2.0259999999999998</c:v>
                </c:pt>
                <c:pt idx="3027">
                  <c:v>2.0270000000000001</c:v>
                </c:pt>
                <c:pt idx="3028">
                  <c:v>2.028</c:v>
                </c:pt>
                <c:pt idx="3029">
                  <c:v>2.0289999999999999</c:v>
                </c:pt>
                <c:pt idx="3030">
                  <c:v>2.0299999999999998</c:v>
                </c:pt>
                <c:pt idx="3031">
                  <c:v>2.0310000000000001</c:v>
                </c:pt>
                <c:pt idx="3032">
                  <c:v>2.032</c:v>
                </c:pt>
                <c:pt idx="3033">
                  <c:v>2.0329999999999999</c:v>
                </c:pt>
                <c:pt idx="3034">
                  <c:v>2.0339999999999998</c:v>
                </c:pt>
                <c:pt idx="3035">
                  <c:v>2.0350000000000001</c:v>
                </c:pt>
                <c:pt idx="3036">
                  <c:v>2.036</c:v>
                </c:pt>
                <c:pt idx="3037">
                  <c:v>2.0369999999999999</c:v>
                </c:pt>
                <c:pt idx="3038">
                  <c:v>2.0379999999999998</c:v>
                </c:pt>
                <c:pt idx="3039">
                  <c:v>2.0390000000000001</c:v>
                </c:pt>
                <c:pt idx="3040">
                  <c:v>2.04</c:v>
                </c:pt>
                <c:pt idx="3041">
                  <c:v>2.0409999999999999</c:v>
                </c:pt>
                <c:pt idx="3042">
                  <c:v>2.0419999999999998</c:v>
                </c:pt>
                <c:pt idx="3043">
                  <c:v>2.0430000000000001</c:v>
                </c:pt>
                <c:pt idx="3044">
                  <c:v>2.044</c:v>
                </c:pt>
                <c:pt idx="3045">
                  <c:v>2.0449999999999999</c:v>
                </c:pt>
                <c:pt idx="3046">
                  <c:v>2.0459999999999998</c:v>
                </c:pt>
                <c:pt idx="3047">
                  <c:v>2.0470000000000002</c:v>
                </c:pt>
                <c:pt idx="3048">
                  <c:v>2.048</c:v>
                </c:pt>
                <c:pt idx="3049">
                  <c:v>2.0489999999999999</c:v>
                </c:pt>
                <c:pt idx="3050">
                  <c:v>2.0499999999999998</c:v>
                </c:pt>
                <c:pt idx="3051">
                  <c:v>2.0510000000000002</c:v>
                </c:pt>
                <c:pt idx="3052">
                  <c:v>2.052</c:v>
                </c:pt>
                <c:pt idx="3053">
                  <c:v>2.0529999999999999</c:v>
                </c:pt>
                <c:pt idx="3054">
                  <c:v>2.0539999999999998</c:v>
                </c:pt>
                <c:pt idx="3055">
                  <c:v>2.0550000000000002</c:v>
                </c:pt>
                <c:pt idx="3056">
                  <c:v>2.056</c:v>
                </c:pt>
                <c:pt idx="3057">
                  <c:v>2.0569999999999999</c:v>
                </c:pt>
                <c:pt idx="3058">
                  <c:v>2.0579999999999998</c:v>
                </c:pt>
                <c:pt idx="3059">
                  <c:v>2.0590000000000002</c:v>
                </c:pt>
                <c:pt idx="3060">
                  <c:v>2.06</c:v>
                </c:pt>
                <c:pt idx="3061">
                  <c:v>2.0609999999999999</c:v>
                </c:pt>
                <c:pt idx="3062">
                  <c:v>2.0619999999999998</c:v>
                </c:pt>
                <c:pt idx="3063">
                  <c:v>2.0630000000000002</c:v>
                </c:pt>
                <c:pt idx="3064">
                  <c:v>2.0640000000000001</c:v>
                </c:pt>
                <c:pt idx="3065">
                  <c:v>2.0649999999999999</c:v>
                </c:pt>
                <c:pt idx="3066">
                  <c:v>2.0659999999999998</c:v>
                </c:pt>
                <c:pt idx="3067">
                  <c:v>2.0670000000000002</c:v>
                </c:pt>
                <c:pt idx="3068">
                  <c:v>2.0680000000000001</c:v>
                </c:pt>
                <c:pt idx="3069">
                  <c:v>2.069</c:v>
                </c:pt>
                <c:pt idx="3070">
                  <c:v>2.0699999999999998</c:v>
                </c:pt>
                <c:pt idx="3071">
                  <c:v>2.0710000000000002</c:v>
                </c:pt>
                <c:pt idx="3072">
                  <c:v>2.0720000000000001</c:v>
                </c:pt>
                <c:pt idx="3073">
                  <c:v>2.073</c:v>
                </c:pt>
                <c:pt idx="3074">
                  <c:v>2.0739999999999998</c:v>
                </c:pt>
                <c:pt idx="3075">
                  <c:v>2.0750000000000002</c:v>
                </c:pt>
                <c:pt idx="3076">
                  <c:v>2.0760000000000001</c:v>
                </c:pt>
                <c:pt idx="3077">
                  <c:v>2.077</c:v>
                </c:pt>
                <c:pt idx="3078">
                  <c:v>2.0779999999999998</c:v>
                </c:pt>
                <c:pt idx="3079">
                  <c:v>2.0790000000000002</c:v>
                </c:pt>
                <c:pt idx="3080">
                  <c:v>2.08</c:v>
                </c:pt>
                <c:pt idx="3081">
                  <c:v>2.081</c:v>
                </c:pt>
                <c:pt idx="3082">
                  <c:v>2.0819999999999999</c:v>
                </c:pt>
                <c:pt idx="3083">
                  <c:v>2.0830000000000002</c:v>
                </c:pt>
                <c:pt idx="3084">
                  <c:v>2.0840000000000001</c:v>
                </c:pt>
                <c:pt idx="3085">
                  <c:v>2.085</c:v>
                </c:pt>
                <c:pt idx="3086">
                  <c:v>2.0859999999999999</c:v>
                </c:pt>
                <c:pt idx="3087">
                  <c:v>2.0870000000000002</c:v>
                </c:pt>
                <c:pt idx="3088">
                  <c:v>2.0880000000000001</c:v>
                </c:pt>
                <c:pt idx="3089">
                  <c:v>2.089</c:v>
                </c:pt>
                <c:pt idx="3090">
                  <c:v>2.09</c:v>
                </c:pt>
                <c:pt idx="3091">
                  <c:v>2.0910000000000002</c:v>
                </c:pt>
                <c:pt idx="3092">
                  <c:v>2.0920000000000001</c:v>
                </c:pt>
                <c:pt idx="3093">
                  <c:v>2.093</c:v>
                </c:pt>
                <c:pt idx="3094">
                  <c:v>2.0939999999999999</c:v>
                </c:pt>
                <c:pt idx="3095">
                  <c:v>2.0950000000000002</c:v>
                </c:pt>
                <c:pt idx="3096">
                  <c:v>2.0960000000000001</c:v>
                </c:pt>
                <c:pt idx="3097">
                  <c:v>2.097</c:v>
                </c:pt>
                <c:pt idx="3098">
                  <c:v>2.0979999999999999</c:v>
                </c:pt>
                <c:pt idx="3099">
                  <c:v>2.0990000000000002</c:v>
                </c:pt>
                <c:pt idx="3100">
                  <c:v>2.1</c:v>
                </c:pt>
                <c:pt idx="3101">
                  <c:v>2.101</c:v>
                </c:pt>
                <c:pt idx="3102">
                  <c:v>2.1019999999999999</c:v>
                </c:pt>
                <c:pt idx="3103">
                  <c:v>2.1030000000000002</c:v>
                </c:pt>
                <c:pt idx="3104">
                  <c:v>2.1040000000000001</c:v>
                </c:pt>
                <c:pt idx="3105">
                  <c:v>2.105</c:v>
                </c:pt>
                <c:pt idx="3106">
                  <c:v>2.1059999999999999</c:v>
                </c:pt>
                <c:pt idx="3107">
                  <c:v>2.1070000000000002</c:v>
                </c:pt>
                <c:pt idx="3108">
                  <c:v>2.1080000000000001</c:v>
                </c:pt>
                <c:pt idx="3109">
                  <c:v>2.109</c:v>
                </c:pt>
                <c:pt idx="3110">
                  <c:v>2.11</c:v>
                </c:pt>
                <c:pt idx="3111">
                  <c:v>2.1110000000000002</c:v>
                </c:pt>
                <c:pt idx="3112">
                  <c:v>2.1120000000000001</c:v>
                </c:pt>
                <c:pt idx="3113">
                  <c:v>2.113</c:v>
                </c:pt>
                <c:pt idx="3114">
                  <c:v>2.1139999999999999</c:v>
                </c:pt>
                <c:pt idx="3115">
                  <c:v>2.1150000000000002</c:v>
                </c:pt>
                <c:pt idx="3116">
                  <c:v>2.1160000000000001</c:v>
                </c:pt>
                <c:pt idx="3117">
                  <c:v>2.117</c:v>
                </c:pt>
                <c:pt idx="3118">
                  <c:v>2.1179999999999999</c:v>
                </c:pt>
                <c:pt idx="3119">
                  <c:v>2.1190000000000002</c:v>
                </c:pt>
                <c:pt idx="3120">
                  <c:v>2.12</c:v>
                </c:pt>
                <c:pt idx="3121">
                  <c:v>2.121</c:v>
                </c:pt>
                <c:pt idx="3122">
                  <c:v>2.1219999999999999</c:v>
                </c:pt>
                <c:pt idx="3123">
                  <c:v>2.1230000000000002</c:v>
                </c:pt>
                <c:pt idx="3124">
                  <c:v>2.1240000000000001</c:v>
                </c:pt>
                <c:pt idx="3125">
                  <c:v>2.125</c:v>
                </c:pt>
                <c:pt idx="3126">
                  <c:v>2.1259999999999999</c:v>
                </c:pt>
                <c:pt idx="3127">
                  <c:v>2.1269999999999998</c:v>
                </c:pt>
                <c:pt idx="3128">
                  <c:v>2.1280000000000001</c:v>
                </c:pt>
                <c:pt idx="3129">
                  <c:v>2.129</c:v>
                </c:pt>
                <c:pt idx="3130">
                  <c:v>2.13</c:v>
                </c:pt>
                <c:pt idx="3131">
                  <c:v>2.1309999999999998</c:v>
                </c:pt>
                <c:pt idx="3132">
                  <c:v>2.1320000000000001</c:v>
                </c:pt>
                <c:pt idx="3133">
                  <c:v>2.133</c:v>
                </c:pt>
                <c:pt idx="3134">
                  <c:v>2.1339999999999999</c:v>
                </c:pt>
                <c:pt idx="3135">
                  <c:v>2.1349999999999998</c:v>
                </c:pt>
                <c:pt idx="3136">
                  <c:v>2.1360000000000001</c:v>
                </c:pt>
                <c:pt idx="3137">
                  <c:v>2.137</c:v>
                </c:pt>
                <c:pt idx="3138">
                  <c:v>2.1379999999999999</c:v>
                </c:pt>
                <c:pt idx="3139">
                  <c:v>2.1389999999999998</c:v>
                </c:pt>
                <c:pt idx="3140">
                  <c:v>2.14</c:v>
                </c:pt>
                <c:pt idx="3141">
                  <c:v>2.141</c:v>
                </c:pt>
                <c:pt idx="3142">
                  <c:v>2.1419999999999999</c:v>
                </c:pt>
                <c:pt idx="3143">
                  <c:v>2.1429999999999998</c:v>
                </c:pt>
                <c:pt idx="3144">
                  <c:v>2.1440000000000001</c:v>
                </c:pt>
                <c:pt idx="3145">
                  <c:v>2.145</c:v>
                </c:pt>
                <c:pt idx="3146">
                  <c:v>2.1459999999999999</c:v>
                </c:pt>
                <c:pt idx="3147">
                  <c:v>2.1469999999999998</c:v>
                </c:pt>
                <c:pt idx="3148">
                  <c:v>2.1480000000000001</c:v>
                </c:pt>
                <c:pt idx="3149">
                  <c:v>2.149</c:v>
                </c:pt>
                <c:pt idx="3150">
                  <c:v>2.15</c:v>
                </c:pt>
                <c:pt idx="3151">
                  <c:v>2.1509999999999998</c:v>
                </c:pt>
                <c:pt idx="3152">
                  <c:v>2.1520000000000001</c:v>
                </c:pt>
                <c:pt idx="3153">
                  <c:v>2.153</c:v>
                </c:pt>
                <c:pt idx="3154">
                  <c:v>2.1539999999999999</c:v>
                </c:pt>
                <c:pt idx="3155">
                  <c:v>2.1549999999999998</c:v>
                </c:pt>
                <c:pt idx="3156">
                  <c:v>2.1560000000000001</c:v>
                </c:pt>
                <c:pt idx="3157">
                  <c:v>2.157</c:v>
                </c:pt>
                <c:pt idx="3158">
                  <c:v>2.1579999999999999</c:v>
                </c:pt>
                <c:pt idx="3159">
                  <c:v>2.1589999999999998</c:v>
                </c:pt>
                <c:pt idx="3160">
                  <c:v>2.16</c:v>
                </c:pt>
                <c:pt idx="3161">
                  <c:v>2.161</c:v>
                </c:pt>
                <c:pt idx="3162">
                  <c:v>2.1619999999999999</c:v>
                </c:pt>
                <c:pt idx="3163">
                  <c:v>2.1629999999999998</c:v>
                </c:pt>
                <c:pt idx="3164">
                  <c:v>2.1640000000000001</c:v>
                </c:pt>
                <c:pt idx="3165">
                  <c:v>2.165</c:v>
                </c:pt>
                <c:pt idx="3166">
                  <c:v>2.1659999999999999</c:v>
                </c:pt>
                <c:pt idx="3167">
                  <c:v>2.1669999999999998</c:v>
                </c:pt>
                <c:pt idx="3168">
                  <c:v>2.1680000000000001</c:v>
                </c:pt>
                <c:pt idx="3169">
                  <c:v>2.169</c:v>
                </c:pt>
                <c:pt idx="3170">
                  <c:v>2.17</c:v>
                </c:pt>
                <c:pt idx="3171">
                  <c:v>2.1709999999999998</c:v>
                </c:pt>
                <c:pt idx="3172">
                  <c:v>2.1720000000000002</c:v>
                </c:pt>
                <c:pt idx="3173">
                  <c:v>2.173</c:v>
                </c:pt>
                <c:pt idx="3174">
                  <c:v>2.1739999999999999</c:v>
                </c:pt>
                <c:pt idx="3175">
                  <c:v>2.1749999999999998</c:v>
                </c:pt>
                <c:pt idx="3176">
                  <c:v>2.1760000000000002</c:v>
                </c:pt>
                <c:pt idx="3177">
                  <c:v>2.177</c:v>
                </c:pt>
                <c:pt idx="3178">
                  <c:v>2.1779999999999999</c:v>
                </c:pt>
                <c:pt idx="3179">
                  <c:v>2.1789999999999998</c:v>
                </c:pt>
                <c:pt idx="3180">
                  <c:v>2.1800000000000002</c:v>
                </c:pt>
                <c:pt idx="3181">
                  <c:v>2.181</c:v>
                </c:pt>
                <c:pt idx="3182">
                  <c:v>2.1819999999999999</c:v>
                </c:pt>
                <c:pt idx="3183">
                  <c:v>2.1829999999999998</c:v>
                </c:pt>
                <c:pt idx="3184">
                  <c:v>2.1840000000000002</c:v>
                </c:pt>
                <c:pt idx="3185">
                  <c:v>2.1850000000000001</c:v>
                </c:pt>
                <c:pt idx="3186">
                  <c:v>2.1859999999999999</c:v>
                </c:pt>
                <c:pt idx="3187">
                  <c:v>2.1869999999999998</c:v>
                </c:pt>
                <c:pt idx="3188">
                  <c:v>2.1880000000000002</c:v>
                </c:pt>
                <c:pt idx="3189">
                  <c:v>2.1890000000000001</c:v>
                </c:pt>
                <c:pt idx="3190">
                  <c:v>2.19</c:v>
                </c:pt>
                <c:pt idx="3191">
                  <c:v>2.1909999999999998</c:v>
                </c:pt>
                <c:pt idx="3192">
                  <c:v>2.1920000000000002</c:v>
                </c:pt>
                <c:pt idx="3193">
                  <c:v>2.1930000000000001</c:v>
                </c:pt>
                <c:pt idx="3194">
                  <c:v>2.194</c:v>
                </c:pt>
                <c:pt idx="3195">
                  <c:v>2.1949999999999998</c:v>
                </c:pt>
                <c:pt idx="3196">
                  <c:v>2.1960000000000002</c:v>
                </c:pt>
                <c:pt idx="3197">
                  <c:v>2.1970000000000001</c:v>
                </c:pt>
                <c:pt idx="3198">
                  <c:v>2.198</c:v>
                </c:pt>
                <c:pt idx="3199">
                  <c:v>2.1989999999999998</c:v>
                </c:pt>
                <c:pt idx="3200">
                  <c:v>2.2000000000000002</c:v>
                </c:pt>
                <c:pt idx="3201">
                  <c:v>2.2010000000000001</c:v>
                </c:pt>
                <c:pt idx="3202">
                  <c:v>2.202</c:v>
                </c:pt>
                <c:pt idx="3203">
                  <c:v>2.2029999999999998</c:v>
                </c:pt>
                <c:pt idx="3204">
                  <c:v>2.2040000000000002</c:v>
                </c:pt>
                <c:pt idx="3205">
                  <c:v>2.2050000000000001</c:v>
                </c:pt>
                <c:pt idx="3206">
                  <c:v>2.206</c:v>
                </c:pt>
                <c:pt idx="3207">
                  <c:v>2.2069999999999999</c:v>
                </c:pt>
                <c:pt idx="3208">
                  <c:v>2.2080000000000002</c:v>
                </c:pt>
                <c:pt idx="3209">
                  <c:v>2.2090000000000001</c:v>
                </c:pt>
                <c:pt idx="3210">
                  <c:v>2.21</c:v>
                </c:pt>
                <c:pt idx="3211">
                  <c:v>2.2109999999999999</c:v>
                </c:pt>
                <c:pt idx="3212">
                  <c:v>2.2120000000000002</c:v>
                </c:pt>
                <c:pt idx="3213">
                  <c:v>2.2130000000000001</c:v>
                </c:pt>
                <c:pt idx="3214">
                  <c:v>2.214</c:v>
                </c:pt>
                <c:pt idx="3215">
                  <c:v>2.2149999999999999</c:v>
                </c:pt>
                <c:pt idx="3216">
                  <c:v>2.2160000000000002</c:v>
                </c:pt>
                <c:pt idx="3217">
                  <c:v>2.2170000000000001</c:v>
                </c:pt>
                <c:pt idx="3218">
                  <c:v>2.218</c:v>
                </c:pt>
                <c:pt idx="3219">
                  <c:v>2.2189999999999999</c:v>
                </c:pt>
                <c:pt idx="3220">
                  <c:v>2.2200000000000002</c:v>
                </c:pt>
                <c:pt idx="3221">
                  <c:v>2.2210000000000001</c:v>
                </c:pt>
                <c:pt idx="3222">
                  <c:v>2.222</c:v>
                </c:pt>
                <c:pt idx="3223">
                  <c:v>2.2229999999999999</c:v>
                </c:pt>
                <c:pt idx="3224">
                  <c:v>2.2240000000000002</c:v>
                </c:pt>
                <c:pt idx="3225">
                  <c:v>2.2250000000000001</c:v>
                </c:pt>
                <c:pt idx="3226">
                  <c:v>2.226</c:v>
                </c:pt>
                <c:pt idx="3227">
                  <c:v>2.2269999999999999</c:v>
                </c:pt>
                <c:pt idx="3228">
                  <c:v>2.2280000000000002</c:v>
                </c:pt>
                <c:pt idx="3229">
                  <c:v>2.2290000000000001</c:v>
                </c:pt>
                <c:pt idx="3230">
                  <c:v>2.23</c:v>
                </c:pt>
                <c:pt idx="3231">
                  <c:v>2.2309999999999999</c:v>
                </c:pt>
                <c:pt idx="3232">
                  <c:v>2.2320000000000002</c:v>
                </c:pt>
                <c:pt idx="3233">
                  <c:v>2.2330000000000001</c:v>
                </c:pt>
                <c:pt idx="3234">
                  <c:v>2.234</c:v>
                </c:pt>
                <c:pt idx="3235">
                  <c:v>2.2349999999999999</c:v>
                </c:pt>
                <c:pt idx="3236">
                  <c:v>2.2360000000000002</c:v>
                </c:pt>
                <c:pt idx="3237">
                  <c:v>2.2370000000000001</c:v>
                </c:pt>
                <c:pt idx="3238">
                  <c:v>2.238</c:v>
                </c:pt>
                <c:pt idx="3239">
                  <c:v>2.2389999999999999</c:v>
                </c:pt>
                <c:pt idx="3240">
                  <c:v>2.2400000000000002</c:v>
                </c:pt>
                <c:pt idx="3241">
                  <c:v>2.2410000000000001</c:v>
                </c:pt>
                <c:pt idx="3242">
                  <c:v>2.242</c:v>
                </c:pt>
                <c:pt idx="3243">
                  <c:v>2.2429999999999999</c:v>
                </c:pt>
                <c:pt idx="3244">
                  <c:v>2.2440000000000002</c:v>
                </c:pt>
                <c:pt idx="3245">
                  <c:v>2.2450000000000001</c:v>
                </c:pt>
                <c:pt idx="3246">
                  <c:v>2.246</c:v>
                </c:pt>
                <c:pt idx="3247">
                  <c:v>2.2469999999999999</c:v>
                </c:pt>
                <c:pt idx="3248">
                  <c:v>2.2480000000000002</c:v>
                </c:pt>
                <c:pt idx="3249">
                  <c:v>2.2490000000000001</c:v>
                </c:pt>
                <c:pt idx="3250">
                  <c:v>2.25</c:v>
                </c:pt>
                <c:pt idx="3251">
                  <c:v>2.2509999999999999</c:v>
                </c:pt>
                <c:pt idx="3252">
                  <c:v>2.2519999999999998</c:v>
                </c:pt>
                <c:pt idx="3253">
                  <c:v>2.2530000000000001</c:v>
                </c:pt>
                <c:pt idx="3254">
                  <c:v>2.254</c:v>
                </c:pt>
                <c:pt idx="3255">
                  <c:v>2.2549999999999999</c:v>
                </c:pt>
                <c:pt idx="3256">
                  <c:v>2.2559999999999998</c:v>
                </c:pt>
                <c:pt idx="3257">
                  <c:v>2.2570000000000001</c:v>
                </c:pt>
                <c:pt idx="3258">
                  <c:v>2.258</c:v>
                </c:pt>
                <c:pt idx="3259">
                  <c:v>2.2589999999999999</c:v>
                </c:pt>
                <c:pt idx="3260">
                  <c:v>2.2599999999999998</c:v>
                </c:pt>
                <c:pt idx="3261">
                  <c:v>2.2610000000000001</c:v>
                </c:pt>
                <c:pt idx="3262">
                  <c:v>2.262</c:v>
                </c:pt>
                <c:pt idx="3263">
                  <c:v>2.2629999999999999</c:v>
                </c:pt>
                <c:pt idx="3264">
                  <c:v>2.2639999999999998</c:v>
                </c:pt>
                <c:pt idx="3265">
                  <c:v>2.2650000000000001</c:v>
                </c:pt>
                <c:pt idx="3266">
                  <c:v>2.266</c:v>
                </c:pt>
                <c:pt idx="3267">
                  <c:v>2.2669999999999999</c:v>
                </c:pt>
                <c:pt idx="3268">
                  <c:v>2.2679999999999998</c:v>
                </c:pt>
                <c:pt idx="3269">
                  <c:v>2.2690000000000001</c:v>
                </c:pt>
                <c:pt idx="3270">
                  <c:v>2.27</c:v>
                </c:pt>
                <c:pt idx="3271">
                  <c:v>2.2709999999999999</c:v>
                </c:pt>
                <c:pt idx="3272">
                  <c:v>2.2719999999999998</c:v>
                </c:pt>
                <c:pt idx="3273">
                  <c:v>2.2730000000000001</c:v>
                </c:pt>
                <c:pt idx="3274">
                  <c:v>2.274</c:v>
                </c:pt>
                <c:pt idx="3275">
                  <c:v>2.2749999999999999</c:v>
                </c:pt>
                <c:pt idx="3276">
                  <c:v>2.2759999999999998</c:v>
                </c:pt>
                <c:pt idx="3277">
                  <c:v>2.2770000000000001</c:v>
                </c:pt>
                <c:pt idx="3278">
                  <c:v>2.278</c:v>
                </c:pt>
                <c:pt idx="3279">
                  <c:v>2.2789999999999999</c:v>
                </c:pt>
                <c:pt idx="3280">
                  <c:v>2.2799999999999998</c:v>
                </c:pt>
                <c:pt idx="3281">
                  <c:v>2.2810000000000001</c:v>
                </c:pt>
                <c:pt idx="3282">
                  <c:v>2.282</c:v>
                </c:pt>
                <c:pt idx="3283">
                  <c:v>2.2829999999999999</c:v>
                </c:pt>
                <c:pt idx="3284">
                  <c:v>2.2839999999999998</c:v>
                </c:pt>
                <c:pt idx="3285">
                  <c:v>2.2850000000000001</c:v>
                </c:pt>
                <c:pt idx="3286">
                  <c:v>2.286</c:v>
                </c:pt>
                <c:pt idx="3287">
                  <c:v>2.2869999999999999</c:v>
                </c:pt>
                <c:pt idx="3288">
                  <c:v>2.2879999999999998</c:v>
                </c:pt>
                <c:pt idx="3289">
                  <c:v>2.2890000000000001</c:v>
                </c:pt>
                <c:pt idx="3290">
                  <c:v>2.29</c:v>
                </c:pt>
                <c:pt idx="3291">
                  <c:v>2.2909999999999999</c:v>
                </c:pt>
                <c:pt idx="3292">
                  <c:v>2.2919999999999998</c:v>
                </c:pt>
                <c:pt idx="3293">
                  <c:v>2.2930000000000001</c:v>
                </c:pt>
                <c:pt idx="3294">
                  <c:v>2.294</c:v>
                </c:pt>
                <c:pt idx="3295">
                  <c:v>2.2949999999999999</c:v>
                </c:pt>
                <c:pt idx="3296">
                  <c:v>2.2959999999999998</c:v>
                </c:pt>
                <c:pt idx="3297">
                  <c:v>2.2970000000000002</c:v>
                </c:pt>
                <c:pt idx="3298">
                  <c:v>2.298</c:v>
                </c:pt>
                <c:pt idx="3299">
                  <c:v>2.2989999999999999</c:v>
                </c:pt>
                <c:pt idx="3300">
                  <c:v>2.2999999999999998</c:v>
                </c:pt>
                <c:pt idx="3301">
                  <c:v>2.3010000000000002</c:v>
                </c:pt>
                <c:pt idx="3302">
                  <c:v>2.302</c:v>
                </c:pt>
                <c:pt idx="3303">
                  <c:v>2.3029999999999999</c:v>
                </c:pt>
                <c:pt idx="3304">
                  <c:v>2.3039999999999998</c:v>
                </c:pt>
                <c:pt idx="3305">
                  <c:v>2.3050000000000002</c:v>
                </c:pt>
                <c:pt idx="3306">
                  <c:v>2.306</c:v>
                </c:pt>
                <c:pt idx="3307">
                  <c:v>2.3069999999999999</c:v>
                </c:pt>
                <c:pt idx="3308">
                  <c:v>2.3079999999999998</c:v>
                </c:pt>
                <c:pt idx="3309">
                  <c:v>2.3090000000000002</c:v>
                </c:pt>
                <c:pt idx="3310">
                  <c:v>2.31</c:v>
                </c:pt>
                <c:pt idx="3311">
                  <c:v>2.3109999999999999</c:v>
                </c:pt>
                <c:pt idx="3312">
                  <c:v>2.3119999999999998</c:v>
                </c:pt>
                <c:pt idx="3313">
                  <c:v>2.3130000000000002</c:v>
                </c:pt>
                <c:pt idx="3314">
                  <c:v>2.3140000000000001</c:v>
                </c:pt>
                <c:pt idx="3315">
                  <c:v>2.3149999999999999</c:v>
                </c:pt>
                <c:pt idx="3316">
                  <c:v>2.3159999999999998</c:v>
                </c:pt>
                <c:pt idx="3317">
                  <c:v>2.3170000000000002</c:v>
                </c:pt>
                <c:pt idx="3318">
                  <c:v>2.3180000000000001</c:v>
                </c:pt>
                <c:pt idx="3319">
                  <c:v>2.319</c:v>
                </c:pt>
                <c:pt idx="3320">
                  <c:v>2.3199999999999998</c:v>
                </c:pt>
                <c:pt idx="3321">
                  <c:v>2.3210000000000002</c:v>
                </c:pt>
                <c:pt idx="3322">
                  <c:v>2.3220000000000001</c:v>
                </c:pt>
                <c:pt idx="3323">
                  <c:v>2.323</c:v>
                </c:pt>
                <c:pt idx="3324">
                  <c:v>2.3239999999999998</c:v>
                </c:pt>
                <c:pt idx="3325">
                  <c:v>2.3250000000000002</c:v>
                </c:pt>
                <c:pt idx="3326">
                  <c:v>2.3260000000000001</c:v>
                </c:pt>
                <c:pt idx="3327">
                  <c:v>2.327</c:v>
                </c:pt>
                <c:pt idx="3328">
                  <c:v>2.3279999999999998</c:v>
                </c:pt>
                <c:pt idx="3329">
                  <c:v>2.3290000000000002</c:v>
                </c:pt>
                <c:pt idx="3330">
                  <c:v>2.33</c:v>
                </c:pt>
                <c:pt idx="3331">
                  <c:v>2.331</c:v>
                </c:pt>
                <c:pt idx="3332">
                  <c:v>2.3319999999999999</c:v>
                </c:pt>
                <c:pt idx="3333">
                  <c:v>2.3330000000000002</c:v>
                </c:pt>
                <c:pt idx="3334">
                  <c:v>2.3340000000000001</c:v>
                </c:pt>
                <c:pt idx="3335">
                  <c:v>2.335</c:v>
                </c:pt>
                <c:pt idx="3336">
                  <c:v>2.3359999999999999</c:v>
                </c:pt>
                <c:pt idx="3337">
                  <c:v>2.3370000000000002</c:v>
                </c:pt>
                <c:pt idx="3338">
                  <c:v>2.3380000000000001</c:v>
                </c:pt>
                <c:pt idx="3339">
                  <c:v>2.339</c:v>
                </c:pt>
                <c:pt idx="3340">
                  <c:v>2.34</c:v>
                </c:pt>
                <c:pt idx="3341">
                  <c:v>2.3410000000000002</c:v>
                </c:pt>
                <c:pt idx="3342">
                  <c:v>2.3420000000000001</c:v>
                </c:pt>
                <c:pt idx="3343">
                  <c:v>2.343</c:v>
                </c:pt>
                <c:pt idx="3344">
                  <c:v>2.3439999999999999</c:v>
                </c:pt>
                <c:pt idx="3345">
                  <c:v>2.3450000000000002</c:v>
                </c:pt>
                <c:pt idx="3346">
                  <c:v>2.3460000000000001</c:v>
                </c:pt>
                <c:pt idx="3347">
                  <c:v>2.347</c:v>
                </c:pt>
                <c:pt idx="3348">
                  <c:v>2.3479999999999999</c:v>
                </c:pt>
                <c:pt idx="3349">
                  <c:v>2.3490000000000002</c:v>
                </c:pt>
                <c:pt idx="3350">
                  <c:v>2.35</c:v>
                </c:pt>
                <c:pt idx="3351">
                  <c:v>2.351</c:v>
                </c:pt>
                <c:pt idx="3352">
                  <c:v>2.3519999999999999</c:v>
                </c:pt>
                <c:pt idx="3353">
                  <c:v>2.3530000000000002</c:v>
                </c:pt>
                <c:pt idx="3354">
                  <c:v>2.3540000000000001</c:v>
                </c:pt>
                <c:pt idx="3355">
                  <c:v>2.355</c:v>
                </c:pt>
                <c:pt idx="3356">
                  <c:v>2.3559999999999999</c:v>
                </c:pt>
                <c:pt idx="3357">
                  <c:v>2.3570000000000002</c:v>
                </c:pt>
                <c:pt idx="3358">
                  <c:v>2.3580000000000001</c:v>
                </c:pt>
                <c:pt idx="3359">
                  <c:v>2.359</c:v>
                </c:pt>
                <c:pt idx="3360">
                  <c:v>2.36</c:v>
                </c:pt>
                <c:pt idx="3361">
                  <c:v>2.3610000000000002</c:v>
                </c:pt>
                <c:pt idx="3362">
                  <c:v>2.3620000000000001</c:v>
                </c:pt>
                <c:pt idx="3363">
                  <c:v>2.363</c:v>
                </c:pt>
                <c:pt idx="3364">
                  <c:v>2.3639999999999999</c:v>
                </c:pt>
                <c:pt idx="3365">
                  <c:v>2.3650000000000002</c:v>
                </c:pt>
                <c:pt idx="3366">
                  <c:v>2.3660000000000001</c:v>
                </c:pt>
                <c:pt idx="3367">
                  <c:v>2.367</c:v>
                </c:pt>
                <c:pt idx="3368">
                  <c:v>2.3679999999999999</c:v>
                </c:pt>
                <c:pt idx="3369">
                  <c:v>2.3690000000000002</c:v>
                </c:pt>
                <c:pt idx="3370">
                  <c:v>2.37</c:v>
                </c:pt>
                <c:pt idx="3371">
                  <c:v>2.371</c:v>
                </c:pt>
                <c:pt idx="3372">
                  <c:v>2.3719999999999999</c:v>
                </c:pt>
                <c:pt idx="3373">
                  <c:v>2.3730000000000002</c:v>
                </c:pt>
                <c:pt idx="3374">
                  <c:v>2.3740000000000001</c:v>
                </c:pt>
                <c:pt idx="3375">
                  <c:v>2.375</c:v>
                </c:pt>
                <c:pt idx="3376">
                  <c:v>2.3759999999999999</c:v>
                </c:pt>
                <c:pt idx="3377">
                  <c:v>2.3769999999999998</c:v>
                </c:pt>
                <c:pt idx="3378">
                  <c:v>2.3780000000000001</c:v>
                </c:pt>
                <c:pt idx="3379">
                  <c:v>2.379</c:v>
                </c:pt>
                <c:pt idx="3380">
                  <c:v>2.38</c:v>
                </c:pt>
                <c:pt idx="3381">
                  <c:v>2.3809999999999998</c:v>
                </c:pt>
                <c:pt idx="3382">
                  <c:v>2.3820000000000001</c:v>
                </c:pt>
                <c:pt idx="3383">
                  <c:v>2.383</c:v>
                </c:pt>
                <c:pt idx="3384">
                  <c:v>2.3839999999999999</c:v>
                </c:pt>
                <c:pt idx="3385">
                  <c:v>2.3849999999999998</c:v>
                </c:pt>
                <c:pt idx="3386">
                  <c:v>2.3860000000000001</c:v>
                </c:pt>
                <c:pt idx="3387">
                  <c:v>2.387</c:v>
                </c:pt>
                <c:pt idx="3388">
                  <c:v>2.3879999999999999</c:v>
                </c:pt>
                <c:pt idx="3389">
                  <c:v>2.3889999999999998</c:v>
                </c:pt>
                <c:pt idx="3390">
                  <c:v>2.39</c:v>
                </c:pt>
                <c:pt idx="3391">
                  <c:v>2.391</c:v>
                </c:pt>
                <c:pt idx="3392">
                  <c:v>2.3919999999999999</c:v>
                </c:pt>
                <c:pt idx="3393">
                  <c:v>2.3929999999999998</c:v>
                </c:pt>
                <c:pt idx="3394">
                  <c:v>2.3940000000000001</c:v>
                </c:pt>
                <c:pt idx="3395">
                  <c:v>2.395</c:v>
                </c:pt>
                <c:pt idx="3396">
                  <c:v>2.3959999999999999</c:v>
                </c:pt>
                <c:pt idx="3397">
                  <c:v>2.3969999999999998</c:v>
                </c:pt>
                <c:pt idx="3398">
                  <c:v>2.3980000000000001</c:v>
                </c:pt>
                <c:pt idx="3399">
                  <c:v>2.399</c:v>
                </c:pt>
                <c:pt idx="3400">
                  <c:v>2.4</c:v>
                </c:pt>
              </c:numCache>
            </c:numRef>
          </c:xVal>
          <c:yVal>
            <c:numRef>
              <c:f>Sheet1!$C$1:$C$3401</c:f>
              <c:numCache>
                <c:formatCode>General</c:formatCode>
                <c:ptCount val="3401"/>
                <c:pt idx="0">
                  <c:v>141.43</c:v>
                </c:pt>
                <c:pt idx="1">
                  <c:v>141.30000000000001</c:v>
                </c:pt>
                <c:pt idx="2">
                  <c:v>141.16</c:v>
                </c:pt>
                <c:pt idx="3">
                  <c:v>141.03</c:v>
                </c:pt>
                <c:pt idx="4">
                  <c:v>140.9</c:v>
                </c:pt>
                <c:pt idx="5">
                  <c:v>140.77000000000001</c:v>
                </c:pt>
                <c:pt idx="6">
                  <c:v>140.63999999999999</c:v>
                </c:pt>
                <c:pt idx="7">
                  <c:v>140.5</c:v>
                </c:pt>
                <c:pt idx="8">
                  <c:v>140.37</c:v>
                </c:pt>
                <c:pt idx="9">
                  <c:v>140.24</c:v>
                </c:pt>
                <c:pt idx="10">
                  <c:v>140.11000000000001</c:v>
                </c:pt>
                <c:pt idx="11">
                  <c:v>139.97999999999999</c:v>
                </c:pt>
                <c:pt idx="12">
                  <c:v>139.84</c:v>
                </c:pt>
                <c:pt idx="13">
                  <c:v>139.71</c:v>
                </c:pt>
                <c:pt idx="14">
                  <c:v>139.58000000000001</c:v>
                </c:pt>
                <c:pt idx="15">
                  <c:v>139.44999999999999</c:v>
                </c:pt>
                <c:pt idx="16">
                  <c:v>139.31</c:v>
                </c:pt>
                <c:pt idx="17">
                  <c:v>139.18</c:v>
                </c:pt>
                <c:pt idx="18">
                  <c:v>139.05000000000001</c:v>
                </c:pt>
                <c:pt idx="19">
                  <c:v>138.91999999999999</c:v>
                </c:pt>
                <c:pt idx="20">
                  <c:v>138.79</c:v>
                </c:pt>
                <c:pt idx="21">
                  <c:v>138.65</c:v>
                </c:pt>
                <c:pt idx="22">
                  <c:v>138.52000000000001</c:v>
                </c:pt>
                <c:pt idx="23">
                  <c:v>138.38999999999999</c:v>
                </c:pt>
                <c:pt idx="24">
                  <c:v>138.26</c:v>
                </c:pt>
                <c:pt idx="25">
                  <c:v>138.13</c:v>
                </c:pt>
                <c:pt idx="26">
                  <c:v>137.99</c:v>
                </c:pt>
                <c:pt idx="27">
                  <c:v>137.86000000000001</c:v>
                </c:pt>
                <c:pt idx="28">
                  <c:v>137.72999999999999</c:v>
                </c:pt>
                <c:pt idx="29">
                  <c:v>137.6</c:v>
                </c:pt>
                <c:pt idx="30">
                  <c:v>137.47</c:v>
                </c:pt>
                <c:pt idx="31">
                  <c:v>137.33000000000001</c:v>
                </c:pt>
                <c:pt idx="32">
                  <c:v>137.19999999999999</c:v>
                </c:pt>
                <c:pt idx="33">
                  <c:v>137.07</c:v>
                </c:pt>
                <c:pt idx="34">
                  <c:v>136.94</c:v>
                </c:pt>
                <c:pt idx="35">
                  <c:v>136.80000000000001</c:v>
                </c:pt>
                <c:pt idx="36">
                  <c:v>136.66999999999999</c:v>
                </c:pt>
                <c:pt idx="37">
                  <c:v>136.54</c:v>
                </c:pt>
                <c:pt idx="38">
                  <c:v>136.41</c:v>
                </c:pt>
                <c:pt idx="39">
                  <c:v>136.28</c:v>
                </c:pt>
                <c:pt idx="40">
                  <c:v>136.13999999999999</c:v>
                </c:pt>
                <c:pt idx="41">
                  <c:v>136.01</c:v>
                </c:pt>
                <c:pt idx="42">
                  <c:v>135.88</c:v>
                </c:pt>
                <c:pt idx="43">
                  <c:v>135.75</c:v>
                </c:pt>
                <c:pt idx="44">
                  <c:v>135.62</c:v>
                </c:pt>
                <c:pt idx="45">
                  <c:v>135.47999999999999</c:v>
                </c:pt>
                <c:pt idx="46">
                  <c:v>135.35</c:v>
                </c:pt>
                <c:pt idx="47">
                  <c:v>135.22</c:v>
                </c:pt>
                <c:pt idx="48">
                  <c:v>135.09</c:v>
                </c:pt>
                <c:pt idx="49">
                  <c:v>134.96</c:v>
                </c:pt>
                <c:pt idx="50">
                  <c:v>134.82</c:v>
                </c:pt>
                <c:pt idx="51">
                  <c:v>134.69</c:v>
                </c:pt>
                <c:pt idx="52">
                  <c:v>134.56</c:v>
                </c:pt>
                <c:pt idx="53">
                  <c:v>134.43</c:v>
                </c:pt>
                <c:pt idx="54">
                  <c:v>134.29</c:v>
                </c:pt>
                <c:pt idx="55">
                  <c:v>134.16</c:v>
                </c:pt>
                <c:pt idx="56">
                  <c:v>134.03</c:v>
                </c:pt>
                <c:pt idx="57">
                  <c:v>133.9</c:v>
                </c:pt>
                <c:pt idx="58">
                  <c:v>133.77000000000001</c:v>
                </c:pt>
                <c:pt idx="59">
                  <c:v>133.63</c:v>
                </c:pt>
                <c:pt idx="60">
                  <c:v>133.5</c:v>
                </c:pt>
                <c:pt idx="61">
                  <c:v>133.37</c:v>
                </c:pt>
                <c:pt idx="62">
                  <c:v>133.24</c:v>
                </c:pt>
                <c:pt idx="63">
                  <c:v>133.11000000000001</c:v>
                </c:pt>
                <c:pt idx="64">
                  <c:v>132.97</c:v>
                </c:pt>
                <c:pt idx="65">
                  <c:v>132.84</c:v>
                </c:pt>
                <c:pt idx="66">
                  <c:v>132.71</c:v>
                </c:pt>
                <c:pt idx="67">
                  <c:v>132.58000000000001</c:v>
                </c:pt>
                <c:pt idx="68">
                  <c:v>132.44999999999999</c:v>
                </c:pt>
                <c:pt idx="69">
                  <c:v>132.31</c:v>
                </c:pt>
                <c:pt idx="70">
                  <c:v>132.18</c:v>
                </c:pt>
                <c:pt idx="71">
                  <c:v>132.05000000000001</c:v>
                </c:pt>
                <c:pt idx="72">
                  <c:v>131.91999999999999</c:v>
                </c:pt>
                <c:pt idx="73">
                  <c:v>131.78</c:v>
                </c:pt>
                <c:pt idx="74">
                  <c:v>131.65</c:v>
                </c:pt>
                <c:pt idx="75">
                  <c:v>131.52000000000001</c:v>
                </c:pt>
                <c:pt idx="76">
                  <c:v>131.38999999999999</c:v>
                </c:pt>
                <c:pt idx="77">
                  <c:v>131.26</c:v>
                </c:pt>
                <c:pt idx="78">
                  <c:v>131.12</c:v>
                </c:pt>
                <c:pt idx="79">
                  <c:v>130.99</c:v>
                </c:pt>
                <c:pt idx="80">
                  <c:v>130.86000000000001</c:v>
                </c:pt>
                <c:pt idx="81">
                  <c:v>130.72999999999999</c:v>
                </c:pt>
                <c:pt idx="82">
                  <c:v>130.6</c:v>
                </c:pt>
                <c:pt idx="83">
                  <c:v>130.46</c:v>
                </c:pt>
                <c:pt idx="84">
                  <c:v>130.33000000000001</c:v>
                </c:pt>
                <c:pt idx="85">
                  <c:v>130.19999999999999</c:v>
                </c:pt>
                <c:pt idx="86">
                  <c:v>130.07</c:v>
                </c:pt>
                <c:pt idx="87">
                  <c:v>129.94</c:v>
                </c:pt>
                <c:pt idx="88">
                  <c:v>129.80000000000001</c:v>
                </c:pt>
                <c:pt idx="89">
                  <c:v>129.66999999999999</c:v>
                </c:pt>
                <c:pt idx="90">
                  <c:v>129.54</c:v>
                </c:pt>
                <c:pt idx="91">
                  <c:v>129.41</c:v>
                </c:pt>
                <c:pt idx="92">
                  <c:v>129.27000000000001</c:v>
                </c:pt>
                <c:pt idx="93">
                  <c:v>129.13999999999999</c:v>
                </c:pt>
                <c:pt idx="94">
                  <c:v>129.01</c:v>
                </c:pt>
                <c:pt idx="95">
                  <c:v>128.88</c:v>
                </c:pt>
                <c:pt idx="96">
                  <c:v>128.75</c:v>
                </c:pt>
                <c:pt idx="97">
                  <c:v>128.61000000000001</c:v>
                </c:pt>
                <c:pt idx="98">
                  <c:v>128.47999999999999</c:v>
                </c:pt>
                <c:pt idx="99">
                  <c:v>128.35</c:v>
                </c:pt>
                <c:pt idx="100">
                  <c:v>128.22</c:v>
                </c:pt>
                <c:pt idx="101">
                  <c:v>128.09</c:v>
                </c:pt>
                <c:pt idx="102">
                  <c:v>127.95</c:v>
                </c:pt>
                <c:pt idx="103">
                  <c:v>127.82</c:v>
                </c:pt>
                <c:pt idx="104">
                  <c:v>127.69</c:v>
                </c:pt>
                <c:pt idx="105">
                  <c:v>127.56</c:v>
                </c:pt>
                <c:pt idx="106">
                  <c:v>127.43</c:v>
                </c:pt>
                <c:pt idx="107">
                  <c:v>127.29</c:v>
                </c:pt>
                <c:pt idx="108">
                  <c:v>127.16</c:v>
                </c:pt>
                <c:pt idx="109">
                  <c:v>127.03</c:v>
                </c:pt>
                <c:pt idx="110">
                  <c:v>126.9</c:v>
                </c:pt>
                <c:pt idx="111">
                  <c:v>126.76</c:v>
                </c:pt>
                <c:pt idx="112">
                  <c:v>126.63</c:v>
                </c:pt>
                <c:pt idx="113">
                  <c:v>126.5</c:v>
                </c:pt>
                <c:pt idx="114">
                  <c:v>126.37</c:v>
                </c:pt>
                <c:pt idx="115">
                  <c:v>126.24</c:v>
                </c:pt>
                <c:pt idx="116">
                  <c:v>126.1</c:v>
                </c:pt>
                <c:pt idx="117">
                  <c:v>125.97</c:v>
                </c:pt>
                <c:pt idx="118">
                  <c:v>125.84</c:v>
                </c:pt>
                <c:pt idx="119">
                  <c:v>125.71</c:v>
                </c:pt>
                <c:pt idx="120">
                  <c:v>125.58</c:v>
                </c:pt>
                <c:pt idx="121">
                  <c:v>125.44</c:v>
                </c:pt>
                <c:pt idx="122">
                  <c:v>125.31</c:v>
                </c:pt>
                <c:pt idx="123">
                  <c:v>125.18</c:v>
                </c:pt>
                <c:pt idx="124">
                  <c:v>125.05</c:v>
                </c:pt>
                <c:pt idx="125">
                  <c:v>124.92</c:v>
                </c:pt>
                <c:pt idx="126">
                  <c:v>124.78</c:v>
                </c:pt>
                <c:pt idx="127">
                  <c:v>124.65</c:v>
                </c:pt>
                <c:pt idx="128">
                  <c:v>124.52</c:v>
                </c:pt>
                <c:pt idx="129">
                  <c:v>124.39</c:v>
                </c:pt>
                <c:pt idx="130">
                  <c:v>124.25</c:v>
                </c:pt>
                <c:pt idx="131">
                  <c:v>124.12</c:v>
                </c:pt>
                <c:pt idx="132">
                  <c:v>123.99</c:v>
                </c:pt>
                <c:pt idx="133">
                  <c:v>123.86</c:v>
                </c:pt>
                <c:pt idx="134">
                  <c:v>123.73</c:v>
                </c:pt>
                <c:pt idx="135">
                  <c:v>123.59</c:v>
                </c:pt>
                <c:pt idx="136">
                  <c:v>123.46</c:v>
                </c:pt>
                <c:pt idx="137">
                  <c:v>123.33</c:v>
                </c:pt>
                <c:pt idx="138">
                  <c:v>123.2</c:v>
                </c:pt>
                <c:pt idx="139">
                  <c:v>123.07</c:v>
                </c:pt>
                <c:pt idx="140">
                  <c:v>122.93</c:v>
                </c:pt>
                <c:pt idx="141">
                  <c:v>122.8</c:v>
                </c:pt>
                <c:pt idx="142">
                  <c:v>122.67</c:v>
                </c:pt>
                <c:pt idx="143">
                  <c:v>122.54</c:v>
                </c:pt>
                <c:pt idx="144">
                  <c:v>122.41</c:v>
                </c:pt>
                <c:pt idx="145">
                  <c:v>122.27</c:v>
                </c:pt>
                <c:pt idx="146">
                  <c:v>122.14</c:v>
                </c:pt>
                <c:pt idx="147">
                  <c:v>122.01</c:v>
                </c:pt>
                <c:pt idx="148">
                  <c:v>121.88</c:v>
                </c:pt>
                <c:pt idx="149">
                  <c:v>121.74</c:v>
                </c:pt>
                <c:pt idx="150">
                  <c:v>121.61</c:v>
                </c:pt>
                <c:pt idx="151">
                  <c:v>121.48</c:v>
                </c:pt>
                <c:pt idx="152">
                  <c:v>121.35</c:v>
                </c:pt>
                <c:pt idx="153">
                  <c:v>121.22</c:v>
                </c:pt>
                <c:pt idx="154">
                  <c:v>121.08</c:v>
                </c:pt>
                <c:pt idx="155">
                  <c:v>120.95</c:v>
                </c:pt>
                <c:pt idx="156">
                  <c:v>120.82</c:v>
                </c:pt>
                <c:pt idx="157">
                  <c:v>120.69</c:v>
                </c:pt>
                <c:pt idx="158">
                  <c:v>120.56</c:v>
                </c:pt>
                <c:pt idx="159">
                  <c:v>120.42</c:v>
                </c:pt>
                <c:pt idx="160">
                  <c:v>120.29</c:v>
                </c:pt>
                <c:pt idx="161">
                  <c:v>120.16</c:v>
                </c:pt>
                <c:pt idx="162">
                  <c:v>120.03</c:v>
                </c:pt>
                <c:pt idx="163">
                  <c:v>119.9</c:v>
                </c:pt>
                <c:pt idx="164">
                  <c:v>119.76</c:v>
                </c:pt>
                <c:pt idx="165">
                  <c:v>119.63</c:v>
                </c:pt>
                <c:pt idx="166">
                  <c:v>119.5</c:v>
                </c:pt>
                <c:pt idx="167">
                  <c:v>119.37</c:v>
                </c:pt>
                <c:pt idx="168">
                  <c:v>119.23</c:v>
                </c:pt>
                <c:pt idx="169">
                  <c:v>119.1</c:v>
                </c:pt>
                <c:pt idx="170">
                  <c:v>118.97</c:v>
                </c:pt>
                <c:pt idx="171">
                  <c:v>118.84</c:v>
                </c:pt>
                <c:pt idx="172">
                  <c:v>118.71</c:v>
                </c:pt>
                <c:pt idx="173">
                  <c:v>118.57</c:v>
                </c:pt>
                <c:pt idx="174">
                  <c:v>118.44</c:v>
                </c:pt>
                <c:pt idx="175">
                  <c:v>118.31</c:v>
                </c:pt>
                <c:pt idx="176">
                  <c:v>118.18</c:v>
                </c:pt>
                <c:pt idx="177">
                  <c:v>118.05</c:v>
                </c:pt>
                <c:pt idx="178">
                  <c:v>117.91</c:v>
                </c:pt>
                <c:pt idx="179">
                  <c:v>117.78</c:v>
                </c:pt>
                <c:pt idx="180">
                  <c:v>117.65</c:v>
                </c:pt>
                <c:pt idx="181">
                  <c:v>117.52</c:v>
                </c:pt>
                <c:pt idx="182">
                  <c:v>117.39</c:v>
                </c:pt>
                <c:pt idx="183">
                  <c:v>117.25</c:v>
                </c:pt>
                <c:pt idx="184">
                  <c:v>117.12</c:v>
                </c:pt>
                <c:pt idx="185">
                  <c:v>116.99</c:v>
                </c:pt>
                <c:pt idx="186">
                  <c:v>116.86</c:v>
                </c:pt>
                <c:pt idx="187">
                  <c:v>116.72</c:v>
                </c:pt>
                <c:pt idx="188">
                  <c:v>116.59</c:v>
                </c:pt>
                <c:pt idx="189">
                  <c:v>116.46</c:v>
                </c:pt>
                <c:pt idx="190">
                  <c:v>116.33</c:v>
                </c:pt>
                <c:pt idx="191">
                  <c:v>116.2</c:v>
                </c:pt>
                <c:pt idx="192">
                  <c:v>116.06</c:v>
                </c:pt>
                <c:pt idx="193">
                  <c:v>115.93</c:v>
                </c:pt>
                <c:pt idx="194">
                  <c:v>115.8</c:v>
                </c:pt>
                <c:pt idx="195">
                  <c:v>115.67</c:v>
                </c:pt>
                <c:pt idx="196">
                  <c:v>115.54</c:v>
                </c:pt>
                <c:pt idx="197">
                  <c:v>115.4</c:v>
                </c:pt>
                <c:pt idx="198">
                  <c:v>115.27</c:v>
                </c:pt>
                <c:pt idx="199">
                  <c:v>115.14</c:v>
                </c:pt>
                <c:pt idx="200">
                  <c:v>115.01</c:v>
                </c:pt>
                <c:pt idx="201">
                  <c:v>114.88</c:v>
                </c:pt>
                <c:pt idx="202">
                  <c:v>114.74</c:v>
                </c:pt>
                <c:pt idx="203">
                  <c:v>114.61</c:v>
                </c:pt>
                <c:pt idx="204">
                  <c:v>114.48</c:v>
                </c:pt>
                <c:pt idx="205">
                  <c:v>114.35</c:v>
                </c:pt>
                <c:pt idx="206">
                  <c:v>114.21</c:v>
                </c:pt>
                <c:pt idx="207">
                  <c:v>114.08</c:v>
                </c:pt>
                <c:pt idx="208">
                  <c:v>113.95</c:v>
                </c:pt>
                <c:pt idx="209">
                  <c:v>113.82</c:v>
                </c:pt>
                <c:pt idx="210">
                  <c:v>113.69</c:v>
                </c:pt>
                <c:pt idx="211">
                  <c:v>113.55</c:v>
                </c:pt>
                <c:pt idx="212">
                  <c:v>113.42</c:v>
                </c:pt>
                <c:pt idx="213">
                  <c:v>113.29</c:v>
                </c:pt>
                <c:pt idx="214">
                  <c:v>113.16</c:v>
                </c:pt>
                <c:pt idx="215">
                  <c:v>113.03</c:v>
                </c:pt>
                <c:pt idx="216">
                  <c:v>112.89</c:v>
                </c:pt>
                <c:pt idx="217">
                  <c:v>112.76</c:v>
                </c:pt>
                <c:pt idx="218">
                  <c:v>112.63</c:v>
                </c:pt>
                <c:pt idx="219">
                  <c:v>112.5</c:v>
                </c:pt>
                <c:pt idx="220">
                  <c:v>112.37</c:v>
                </c:pt>
                <c:pt idx="221">
                  <c:v>112.23</c:v>
                </c:pt>
                <c:pt idx="222">
                  <c:v>112.1</c:v>
                </c:pt>
                <c:pt idx="223">
                  <c:v>111.97</c:v>
                </c:pt>
                <c:pt idx="224">
                  <c:v>111.84</c:v>
                </c:pt>
                <c:pt idx="225">
                  <c:v>111.7</c:v>
                </c:pt>
                <c:pt idx="226">
                  <c:v>111.57</c:v>
                </c:pt>
                <c:pt idx="227">
                  <c:v>111.44</c:v>
                </c:pt>
                <c:pt idx="228">
                  <c:v>111.31</c:v>
                </c:pt>
                <c:pt idx="229">
                  <c:v>111.18</c:v>
                </c:pt>
                <c:pt idx="230">
                  <c:v>111.04</c:v>
                </c:pt>
                <c:pt idx="231">
                  <c:v>110.91</c:v>
                </c:pt>
                <c:pt idx="232">
                  <c:v>110.78</c:v>
                </c:pt>
                <c:pt idx="233">
                  <c:v>110.65</c:v>
                </c:pt>
                <c:pt idx="234">
                  <c:v>110.52</c:v>
                </c:pt>
                <c:pt idx="235">
                  <c:v>110.38</c:v>
                </c:pt>
                <c:pt idx="236">
                  <c:v>110.25</c:v>
                </c:pt>
                <c:pt idx="237">
                  <c:v>110.12</c:v>
                </c:pt>
                <c:pt idx="238">
                  <c:v>109.99</c:v>
                </c:pt>
                <c:pt idx="239">
                  <c:v>109.86</c:v>
                </c:pt>
                <c:pt idx="240">
                  <c:v>109.72</c:v>
                </c:pt>
                <c:pt idx="241">
                  <c:v>109.59</c:v>
                </c:pt>
                <c:pt idx="242">
                  <c:v>109.46</c:v>
                </c:pt>
                <c:pt idx="243">
                  <c:v>109.33</c:v>
                </c:pt>
                <c:pt idx="244">
                  <c:v>109.19</c:v>
                </c:pt>
                <c:pt idx="245">
                  <c:v>109.06</c:v>
                </c:pt>
                <c:pt idx="246">
                  <c:v>108.93</c:v>
                </c:pt>
                <c:pt idx="247">
                  <c:v>108.8</c:v>
                </c:pt>
                <c:pt idx="248">
                  <c:v>108.67</c:v>
                </c:pt>
                <c:pt idx="249">
                  <c:v>108.53</c:v>
                </c:pt>
                <c:pt idx="250">
                  <c:v>108.4</c:v>
                </c:pt>
                <c:pt idx="251">
                  <c:v>108.27</c:v>
                </c:pt>
                <c:pt idx="252">
                  <c:v>108.14</c:v>
                </c:pt>
                <c:pt idx="253">
                  <c:v>108.01</c:v>
                </c:pt>
                <c:pt idx="254">
                  <c:v>107.87</c:v>
                </c:pt>
                <c:pt idx="255">
                  <c:v>107.74</c:v>
                </c:pt>
                <c:pt idx="256">
                  <c:v>107.61</c:v>
                </c:pt>
                <c:pt idx="257">
                  <c:v>107.48</c:v>
                </c:pt>
                <c:pt idx="258">
                  <c:v>107.35</c:v>
                </c:pt>
                <c:pt idx="259">
                  <c:v>107.21</c:v>
                </c:pt>
                <c:pt idx="260">
                  <c:v>107.08</c:v>
                </c:pt>
                <c:pt idx="261">
                  <c:v>106.95</c:v>
                </c:pt>
                <c:pt idx="262">
                  <c:v>106.82</c:v>
                </c:pt>
                <c:pt idx="263">
                  <c:v>106.68</c:v>
                </c:pt>
                <c:pt idx="264">
                  <c:v>106.55</c:v>
                </c:pt>
                <c:pt idx="265">
                  <c:v>106.42</c:v>
                </c:pt>
                <c:pt idx="266">
                  <c:v>106.29</c:v>
                </c:pt>
                <c:pt idx="267">
                  <c:v>106.16</c:v>
                </c:pt>
                <c:pt idx="268">
                  <c:v>106.02</c:v>
                </c:pt>
                <c:pt idx="269">
                  <c:v>105.89</c:v>
                </c:pt>
                <c:pt idx="270">
                  <c:v>105.76</c:v>
                </c:pt>
                <c:pt idx="271">
                  <c:v>105.63</c:v>
                </c:pt>
                <c:pt idx="272">
                  <c:v>105.5</c:v>
                </c:pt>
                <c:pt idx="273">
                  <c:v>105.36</c:v>
                </c:pt>
                <c:pt idx="274">
                  <c:v>105.23</c:v>
                </c:pt>
                <c:pt idx="275">
                  <c:v>105.1</c:v>
                </c:pt>
                <c:pt idx="276">
                  <c:v>104.97</c:v>
                </c:pt>
                <c:pt idx="277">
                  <c:v>104.84</c:v>
                </c:pt>
                <c:pt idx="278">
                  <c:v>104.7</c:v>
                </c:pt>
                <c:pt idx="279">
                  <c:v>104.57</c:v>
                </c:pt>
                <c:pt idx="280">
                  <c:v>104.44</c:v>
                </c:pt>
                <c:pt idx="281">
                  <c:v>104.31</c:v>
                </c:pt>
                <c:pt idx="282">
                  <c:v>104.17</c:v>
                </c:pt>
                <c:pt idx="283">
                  <c:v>104.04</c:v>
                </c:pt>
                <c:pt idx="284">
                  <c:v>103.91</c:v>
                </c:pt>
                <c:pt idx="285">
                  <c:v>103.78</c:v>
                </c:pt>
                <c:pt idx="286">
                  <c:v>103.65</c:v>
                </c:pt>
                <c:pt idx="287">
                  <c:v>103.51</c:v>
                </c:pt>
                <c:pt idx="288">
                  <c:v>103.38</c:v>
                </c:pt>
                <c:pt idx="289">
                  <c:v>103.25</c:v>
                </c:pt>
                <c:pt idx="290">
                  <c:v>103.12</c:v>
                </c:pt>
                <c:pt idx="291">
                  <c:v>102.99</c:v>
                </c:pt>
                <c:pt idx="292">
                  <c:v>102.85</c:v>
                </c:pt>
                <c:pt idx="293">
                  <c:v>102.72</c:v>
                </c:pt>
                <c:pt idx="294">
                  <c:v>102.59</c:v>
                </c:pt>
                <c:pt idx="295">
                  <c:v>102.46</c:v>
                </c:pt>
                <c:pt idx="296">
                  <c:v>102.33</c:v>
                </c:pt>
                <c:pt idx="297">
                  <c:v>102.19</c:v>
                </c:pt>
                <c:pt idx="298">
                  <c:v>102.06</c:v>
                </c:pt>
                <c:pt idx="299">
                  <c:v>101.93</c:v>
                </c:pt>
                <c:pt idx="300">
                  <c:v>101.8</c:v>
                </c:pt>
                <c:pt idx="301">
                  <c:v>101.66</c:v>
                </c:pt>
                <c:pt idx="302">
                  <c:v>101.53</c:v>
                </c:pt>
                <c:pt idx="303">
                  <c:v>101.4</c:v>
                </c:pt>
                <c:pt idx="304">
                  <c:v>101.27</c:v>
                </c:pt>
                <c:pt idx="305">
                  <c:v>101.14</c:v>
                </c:pt>
                <c:pt idx="306">
                  <c:v>101</c:v>
                </c:pt>
                <c:pt idx="307">
                  <c:v>100.87</c:v>
                </c:pt>
                <c:pt idx="308">
                  <c:v>100.74</c:v>
                </c:pt>
                <c:pt idx="309">
                  <c:v>100.61</c:v>
                </c:pt>
                <c:pt idx="310">
                  <c:v>100.48</c:v>
                </c:pt>
                <c:pt idx="311">
                  <c:v>100.34</c:v>
                </c:pt>
                <c:pt idx="312">
                  <c:v>100.21</c:v>
                </c:pt>
                <c:pt idx="313">
                  <c:v>100.08</c:v>
                </c:pt>
                <c:pt idx="314">
                  <c:v>99.947000000000003</c:v>
                </c:pt>
                <c:pt idx="315">
                  <c:v>99.814999999999998</c:v>
                </c:pt>
                <c:pt idx="316">
                  <c:v>99.683000000000007</c:v>
                </c:pt>
                <c:pt idx="317">
                  <c:v>99.551000000000002</c:v>
                </c:pt>
                <c:pt idx="318">
                  <c:v>99.418999999999997</c:v>
                </c:pt>
                <c:pt idx="319">
                  <c:v>99.287000000000006</c:v>
                </c:pt>
                <c:pt idx="320">
                  <c:v>99.155000000000001</c:v>
                </c:pt>
                <c:pt idx="321">
                  <c:v>99.022999999999996</c:v>
                </c:pt>
                <c:pt idx="322">
                  <c:v>98.89</c:v>
                </c:pt>
                <c:pt idx="323">
                  <c:v>98.757999999999996</c:v>
                </c:pt>
                <c:pt idx="324">
                  <c:v>98.626000000000005</c:v>
                </c:pt>
                <c:pt idx="325">
                  <c:v>98.494</c:v>
                </c:pt>
                <c:pt idx="326">
                  <c:v>98.361999999999995</c:v>
                </c:pt>
                <c:pt idx="327">
                  <c:v>98.23</c:v>
                </c:pt>
                <c:pt idx="328">
                  <c:v>98.097999999999999</c:v>
                </c:pt>
                <c:pt idx="329">
                  <c:v>97.965999999999994</c:v>
                </c:pt>
                <c:pt idx="330">
                  <c:v>97.834000000000003</c:v>
                </c:pt>
                <c:pt idx="331">
                  <c:v>97.700999999999993</c:v>
                </c:pt>
                <c:pt idx="332">
                  <c:v>97.569000000000003</c:v>
                </c:pt>
                <c:pt idx="333">
                  <c:v>97.436999999999998</c:v>
                </c:pt>
                <c:pt idx="334">
                  <c:v>97.305000000000007</c:v>
                </c:pt>
                <c:pt idx="335">
                  <c:v>97.173000000000002</c:v>
                </c:pt>
                <c:pt idx="336">
                  <c:v>97.040999999999997</c:v>
                </c:pt>
                <c:pt idx="337">
                  <c:v>96.909000000000006</c:v>
                </c:pt>
                <c:pt idx="338">
                  <c:v>96.777000000000001</c:v>
                </c:pt>
                <c:pt idx="339">
                  <c:v>96.644999999999996</c:v>
                </c:pt>
                <c:pt idx="340">
                  <c:v>96.513000000000005</c:v>
                </c:pt>
                <c:pt idx="341">
                  <c:v>96.38</c:v>
                </c:pt>
                <c:pt idx="342">
                  <c:v>96.248000000000005</c:v>
                </c:pt>
                <c:pt idx="343">
                  <c:v>96.116</c:v>
                </c:pt>
                <c:pt idx="344">
                  <c:v>95.983999999999995</c:v>
                </c:pt>
                <c:pt idx="345">
                  <c:v>95.852000000000004</c:v>
                </c:pt>
                <c:pt idx="346">
                  <c:v>95.72</c:v>
                </c:pt>
                <c:pt idx="347">
                  <c:v>95.587999999999994</c:v>
                </c:pt>
                <c:pt idx="348">
                  <c:v>95.456000000000003</c:v>
                </c:pt>
                <c:pt idx="349">
                  <c:v>95.323999999999998</c:v>
                </c:pt>
                <c:pt idx="350">
                  <c:v>95.191000000000003</c:v>
                </c:pt>
                <c:pt idx="351">
                  <c:v>95.058999999999997</c:v>
                </c:pt>
                <c:pt idx="352">
                  <c:v>94.927000000000007</c:v>
                </c:pt>
                <c:pt idx="353">
                  <c:v>94.795000000000002</c:v>
                </c:pt>
                <c:pt idx="354">
                  <c:v>94.662999999999997</c:v>
                </c:pt>
                <c:pt idx="355">
                  <c:v>94.531000000000006</c:v>
                </c:pt>
                <c:pt idx="356">
                  <c:v>94.399000000000001</c:v>
                </c:pt>
                <c:pt idx="357">
                  <c:v>94.266999999999996</c:v>
                </c:pt>
                <c:pt idx="358">
                  <c:v>94.135000000000005</c:v>
                </c:pt>
                <c:pt idx="359">
                  <c:v>94.001999999999995</c:v>
                </c:pt>
                <c:pt idx="360">
                  <c:v>93.87</c:v>
                </c:pt>
                <c:pt idx="361">
                  <c:v>93.738</c:v>
                </c:pt>
                <c:pt idx="362">
                  <c:v>93.605999999999995</c:v>
                </c:pt>
                <c:pt idx="363">
                  <c:v>93.474000000000004</c:v>
                </c:pt>
                <c:pt idx="364">
                  <c:v>93.341999999999999</c:v>
                </c:pt>
                <c:pt idx="365">
                  <c:v>93.21</c:v>
                </c:pt>
                <c:pt idx="366">
                  <c:v>93.078000000000003</c:v>
                </c:pt>
                <c:pt idx="367">
                  <c:v>92.945999999999998</c:v>
                </c:pt>
                <c:pt idx="368">
                  <c:v>92.813999999999993</c:v>
                </c:pt>
                <c:pt idx="369">
                  <c:v>92.680999999999997</c:v>
                </c:pt>
                <c:pt idx="370">
                  <c:v>92.549000000000007</c:v>
                </c:pt>
                <c:pt idx="371">
                  <c:v>92.417000000000002</c:v>
                </c:pt>
                <c:pt idx="372">
                  <c:v>92.284999999999997</c:v>
                </c:pt>
                <c:pt idx="373">
                  <c:v>92.153000000000006</c:v>
                </c:pt>
                <c:pt idx="374">
                  <c:v>92.021000000000001</c:v>
                </c:pt>
                <c:pt idx="375">
                  <c:v>91.888999999999996</c:v>
                </c:pt>
                <c:pt idx="376">
                  <c:v>91.757000000000005</c:v>
                </c:pt>
                <c:pt idx="377">
                  <c:v>91.625</c:v>
                </c:pt>
                <c:pt idx="378">
                  <c:v>91.492000000000004</c:v>
                </c:pt>
                <c:pt idx="379">
                  <c:v>91.36</c:v>
                </c:pt>
                <c:pt idx="380">
                  <c:v>91.227999999999994</c:v>
                </c:pt>
                <c:pt idx="381">
                  <c:v>91.096000000000004</c:v>
                </c:pt>
                <c:pt idx="382">
                  <c:v>90.963999999999999</c:v>
                </c:pt>
                <c:pt idx="383">
                  <c:v>90.831999999999994</c:v>
                </c:pt>
                <c:pt idx="384">
                  <c:v>90.7</c:v>
                </c:pt>
                <c:pt idx="385">
                  <c:v>90.567999999999998</c:v>
                </c:pt>
                <c:pt idx="386">
                  <c:v>90.436000000000007</c:v>
                </c:pt>
                <c:pt idx="387">
                  <c:v>90.304000000000002</c:v>
                </c:pt>
                <c:pt idx="388">
                  <c:v>90.171000000000006</c:v>
                </c:pt>
                <c:pt idx="389">
                  <c:v>90.039000000000001</c:v>
                </c:pt>
                <c:pt idx="390">
                  <c:v>89.906999999999996</c:v>
                </c:pt>
                <c:pt idx="391">
                  <c:v>89.775000000000006</c:v>
                </c:pt>
                <c:pt idx="392">
                  <c:v>89.643000000000001</c:v>
                </c:pt>
                <c:pt idx="393">
                  <c:v>89.510999999999996</c:v>
                </c:pt>
                <c:pt idx="394">
                  <c:v>89.379000000000005</c:v>
                </c:pt>
                <c:pt idx="395">
                  <c:v>89.247</c:v>
                </c:pt>
                <c:pt idx="396">
                  <c:v>89.114999999999995</c:v>
                </c:pt>
                <c:pt idx="397">
                  <c:v>88.981999999999999</c:v>
                </c:pt>
                <c:pt idx="398">
                  <c:v>88.85</c:v>
                </c:pt>
                <c:pt idx="399">
                  <c:v>88.718000000000004</c:v>
                </c:pt>
                <c:pt idx="400">
                  <c:v>88.585999999999999</c:v>
                </c:pt>
                <c:pt idx="401">
                  <c:v>88.453999999999994</c:v>
                </c:pt>
                <c:pt idx="402">
                  <c:v>88.322000000000003</c:v>
                </c:pt>
                <c:pt idx="403">
                  <c:v>88.19</c:v>
                </c:pt>
                <c:pt idx="404">
                  <c:v>88.058000000000007</c:v>
                </c:pt>
                <c:pt idx="405">
                  <c:v>87.926000000000002</c:v>
                </c:pt>
                <c:pt idx="406">
                  <c:v>87.793999999999997</c:v>
                </c:pt>
                <c:pt idx="407">
                  <c:v>87.661000000000001</c:v>
                </c:pt>
                <c:pt idx="408">
                  <c:v>87.528999999999996</c:v>
                </c:pt>
                <c:pt idx="409">
                  <c:v>87.397000000000006</c:v>
                </c:pt>
                <c:pt idx="410">
                  <c:v>87.265000000000001</c:v>
                </c:pt>
                <c:pt idx="411">
                  <c:v>87.132999999999996</c:v>
                </c:pt>
                <c:pt idx="412">
                  <c:v>87.001000000000005</c:v>
                </c:pt>
                <c:pt idx="413">
                  <c:v>86.869</c:v>
                </c:pt>
                <c:pt idx="414">
                  <c:v>86.736999999999995</c:v>
                </c:pt>
                <c:pt idx="415">
                  <c:v>86.605000000000004</c:v>
                </c:pt>
                <c:pt idx="416">
                  <c:v>86.471999999999994</c:v>
                </c:pt>
                <c:pt idx="417">
                  <c:v>86.34</c:v>
                </c:pt>
                <c:pt idx="418">
                  <c:v>86.207999999999998</c:v>
                </c:pt>
                <c:pt idx="419">
                  <c:v>86.075999999999993</c:v>
                </c:pt>
                <c:pt idx="420">
                  <c:v>85.944000000000003</c:v>
                </c:pt>
                <c:pt idx="421">
                  <c:v>85.811999999999998</c:v>
                </c:pt>
                <c:pt idx="422">
                  <c:v>85.68</c:v>
                </c:pt>
                <c:pt idx="423">
                  <c:v>85.548000000000002</c:v>
                </c:pt>
                <c:pt idx="424">
                  <c:v>85.415999999999997</c:v>
                </c:pt>
                <c:pt idx="425">
                  <c:v>85.283000000000001</c:v>
                </c:pt>
                <c:pt idx="426">
                  <c:v>85.150999999999996</c:v>
                </c:pt>
                <c:pt idx="427">
                  <c:v>85.019000000000005</c:v>
                </c:pt>
                <c:pt idx="428">
                  <c:v>84.887</c:v>
                </c:pt>
                <c:pt idx="429">
                  <c:v>84.754999999999995</c:v>
                </c:pt>
                <c:pt idx="430">
                  <c:v>84.623000000000005</c:v>
                </c:pt>
                <c:pt idx="431">
                  <c:v>84.491</c:v>
                </c:pt>
                <c:pt idx="432">
                  <c:v>84.358999999999995</c:v>
                </c:pt>
                <c:pt idx="433">
                  <c:v>84.227000000000004</c:v>
                </c:pt>
                <c:pt idx="434">
                  <c:v>84.094999999999999</c:v>
                </c:pt>
                <c:pt idx="435">
                  <c:v>83.962000000000003</c:v>
                </c:pt>
                <c:pt idx="436">
                  <c:v>83.83</c:v>
                </c:pt>
                <c:pt idx="437">
                  <c:v>83.697999999999993</c:v>
                </c:pt>
                <c:pt idx="438">
                  <c:v>83.566000000000003</c:v>
                </c:pt>
                <c:pt idx="439">
                  <c:v>83.433999999999997</c:v>
                </c:pt>
                <c:pt idx="440">
                  <c:v>83.302000000000007</c:v>
                </c:pt>
                <c:pt idx="441">
                  <c:v>83.17</c:v>
                </c:pt>
                <c:pt idx="442">
                  <c:v>83.037999999999997</c:v>
                </c:pt>
                <c:pt idx="443">
                  <c:v>82.906000000000006</c:v>
                </c:pt>
                <c:pt idx="444">
                  <c:v>82.772999999999996</c:v>
                </c:pt>
                <c:pt idx="445">
                  <c:v>82.641000000000005</c:v>
                </c:pt>
                <c:pt idx="446">
                  <c:v>82.509</c:v>
                </c:pt>
                <c:pt idx="447">
                  <c:v>82.376999999999995</c:v>
                </c:pt>
                <c:pt idx="448">
                  <c:v>82.245000000000005</c:v>
                </c:pt>
                <c:pt idx="449">
                  <c:v>82.113</c:v>
                </c:pt>
                <c:pt idx="450">
                  <c:v>81.980999999999995</c:v>
                </c:pt>
                <c:pt idx="451">
                  <c:v>81.849000000000004</c:v>
                </c:pt>
                <c:pt idx="452">
                  <c:v>81.716999999999999</c:v>
                </c:pt>
                <c:pt idx="453">
                  <c:v>81.584999999999994</c:v>
                </c:pt>
                <c:pt idx="454">
                  <c:v>81.451999999999998</c:v>
                </c:pt>
                <c:pt idx="455">
                  <c:v>81.319999999999993</c:v>
                </c:pt>
                <c:pt idx="456">
                  <c:v>81.188000000000002</c:v>
                </c:pt>
                <c:pt idx="457">
                  <c:v>81.055999999999997</c:v>
                </c:pt>
                <c:pt idx="458">
                  <c:v>80.924000000000007</c:v>
                </c:pt>
                <c:pt idx="459">
                  <c:v>80.792000000000002</c:v>
                </c:pt>
                <c:pt idx="460">
                  <c:v>80.66</c:v>
                </c:pt>
                <c:pt idx="461">
                  <c:v>80.528000000000006</c:v>
                </c:pt>
                <c:pt idx="462">
                  <c:v>80.396000000000001</c:v>
                </c:pt>
                <c:pt idx="463">
                  <c:v>80.263000000000005</c:v>
                </c:pt>
                <c:pt idx="464">
                  <c:v>80.131</c:v>
                </c:pt>
                <c:pt idx="465">
                  <c:v>79.998999999999995</c:v>
                </c:pt>
                <c:pt idx="466">
                  <c:v>79.867000000000004</c:v>
                </c:pt>
                <c:pt idx="467">
                  <c:v>79.734999999999999</c:v>
                </c:pt>
                <c:pt idx="468">
                  <c:v>79.602999999999994</c:v>
                </c:pt>
                <c:pt idx="469">
                  <c:v>79.471000000000004</c:v>
                </c:pt>
                <c:pt idx="470">
                  <c:v>79.338999999999999</c:v>
                </c:pt>
                <c:pt idx="471">
                  <c:v>79.206999999999994</c:v>
                </c:pt>
                <c:pt idx="472">
                  <c:v>79.075000000000003</c:v>
                </c:pt>
                <c:pt idx="473">
                  <c:v>78.941999999999993</c:v>
                </c:pt>
                <c:pt idx="474">
                  <c:v>78.81</c:v>
                </c:pt>
                <c:pt idx="475">
                  <c:v>78.677999999999997</c:v>
                </c:pt>
                <c:pt idx="476">
                  <c:v>78.546000000000006</c:v>
                </c:pt>
                <c:pt idx="477">
                  <c:v>78.414000000000001</c:v>
                </c:pt>
                <c:pt idx="478">
                  <c:v>78.281999999999996</c:v>
                </c:pt>
                <c:pt idx="479">
                  <c:v>78.150000000000006</c:v>
                </c:pt>
                <c:pt idx="480">
                  <c:v>78.018000000000001</c:v>
                </c:pt>
                <c:pt idx="481">
                  <c:v>77.885999999999996</c:v>
                </c:pt>
                <c:pt idx="482">
                  <c:v>77.753</c:v>
                </c:pt>
                <c:pt idx="483">
                  <c:v>77.620999999999995</c:v>
                </c:pt>
                <c:pt idx="484">
                  <c:v>77.489000000000004</c:v>
                </c:pt>
                <c:pt idx="485">
                  <c:v>77.356999999999999</c:v>
                </c:pt>
                <c:pt idx="486">
                  <c:v>77.224999999999994</c:v>
                </c:pt>
                <c:pt idx="487">
                  <c:v>77.093000000000004</c:v>
                </c:pt>
                <c:pt idx="488">
                  <c:v>76.960999999999999</c:v>
                </c:pt>
                <c:pt idx="489">
                  <c:v>76.828999999999994</c:v>
                </c:pt>
                <c:pt idx="490">
                  <c:v>76.697000000000003</c:v>
                </c:pt>
                <c:pt idx="491">
                  <c:v>76.563999999999993</c:v>
                </c:pt>
                <c:pt idx="492">
                  <c:v>76.432000000000002</c:v>
                </c:pt>
                <c:pt idx="493">
                  <c:v>76.3</c:v>
                </c:pt>
                <c:pt idx="494">
                  <c:v>76.168000000000006</c:v>
                </c:pt>
                <c:pt idx="495">
                  <c:v>76.036000000000001</c:v>
                </c:pt>
                <c:pt idx="496">
                  <c:v>75.903999999999996</c:v>
                </c:pt>
                <c:pt idx="497">
                  <c:v>75.772000000000006</c:v>
                </c:pt>
                <c:pt idx="498">
                  <c:v>75.64</c:v>
                </c:pt>
                <c:pt idx="499">
                  <c:v>75.507999999999996</c:v>
                </c:pt>
                <c:pt idx="500">
                  <c:v>75.376000000000005</c:v>
                </c:pt>
                <c:pt idx="501">
                  <c:v>75.242999999999995</c:v>
                </c:pt>
                <c:pt idx="502">
                  <c:v>75.111000000000004</c:v>
                </c:pt>
                <c:pt idx="503">
                  <c:v>74.978999999999999</c:v>
                </c:pt>
                <c:pt idx="504">
                  <c:v>74.846999999999994</c:v>
                </c:pt>
                <c:pt idx="505">
                  <c:v>74.715000000000003</c:v>
                </c:pt>
                <c:pt idx="506">
                  <c:v>74.582999999999998</c:v>
                </c:pt>
                <c:pt idx="507">
                  <c:v>74.450999999999993</c:v>
                </c:pt>
                <c:pt idx="508">
                  <c:v>74.319000000000003</c:v>
                </c:pt>
                <c:pt idx="509">
                  <c:v>74.186999999999998</c:v>
                </c:pt>
                <c:pt idx="510">
                  <c:v>74.054000000000002</c:v>
                </c:pt>
                <c:pt idx="511">
                  <c:v>73.921999999999997</c:v>
                </c:pt>
                <c:pt idx="512">
                  <c:v>73.790000000000006</c:v>
                </c:pt>
                <c:pt idx="513">
                  <c:v>73.658000000000001</c:v>
                </c:pt>
                <c:pt idx="514">
                  <c:v>73.525999999999996</c:v>
                </c:pt>
                <c:pt idx="515">
                  <c:v>73.394000000000005</c:v>
                </c:pt>
                <c:pt idx="516">
                  <c:v>73.262</c:v>
                </c:pt>
                <c:pt idx="517">
                  <c:v>73.13</c:v>
                </c:pt>
                <c:pt idx="518">
                  <c:v>72.998000000000005</c:v>
                </c:pt>
                <c:pt idx="519">
                  <c:v>72.866</c:v>
                </c:pt>
                <c:pt idx="520">
                  <c:v>72.733000000000004</c:v>
                </c:pt>
                <c:pt idx="521">
                  <c:v>72.600999999999999</c:v>
                </c:pt>
                <c:pt idx="522">
                  <c:v>72.468999999999994</c:v>
                </c:pt>
                <c:pt idx="523">
                  <c:v>72.337000000000003</c:v>
                </c:pt>
                <c:pt idx="524">
                  <c:v>72.204999999999998</c:v>
                </c:pt>
                <c:pt idx="525">
                  <c:v>72.072999999999993</c:v>
                </c:pt>
                <c:pt idx="526">
                  <c:v>71.941000000000003</c:v>
                </c:pt>
                <c:pt idx="527">
                  <c:v>71.808999999999997</c:v>
                </c:pt>
                <c:pt idx="528">
                  <c:v>71.677000000000007</c:v>
                </c:pt>
                <c:pt idx="529">
                  <c:v>71.543999999999997</c:v>
                </c:pt>
                <c:pt idx="530">
                  <c:v>71.412000000000006</c:v>
                </c:pt>
                <c:pt idx="531">
                  <c:v>71.28</c:v>
                </c:pt>
                <c:pt idx="532">
                  <c:v>71.147999999999996</c:v>
                </c:pt>
                <c:pt idx="533">
                  <c:v>71.016000000000005</c:v>
                </c:pt>
                <c:pt idx="534">
                  <c:v>70.884</c:v>
                </c:pt>
                <c:pt idx="535">
                  <c:v>70.751999999999995</c:v>
                </c:pt>
                <c:pt idx="536">
                  <c:v>70.62</c:v>
                </c:pt>
                <c:pt idx="537">
                  <c:v>70.488</c:v>
                </c:pt>
                <c:pt idx="538">
                  <c:v>70.355999999999995</c:v>
                </c:pt>
                <c:pt idx="539">
                  <c:v>70.222999999999999</c:v>
                </c:pt>
                <c:pt idx="540">
                  <c:v>70.090999999999994</c:v>
                </c:pt>
                <c:pt idx="541">
                  <c:v>69.959000000000003</c:v>
                </c:pt>
                <c:pt idx="542">
                  <c:v>69.826999999999998</c:v>
                </c:pt>
                <c:pt idx="543">
                  <c:v>69.694999999999993</c:v>
                </c:pt>
                <c:pt idx="544">
                  <c:v>69.563000000000002</c:v>
                </c:pt>
                <c:pt idx="545">
                  <c:v>69.430999999999997</c:v>
                </c:pt>
                <c:pt idx="546">
                  <c:v>69.299000000000007</c:v>
                </c:pt>
                <c:pt idx="547">
                  <c:v>69.167000000000002</c:v>
                </c:pt>
                <c:pt idx="548">
                  <c:v>69.034000000000006</c:v>
                </c:pt>
                <c:pt idx="549">
                  <c:v>68.902000000000001</c:v>
                </c:pt>
                <c:pt idx="550">
                  <c:v>68.77</c:v>
                </c:pt>
                <c:pt idx="551">
                  <c:v>68.638000000000005</c:v>
                </c:pt>
                <c:pt idx="552">
                  <c:v>68.506</c:v>
                </c:pt>
                <c:pt idx="553">
                  <c:v>68.373999999999995</c:v>
                </c:pt>
                <c:pt idx="554">
                  <c:v>68.242000000000004</c:v>
                </c:pt>
                <c:pt idx="555">
                  <c:v>68.11</c:v>
                </c:pt>
                <c:pt idx="556">
                  <c:v>67.977999999999994</c:v>
                </c:pt>
                <c:pt idx="557">
                  <c:v>67.844999999999999</c:v>
                </c:pt>
                <c:pt idx="558">
                  <c:v>67.712999999999994</c:v>
                </c:pt>
                <c:pt idx="559">
                  <c:v>67.581000000000003</c:v>
                </c:pt>
                <c:pt idx="560">
                  <c:v>67.448999999999998</c:v>
                </c:pt>
                <c:pt idx="561">
                  <c:v>67.316999999999993</c:v>
                </c:pt>
                <c:pt idx="562">
                  <c:v>67.185000000000002</c:v>
                </c:pt>
                <c:pt idx="563">
                  <c:v>67.052999999999997</c:v>
                </c:pt>
                <c:pt idx="564">
                  <c:v>66.921000000000006</c:v>
                </c:pt>
                <c:pt idx="565">
                  <c:v>66.789000000000001</c:v>
                </c:pt>
                <c:pt idx="566">
                  <c:v>66.656999999999996</c:v>
                </c:pt>
                <c:pt idx="567">
                  <c:v>66.524000000000001</c:v>
                </c:pt>
                <c:pt idx="568">
                  <c:v>66.391999999999996</c:v>
                </c:pt>
                <c:pt idx="569">
                  <c:v>66.260000000000005</c:v>
                </c:pt>
                <c:pt idx="570">
                  <c:v>66.128</c:v>
                </c:pt>
                <c:pt idx="571">
                  <c:v>65.995999999999995</c:v>
                </c:pt>
                <c:pt idx="572">
                  <c:v>65.864000000000004</c:v>
                </c:pt>
                <c:pt idx="573">
                  <c:v>65.731999999999999</c:v>
                </c:pt>
                <c:pt idx="574">
                  <c:v>65.599999999999994</c:v>
                </c:pt>
                <c:pt idx="575">
                  <c:v>65.468000000000004</c:v>
                </c:pt>
                <c:pt idx="576">
                  <c:v>65.334999999999994</c:v>
                </c:pt>
                <c:pt idx="577">
                  <c:v>65.203000000000003</c:v>
                </c:pt>
                <c:pt idx="578">
                  <c:v>65.070999999999998</c:v>
                </c:pt>
                <c:pt idx="579">
                  <c:v>64.938999999999993</c:v>
                </c:pt>
                <c:pt idx="580">
                  <c:v>64.807000000000002</c:v>
                </c:pt>
                <c:pt idx="581">
                  <c:v>64.674999999999997</c:v>
                </c:pt>
                <c:pt idx="582">
                  <c:v>64.543000000000006</c:v>
                </c:pt>
                <c:pt idx="583">
                  <c:v>64.411000000000001</c:v>
                </c:pt>
                <c:pt idx="584">
                  <c:v>64.278999999999996</c:v>
                </c:pt>
                <c:pt idx="585">
                  <c:v>64.147000000000006</c:v>
                </c:pt>
                <c:pt idx="586">
                  <c:v>64.013999999999996</c:v>
                </c:pt>
                <c:pt idx="587">
                  <c:v>63.881999999999998</c:v>
                </c:pt>
                <c:pt idx="588">
                  <c:v>63.75</c:v>
                </c:pt>
                <c:pt idx="589">
                  <c:v>63.618000000000002</c:v>
                </c:pt>
                <c:pt idx="590">
                  <c:v>63.485999999999997</c:v>
                </c:pt>
                <c:pt idx="591">
                  <c:v>63.353999999999999</c:v>
                </c:pt>
                <c:pt idx="592">
                  <c:v>63.222000000000001</c:v>
                </c:pt>
                <c:pt idx="593">
                  <c:v>63.09</c:v>
                </c:pt>
                <c:pt idx="594">
                  <c:v>62.957999999999998</c:v>
                </c:pt>
                <c:pt idx="595">
                  <c:v>62.825000000000003</c:v>
                </c:pt>
                <c:pt idx="596">
                  <c:v>62.692999999999998</c:v>
                </c:pt>
                <c:pt idx="597">
                  <c:v>62.561</c:v>
                </c:pt>
                <c:pt idx="598">
                  <c:v>62.429000000000002</c:v>
                </c:pt>
                <c:pt idx="599">
                  <c:v>62.296999999999997</c:v>
                </c:pt>
                <c:pt idx="600">
                  <c:v>62.164999999999999</c:v>
                </c:pt>
                <c:pt idx="601">
                  <c:v>62.033000000000001</c:v>
                </c:pt>
                <c:pt idx="602">
                  <c:v>61.901000000000003</c:v>
                </c:pt>
                <c:pt idx="603">
                  <c:v>61.768999999999998</c:v>
                </c:pt>
                <c:pt idx="604">
                  <c:v>61.637</c:v>
                </c:pt>
                <c:pt idx="605">
                  <c:v>61.503999999999998</c:v>
                </c:pt>
                <c:pt idx="606">
                  <c:v>61.372</c:v>
                </c:pt>
                <c:pt idx="607">
                  <c:v>61.24</c:v>
                </c:pt>
                <c:pt idx="608">
                  <c:v>61.107999999999997</c:v>
                </c:pt>
                <c:pt idx="609">
                  <c:v>60.975999999999999</c:v>
                </c:pt>
                <c:pt idx="610">
                  <c:v>60.844000000000001</c:v>
                </c:pt>
                <c:pt idx="611">
                  <c:v>60.712000000000003</c:v>
                </c:pt>
                <c:pt idx="612">
                  <c:v>60.58</c:v>
                </c:pt>
                <c:pt idx="613">
                  <c:v>60.448</c:v>
                </c:pt>
                <c:pt idx="614">
                  <c:v>60.314999999999998</c:v>
                </c:pt>
                <c:pt idx="615">
                  <c:v>60.183</c:v>
                </c:pt>
                <c:pt idx="616">
                  <c:v>60.051000000000002</c:v>
                </c:pt>
                <c:pt idx="617">
                  <c:v>59.918999999999997</c:v>
                </c:pt>
                <c:pt idx="618">
                  <c:v>59.786999999999999</c:v>
                </c:pt>
                <c:pt idx="619">
                  <c:v>59.655000000000001</c:v>
                </c:pt>
                <c:pt idx="620">
                  <c:v>59.523000000000003</c:v>
                </c:pt>
                <c:pt idx="621">
                  <c:v>59.390999999999998</c:v>
                </c:pt>
                <c:pt idx="622">
                  <c:v>59.259</c:v>
                </c:pt>
                <c:pt idx="623">
                  <c:v>59.125999999999998</c:v>
                </c:pt>
                <c:pt idx="624">
                  <c:v>58.994</c:v>
                </c:pt>
                <c:pt idx="625">
                  <c:v>58.862000000000002</c:v>
                </c:pt>
                <c:pt idx="626">
                  <c:v>58.73</c:v>
                </c:pt>
                <c:pt idx="627">
                  <c:v>58.597999999999999</c:v>
                </c:pt>
                <c:pt idx="628">
                  <c:v>58.466000000000001</c:v>
                </c:pt>
                <c:pt idx="629">
                  <c:v>58.334000000000003</c:v>
                </c:pt>
                <c:pt idx="630">
                  <c:v>58.201999999999998</c:v>
                </c:pt>
                <c:pt idx="631">
                  <c:v>58.07</c:v>
                </c:pt>
                <c:pt idx="632">
                  <c:v>57.938000000000002</c:v>
                </c:pt>
                <c:pt idx="633">
                  <c:v>57.805</c:v>
                </c:pt>
                <c:pt idx="634">
                  <c:v>57.673000000000002</c:v>
                </c:pt>
                <c:pt idx="635">
                  <c:v>57.540999999999997</c:v>
                </c:pt>
                <c:pt idx="636">
                  <c:v>57.408999999999999</c:v>
                </c:pt>
                <c:pt idx="637">
                  <c:v>57.277000000000001</c:v>
                </c:pt>
                <c:pt idx="638">
                  <c:v>57.145000000000003</c:v>
                </c:pt>
                <c:pt idx="639">
                  <c:v>57.012999999999998</c:v>
                </c:pt>
                <c:pt idx="640">
                  <c:v>56.881</c:v>
                </c:pt>
                <c:pt idx="641">
                  <c:v>56.749000000000002</c:v>
                </c:pt>
                <c:pt idx="642">
                  <c:v>56.616</c:v>
                </c:pt>
                <c:pt idx="643">
                  <c:v>56.484000000000002</c:v>
                </c:pt>
                <c:pt idx="644">
                  <c:v>56.351999999999997</c:v>
                </c:pt>
                <c:pt idx="645">
                  <c:v>56.22</c:v>
                </c:pt>
                <c:pt idx="646">
                  <c:v>56.088000000000001</c:v>
                </c:pt>
                <c:pt idx="647">
                  <c:v>55.956000000000003</c:v>
                </c:pt>
                <c:pt idx="648">
                  <c:v>55.823999999999998</c:v>
                </c:pt>
                <c:pt idx="649">
                  <c:v>55.692</c:v>
                </c:pt>
                <c:pt idx="650">
                  <c:v>55.56</c:v>
                </c:pt>
                <c:pt idx="651">
                  <c:v>55.427999999999997</c:v>
                </c:pt>
                <c:pt idx="652">
                  <c:v>55.295000000000002</c:v>
                </c:pt>
                <c:pt idx="653">
                  <c:v>55.162999999999997</c:v>
                </c:pt>
                <c:pt idx="654">
                  <c:v>55.030999999999999</c:v>
                </c:pt>
                <c:pt idx="655">
                  <c:v>54.899000000000001</c:v>
                </c:pt>
                <c:pt idx="656">
                  <c:v>54.767000000000003</c:v>
                </c:pt>
                <c:pt idx="657">
                  <c:v>54.634999999999998</c:v>
                </c:pt>
                <c:pt idx="658">
                  <c:v>54.503</c:v>
                </c:pt>
                <c:pt idx="659">
                  <c:v>54.371000000000002</c:v>
                </c:pt>
                <c:pt idx="660">
                  <c:v>54.238999999999997</c:v>
                </c:pt>
                <c:pt idx="661">
                  <c:v>54.106000000000002</c:v>
                </c:pt>
                <c:pt idx="662">
                  <c:v>53.973999999999997</c:v>
                </c:pt>
                <c:pt idx="663">
                  <c:v>53.841999999999999</c:v>
                </c:pt>
                <c:pt idx="664">
                  <c:v>53.71</c:v>
                </c:pt>
                <c:pt idx="665">
                  <c:v>53.578000000000003</c:v>
                </c:pt>
                <c:pt idx="666">
                  <c:v>53.445999999999998</c:v>
                </c:pt>
                <c:pt idx="667">
                  <c:v>53.314</c:v>
                </c:pt>
                <c:pt idx="668">
                  <c:v>53.182000000000002</c:v>
                </c:pt>
                <c:pt idx="669">
                  <c:v>53.05</c:v>
                </c:pt>
                <c:pt idx="670">
                  <c:v>52.917999999999999</c:v>
                </c:pt>
                <c:pt idx="671">
                  <c:v>52.784999999999997</c:v>
                </c:pt>
                <c:pt idx="672">
                  <c:v>52.652999999999999</c:v>
                </c:pt>
                <c:pt idx="673">
                  <c:v>52.521000000000001</c:v>
                </c:pt>
                <c:pt idx="674">
                  <c:v>52.389000000000003</c:v>
                </c:pt>
                <c:pt idx="675">
                  <c:v>52.256999999999998</c:v>
                </c:pt>
                <c:pt idx="676">
                  <c:v>52.125</c:v>
                </c:pt>
                <c:pt idx="677">
                  <c:v>51.993000000000002</c:v>
                </c:pt>
                <c:pt idx="678">
                  <c:v>51.860999999999997</c:v>
                </c:pt>
                <c:pt idx="679">
                  <c:v>51.728999999999999</c:v>
                </c:pt>
                <c:pt idx="680">
                  <c:v>51.595999999999997</c:v>
                </c:pt>
                <c:pt idx="681">
                  <c:v>51.463999999999999</c:v>
                </c:pt>
                <c:pt idx="682">
                  <c:v>51.332000000000001</c:v>
                </c:pt>
                <c:pt idx="683">
                  <c:v>51.2</c:v>
                </c:pt>
                <c:pt idx="684">
                  <c:v>51.067999999999998</c:v>
                </c:pt>
                <c:pt idx="685">
                  <c:v>50.936</c:v>
                </c:pt>
                <c:pt idx="686">
                  <c:v>50.804000000000002</c:v>
                </c:pt>
                <c:pt idx="687">
                  <c:v>50.671999999999997</c:v>
                </c:pt>
                <c:pt idx="688">
                  <c:v>50.54</c:v>
                </c:pt>
                <c:pt idx="689">
                  <c:v>50.406999999999996</c:v>
                </c:pt>
                <c:pt idx="690">
                  <c:v>50.274999999999999</c:v>
                </c:pt>
                <c:pt idx="691">
                  <c:v>50.143000000000001</c:v>
                </c:pt>
                <c:pt idx="692">
                  <c:v>50.011000000000003</c:v>
                </c:pt>
                <c:pt idx="693">
                  <c:v>49.878999999999998</c:v>
                </c:pt>
                <c:pt idx="694">
                  <c:v>49.747</c:v>
                </c:pt>
                <c:pt idx="695">
                  <c:v>49.615000000000002</c:v>
                </c:pt>
                <c:pt idx="696">
                  <c:v>49.482999999999997</c:v>
                </c:pt>
                <c:pt idx="697">
                  <c:v>49.350999999999999</c:v>
                </c:pt>
                <c:pt idx="698">
                  <c:v>49.219000000000001</c:v>
                </c:pt>
                <c:pt idx="699">
                  <c:v>49.085999999999999</c:v>
                </c:pt>
                <c:pt idx="700">
                  <c:v>48.954000000000001</c:v>
                </c:pt>
                <c:pt idx="701">
                  <c:v>48.822000000000003</c:v>
                </c:pt>
                <c:pt idx="702">
                  <c:v>48.69</c:v>
                </c:pt>
                <c:pt idx="703">
                  <c:v>48.558</c:v>
                </c:pt>
                <c:pt idx="704">
                  <c:v>48.426000000000002</c:v>
                </c:pt>
                <c:pt idx="705">
                  <c:v>48.293999999999997</c:v>
                </c:pt>
                <c:pt idx="706">
                  <c:v>48.161999999999999</c:v>
                </c:pt>
                <c:pt idx="707">
                  <c:v>48.03</c:v>
                </c:pt>
                <c:pt idx="708">
                  <c:v>47.896999999999998</c:v>
                </c:pt>
                <c:pt idx="709">
                  <c:v>47.765000000000001</c:v>
                </c:pt>
                <c:pt idx="710">
                  <c:v>47.633000000000003</c:v>
                </c:pt>
                <c:pt idx="711">
                  <c:v>47.500999999999998</c:v>
                </c:pt>
                <c:pt idx="712">
                  <c:v>47.369</c:v>
                </c:pt>
                <c:pt idx="713">
                  <c:v>47.237000000000002</c:v>
                </c:pt>
                <c:pt idx="714">
                  <c:v>47.104999999999997</c:v>
                </c:pt>
                <c:pt idx="715">
                  <c:v>46.972999999999999</c:v>
                </c:pt>
                <c:pt idx="716">
                  <c:v>46.841000000000001</c:v>
                </c:pt>
                <c:pt idx="717">
                  <c:v>46.709000000000003</c:v>
                </c:pt>
                <c:pt idx="718">
                  <c:v>46.576000000000001</c:v>
                </c:pt>
                <c:pt idx="719">
                  <c:v>46.444000000000003</c:v>
                </c:pt>
                <c:pt idx="720">
                  <c:v>46.311999999999998</c:v>
                </c:pt>
                <c:pt idx="721">
                  <c:v>46.18</c:v>
                </c:pt>
                <c:pt idx="722">
                  <c:v>46.048000000000002</c:v>
                </c:pt>
                <c:pt idx="723">
                  <c:v>45.915999999999997</c:v>
                </c:pt>
                <c:pt idx="724">
                  <c:v>45.783999999999999</c:v>
                </c:pt>
                <c:pt idx="725">
                  <c:v>45.652000000000001</c:v>
                </c:pt>
                <c:pt idx="726">
                  <c:v>45.52</c:v>
                </c:pt>
                <c:pt idx="727">
                  <c:v>45.387</c:v>
                </c:pt>
                <c:pt idx="728">
                  <c:v>45.255000000000003</c:v>
                </c:pt>
                <c:pt idx="729">
                  <c:v>45.122999999999998</c:v>
                </c:pt>
                <c:pt idx="730">
                  <c:v>44.991</c:v>
                </c:pt>
                <c:pt idx="731">
                  <c:v>44.859000000000002</c:v>
                </c:pt>
                <c:pt idx="732">
                  <c:v>44.726999999999997</c:v>
                </c:pt>
                <c:pt idx="733">
                  <c:v>44.594999999999999</c:v>
                </c:pt>
                <c:pt idx="734">
                  <c:v>44.463000000000001</c:v>
                </c:pt>
                <c:pt idx="735">
                  <c:v>44.331000000000003</c:v>
                </c:pt>
                <c:pt idx="736">
                  <c:v>44.198999999999998</c:v>
                </c:pt>
                <c:pt idx="737">
                  <c:v>44.066000000000003</c:v>
                </c:pt>
                <c:pt idx="738">
                  <c:v>43.933999999999997</c:v>
                </c:pt>
                <c:pt idx="739">
                  <c:v>43.802</c:v>
                </c:pt>
                <c:pt idx="740">
                  <c:v>43.67</c:v>
                </c:pt>
                <c:pt idx="741">
                  <c:v>43.537999999999997</c:v>
                </c:pt>
                <c:pt idx="742">
                  <c:v>43.405999999999999</c:v>
                </c:pt>
                <c:pt idx="743">
                  <c:v>43.274000000000001</c:v>
                </c:pt>
                <c:pt idx="744">
                  <c:v>43.142000000000003</c:v>
                </c:pt>
                <c:pt idx="745">
                  <c:v>43.01</c:v>
                </c:pt>
                <c:pt idx="746">
                  <c:v>42.877000000000002</c:v>
                </c:pt>
                <c:pt idx="747">
                  <c:v>42.744999999999997</c:v>
                </c:pt>
                <c:pt idx="748">
                  <c:v>42.613</c:v>
                </c:pt>
                <c:pt idx="749">
                  <c:v>42.481000000000002</c:v>
                </c:pt>
                <c:pt idx="750">
                  <c:v>42.348999999999997</c:v>
                </c:pt>
                <c:pt idx="751">
                  <c:v>42.216999999999999</c:v>
                </c:pt>
                <c:pt idx="752">
                  <c:v>42.085000000000001</c:v>
                </c:pt>
                <c:pt idx="753">
                  <c:v>41.953000000000003</c:v>
                </c:pt>
                <c:pt idx="754">
                  <c:v>41.820999999999998</c:v>
                </c:pt>
                <c:pt idx="755">
                  <c:v>41.688000000000002</c:v>
                </c:pt>
                <c:pt idx="756">
                  <c:v>41.555999999999997</c:v>
                </c:pt>
                <c:pt idx="757">
                  <c:v>41.423999999999999</c:v>
                </c:pt>
                <c:pt idx="758">
                  <c:v>41.292000000000002</c:v>
                </c:pt>
                <c:pt idx="759">
                  <c:v>41.16</c:v>
                </c:pt>
                <c:pt idx="760">
                  <c:v>41.027999999999999</c:v>
                </c:pt>
                <c:pt idx="761">
                  <c:v>40.896000000000001</c:v>
                </c:pt>
                <c:pt idx="762">
                  <c:v>40.764000000000003</c:v>
                </c:pt>
                <c:pt idx="763">
                  <c:v>40.631999999999998</c:v>
                </c:pt>
                <c:pt idx="764">
                  <c:v>40.5</c:v>
                </c:pt>
                <c:pt idx="765">
                  <c:v>40.366999999999997</c:v>
                </c:pt>
                <c:pt idx="766">
                  <c:v>40.234999999999999</c:v>
                </c:pt>
                <c:pt idx="767">
                  <c:v>40.103000000000002</c:v>
                </c:pt>
                <c:pt idx="768">
                  <c:v>39.970999999999997</c:v>
                </c:pt>
                <c:pt idx="769">
                  <c:v>39.838999999999999</c:v>
                </c:pt>
                <c:pt idx="770">
                  <c:v>39.707000000000001</c:v>
                </c:pt>
                <c:pt idx="771">
                  <c:v>39.575000000000003</c:v>
                </c:pt>
                <c:pt idx="772">
                  <c:v>39.442999999999998</c:v>
                </c:pt>
                <c:pt idx="773">
                  <c:v>39.311</c:v>
                </c:pt>
                <c:pt idx="774">
                  <c:v>39.177999999999997</c:v>
                </c:pt>
                <c:pt idx="775">
                  <c:v>39.045999999999999</c:v>
                </c:pt>
                <c:pt idx="776">
                  <c:v>38.914000000000001</c:v>
                </c:pt>
                <c:pt idx="777">
                  <c:v>38.781999999999996</c:v>
                </c:pt>
                <c:pt idx="778">
                  <c:v>38.65</c:v>
                </c:pt>
                <c:pt idx="779">
                  <c:v>38.518000000000001</c:v>
                </c:pt>
                <c:pt idx="780">
                  <c:v>38.386000000000003</c:v>
                </c:pt>
                <c:pt idx="781">
                  <c:v>38.253999999999998</c:v>
                </c:pt>
                <c:pt idx="782">
                  <c:v>38.122</c:v>
                </c:pt>
                <c:pt idx="783">
                  <c:v>37.99</c:v>
                </c:pt>
                <c:pt idx="784">
                  <c:v>37.856999999999999</c:v>
                </c:pt>
                <c:pt idx="785">
                  <c:v>37.725000000000001</c:v>
                </c:pt>
                <c:pt idx="786">
                  <c:v>37.593000000000004</c:v>
                </c:pt>
                <c:pt idx="787">
                  <c:v>37.460999999999999</c:v>
                </c:pt>
                <c:pt idx="788">
                  <c:v>37.329000000000001</c:v>
                </c:pt>
                <c:pt idx="789">
                  <c:v>37.197000000000003</c:v>
                </c:pt>
                <c:pt idx="790">
                  <c:v>37.064999999999998</c:v>
                </c:pt>
                <c:pt idx="791">
                  <c:v>36.933</c:v>
                </c:pt>
                <c:pt idx="792">
                  <c:v>36.801000000000002</c:v>
                </c:pt>
                <c:pt idx="793">
                  <c:v>36.667999999999999</c:v>
                </c:pt>
                <c:pt idx="794">
                  <c:v>36.536000000000001</c:v>
                </c:pt>
                <c:pt idx="795">
                  <c:v>36.404000000000003</c:v>
                </c:pt>
                <c:pt idx="796">
                  <c:v>36.271999999999998</c:v>
                </c:pt>
                <c:pt idx="797">
                  <c:v>36.14</c:v>
                </c:pt>
                <c:pt idx="798">
                  <c:v>36.008000000000003</c:v>
                </c:pt>
                <c:pt idx="799">
                  <c:v>35.875999999999998</c:v>
                </c:pt>
                <c:pt idx="800">
                  <c:v>35.744</c:v>
                </c:pt>
                <c:pt idx="801">
                  <c:v>35.612000000000002</c:v>
                </c:pt>
                <c:pt idx="802">
                  <c:v>35.479999999999997</c:v>
                </c:pt>
                <c:pt idx="803">
                  <c:v>35.347000000000001</c:v>
                </c:pt>
                <c:pt idx="804">
                  <c:v>35.215000000000003</c:v>
                </c:pt>
                <c:pt idx="805">
                  <c:v>35.082999999999998</c:v>
                </c:pt>
                <c:pt idx="806">
                  <c:v>34.951000000000001</c:v>
                </c:pt>
                <c:pt idx="807">
                  <c:v>34.819000000000003</c:v>
                </c:pt>
                <c:pt idx="808">
                  <c:v>34.686999999999998</c:v>
                </c:pt>
                <c:pt idx="809">
                  <c:v>34.555</c:v>
                </c:pt>
                <c:pt idx="810">
                  <c:v>34.423000000000002</c:v>
                </c:pt>
                <c:pt idx="811">
                  <c:v>34.290999999999997</c:v>
                </c:pt>
                <c:pt idx="812">
                  <c:v>34.158000000000001</c:v>
                </c:pt>
                <c:pt idx="813">
                  <c:v>34.026000000000003</c:v>
                </c:pt>
                <c:pt idx="814">
                  <c:v>33.893999999999998</c:v>
                </c:pt>
                <c:pt idx="815">
                  <c:v>33.762</c:v>
                </c:pt>
                <c:pt idx="816">
                  <c:v>33.630000000000003</c:v>
                </c:pt>
                <c:pt idx="817">
                  <c:v>33.497999999999998</c:v>
                </c:pt>
                <c:pt idx="818">
                  <c:v>33.366</c:v>
                </c:pt>
                <c:pt idx="819">
                  <c:v>33.234000000000002</c:v>
                </c:pt>
                <c:pt idx="820">
                  <c:v>33.101999999999997</c:v>
                </c:pt>
                <c:pt idx="821">
                  <c:v>32.969000000000001</c:v>
                </c:pt>
                <c:pt idx="822">
                  <c:v>32.837000000000003</c:v>
                </c:pt>
                <c:pt idx="823">
                  <c:v>32.704999999999998</c:v>
                </c:pt>
                <c:pt idx="824">
                  <c:v>32.573</c:v>
                </c:pt>
                <c:pt idx="825">
                  <c:v>32.441000000000003</c:v>
                </c:pt>
                <c:pt idx="826">
                  <c:v>32.308999999999997</c:v>
                </c:pt>
                <c:pt idx="827">
                  <c:v>32.177</c:v>
                </c:pt>
                <c:pt idx="828">
                  <c:v>32.045000000000002</c:v>
                </c:pt>
                <c:pt idx="829">
                  <c:v>31.913</c:v>
                </c:pt>
                <c:pt idx="830">
                  <c:v>31.780999999999999</c:v>
                </c:pt>
                <c:pt idx="831">
                  <c:v>31.648</c:v>
                </c:pt>
                <c:pt idx="832">
                  <c:v>31.515999999999998</c:v>
                </c:pt>
                <c:pt idx="833">
                  <c:v>31.384</c:v>
                </c:pt>
                <c:pt idx="834">
                  <c:v>31.251999999999999</c:v>
                </c:pt>
                <c:pt idx="835">
                  <c:v>31.12</c:v>
                </c:pt>
                <c:pt idx="836">
                  <c:v>30.988</c:v>
                </c:pt>
                <c:pt idx="837">
                  <c:v>30.856000000000002</c:v>
                </c:pt>
                <c:pt idx="838">
                  <c:v>30.724</c:v>
                </c:pt>
                <c:pt idx="839">
                  <c:v>30.591999999999999</c:v>
                </c:pt>
                <c:pt idx="840">
                  <c:v>30.459</c:v>
                </c:pt>
                <c:pt idx="841">
                  <c:v>30.327000000000002</c:v>
                </c:pt>
                <c:pt idx="842">
                  <c:v>30.195</c:v>
                </c:pt>
                <c:pt idx="843">
                  <c:v>30.062999999999999</c:v>
                </c:pt>
                <c:pt idx="844">
                  <c:v>29.931000000000001</c:v>
                </c:pt>
                <c:pt idx="845">
                  <c:v>29.798999999999999</c:v>
                </c:pt>
                <c:pt idx="846">
                  <c:v>29.667000000000002</c:v>
                </c:pt>
                <c:pt idx="847">
                  <c:v>29.535</c:v>
                </c:pt>
                <c:pt idx="848">
                  <c:v>29.402999999999999</c:v>
                </c:pt>
                <c:pt idx="849">
                  <c:v>29.271000000000001</c:v>
                </c:pt>
                <c:pt idx="850">
                  <c:v>29.138000000000002</c:v>
                </c:pt>
                <c:pt idx="851">
                  <c:v>29.006</c:v>
                </c:pt>
                <c:pt idx="852">
                  <c:v>28.873999999999999</c:v>
                </c:pt>
                <c:pt idx="853">
                  <c:v>28.742000000000001</c:v>
                </c:pt>
                <c:pt idx="854">
                  <c:v>28.61</c:v>
                </c:pt>
                <c:pt idx="855">
                  <c:v>28.478000000000002</c:v>
                </c:pt>
                <c:pt idx="856">
                  <c:v>28.346</c:v>
                </c:pt>
                <c:pt idx="857">
                  <c:v>28.213999999999999</c:v>
                </c:pt>
                <c:pt idx="858">
                  <c:v>28.082000000000001</c:v>
                </c:pt>
                <c:pt idx="859">
                  <c:v>27.949000000000002</c:v>
                </c:pt>
                <c:pt idx="860">
                  <c:v>27.817</c:v>
                </c:pt>
                <c:pt idx="861">
                  <c:v>27.684999999999999</c:v>
                </c:pt>
                <c:pt idx="862">
                  <c:v>27.553000000000001</c:v>
                </c:pt>
                <c:pt idx="863">
                  <c:v>27.420999999999999</c:v>
                </c:pt>
                <c:pt idx="864">
                  <c:v>27.289000000000001</c:v>
                </c:pt>
                <c:pt idx="865">
                  <c:v>27.157</c:v>
                </c:pt>
                <c:pt idx="866">
                  <c:v>27.024999999999999</c:v>
                </c:pt>
                <c:pt idx="867">
                  <c:v>26.893000000000001</c:v>
                </c:pt>
                <c:pt idx="868">
                  <c:v>26.760999999999999</c:v>
                </c:pt>
                <c:pt idx="869">
                  <c:v>26.628</c:v>
                </c:pt>
                <c:pt idx="870">
                  <c:v>26.495999999999999</c:v>
                </c:pt>
                <c:pt idx="871">
                  <c:v>26.364000000000001</c:v>
                </c:pt>
                <c:pt idx="872">
                  <c:v>26.231999999999999</c:v>
                </c:pt>
                <c:pt idx="873">
                  <c:v>26.1</c:v>
                </c:pt>
                <c:pt idx="874">
                  <c:v>25.968</c:v>
                </c:pt>
                <c:pt idx="875">
                  <c:v>25.835999999999999</c:v>
                </c:pt>
                <c:pt idx="876">
                  <c:v>25.704000000000001</c:v>
                </c:pt>
                <c:pt idx="877">
                  <c:v>25.571999999999999</c:v>
                </c:pt>
                <c:pt idx="878">
                  <c:v>25.439</c:v>
                </c:pt>
                <c:pt idx="879">
                  <c:v>25.306999999999999</c:v>
                </c:pt>
                <c:pt idx="880">
                  <c:v>25.175000000000001</c:v>
                </c:pt>
                <c:pt idx="881">
                  <c:v>25.042999999999999</c:v>
                </c:pt>
                <c:pt idx="882">
                  <c:v>24.911000000000001</c:v>
                </c:pt>
                <c:pt idx="883">
                  <c:v>24.779</c:v>
                </c:pt>
                <c:pt idx="884">
                  <c:v>24.646999999999998</c:v>
                </c:pt>
                <c:pt idx="885">
                  <c:v>24.515000000000001</c:v>
                </c:pt>
                <c:pt idx="886">
                  <c:v>24.382999999999999</c:v>
                </c:pt>
                <c:pt idx="887">
                  <c:v>24.25</c:v>
                </c:pt>
                <c:pt idx="888">
                  <c:v>24.117999999999999</c:v>
                </c:pt>
                <c:pt idx="889">
                  <c:v>23.986000000000001</c:v>
                </c:pt>
                <c:pt idx="890">
                  <c:v>23.853999999999999</c:v>
                </c:pt>
                <c:pt idx="891">
                  <c:v>23.722000000000001</c:v>
                </c:pt>
                <c:pt idx="892">
                  <c:v>23.59</c:v>
                </c:pt>
                <c:pt idx="893">
                  <c:v>23.457999999999998</c:v>
                </c:pt>
                <c:pt idx="894">
                  <c:v>23.326000000000001</c:v>
                </c:pt>
                <c:pt idx="895">
                  <c:v>23.193999999999999</c:v>
                </c:pt>
                <c:pt idx="896">
                  <c:v>23.062000000000001</c:v>
                </c:pt>
                <c:pt idx="897">
                  <c:v>22.928999999999998</c:v>
                </c:pt>
                <c:pt idx="898">
                  <c:v>22.797000000000001</c:v>
                </c:pt>
                <c:pt idx="899">
                  <c:v>22.664999999999999</c:v>
                </c:pt>
                <c:pt idx="900">
                  <c:v>22.533000000000001</c:v>
                </c:pt>
                <c:pt idx="901">
                  <c:v>22.401</c:v>
                </c:pt>
                <c:pt idx="902">
                  <c:v>22.268999999999998</c:v>
                </c:pt>
                <c:pt idx="903">
                  <c:v>22.137</c:v>
                </c:pt>
                <c:pt idx="904">
                  <c:v>22.004999999999999</c:v>
                </c:pt>
                <c:pt idx="905">
                  <c:v>21.873000000000001</c:v>
                </c:pt>
                <c:pt idx="906">
                  <c:v>21.74</c:v>
                </c:pt>
                <c:pt idx="907">
                  <c:v>21.608000000000001</c:v>
                </c:pt>
                <c:pt idx="908">
                  <c:v>21.475999999999999</c:v>
                </c:pt>
                <c:pt idx="909">
                  <c:v>21.344000000000001</c:v>
                </c:pt>
                <c:pt idx="910">
                  <c:v>21.212</c:v>
                </c:pt>
                <c:pt idx="911">
                  <c:v>21.08</c:v>
                </c:pt>
                <c:pt idx="912">
                  <c:v>20.948</c:v>
                </c:pt>
                <c:pt idx="913">
                  <c:v>20.815999999999999</c:v>
                </c:pt>
                <c:pt idx="914">
                  <c:v>20.684000000000001</c:v>
                </c:pt>
                <c:pt idx="915">
                  <c:v>20.552</c:v>
                </c:pt>
                <c:pt idx="916">
                  <c:v>20.419</c:v>
                </c:pt>
                <c:pt idx="917">
                  <c:v>20.286999999999999</c:v>
                </c:pt>
                <c:pt idx="918">
                  <c:v>20.155000000000001</c:v>
                </c:pt>
                <c:pt idx="919">
                  <c:v>20.023</c:v>
                </c:pt>
                <c:pt idx="920">
                  <c:v>19.890999999999998</c:v>
                </c:pt>
                <c:pt idx="921">
                  <c:v>19.759</c:v>
                </c:pt>
                <c:pt idx="922">
                  <c:v>19.626999999999999</c:v>
                </c:pt>
                <c:pt idx="923">
                  <c:v>19.495000000000001</c:v>
                </c:pt>
                <c:pt idx="924">
                  <c:v>19.363</c:v>
                </c:pt>
                <c:pt idx="925">
                  <c:v>19.23</c:v>
                </c:pt>
                <c:pt idx="926">
                  <c:v>19.097999999999999</c:v>
                </c:pt>
                <c:pt idx="927">
                  <c:v>18.966000000000001</c:v>
                </c:pt>
                <c:pt idx="928">
                  <c:v>18.834</c:v>
                </c:pt>
                <c:pt idx="929">
                  <c:v>18.702000000000002</c:v>
                </c:pt>
                <c:pt idx="930">
                  <c:v>18.57</c:v>
                </c:pt>
                <c:pt idx="931">
                  <c:v>18.437999999999999</c:v>
                </c:pt>
                <c:pt idx="932">
                  <c:v>18.306000000000001</c:v>
                </c:pt>
                <c:pt idx="933">
                  <c:v>18.173999999999999</c:v>
                </c:pt>
                <c:pt idx="934">
                  <c:v>18.042000000000002</c:v>
                </c:pt>
                <c:pt idx="935">
                  <c:v>17.908999999999999</c:v>
                </c:pt>
                <c:pt idx="936">
                  <c:v>17.777000000000001</c:v>
                </c:pt>
                <c:pt idx="937">
                  <c:v>17.645</c:v>
                </c:pt>
                <c:pt idx="938">
                  <c:v>17.513000000000002</c:v>
                </c:pt>
                <c:pt idx="939">
                  <c:v>17.381</c:v>
                </c:pt>
                <c:pt idx="940">
                  <c:v>17.248999999999999</c:v>
                </c:pt>
                <c:pt idx="941">
                  <c:v>17.117000000000001</c:v>
                </c:pt>
                <c:pt idx="942">
                  <c:v>16.984999999999999</c:v>
                </c:pt>
                <c:pt idx="943">
                  <c:v>16.853000000000002</c:v>
                </c:pt>
                <c:pt idx="944">
                  <c:v>16.72</c:v>
                </c:pt>
                <c:pt idx="945">
                  <c:v>16.588000000000001</c:v>
                </c:pt>
                <c:pt idx="946">
                  <c:v>16.456</c:v>
                </c:pt>
                <c:pt idx="947">
                  <c:v>16.324000000000002</c:v>
                </c:pt>
                <c:pt idx="948">
                  <c:v>16.192</c:v>
                </c:pt>
                <c:pt idx="949">
                  <c:v>16.059999999999999</c:v>
                </c:pt>
                <c:pt idx="950">
                  <c:v>15.928000000000001</c:v>
                </c:pt>
                <c:pt idx="951">
                  <c:v>15.795999999999999</c:v>
                </c:pt>
                <c:pt idx="952">
                  <c:v>15.664</c:v>
                </c:pt>
                <c:pt idx="953">
                  <c:v>15.531000000000001</c:v>
                </c:pt>
                <c:pt idx="954">
                  <c:v>15.398999999999999</c:v>
                </c:pt>
                <c:pt idx="955">
                  <c:v>15.266999999999999</c:v>
                </c:pt>
                <c:pt idx="956">
                  <c:v>15.135</c:v>
                </c:pt>
                <c:pt idx="957">
                  <c:v>15.003</c:v>
                </c:pt>
                <c:pt idx="958">
                  <c:v>14.871</c:v>
                </c:pt>
                <c:pt idx="959">
                  <c:v>14.739000000000001</c:v>
                </c:pt>
                <c:pt idx="960">
                  <c:v>14.606999999999999</c:v>
                </c:pt>
                <c:pt idx="961">
                  <c:v>14.475</c:v>
                </c:pt>
                <c:pt idx="962">
                  <c:v>14.343</c:v>
                </c:pt>
                <c:pt idx="963">
                  <c:v>14.21</c:v>
                </c:pt>
                <c:pt idx="964">
                  <c:v>14.077999999999999</c:v>
                </c:pt>
                <c:pt idx="965">
                  <c:v>13.946</c:v>
                </c:pt>
                <c:pt idx="966">
                  <c:v>13.814</c:v>
                </c:pt>
                <c:pt idx="967">
                  <c:v>13.682</c:v>
                </c:pt>
                <c:pt idx="968">
                  <c:v>13.55</c:v>
                </c:pt>
                <c:pt idx="969">
                  <c:v>13.417999999999999</c:v>
                </c:pt>
                <c:pt idx="970">
                  <c:v>13.286</c:v>
                </c:pt>
                <c:pt idx="971">
                  <c:v>13.154</c:v>
                </c:pt>
                <c:pt idx="972">
                  <c:v>13.021000000000001</c:v>
                </c:pt>
                <c:pt idx="973">
                  <c:v>12.888999999999999</c:v>
                </c:pt>
                <c:pt idx="974">
                  <c:v>12.757</c:v>
                </c:pt>
                <c:pt idx="975">
                  <c:v>12.625</c:v>
                </c:pt>
                <c:pt idx="976">
                  <c:v>12.493</c:v>
                </c:pt>
                <c:pt idx="977">
                  <c:v>12.361000000000001</c:v>
                </c:pt>
                <c:pt idx="978">
                  <c:v>12.228999999999999</c:v>
                </c:pt>
                <c:pt idx="979">
                  <c:v>12.097</c:v>
                </c:pt>
                <c:pt idx="980">
                  <c:v>11.965</c:v>
                </c:pt>
                <c:pt idx="981">
                  <c:v>11.833</c:v>
                </c:pt>
                <c:pt idx="982">
                  <c:v>11.7</c:v>
                </c:pt>
                <c:pt idx="983">
                  <c:v>11.568</c:v>
                </c:pt>
                <c:pt idx="984">
                  <c:v>11.436</c:v>
                </c:pt>
                <c:pt idx="985">
                  <c:v>11.304</c:v>
                </c:pt>
                <c:pt idx="986">
                  <c:v>11.172000000000001</c:v>
                </c:pt>
                <c:pt idx="987">
                  <c:v>11.04</c:v>
                </c:pt>
                <c:pt idx="988">
                  <c:v>10.907999999999999</c:v>
                </c:pt>
                <c:pt idx="989">
                  <c:v>10.776</c:v>
                </c:pt>
                <c:pt idx="990">
                  <c:v>10.644</c:v>
                </c:pt>
                <c:pt idx="991">
                  <c:v>10.510999999999999</c:v>
                </c:pt>
                <c:pt idx="992">
                  <c:v>10.379</c:v>
                </c:pt>
                <c:pt idx="993">
                  <c:v>10.247</c:v>
                </c:pt>
                <c:pt idx="994">
                  <c:v>10.115</c:v>
                </c:pt>
                <c:pt idx="995">
                  <c:v>9.9830000000000005</c:v>
                </c:pt>
                <c:pt idx="996">
                  <c:v>9.8508999999999993</c:v>
                </c:pt>
                <c:pt idx="997">
                  <c:v>9.7187999999999999</c:v>
                </c:pt>
                <c:pt idx="998">
                  <c:v>9.5867000000000004</c:v>
                </c:pt>
                <c:pt idx="999">
                  <c:v>9.4545999999999992</c:v>
                </c:pt>
                <c:pt idx="1000">
                  <c:v>9.3224999999999998</c:v>
                </c:pt>
                <c:pt idx="1001">
                  <c:v>9.1734000000000009</c:v>
                </c:pt>
                <c:pt idx="1002">
                  <c:v>9.0257000000000005</c:v>
                </c:pt>
                <c:pt idx="1003">
                  <c:v>8.8793000000000006</c:v>
                </c:pt>
                <c:pt idx="1004">
                  <c:v>8.7341999999999995</c:v>
                </c:pt>
                <c:pt idx="1005">
                  <c:v>8.5905000000000005</c:v>
                </c:pt>
                <c:pt idx="1006">
                  <c:v>8.4481999999999999</c:v>
                </c:pt>
                <c:pt idx="1007">
                  <c:v>8.3071999999999999</c:v>
                </c:pt>
                <c:pt idx="1008">
                  <c:v>8.1675000000000004</c:v>
                </c:pt>
                <c:pt idx="1009">
                  <c:v>8.0291999999999994</c:v>
                </c:pt>
                <c:pt idx="1010">
                  <c:v>7.8921999999999999</c:v>
                </c:pt>
                <c:pt idx="1011">
                  <c:v>7.7565</c:v>
                </c:pt>
                <c:pt idx="1012">
                  <c:v>7.6222000000000003</c:v>
                </c:pt>
                <c:pt idx="1013">
                  <c:v>7.4892000000000003</c:v>
                </c:pt>
                <c:pt idx="1014">
                  <c:v>7.3574999999999999</c:v>
                </c:pt>
                <c:pt idx="1015">
                  <c:v>7.2271999999999998</c:v>
                </c:pt>
                <c:pt idx="1016">
                  <c:v>7.0982000000000003</c:v>
                </c:pt>
                <c:pt idx="1017">
                  <c:v>6.9705000000000004</c:v>
                </c:pt>
                <c:pt idx="1018">
                  <c:v>6.8441999999999998</c:v>
                </c:pt>
                <c:pt idx="1019">
                  <c:v>6.7191999999999998</c:v>
                </c:pt>
                <c:pt idx="1020">
                  <c:v>6.5955000000000004</c:v>
                </c:pt>
                <c:pt idx="1021">
                  <c:v>6.4730999999999996</c:v>
                </c:pt>
                <c:pt idx="1022">
                  <c:v>6.3521000000000001</c:v>
                </c:pt>
                <c:pt idx="1023">
                  <c:v>6.2323000000000004</c:v>
                </c:pt>
                <c:pt idx="1024">
                  <c:v>6.1139000000000001</c:v>
                </c:pt>
                <c:pt idx="1025">
                  <c:v>5.9968000000000004</c:v>
                </c:pt>
                <c:pt idx="1026">
                  <c:v>5.8810000000000002</c:v>
                </c:pt>
                <c:pt idx="1027">
                  <c:v>5.7666000000000004</c:v>
                </c:pt>
                <c:pt idx="1028">
                  <c:v>5.6534000000000004</c:v>
                </c:pt>
                <c:pt idx="1029">
                  <c:v>5.5415999999999999</c:v>
                </c:pt>
                <c:pt idx="1030">
                  <c:v>5.431</c:v>
                </c:pt>
                <c:pt idx="1031">
                  <c:v>5.3217999999999996</c:v>
                </c:pt>
                <c:pt idx="1032">
                  <c:v>5.2138999999999998</c:v>
                </c:pt>
                <c:pt idx="1033">
                  <c:v>5.1073000000000004</c:v>
                </c:pt>
                <c:pt idx="1034">
                  <c:v>5.0019</c:v>
                </c:pt>
                <c:pt idx="1035">
                  <c:v>4.8978999999999999</c:v>
                </c:pt>
                <c:pt idx="1036">
                  <c:v>4.7952000000000004</c:v>
                </c:pt>
                <c:pt idx="1037">
                  <c:v>4.6936999999999998</c:v>
                </c:pt>
                <c:pt idx="1038">
                  <c:v>4.5936000000000003</c:v>
                </c:pt>
                <c:pt idx="1039">
                  <c:v>4.4946999999999999</c:v>
                </c:pt>
                <c:pt idx="1040">
                  <c:v>4.3971</c:v>
                </c:pt>
                <c:pt idx="1041">
                  <c:v>4.3007999999999997</c:v>
                </c:pt>
                <c:pt idx="1042">
                  <c:v>4.2058</c:v>
                </c:pt>
                <c:pt idx="1043">
                  <c:v>4.1120999999999999</c:v>
                </c:pt>
                <c:pt idx="1044">
                  <c:v>4.0195999999999996</c:v>
                </c:pt>
                <c:pt idx="1045">
                  <c:v>3.9283999999999999</c:v>
                </c:pt>
                <c:pt idx="1046">
                  <c:v>3.8384999999999998</c:v>
                </c:pt>
                <c:pt idx="1047">
                  <c:v>3.7498</c:v>
                </c:pt>
                <c:pt idx="1048">
                  <c:v>3.6623999999999999</c:v>
                </c:pt>
                <c:pt idx="1049">
                  <c:v>3.5762999999999998</c:v>
                </c:pt>
                <c:pt idx="1050">
                  <c:v>3.4914000000000001</c:v>
                </c:pt>
                <c:pt idx="1051">
                  <c:v>3.4077999999999999</c:v>
                </c:pt>
                <c:pt idx="1052">
                  <c:v>3.3254000000000001</c:v>
                </c:pt>
                <c:pt idx="1053">
                  <c:v>3.2442000000000002</c:v>
                </c:pt>
                <c:pt idx="1054">
                  <c:v>3.1644000000000001</c:v>
                </c:pt>
                <c:pt idx="1055">
                  <c:v>3.0857000000000001</c:v>
                </c:pt>
                <c:pt idx="1056">
                  <c:v>3.0083000000000002</c:v>
                </c:pt>
                <c:pt idx="1057">
                  <c:v>2.9321000000000002</c:v>
                </c:pt>
                <c:pt idx="1058">
                  <c:v>2.8571</c:v>
                </c:pt>
                <c:pt idx="1059">
                  <c:v>2.7833999999999999</c:v>
                </c:pt>
                <c:pt idx="1060">
                  <c:v>2.7109000000000001</c:v>
                </c:pt>
                <c:pt idx="1061">
                  <c:v>2.6396000000000002</c:v>
                </c:pt>
                <c:pt idx="1062">
                  <c:v>2.5695000000000001</c:v>
                </c:pt>
                <c:pt idx="1063">
                  <c:v>2.5005999999999999</c:v>
                </c:pt>
                <c:pt idx="1064">
                  <c:v>2.4329000000000001</c:v>
                </c:pt>
                <c:pt idx="1065">
                  <c:v>2.3664000000000001</c:v>
                </c:pt>
                <c:pt idx="1066">
                  <c:v>2.3010999999999999</c:v>
                </c:pt>
                <c:pt idx="1067">
                  <c:v>2.2368999999999999</c:v>
                </c:pt>
                <c:pt idx="1068">
                  <c:v>2.1739999999999999</c:v>
                </c:pt>
                <c:pt idx="1069">
                  <c:v>2.1122000000000001</c:v>
                </c:pt>
                <c:pt idx="1070">
                  <c:v>2.0516000000000001</c:v>
                </c:pt>
                <c:pt idx="1071">
                  <c:v>1.9922</c:v>
                </c:pt>
                <c:pt idx="1072">
                  <c:v>1.9339</c:v>
                </c:pt>
                <c:pt idx="1073">
                  <c:v>1.8767</c:v>
                </c:pt>
                <c:pt idx="1074">
                  <c:v>1.8207</c:v>
                </c:pt>
                <c:pt idx="1075">
                  <c:v>1.7659</c:v>
                </c:pt>
                <c:pt idx="1076">
                  <c:v>1.7121</c:v>
                </c:pt>
                <c:pt idx="1077">
                  <c:v>1.6595</c:v>
                </c:pt>
                <c:pt idx="1078">
                  <c:v>1.6080000000000001</c:v>
                </c:pt>
                <c:pt idx="1079">
                  <c:v>1.5576000000000001</c:v>
                </c:pt>
                <c:pt idx="1080">
                  <c:v>1.5083</c:v>
                </c:pt>
                <c:pt idx="1081">
                  <c:v>1.4601</c:v>
                </c:pt>
                <c:pt idx="1082">
                  <c:v>1.413</c:v>
                </c:pt>
                <c:pt idx="1083">
                  <c:v>1.3669</c:v>
                </c:pt>
                <c:pt idx="1084">
                  <c:v>1.3220000000000001</c:v>
                </c:pt>
                <c:pt idx="1085">
                  <c:v>1.278</c:v>
                </c:pt>
                <c:pt idx="1086">
                  <c:v>1.2352000000000001</c:v>
                </c:pt>
                <c:pt idx="1087">
                  <c:v>1.1933</c:v>
                </c:pt>
                <c:pt idx="1088">
                  <c:v>1.1525000000000001</c:v>
                </c:pt>
                <c:pt idx="1089">
                  <c:v>1.1128</c:v>
                </c:pt>
                <c:pt idx="1090">
                  <c:v>1.0740000000000001</c:v>
                </c:pt>
                <c:pt idx="1091">
                  <c:v>1.0362</c:v>
                </c:pt>
                <c:pt idx="1092">
                  <c:v>0.99941999999999998</c:v>
                </c:pt>
                <c:pt idx="1093">
                  <c:v>0.96360999999999997</c:v>
                </c:pt>
                <c:pt idx="1094">
                  <c:v>0.92876999999999998</c:v>
                </c:pt>
                <c:pt idx="1095">
                  <c:v>0.89488999999999996</c:v>
                </c:pt>
                <c:pt idx="1096">
                  <c:v>0.86194999999999999</c:v>
                </c:pt>
                <c:pt idx="1097">
                  <c:v>0.82994000000000001</c:v>
                </c:pt>
                <c:pt idx="1098">
                  <c:v>0.79886000000000001</c:v>
                </c:pt>
                <c:pt idx="1099">
                  <c:v>0.76868000000000003</c:v>
                </c:pt>
                <c:pt idx="1100">
                  <c:v>0.73939999999999995</c:v>
                </c:pt>
                <c:pt idx="1101">
                  <c:v>0.71099999999999997</c:v>
                </c:pt>
                <c:pt idx="1102">
                  <c:v>0.68347000000000002</c:v>
                </c:pt>
                <c:pt idx="1103">
                  <c:v>0.65680000000000005</c:v>
                </c:pt>
                <c:pt idx="1104">
                  <c:v>0.63097000000000003</c:v>
                </c:pt>
                <c:pt idx="1105">
                  <c:v>0.60597000000000001</c:v>
                </c:pt>
                <c:pt idx="1106">
                  <c:v>0.58177999999999996</c:v>
                </c:pt>
                <c:pt idx="1107">
                  <c:v>0.55840000000000001</c:v>
                </c:pt>
                <c:pt idx="1108">
                  <c:v>0.53580000000000005</c:v>
                </c:pt>
                <c:pt idx="1109">
                  <c:v>0.51397999999999999</c:v>
                </c:pt>
                <c:pt idx="1110">
                  <c:v>0.49292000000000002</c:v>
                </c:pt>
                <c:pt idx="1111">
                  <c:v>0.47260000000000002</c:v>
                </c:pt>
                <c:pt idx="1112">
                  <c:v>0.45301000000000002</c:v>
                </c:pt>
                <c:pt idx="1113">
                  <c:v>0.43413000000000002</c:v>
                </c:pt>
                <c:pt idx="1114">
                  <c:v>0.41594999999999999</c:v>
                </c:pt>
                <c:pt idx="1115">
                  <c:v>0.39845999999999998</c:v>
                </c:pt>
                <c:pt idx="1116">
                  <c:v>0.38163000000000002</c:v>
                </c:pt>
                <c:pt idx="1117">
                  <c:v>0.36546000000000001</c:v>
                </c:pt>
                <c:pt idx="1118">
                  <c:v>0.34993000000000002</c:v>
                </c:pt>
                <c:pt idx="1119">
                  <c:v>0.33501999999999998</c:v>
                </c:pt>
                <c:pt idx="1120">
                  <c:v>0.32071</c:v>
                </c:pt>
                <c:pt idx="1121">
                  <c:v>0.30701000000000001</c:v>
                </c:pt>
                <c:pt idx="1122">
                  <c:v>0.29387000000000002</c:v>
                </c:pt>
                <c:pt idx="1123">
                  <c:v>0.28131</c:v>
                </c:pt>
                <c:pt idx="1124">
                  <c:v>0.26928999999999997</c:v>
                </c:pt>
                <c:pt idx="1125">
                  <c:v>0.25779999999999997</c:v>
                </c:pt>
                <c:pt idx="1126">
                  <c:v>0.24682999999999999</c:v>
                </c:pt>
                <c:pt idx="1127">
                  <c:v>0.23637</c:v>
                </c:pt>
                <c:pt idx="1128">
                  <c:v>0.22639999999999999</c:v>
                </c:pt>
                <c:pt idx="1129">
                  <c:v>0.21690999999999999</c:v>
                </c:pt>
                <c:pt idx="1130">
                  <c:v>0.20788999999999999</c:v>
                </c:pt>
                <c:pt idx="1131">
                  <c:v>0.19930999999999999</c:v>
                </c:pt>
                <c:pt idx="1132">
                  <c:v>0.19117000000000001</c:v>
                </c:pt>
                <c:pt idx="1133">
                  <c:v>0.18346000000000001</c:v>
                </c:pt>
                <c:pt idx="1134">
                  <c:v>0.17616000000000001</c:v>
                </c:pt>
                <c:pt idx="1135">
                  <c:v>0.16925999999999999</c:v>
                </c:pt>
                <c:pt idx="1136">
                  <c:v>0.16275999999999999</c:v>
                </c:pt>
                <c:pt idx="1137">
                  <c:v>0.15662999999999999</c:v>
                </c:pt>
                <c:pt idx="1138">
                  <c:v>0.15087</c:v>
                </c:pt>
                <c:pt idx="1139">
                  <c:v>0.14546999999999999</c:v>
                </c:pt>
                <c:pt idx="1140">
                  <c:v>0.14041999999999999</c:v>
                </c:pt>
                <c:pt idx="1141">
                  <c:v>0.13571</c:v>
                </c:pt>
                <c:pt idx="1142">
                  <c:v>0.13134000000000001</c:v>
                </c:pt>
                <c:pt idx="1143">
                  <c:v>0.12728</c:v>
                </c:pt>
                <c:pt idx="1144">
                  <c:v>0.12352</c:v>
                </c:pt>
                <c:pt idx="1145">
                  <c:v>0.12005</c:v>
                </c:pt>
                <c:pt idx="1146">
                  <c:v>0.11684</c:v>
                </c:pt>
                <c:pt idx="1147">
                  <c:v>0.11387</c:v>
                </c:pt>
                <c:pt idx="1148">
                  <c:v>0.11113000000000001</c:v>
                </c:pt>
                <c:pt idx="1149">
                  <c:v>0.1086</c:v>
                </c:pt>
                <c:pt idx="1150">
                  <c:v>0.10625</c:v>
                </c:pt>
                <c:pt idx="1151">
                  <c:v>0.10408000000000001</c:v>
                </c:pt>
                <c:pt idx="1152">
                  <c:v>0.10206</c:v>
                </c:pt>
                <c:pt idx="1153">
                  <c:v>0.10019</c:v>
                </c:pt>
                <c:pt idx="1154">
                  <c:v>9.8449999999999996E-2</c:v>
                </c:pt>
                <c:pt idx="1155">
                  <c:v>9.6829999999999999E-2</c:v>
                </c:pt>
                <c:pt idx="1156">
                  <c:v>9.5319000000000001E-2</c:v>
                </c:pt>
                <c:pt idx="1157">
                  <c:v>9.3909000000000006E-2</c:v>
                </c:pt>
                <c:pt idx="1158">
                  <c:v>9.2591999999999994E-2</c:v>
                </c:pt>
                <c:pt idx="1159">
                  <c:v>9.1358999999999996E-2</c:v>
                </c:pt>
                <c:pt idx="1160">
                  <c:v>9.0204000000000006E-2</c:v>
                </c:pt>
                <c:pt idx="1161">
                  <c:v>8.9121000000000006E-2</c:v>
                </c:pt>
                <c:pt idx="1162">
                  <c:v>8.8103000000000001E-2</c:v>
                </c:pt>
                <c:pt idx="1163">
                  <c:v>8.7147000000000002E-2</c:v>
                </c:pt>
                <c:pt idx="1164">
                  <c:v>8.6247000000000004E-2</c:v>
                </c:pt>
                <c:pt idx="1165">
                  <c:v>8.5398000000000002E-2</c:v>
                </c:pt>
                <c:pt idx="1166">
                  <c:v>8.4598000000000007E-2</c:v>
                </c:pt>
                <c:pt idx="1167">
                  <c:v>8.3842E-2</c:v>
                </c:pt>
                <c:pt idx="1168">
                  <c:v>8.3127999999999994E-2</c:v>
                </c:pt>
                <c:pt idx="1169">
                  <c:v>8.2451999999999998E-2</c:v>
                </c:pt>
                <c:pt idx="1170">
                  <c:v>8.1810999999999995E-2</c:v>
                </c:pt>
                <c:pt idx="1171">
                  <c:v>8.1203999999999998E-2</c:v>
                </c:pt>
                <c:pt idx="1172">
                  <c:v>8.0628000000000005E-2</c:v>
                </c:pt>
                <c:pt idx="1173">
                  <c:v>8.0080999999999999E-2</c:v>
                </c:pt>
                <c:pt idx="1174">
                  <c:v>7.9561000000000007E-2</c:v>
                </c:pt>
                <c:pt idx="1175">
                  <c:v>7.9066999999999998E-2</c:v>
                </c:pt>
                <c:pt idx="1176">
                  <c:v>7.8595999999999999E-2</c:v>
                </c:pt>
                <c:pt idx="1177">
                  <c:v>7.8146999999999994E-2</c:v>
                </c:pt>
                <c:pt idx="1178">
                  <c:v>7.7718999999999996E-2</c:v>
                </c:pt>
                <c:pt idx="1179">
                  <c:v>7.7311000000000005E-2</c:v>
                </c:pt>
                <c:pt idx="1180">
                  <c:v>7.6921000000000003E-2</c:v>
                </c:pt>
                <c:pt idx="1181">
                  <c:v>7.6549000000000006E-2</c:v>
                </c:pt>
                <c:pt idx="1182">
                  <c:v>7.6191999999999996E-2</c:v>
                </c:pt>
                <c:pt idx="1183">
                  <c:v>7.5851000000000002E-2</c:v>
                </c:pt>
                <c:pt idx="1184">
                  <c:v>7.5524999999999995E-2</c:v>
                </c:pt>
                <c:pt idx="1185">
                  <c:v>7.5212000000000001E-2</c:v>
                </c:pt>
                <c:pt idx="1186">
                  <c:v>7.4912000000000006E-2</c:v>
                </c:pt>
                <c:pt idx="1187">
                  <c:v>7.4624999999999997E-2</c:v>
                </c:pt>
                <c:pt idx="1188">
                  <c:v>7.4348999999999998E-2</c:v>
                </c:pt>
                <c:pt idx="1189">
                  <c:v>7.4083999999999997E-2</c:v>
                </c:pt>
                <c:pt idx="1190">
                  <c:v>7.3829000000000006E-2</c:v>
                </c:pt>
                <c:pt idx="1191">
                  <c:v>7.3583999999999997E-2</c:v>
                </c:pt>
                <c:pt idx="1192">
                  <c:v>7.3348999999999998E-2</c:v>
                </c:pt>
                <c:pt idx="1193">
                  <c:v>7.3122000000000006E-2</c:v>
                </c:pt>
                <c:pt idx="1194">
                  <c:v>7.2903999999999997E-2</c:v>
                </c:pt>
                <c:pt idx="1195">
                  <c:v>7.2693999999999995E-2</c:v>
                </c:pt>
                <c:pt idx="1196">
                  <c:v>7.2491E-2</c:v>
                </c:pt>
                <c:pt idx="1197">
                  <c:v>7.2295999999999999E-2</c:v>
                </c:pt>
                <c:pt idx="1198">
                  <c:v>7.2108000000000005E-2</c:v>
                </c:pt>
                <c:pt idx="1199">
                  <c:v>7.1926000000000004E-2</c:v>
                </c:pt>
                <c:pt idx="1200">
                  <c:v>7.1749999999999994E-2</c:v>
                </c:pt>
                <c:pt idx="1201">
                  <c:v>7.1581000000000006E-2</c:v>
                </c:pt>
                <c:pt idx="1202">
                  <c:v>7.1416999999999994E-2</c:v>
                </c:pt>
                <c:pt idx="1203">
                  <c:v>7.1259000000000003E-2</c:v>
                </c:pt>
                <c:pt idx="1204">
                  <c:v>7.1106000000000003E-2</c:v>
                </c:pt>
                <c:pt idx="1205">
                  <c:v>7.0957999999999993E-2</c:v>
                </c:pt>
                <c:pt idx="1206">
                  <c:v>7.0815000000000003E-2</c:v>
                </c:pt>
                <c:pt idx="1207">
                  <c:v>7.0676000000000003E-2</c:v>
                </c:pt>
                <c:pt idx="1208">
                  <c:v>7.0541999999999994E-2</c:v>
                </c:pt>
                <c:pt idx="1209">
                  <c:v>7.0412000000000002E-2</c:v>
                </c:pt>
                <c:pt idx="1210">
                  <c:v>7.0286000000000001E-2</c:v>
                </c:pt>
                <c:pt idx="1211">
                  <c:v>7.0163000000000003E-2</c:v>
                </c:pt>
                <c:pt idx="1212">
                  <c:v>7.0044999999999996E-2</c:v>
                </c:pt>
                <c:pt idx="1213">
                  <c:v>6.9930000000000006E-2</c:v>
                </c:pt>
                <c:pt idx="1214">
                  <c:v>6.9819000000000006E-2</c:v>
                </c:pt>
                <c:pt idx="1215">
                  <c:v>6.9709999999999994E-2</c:v>
                </c:pt>
                <c:pt idx="1216">
                  <c:v>6.9605E-2</c:v>
                </c:pt>
                <c:pt idx="1217">
                  <c:v>6.9502999999999995E-2</c:v>
                </c:pt>
                <c:pt idx="1218">
                  <c:v>6.9403999999999993E-2</c:v>
                </c:pt>
                <c:pt idx="1219">
                  <c:v>6.9307999999999995E-2</c:v>
                </c:pt>
                <c:pt idx="1220">
                  <c:v>6.9213999999999998E-2</c:v>
                </c:pt>
                <c:pt idx="1221">
                  <c:v>6.9123000000000004E-2</c:v>
                </c:pt>
                <c:pt idx="1222">
                  <c:v>6.9034999999999999E-2</c:v>
                </c:pt>
                <c:pt idx="1223">
                  <c:v>6.8948999999999996E-2</c:v>
                </c:pt>
                <c:pt idx="1224">
                  <c:v>6.8864999999999996E-2</c:v>
                </c:pt>
                <c:pt idx="1225">
                  <c:v>6.8783999999999998E-2</c:v>
                </c:pt>
                <c:pt idx="1226">
                  <c:v>6.8704000000000001E-2</c:v>
                </c:pt>
                <c:pt idx="1227">
                  <c:v>6.8626999999999994E-2</c:v>
                </c:pt>
                <c:pt idx="1228">
                  <c:v>6.8552000000000002E-2</c:v>
                </c:pt>
                <c:pt idx="1229">
                  <c:v>6.8478999999999998E-2</c:v>
                </c:pt>
                <c:pt idx="1230">
                  <c:v>6.8406999999999996E-2</c:v>
                </c:pt>
                <c:pt idx="1231">
                  <c:v>6.8337999999999996E-2</c:v>
                </c:pt>
                <c:pt idx="1232">
                  <c:v>6.8269999999999997E-2</c:v>
                </c:pt>
                <c:pt idx="1233">
                  <c:v>6.8204000000000001E-2</c:v>
                </c:pt>
                <c:pt idx="1234">
                  <c:v>6.8139000000000005E-2</c:v>
                </c:pt>
                <c:pt idx="1235">
                  <c:v>6.8075999999999998E-2</c:v>
                </c:pt>
                <c:pt idx="1236">
                  <c:v>6.8015000000000006E-2</c:v>
                </c:pt>
                <c:pt idx="1237">
                  <c:v>6.7955000000000002E-2</c:v>
                </c:pt>
                <c:pt idx="1238">
                  <c:v>6.7895999999999998E-2</c:v>
                </c:pt>
                <c:pt idx="1239">
                  <c:v>6.7838999999999997E-2</c:v>
                </c:pt>
                <c:pt idx="1240">
                  <c:v>6.7783999999999997E-2</c:v>
                </c:pt>
                <c:pt idx="1241">
                  <c:v>6.7728999999999998E-2</c:v>
                </c:pt>
                <c:pt idx="1242">
                  <c:v>6.7676E-2</c:v>
                </c:pt>
                <c:pt idx="1243">
                  <c:v>6.7624000000000004E-2</c:v>
                </c:pt>
                <c:pt idx="1244">
                  <c:v>6.7572999999999994E-2</c:v>
                </c:pt>
                <c:pt idx="1245">
                  <c:v>6.7524000000000001E-2</c:v>
                </c:pt>
                <c:pt idx="1246">
                  <c:v>6.7474999999999993E-2</c:v>
                </c:pt>
                <c:pt idx="1247">
                  <c:v>6.7428000000000002E-2</c:v>
                </c:pt>
                <c:pt idx="1248">
                  <c:v>6.7381999999999997E-2</c:v>
                </c:pt>
                <c:pt idx="1249">
                  <c:v>6.7335999999999993E-2</c:v>
                </c:pt>
                <c:pt idx="1250">
                  <c:v>6.7292000000000005E-2</c:v>
                </c:pt>
                <c:pt idx="1251">
                  <c:v>6.7249000000000003E-2</c:v>
                </c:pt>
                <c:pt idx="1252">
                  <c:v>6.7206000000000002E-2</c:v>
                </c:pt>
                <c:pt idx="1253">
                  <c:v>6.7165000000000002E-2</c:v>
                </c:pt>
                <c:pt idx="1254">
                  <c:v>6.7124000000000003E-2</c:v>
                </c:pt>
                <c:pt idx="1255">
                  <c:v>6.7084000000000005E-2</c:v>
                </c:pt>
                <c:pt idx="1256">
                  <c:v>6.7044999999999993E-2</c:v>
                </c:pt>
                <c:pt idx="1257">
                  <c:v>6.7006999999999997E-2</c:v>
                </c:pt>
                <c:pt idx="1258">
                  <c:v>6.6970000000000002E-2</c:v>
                </c:pt>
                <c:pt idx="1259">
                  <c:v>6.6933000000000006E-2</c:v>
                </c:pt>
                <c:pt idx="1260">
                  <c:v>6.6896999999999998E-2</c:v>
                </c:pt>
                <c:pt idx="1261">
                  <c:v>6.6862000000000005E-2</c:v>
                </c:pt>
                <c:pt idx="1262">
                  <c:v>6.6827999999999999E-2</c:v>
                </c:pt>
                <c:pt idx="1263">
                  <c:v>6.6794000000000006E-2</c:v>
                </c:pt>
                <c:pt idx="1264">
                  <c:v>6.6761000000000001E-2</c:v>
                </c:pt>
                <c:pt idx="1265">
                  <c:v>6.6727999999999996E-2</c:v>
                </c:pt>
                <c:pt idx="1266">
                  <c:v>6.6697000000000006E-2</c:v>
                </c:pt>
                <c:pt idx="1267">
                  <c:v>6.6666000000000003E-2</c:v>
                </c:pt>
                <c:pt idx="1268">
                  <c:v>6.6635E-2</c:v>
                </c:pt>
                <c:pt idx="1269">
                  <c:v>6.6604999999999998E-2</c:v>
                </c:pt>
                <c:pt idx="1270">
                  <c:v>6.6575999999999996E-2</c:v>
                </c:pt>
                <c:pt idx="1271">
                  <c:v>6.6546999999999995E-2</c:v>
                </c:pt>
                <c:pt idx="1272">
                  <c:v>6.6517999999999994E-2</c:v>
                </c:pt>
                <c:pt idx="1273">
                  <c:v>6.6490999999999995E-2</c:v>
                </c:pt>
                <c:pt idx="1274">
                  <c:v>6.6462999999999994E-2</c:v>
                </c:pt>
                <c:pt idx="1275">
                  <c:v>6.6436999999999996E-2</c:v>
                </c:pt>
                <c:pt idx="1276">
                  <c:v>6.6409999999999997E-2</c:v>
                </c:pt>
                <c:pt idx="1277">
                  <c:v>6.6385E-2</c:v>
                </c:pt>
                <c:pt idx="1278">
                  <c:v>6.6359000000000001E-2</c:v>
                </c:pt>
                <c:pt idx="1279">
                  <c:v>6.6334000000000004E-2</c:v>
                </c:pt>
                <c:pt idx="1280">
                  <c:v>6.6309999999999994E-2</c:v>
                </c:pt>
                <c:pt idx="1281">
                  <c:v>6.6285999999999998E-2</c:v>
                </c:pt>
                <c:pt idx="1282">
                  <c:v>6.6262000000000001E-2</c:v>
                </c:pt>
                <c:pt idx="1283">
                  <c:v>6.6239000000000006E-2</c:v>
                </c:pt>
                <c:pt idx="1284">
                  <c:v>6.6216999999999998E-2</c:v>
                </c:pt>
                <c:pt idx="1285">
                  <c:v>6.6194000000000003E-2</c:v>
                </c:pt>
                <c:pt idx="1286">
                  <c:v>6.6171999999999995E-2</c:v>
                </c:pt>
                <c:pt idx="1287">
                  <c:v>6.6151000000000001E-2</c:v>
                </c:pt>
                <c:pt idx="1288">
                  <c:v>6.6128999999999993E-2</c:v>
                </c:pt>
                <c:pt idx="1289">
                  <c:v>6.6109000000000001E-2</c:v>
                </c:pt>
                <c:pt idx="1290">
                  <c:v>6.6087999999999994E-2</c:v>
                </c:pt>
                <c:pt idx="1291">
                  <c:v>6.6068000000000002E-2</c:v>
                </c:pt>
                <c:pt idx="1292">
                  <c:v>6.6047999999999996E-2</c:v>
                </c:pt>
                <c:pt idx="1293">
                  <c:v>6.6029000000000004E-2</c:v>
                </c:pt>
                <c:pt idx="1294">
                  <c:v>6.6009999999999999E-2</c:v>
                </c:pt>
                <c:pt idx="1295">
                  <c:v>6.5990999999999994E-2</c:v>
                </c:pt>
                <c:pt idx="1296">
                  <c:v>6.5972000000000003E-2</c:v>
                </c:pt>
                <c:pt idx="1297">
                  <c:v>6.5953999999999999E-2</c:v>
                </c:pt>
                <c:pt idx="1298">
                  <c:v>6.5935999999999995E-2</c:v>
                </c:pt>
                <c:pt idx="1299">
                  <c:v>6.5918000000000004E-2</c:v>
                </c:pt>
                <c:pt idx="1300">
                  <c:v>6.5901000000000001E-2</c:v>
                </c:pt>
                <c:pt idx="1301">
                  <c:v>6.5883999999999998E-2</c:v>
                </c:pt>
                <c:pt idx="1302">
                  <c:v>6.5866999999999995E-2</c:v>
                </c:pt>
                <c:pt idx="1303">
                  <c:v>6.5850000000000006E-2</c:v>
                </c:pt>
                <c:pt idx="1304">
                  <c:v>6.5834000000000004E-2</c:v>
                </c:pt>
                <c:pt idx="1305">
                  <c:v>6.5818000000000002E-2</c:v>
                </c:pt>
                <c:pt idx="1306">
                  <c:v>6.5801999999999999E-2</c:v>
                </c:pt>
                <c:pt idx="1307">
                  <c:v>6.5786999999999998E-2</c:v>
                </c:pt>
                <c:pt idx="1308">
                  <c:v>6.5770999999999996E-2</c:v>
                </c:pt>
                <c:pt idx="1309">
                  <c:v>6.5755999999999995E-2</c:v>
                </c:pt>
                <c:pt idx="1310">
                  <c:v>6.5740999999999994E-2</c:v>
                </c:pt>
                <c:pt idx="1311">
                  <c:v>6.5726999999999994E-2</c:v>
                </c:pt>
                <c:pt idx="1312">
                  <c:v>6.5712000000000007E-2</c:v>
                </c:pt>
                <c:pt idx="1313">
                  <c:v>6.5698000000000006E-2</c:v>
                </c:pt>
                <c:pt idx="1314">
                  <c:v>6.5684000000000006E-2</c:v>
                </c:pt>
                <c:pt idx="1315">
                  <c:v>6.5670000000000006E-2</c:v>
                </c:pt>
                <c:pt idx="1316">
                  <c:v>6.5656999999999993E-2</c:v>
                </c:pt>
                <c:pt idx="1317">
                  <c:v>6.5643000000000007E-2</c:v>
                </c:pt>
                <c:pt idx="1318">
                  <c:v>6.5629999999999994E-2</c:v>
                </c:pt>
                <c:pt idx="1319">
                  <c:v>6.5616999999999995E-2</c:v>
                </c:pt>
                <c:pt idx="1320">
                  <c:v>6.5604999999999997E-2</c:v>
                </c:pt>
                <c:pt idx="1321">
                  <c:v>6.5591999999999998E-2</c:v>
                </c:pt>
                <c:pt idx="1322">
                  <c:v>6.5578999999999998E-2</c:v>
                </c:pt>
                <c:pt idx="1323">
                  <c:v>6.5567E-2</c:v>
                </c:pt>
                <c:pt idx="1324">
                  <c:v>6.5555000000000002E-2</c:v>
                </c:pt>
                <c:pt idx="1325">
                  <c:v>6.5543000000000004E-2</c:v>
                </c:pt>
                <c:pt idx="1326">
                  <c:v>6.5531000000000006E-2</c:v>
                </c:pt>
                <c:pt idx="1327">
                  <c:v>6.5519999999999995E-2</c:v>
                </c:pt>
                <c:pt idx="1328">
                  <c:v>6.5507999999999997E-2</c:v>
                </c:pt>
                <c:pt idx="1329">
                  <c:v>6.5497E-2</c:v>
                </c:pt>
                <c:pt idx="1330">
                  <c:v>6.5486000000000003E-2</c:v>
                </c:pt>
                <c:pt idx="1331">
                  <c:v>6.5475000000000005E-2</c:v>
                </c:pt>
                <c:pt idx="1332">
                  <c:v>6.5463999999999994E-2</c:v>
                </c:pt>
                <c:pt idx="1333">
                  <c:v>6.5453999999999998E-2</c:v>
                </c:pt>
                <c:pt idx="1334">
                  <c:v>6.5443000000000001E-2</c:v>
                </c:pt>
                <c:pt idx="1335">
                  <c:v>6.5433000000000005E-2</c:v>
                </c:pt>
                <c:pt idx="1336">
                  <c:v>6.5421999999999994E-2</c:v>
                </c:pt>
                <c:pt idx="1337">
                  <c:v>6.5411999999999998E-2</c:v>
                </c:pt>
                <c:pt idx="1338">
                  <c:v>6.5402000000000002E-2</c:v>
                </c:pt>
                <c:pt idx="1339">
                  <c:v>6.5393000000000007E-2</c:v>
                </c:pt>
                <c:pt idx="1340">
                  <c:v>6.5382999999999997E-2</c:v>
                </c:pt>
                <c:pt idx="1341">
                  <c:v>6.5373000000000001E-2</c:v>
                </c:pt>
                <c:pt idx="1342">
                  <c:v>6.5364000000000005E-2</c:v>
                </c:pt>
                <c:pt idx="1343">
                  <c:v>6.5354999999999996E-2</c:v>
                </c:pt>
                <c:pt idx="1344">
                  <c:v>6.5345E-2</c:v>
                </c:pt>
                <c:pt idx="1345">
                  <c:v>6.5336000000000005E-2</c:v>
                </c:pt>
                <c:pt idx="1346">
                  <c:v>6.5326999999999996E-2</c:v>
                </c:pt>
                <c:pt idx="1347">
                  <c:v>6.5318000000000001E-2</c:v>
                </c:pt>
                <c:pt idx="1348">
                  <c:v>6.5310000000000007E-2</c:v>
                </c:pt>
                <c:pt idx="1349">
                  <c:v>6.5300999999999998E-2</c:v>
                </c:pt>
                <c:pt idx="1350">
                  <c:v>6.5292000000000003E-2</c:v>
                </c:pt>
                <c:pt idx="1351">
                  <c:v>6.5283999999999995E-2</c:v>
                </c:pt>
                <c:pt idx="1352">
                  <c:v>6.5276000000000001E-2</c:v>
                </c:pt>
                <c:pt idx="1353">
                  <c:v>6.5268000000000007E-2</c:v>
                </c:pt>
                <c:pt idx="1354">
                  <c:v>6.5258999999999998E-2</c:v>
                </c:pt>
                <c:pt idx="1355">
                  <c:v>6.5251000000000003E-2</c:v>
                </c:pt>
                <c:pt idx="1356">
                  <c:v>6.5242999999999995E-2</c:v>
                </c:pt>
                <c:pt idx="1357">
                  <c:v>6.5236000000000002E-2</c:v>
                </c:pt>
                <c:pt idx="1358">
                  <c:v>6.5227999999999994E-2</c:v>
                </c:pt>
                <c:pt idx="1359">
                  <c:v>6.522E-2</c:v>
                </c:pt>
                <c:pt idx="1360">
                  <c:v>6.5212999999999993E-2</c:v>
                </c:pt>
                <c:pt idx="1361">
                  <c:v>6.5204999999999999E-2</c:v>
                </c:pt>
                <c:pt idx="1362">
                  <c:v>6.5198000000000006E-2</c:v>
                </c:pt>
                <c:pt idx="1363">
                  <c:v>6.5190999999999999E-2</c:v>
                </c:pt>
                <c:pt idx="1364">
                  <c:v>6.5184000000000006E-2</c:v>
                </c:pt>
                <c:pt idx="1365">
                  <c:v>6.5175999999999998E-2</c:v>
                </c:pt>
                <c:pt idx="1366">
                  <c:v>6.5169000000000005E-2</c:v>
                </c:pt>
                <c:pt idx="1367">
                  <c:v>6.5162999999999999E-2</c:v>
                </c:pt>
                <c:pt idx="1368">
                  <c:v>6.5156000000000006E-2</c:v>
                </c:pt>
                <c:pt idx="1369">
                  <c:v>6.5148999999999999E-2</c:v>
                </c:pt>
                <c:pt idx="1370">
                  <c:v>6.5142000000000005E-2</c:v>
                </c:pt>
                <c:pt idx="1371">
                  <c:v>6.5135999999999999E-2</c:v>
                </c:pt>
                <c:pt idx="1372">
                  <c:v>6.5129000000000006E-2</c:v>
                </c:pt>
                <c:pt idx="1373">
                  <c:v>6.5123E-2</c:v>
                </c:pt>
                <c:pt idx="1374">
                  <c:v>6.5115999999999993E-2</c:v>
                </c:pt>
                <c:pt idx="1375">
                  <c:v>6.5110000000000001E-2</c:v>
                </c:pt>
                <c:pt idx="1376">
                  <c:v>6.5103999999999995E-2</c:v>
                </c:pt>
                <c:pt idx="1377">
                  <c:v>6.5098000000000003E-2</c:v>
                </c:pt>
                <c:pt idx="1378">
                  <c:v>6.5090999999999996E-2</c:v>
                </c:pt>
                <c:pt idx="1379">
                  <c:v>6.5085000000000004E-2</c:v>
                </c:pt>
                <c:pt idx="1380">
                  <c:v>6.5078999999999998E-2</c:v>
                </c:pt>
                <c:pt idx="1381">
                  <c:v>6.5074000000000007E-2</c:v>
                </c:pt>
                <c:pt idx="1382">
                  <c:v>6.5068000000000001E-2</c:v>
                </c:pt>
                <c:pt idx="1383">
                  <c:v>6.5061999999999995E-2</c:v>
                </c:pt>
                <c:pt idx="1384">
                  <c:v>6.5056000000000003E-2</c:v>
                </c:pt>
                <c:pt idx="1385">
                  <c:v>6.5050999999999998E-2</c:v>
                </c:pt>
                <c:pt idx="1386">
                  <c:v>6.5045000000000006E-2</c:v>
                </c:pt>
                <c:pt idx="1387">
                  <c:v>6.5039E-2</c:v>
                </c:pt>
                <c:pt idx="1388">
                  <c:v>6.5033999999999995E-2</c:v>
                </c:pt>
                <c:pt idx="1389">
                  <c:v>6.5029000000000003E-2</c:v>
                </c:pt>
                <c:pt idx="1390">
                  <c:v>6.5022999999999997E-2</c:v>
                </c:pt>
                <c:pt idx="1391">
                  <c:v>6.5018000000000006E-2</c:v>
                </c:pt>
                <c:pt idx="1392">
                  <c:v>6.5013000000000001E-2</c:v>
                </c:pt>
                <c:pt idx="1393">
                  <c:v>6.5007999999999996E-2</c:v>
                </c:pt>
                <c:pt idx="1394">
                  <c:v>6.5002000000000004E-2</c:v>
                </c:pt>
                <c:pt idx="1395">
                  <c:v>6.4996999999999999E-2</c:v>
                </c:pt>
                <c:pt idx="1396">
                  <c:v>6.4991999999999994E-2</c:v>
                </c:pt>
                <c:pt idx="1397">
                  <c:v>6.4987000000000003E-2</c:v>
                </c:pt>
                <c:pt idx="1398">
                  <c:v>6.4982999999999999E-2</c:v>
                </c:pt>
                <c:pt idx="1399">
                  <c:v>6.4977999999999994E-2</c:v>
                </c:pt>
                <c:pt idx="1400">
                  <c:v>6.4973000000000003E-2</c:v>
                </c:pt>
                <c:pt idx="1401">
                  <c:v>6.4967999999999998E-2</c:v>
                </c:pt>
                <c:pt idx="1402">
                  <c:v>6.4963000000000007E-2</c:v>
                </c:pt>
                <c:pt idx="1403">
                  <c:v>6.4959000000000003E-2</c:v>
                </c:pt>
                <c:pt idx="1404">
                  <c:v>6.4953999999999998E-2</c:v>
                </c:pt>
                <c:pt idx="1405">
                  <c:v>6.4949999999999994E-2</c:v>
                </c:pt>
                <c:pt idx="1406">
                  <c:v>6.4945000000000003E-2</c:v>
                </c:pt>
                <c:pt idx="1407">
                  <c:v>6.4940999999999999E-2</c:v>
                </c:pt>
                <c:pt idx="1408">
                  <c:v>6.4935999999999994E-2</c:v>
                </c:pt>
                <c:pt idx="1409">
                  <c:v>6.4932000000000004E-2</c:v>
                </c:pt>
                <c:pt idx="1410">
                  <c:v>6.4928E-2</c:v>
                </c:pt>
                <c:pt idx="1411">
                  <c:v>6.4922999999999995E-2</c:v>
                </c:pt>
                <c:pt idx="1412">
                  <c:v>6.4919000000000004E-2</c:v>
                </c:pt>
                <c:pt idx="1413">
                  <c:v>6.4915E-2</c:v>
                </c:pt>
                <c:pt idx="1414">
                  <c:v>6.4910999999999996E-2</c:v>
                </c:pt>
                <c:pt idx="1415">
                  <c:v>6.4907000000000006E-2</c:v>
                </c:pt>
                <c:pt idx="1416">
                  <c:v>6.4902000000000001E-2</c:v>
                </c:pt>
                <c:pt idx="1417">
                  <c:v>6.4897999999999997E-2</c:v>
                </c:pt>
                <c:pt idx="1418">
                  <c:v>6.4893999999999993E-2</c:v>
                </c:pt>
                <c:pt idx="1419">
                  <c:v>6.4890000000000003E-2</c:v>
                </c:pt>
                <c:pt idx="1420">
                  <c:v>6.4887E-2</c:v>
                </c:pt>
                <c:pt idx="1421">
                  <c:v>6.4882999999999996E-2</c:v>
                </c:pt>
                <c:pt idx="1422">
                  <c:v>6.4879000000000006E-2</c:v>
                </c:pt>
                <c:pt idx="1423">
                  <c:v>6.4875000000000002E-2</c:v>
                </c:pt>
                <c:pt idx="1424">
                  <c:v>6.4870999999999998E-2</c:v>
                </c:pt>
                <c:pt idx="1425">
                  <c:v>6.4866999999999994E-2</c:v>
                </c:pt>
                <c:pt idx="1426">
                  <c:v>6.4864000000000005E-2</c:v>
                </c:pt>
                <c:pt idx="1427">
                  <c:v>6.4860000000000001E-2</c:v>
                </c:pt>
                <c:pt idx="1428">
                  <c:v>6.4855999999999997E-2</c:v>
                </c:pt>
                <c:pt idx="1429">
                  <c:v>6.4852999999999994E-2</c:v>
                </c:pt>
                <c:pt idx="1430">
                  <c:v>6.4849000000000004E-2</c:v>
                </c:pt>
                <c:pt idx="1431">
                  <c:v>6.4846000000000001E-2</c:v>
                </c:pt>
                <c:pt idx="1432">
                  <c:v>6.4841999999999997E-2</c:v>
                </c:pt>
                <c:pt idx="1433">
                  <c:v>6.4838999999999994E-2</c:v>
                </c:pt>
                <c:pt idx="1434">
                  <c:v>6.4835000000000004E-2</c:v>
                </c:pt>
                <c:pt idx="1435">
                  <c:v>6.4832000000000001E-2</c:v>
                </c:pt>
                <c:pt idx="1436">
                  <c:v>6.4828999999999998E-2</c:v>
                </c:pt>
                <c:pt idx="1437">
                  <c:v>6.4824999999999994E-2</c:v>
                </c:pt>
                <c:pt idx="1438">
                  <c:v>6.4822000000000005E-2</c:v>
                </c:pt>
                <c:pt idx="1439">
                  <c:v>6.4819000000000002E-2</c:v>
                </c:pt>
                <c:pt idx="1440">
                  <c:v>6.4814999999999998E-2</c:v>
                </c:pt>
                <c:pt idx="1441">
                  <c:v>6.4811999999999995E-2</c:v>
                </c:pt>
                <c:pt idx="1442">
                  <c:v>6.4809000000000005E-2</c:v>
                </c:pt>
                <c:pt idx="1443">
                  <c:v>6.4806000000000002E-2</c:v>
                </c:pt>
                <c:pt idx="1444">
                  <c:v>6.4802999999999999E-2</c:v>
                </c:pt>
                <c:pt idx="1445">
                  <c:v>6.4799999999999996E-2</c:v>
                </c:pt>
                <c:pt idx="1446">
                  <c:v>6.4796999999999993E-2</c:v>
                </c:pt>
                <c:pt idx="1447">
                  <c:v>6.4794000000000004E-2</c:v>
                </c:pt>
                <c:pt idx="1448">
                  <c:v>6.479E-2</c:v>
                </c:pt>
                <c:pt idx="1449">
                  <c:v>6.4787999999999998E-2</c:v>
                </c:pt>
                <c:pt idx="1450">
                  <c:v>6.4784999999999995E-2</c:v>
                </c:pt>
                <c:pt idx="1451">
                  <c:v>6.4782000000000006E-2</c:v>
                </c:pt>
                <c:pt idx="1452">
                  <c:v>6.4779000000000003E-2</c:v>
                </c:pt>
                <c:pt idx="1453">
                  <c:v>6.4776E-2</c:v>
                </c:pt>
                <c:pt idx="1454">
                  <c:v>6.4772999999999997E-2</c:v>
                </c:pt>
                <c:pt idx="1455">
                  <c:v>6.4769999999999994E-2</c:v>
                </c:pt>
                <c:pt idx="1456">
                  <c:v>6.4767000000000005E-2</c:v>
                </c:pt>
                <c:pt idx="1457">
                  <c:v>6.4764000000000002E-2</c:v>
                </c:pt>
                <c:pt idx="1458">
                  <c:v>6.4762E-2</c:v>
                </c:pt>
                <c:pt idx="1459">
                  <c:v>6.4758999999999997E-2</c:v>
                </c:pt>
                <c:pt idx="1460">
                  <c:v>6.4755999999999994E-2</c:v>
                </c:pt>
                <c:pt idx="1461">
                  <c:v>6.4754000000000006E-2</c:v>
                </c:pt>
                <c:pt idx="1462">
                  <c:v>6.4751000000000003E-2</c:v>
                </c:pt>
                <c:pt idx="1463">
                  <c:v>6.4748E-2</c:v>
                </c:pt>
                <c:pt idx="1464">
                  <c:v>6.4745999999999998E-2</c:v>
                </c:pt>
                <c:pt idx="1465">
                  <c:v>6.4742999999999995E-2</c:v>
                </c:pt>
                <c:pt idx="1466">
                  <c:v>6.4740000000000006E-2</c:v>
                </c:pt>
                <c:pt idx="1467">
                  <c:v>6.4738000000000004E-2</c:v>
                </c:pt>
                <c:pt idx="1468">
                  <c:v>6.4735000000000001E-2</c:v>
                </c:pt>
                <c:pt idx="1469">
                  <c:v>6.4732999999999999E-2</c:v>
                </c:pt>
                <c:pt idx="1470">
                  <c:v>6.4729999999999996E-2</c:v>
                </c:pt>
                <c:pt idx="1471">
                  <c:v>6.4727999999999994E-2</c:v>
                </c:pt>
                <c:pt idx="1472">
                  <c:v>6.4725000000000005E-2</c:v>
                </c:pt>
                <c:pt idx="1473">
                  <c:v>6.4723000000000003E-2</c:v>
                </c:pt>
                <c:pt idx="1474">
                  <c:v>6.4721000000000001E-2</c:v>
                </c:pt>
                <c:pt idx="1475">
                  <c:v>6.4717999999999998E-2</c:v>
                </c:pt>
                <c:pt idx="1476">
                  <c:v>6.4715999999999996E-2</c:v>
                </c:pt>
                <c:pt idx="1477">
                  <c:v>6.4713000000000007E-2</c:v>
                </c:pt>
                <c:pt idx="1478">
                  <c:v>6.4711000000000005E-2</c:v>
                </c:pt>
                <c:pt idx="1479">
                  <c:v>6.4709000000000003E-2</c:v>
                </c:pt>
                <c:pt idx="1480">
                  <c:v>6.4706E-2</c:v>
                </c:pt>
                <c:pt idx="1481">
                  <c:v>6.4703999999999998E-2</c:v>
                </c:pt>
                <c:pt idx="1482">
                  <c:v>6.4701999999999996E-2</c:v>
                </c:pt>
                <c:pt idx="1483">
                  <c:v>6.4699999999999994E-2</c:v>
                </c:pt>
                <c:pt idx="1484">
                  <c:v>6.4697000000000005E-2</c:v>
                </c:pt>
                <c:pt idx="1485">
                  <c:v>6.4695000000000003E-2</c:v>
                </c:pt>
                <c:pt idx="1486">
                  <c:v>6.4693000000000001E-2</c:v>
                </c:pt>
                <c:pt idx="1487">
                  <c:v>6.4690999999999999E-2</c:v>
                </c:pt>
                <c:pt idx="1488">
                  <c:v>6.4688999999999997E-2</c:v>
                </c:pt>
                <c:pt idx="1489">
                  <c:v>6.4686999999999995E-2</c:v>
                </c:pt>
                <c:pt idx="1490">
                  <c:v>6.4685000000000006E-2</c:v>
                </c:pt>
                <c:pt idx="1491">
                  <c:v>6.4682000000000003E-2</c:v>
                </c:pt>
                <c:pt idx="1492">
                  <c:v>6.4680000000000001E-2</c:v>
                </c:pt>
                <c:pt idx="1493">
                  <c:v>6.4677999999999999E-2</c:v>
                </c:pt>
                <c:pt idx="1494">
                  <c:v>6.4675999999999997E-2</c:v>
                </c:pt>
                <c:pt idx="1495">
                  <c:v>6.4673999999999995E-2</c:v>
                </c:pt>
                <c:pt idx="1496">
                  <c:v>6.4671999999999993E-2</c:v>
                </c:pt>
                <c:pt idx="1497">
                  <c:v>6.4670000000000005E-2</c:v>
                </c:pt>
                <c:pt idx="1498">
                  <c:v>6.4668000000000003E-2</c:v>
                </c:pt>
                <c:pt idx="1499">
                  <c:v>6.4666000000000001E-2</c:v>
                </c:pt>
                <c:pt idx="1500">
                  <c:v>6.4663999999999999E-2</c:v>
                </c:pt>
                <c:pt idx="1501">
                  <c:v>6.4661999999999997E-2</c:v>
                </c:pt>
                <c:pt idx="1502">
                  <c:v>6.4659999999999995E-2</c:v>
                </c:pt>
                <c:pt idx="1503">
                  <c:v>6.4657999999999993E-2</c:v>
                </c:pt>
                <c:pt idx="1504">
                  <c:v>6.4657000000000006E-2</c:v>
                </c:pt>
                <c:pt idx="1505">
                  <c:v>6.4655000000000004E-2</c:v>
                </c:pt>
                <c:pt idx="1506">
                  <c:v>6.4653000000000002E-2</c:v>
                </c:pt>
                <c:pt idx="1507">
                  <c:v>6.4651E-2</c:v>
                </c:pt>
                <c:pt idx="1508">
                  <c:v>6.4648999999999998E-2</c:v>
                </c:pt>
                <c:pt idx="1509">
                  <c:v>6.4646999999999996E-2</c:v>
                </c:pt>
                <c:pt idx="1510">
                  <c:v>6.4644999999999994E-2</c:v>
                </c:pt>
                <c:pt idx="1511">
                  <c:v>6.4643999999999993E-2</c:v>
                </c:pt>
                <c:pt idx="1512">
                  <c:v>6.4642000000000005E-2</c:v>
                </c:pt>
                <c:pt idx="1513">
                  <c:v>6.4640000000000003E-2</c:v>
                </c:pt>
                <c:pt idx="1514">
                  <c:v>6.4638000000000001E-2</c:v>
                </c:pt>
                <c:pt idx="1515">
                  <c:v>6.4637E-2</c:v>
                </c:pt>
                <c:pt idx="1516">
                  <c:v>6.4634999999999998E-2</c:v>
                </c:pt>
                <c:pt idx="1517">
                  <c:v>6.4632999999999996E-2</c:v>
                </c:pt>
                <c:pt idx="1518">
                  <c:v>6.4630999999999994E-2</c:v>
                </c:pt>
                <c:pt idx="1519">
                  <c:v>6.4630000000000007E-2</c:v>
                </c:pt>
                <c:pt idx="1520">
                  <c:v>6.4628000000000005E-2</c:v>
                </c:pt>
                <c:pt idx="1521">
                  <c:v>6.4626000000000003E-2</c:v>
                </c:pt>
                <c:pt idx="1522">
                  <c:v>6.4625000000000002E-2</c:v>
                </c:pt>
                <c:pt idx="1523">
                  <c:v>6.4623E-2</c:v>
                </c:pt>
                <c:pt idx="1524">
                  <c:v>6.4620999999999998E-2</c:v>
                </c:pt>
                <c:pt idx="1525">
                  <c:v>6.4619999999999997E-2</c:v>
                </c:pt>
                <c:pt idx="1526">
                  <c:v>6.4617999999999995E-2</c:v>
                </c:pt>
                <c:pt idx="1527">
                  <c:v>6.4616999999999994E-2</c:v>
                </c:pt>
                <c:pt idx="1528">
                  <c:v>6.4615000000000006E-2</c:v>
                </c:pt>
                <c:pt idx="1529">
                  <c:v>6.4613000000000004E-2</c:v>
                </c:pt>
                <c:pt idx="1530">
                  <c:v>6.4612000000000003E-2</c:v>
                </c:pt>
                <c:pt idx="1531">
                  <c:v>6.4610000000000001E-2</c:v>
                </c:pt>
                <c:pt idx="1532">
                  <c:v>6.4609E-2</c:v>
                </c:pt>
                <c:pt idx="1533">
                  <c:v>6.4606999999999998E-2</c:v>
                </c:pt>
                <c:pt idx="1534">
                  <c:v>6.4605999999999997E-2</c:v>
                </c:pt>
                <c:pt idx="1535">
                  <c:v>6.4603999999999995E-2</c:v>
                </c:pt>
                <c:pt idx="1536">
                  <c:v>6.4602999999999994E-2</c:v>
                </c:pt>
                <c:pt idx="1537">
                  <c:v>6.4601000000000006E-2</c:v>
                </c:pt>
                <c:pt idx="1538">
                  <c:v>6.4600000000000005E-2</c:v>
                </c:pt>
                <c:pt idx="1539">
                  <c:v>6.4598000000000003E-2</c:v>
                </c:pt>
                <c:pt idx="1540">
                  <c:v>6.4597000000000002E-2</c:v>
                </c:pt>
                <c:pt idx="1541">
                  <c:v>6.4595E-2</c:v>
                </c:pt>
                <c:pt idx="1542">
                  <c:v>6.4593999999999999E-2</c:v>
                </c:pt>
                <c:pt idx="1543">
                  <c:v>6.4591999999999997E-2</c:v>
                </c:pt>
                <c:pt idx="1544">
                  <c:v>6.4590999999999996E-2</c:v>
                </c:pt>
                <c:pt idx="1545">
                  <c:v>6.4589999999999995E-2</c:v>
                </c:pt>
                <c:pt idx="1546">
                  <c:v>6.4588000000000007E-2</c:v>
                </c:pt>
                <c:pt idx="1547">
                  <c:v>6.4587000000000006E-2</c:v>
                </c:pt>
                <c:pt idx="1548">
                  <c:v>6.4585000000000004E-2</c:v>
                </c:pt>
                <c:pt idx="1549">
                  <c:v>6.4584000000000003E-2</c:v>
                </c:pt>
                <c:pt idx="1550">
                  <c:v>6.4583000000000002E-2</c:v>
                </c:pt>
                <c:pt idx="1551">
                  <c:v>6.4581E-2</c:v>
                </c:pt>
                <c:pt idx="1552">
                  <c:v>6.4579999999999999E-2</c:v>
                </c:pt>
                <c:pt idx="1553">
                  <c:v>6.4578999999999998E-2</c:v>
                </c:pt>
                <c:pt idx="1554">
                  <c:v>6.4576999999999996E-2</c:v>
                </c:pt>
                <c:pt idx="1555">
                  <c:v>6.4575999999999995E-2</c:v>
                </c:pt>
                <c:pt idx="1556">
                  <c:v>6.4574999999999994E-2</c:v>
                </c:pt>
                <c:pt idx="1557">
                  <c:v>6.4573000000000005E-2</c:v>
                </c:pt>
                <c:pt idx="1558">
                  <c:v>6.4572000000000004E-2</c:v>
                </c:pt>
                <c:pt idx="1559">
                  <c:v>6.4571000000000003E-2</c:v>
                </c:pt>
                <c:pt idx="1560">
                  <c:v>6.4570000000000002E-2</c:v>
                </c:pt>
                <c:pt idx="1561">
                  <c:v>6.4568E-2</c:v>
                </c:pt>
                <c:pt idx="1562">
                  <c:v>6.4566999999999999E-2</c:v>
                </c:pt>
                <c:pt idx="1563">
                  <c:v>6.4565999999999998E-2</c:v>
                </c:pt>
                <c:pt idx="1564">
                  <c:v>6.4564999999999997E-2</c:v>
                </c:pt>
                <c:pt idx="1565">
                  <c:v>6.4562999999999995E-2</c:v>
                </c:pt>
                <c:pt idx="1566">
                  <c:v>6.4561999999999994E-2</c:v>
                </c:pt>
                <c:pt idx="1567">
                  <c:v>6.4560999999999993E-2</c:v>
                </c:pt>
                <c:pt idx="1568">
                  <c:v>6.4560000000000006E-2</c:v>
                </c:pt>
                <c:pt idx="1569">
                  <c:v>6.4559000000000005E-2</c:v>
                </c:pt>
                <c:pt idx="1570">
                  <c:v>6.4557000000000003E-2</c:v>
                </c:pt>
                <c:pt idx="1571">
                  <c:v>6.4556000000000002E-2</c:v>
                </c:pt>
                <c:pt idx="1572">
                  <c:v>6.4555000000000001E-2</c:v>
                </c:pt>
                <c:pt idx="1573">
                  <c:v>6.4554E-2</c:v>
                </c:pt>
                <c:pt idx="1574">
                  <c:v>6.4552999999999999E-2</c:v>
                </c:pt>
                <c:pt idx="1575">
                  <c:v>6.4551999999999998E-2</c:v>
                </c:pt>
                <c:pt idx="1576">
                  <c:v>6.4549999999999996E-2</c:v>
                </c:pt>
                <c:pt idx="1577">
                  <c:v>6.4548999999999995E-2</c:v>
                </c:pt>
                <c:pt idx="1578">
                  <c:v>6.4547999999999994E-2</c:v>
                </c:pt>
                <c:pt idx="1579">
                  <c:v>6.4546999999999993E-2</c:v>
                </c:pt>
                <c:pt idx="1580">
                  <c:v>6.4546000000000006E-2</c:v>
                </c:pt>
                <c:pt idx="1581">
                  <c:v>6.4545000000000005E-2</c:v>
                </c:pt>
                <c:pt idx="1582">
                  <c:v>6.4544000000000004E-2</c:v>
                </c:pt>
                <c:pt idx="1583">
                  <c:v>6.4543000000000003E-2</c:v>
                </c:pt>
                <c:pt idx="1584">
                  <c:v>6.4541000000000001E-2</c:v>
                </c:pt>
                <c:pt idx="1585">
                  <c:v>6.454E-2</c:v>
                </c:pt>
                <c:pt idx="1586">
                  <c:v>6.4538999999999999E-2</c:v>
                </c:pt>
                <c:pt idx="1587">
                  <c:v>6.4537999999999998E-2</c:v>
                </c:pt>
                <c:pt idx="1588">
                  <c:v>6.4536999999999997E-2</c:v>
                </c:pt>
                <c:pt idx="1589">
                  <c:v>6.4535999999999996E-2</c:v>
                </c:pt>
                <c:pt idx="1590">
                  <c:v>6.4534999999999995E-2</c:v>
                </c:pt>
                <c:pt idx="1591">
                  <c:v>6.4533999999999994E-2</c:v>
                </c:pt>
                <c:pt idx="1592">
                  <c:v>6.4532999999999993E-2</c:v>
                </c:pt>
                <c:pt idx="1593">
                  <c:v>6.4532000000000006E-2</c:v>
                </c:pt>
                <c:pt idx="1594">
                  <c:v>6.4531000000000005E-2</c:v>
                </c:pt>
                <c:pt idx="1595">
                  <c:v>6.4530000000000004E-2</c:v>
                </c:pt>
                <c:pt idx="1596">
                  <c:v>6.4529000000000003E-2</c:v>
                </c:pt>
                <c:pt idx="1597">
                  <c:v>6.4528000000000002E-2</c:v>
                </c:pt>
                <c:pt idx="1598">
                  <c:v>6.4527000000000001E-2</c:v>
                </c:pt>
                <c:pt idx="1599">
                  <c:v>6.4526E-2</c:v>
                </c:pt>
                <c:pt idx="1600">
                  <c:v>6.4524999999999999E-2</c:v>
                </c:pt>
                <c:pt idx="1601">
                  <c:v>6.4523999999999998E-2</c:v>
                </c:pt>
                <c:pt idx="1602">
                  <c:v>6.4522999999999997E-2</c:v>
                </c:pt>
                <c:pt idx="1603">
                  <c:v>6.4521999999999996E-2</c:v>
                </c:pt>
                <c:pt idx="1604">
                  <c:v>6.4520999999999995E-2</c:v>
                </c:pt>
                <c:pt idx="1605">
                  <c:v>6.4519999999999994E-2</c:v>
                </c:pt>
                <c:pt idx="1606">
                  <c:v>6.4519000000000007E-2</c:v>
                </c:pt>
                <c:pt idx="1607">
                  <c:v>6.4518000000000006E-2</c:v>
                </c:pt>
                <c:pt idx="1608">
                  <c:v>6.4517000000000005E-2</c:v>
                </c:pt>
                <c:pt idx="1609">
                  <c:v>6.4516000000000004E-2</c:v>
                </c:pt>
                <c:pt idx="1610">
                  <c:v>6.4515000000000003E-2</c:v>
                </c:pt>
                <c:pt idx="1611">
                  <c:v>6.4515000000000003E-2</c:v>
                </c:pt>
                <c:pt idx="1612">
                  <c:v>6.4514000000000002E-2</c:v>
                </c:pt>
                <c:pt idx="1613">
                  <c:v>6.4513000000000001E-2</c:v>
                </c:pt>
                <c:pt idx="1614">
                  <c:v>6.4512E-2</c:v>
                </c:pt>
                <c:pt idx="1615">
                  <c:v>6.4510999999999999E-2</c:v>
                </c:pt>
                <c:pt idx="1616">
                  <c:v>6.4509999999999998E-2</c:v>
                </c:pt>
                <c:pt idx="1617">
                  <c:v>6.4508999999999997E-2</c:v>
                </c:pt>
                <c:pt idx="1618">
                  <c:v>6.4507999999999996E-2</c:v>
                </c:pt>
                <c:pt idx="1619">
                  <c:v>6.4506999999999995E-2</c:v>
                </c:pt>
                <c:pt idx="1620">
                  <c:v>6.4506999999999995E-2</c:v>
                </c:pt>
                <c:pt idx="1621">
                  <c:v>6.4505999999999994E-2</c:v>
                </c:pt>
                <c:pt idx="1622">
                  <c:v>6.4505000000000007E-2</c:v>
                </c:pt>
                <c:pt idx="1623">
                  <c:v>6.4504000000000006E-2</c:v>
                </c:pt>
                <c:pt idx="1624">
                  <c:v>6.4503000000000005E-2</c:v>
                </c:pt>
                <c:pt idx="1625">
                  <c:v>6.4502000000000004E-2</c:v>
                </c:pt>
                <c:pt idx="1626">
                  <c:v>6.4501000000000003E-2</c:v>
                </c:pt>
                <c:pt idx="1627">
                  <c:v>6.4501000000000003E-2</c:v>
                </c:pt>
                <c:pt idx="1628">
                  <c:v>6.4500000000000002E-2</c:v>
                </c:pt>
                <c:pt idx="1629">
                  <c:v>6.4499000000000001E-2</c:v>
                </c:pt>
                <c:pt idx="1630">
                  <c:v>6.4498E-2</c:v>
                </c:pt>
                <c:pt idx="1631">
                  <c:v>6.4496999999999999E-2</c:v>
                </c:pt>
                <c:pt idx="1632">
                  <c:v>6.4495999999999998E-2</c:v>
                </c:pt>
                <c:pt idx="1633">
                  <c:v>6.4495999999999998E-2</c:v>
                </c:pt>
                <c:pt idx="1634">
                  <c:v>6.4494999999999997E-2</c:v>
                </c:pt>
                <c:pt idx="1635">
                  <c:v>6.4493999999999996E-2</c:v>
                </c:pt>
                <c:pt idx="1636">
                  <c:v>6.4492999999999995E-2</c:v>
                </c:pt>
                <c:pt idx="1637">
                  <c:v>6.4491999999999994E-2</c:v>
                </c:pt>
                <c:pt idx="1638">
                  <c:v>6.4491999999999994E-2</c:v>
                </c:pt>
                <c:pt idx="1639">
                  <c:v>6.4491000000000007E-2</c:v>
                </c:pt>
                <c:pt idx="1640">
                  <c:v>6.4490000000000006E-2</c:v>
                </c:pt>
                <c:pt idx="1641">
                  <c:v>6.4489000000000005E-2</c:v>
                </c:pt>
                <c:pt idx="1642">
                  <c:v>6.4489000000000005E-2</c:v>
                </c:pt>
                <c:pt idx="1643">
                  <c:v>6.4488000000000004E-2</c:v>
                </c:pt>
                <c:pt idx="1644">
                  <c:v>6.4487000000000003E-2</c:v>
                </c:pt>
                <c:pt idx="1645">
                  <c:v>6.4486000000000002E-2</c:v>
                </c:pt>
                <c:pt idx="1646">
                  <c:v>6.4486000000000002E-2</c:v>
                </c:pt>
                <c:pt idx="1647">
                  <c:v>6.4485000000000001E-2</c:v>
                </c:pt>
                <c:pt idx="1648">
                  <c:v>6.4484E-2</c:v>
                </c:pt>
                <c:pt idx="1649">
                  <c:v>6.4482999999999999E-2</c:v>
                </c:pt>
                <c:pt idx="1650">
                  <c:v>6.4482999999999999E-2</c:v>
                </c:pt>
                <c:pt idx="1651">
                  <c:v>6.4481999999999998E-2</c:v>
                </c:pt>
                <c:pt idx="1652">
                  <c:v>6.4480999999999997E-2</c:v>
                </c:pt>
                <c:pt idx="1653">
                  <c:v>6.4479999999999996E-2</c:v>
                </c:pt>
                <c:pt idx="1654">
                  <c:v>6.4479999999999996E-2</c:v>
                </c:pt>
                <c:pt idx="1655">
                  <c:v>6.4478999999999995E-2</c:v>
                </c:pt>
                <c:pt idx="1656">
                  <c:v>6.4477999999999994E-2</c:v>
                </c:pt>
                <c:pt idx="1657">
                  <c:v>6.4477999999999994E-2</c:v>
                </c:pt>
                <c:pt idx="1658">
                  <c:v>6.4477000000000007E-2</c:v>
                </c:pt>
                <c:pt idx="1659">
                  <c:v>6.4476000000000006E-2</c:v>
                </c:pt>
                <c:pt idx="1660">
                  <c:v>6.4475000000000005E-2</c:v>
                </c:pt>
                <c:pt idx="1661">
                  <c:v>6.4475000000000005E-2</c:v>
                </c:pt>
                <c:pt idx="1662">
                  <c:v>6.4474000000000004E-2</c:v>
                </c:pt>
                <c:pt idx="1663">
                  <c:v>6.4473000000000003E-2</c:v>
                </c:pt>
                <c:pt idx="1664">
                  <c:v>6.4473000000000003E-2</c:v>
                </c:pt>
                <c:pt idx="1665">
                  <c:v>6.4472000000000002E-2</c:v>
                </c:pt>
                <c:pt idx="1666">
                  <c:v>6.4471000000000001E-2</c:v>
                </c:pt>
                <c:pt idx="1667">
                  <c:v>6.4471000000000001E-2</c:v>
                </c:pt>
                <c:pt idx="1668">
                  <c:v>6.447E-2</c:v>
                </c:pt>
                <c:pt idx="1669">
                  <c:v>6.4468999999999999E-2</c:v>
                </c:pt>
                <c:pt idx="1670">
                  <c:v>6.4468999999999999E-2</c:v>
                </c:pt>
                <c:pt idx="1671">
                  <c:v>6.4467999999999998E-2</c:v>
                </c:pt>
                <c:pt idx="1672">
                  <c:v>6.4466999999999997E-2</c:v>
                </c:pt>
                <c:pt idx="1673">
                  <c:v>6.4466999999999997E-2</c:v>
                </c:pt>
                <c:pt idx="1674">
                  <c:v>6.4465999999999996E-2</c:v>
                </c:pt>
                <c:pt idx="1675">
                  <c:v>6.4465999999999996E-2</c:v>
                </c:pt>
                <c:pt idx="1676">
                  <c:v>6.4464999999999995E-2</c:v>
                </c:pt>
                <c:pt idx="1677">
                  <c:v>6.4463999999999994E-2</c:v>
                </c:pt>
                <c:pt idx="1678">
                  <c:v>6.4463999999999994E-2</c:v>
                </c:pt>
                <c:pt idx="1679">
                  <c:v>6.4463000000000006E-2</c:v>
                </c:pt>
                <c:pt idx="1680">
                  <c:v>6.4462000000000005E-2</c:v>
                </c:pt>
                <c:pt idx="1681">
                  <c:v>6.4462000000000005E-2</c:v>
                </c:pt>
                <c:pt idx="1682">
                  <c:v>6.4461000000000004E-2</c:v>
                </c:pt>
                <c:pt idx="1683">
                  <c:v>6.4461000000000004E-2</c:v>
                </c:pt>
                <c:pt idx="1684">
                  <c:v>6.4460000000000003E-2</c:v>
                </c:pt>
                <c:pt idx="1685">
                  <c:v>6.4459000000000002E-2</c:v>
                </c:pt>
                <c:pt idx="1686">
                  <c:v>6.4459000000000002E-2</c:v>
                </c:pt>
                <c:pt idx="1687">
                  <c:v>6.4458000000000001E-2</c:v>
                </c:pt>
                <c:pt idx="1688">
                  <c:v>6.4458000000000001E-2</c:v>
                </c:pt>
                <c:pt idx="1689">
                  <c:v>6.4457E-2</c:v>
                </c:pt>
                <c:pt idx="1690">
                  <c:v>6.4455999999999999E-2</c:v>
                </c:pt>
                <c:pt idx="1691">
                  <c:v>6.4455999999999999E-2</c:v>
                </c:pt>
                <c:pt idx="1692">
                  <c:v>6.4454999999999998E-2</c:v>
                </c:pt>
                <c:pt idx="1693">
                  <c:v>6.4454999999999998E-2</c:v>
                </c:pt>
                <c:pt idx="1694">
                  <c:v>6.4453999999999997E-2</c:v>
                </c:pt>
                <c:pt idx="1695">
                  <c:v>6.4452999999999996E-2</c:v>
                </c:pt>
                <c:pt idx="1696">
                  <c:v>6.4452999999999996E-2</c:v>
                </c:pt>
                <c:pt idx="1697">
                  <c:v>6.4451999999999995E-2</c:v>
                </c:pt>
                <c:pt idx="1698">
                  <c:v>6.4451999999999995E-2</c:v>
                </c:pt>
                <c:pt idx="1699">
                  <c:v>6.4450999999999994E-2</c:v>
                </c:pt>
                <c:pt idx="1700">
                  <c:v>6.4450999999999994E-2</c:v>
                </c:pt>
                <c:pt idx="1701">
                  <c:v>6.4449999999999993E-2</c:v>
                </c:pt>
                <c:pt idx="1702">
                  <c:v>6.4449000000000006E-2</c:v>
                </c:pt>
                <c:pt idx="1703">
                  <c:v>6.4449000000000006E-2</c:v>
                </c:pt>
                <c:pt idx="1704">
                  <c:v>6.4448000000000005E-2</c:v>
                </c:pt>
                <c:pt idx="1705">
                  <c:v>6.4448000000000005E-2</c:v>
                </c:pt>
                <c:pt idx="1706">
                  <c:v>6.4447000000000004E-2</c:v>
                </c:pt>
                <c:pt idx="1707">
                  <c:v>6.4447000000000004E-2</c:v>
                </c:pt>
                <c:pt idx="1708">
                  <c:v>6.4446000000000003E-2</c:v>
                </c:pt>
                <c:pt idx="1709">
                  <c:v>6.4446000000000003E-2</c:v>
                </c:pt>
                <c:pt idx="1710">
                  <c:v>6.4445000000000002E-2</c:v>
                </c:pt>
                <c:pt idx="1711">
                  <c:v>6.4445000000000002E-2</c:v>
                </c:pt>
                <c:pt idx="1712">
                  <c:v>6.4444000000000001E-2</c:v>
                </c:pt>
                <c:pt idx="1713">
                  <c:v>6.4444000000000001E-2</c:v>
                </c:pt>
                <c:pt idx="1714">
                  <c:v>6.4443E-2</c:v>
                </c:pt>
                <c:pt idx="1715">
                  <c:v>6.4441999999999999E-2</c:v>
                </c:pt>
                <c:pt idx="1716">
                  <c:v>6.4441999999999999E-2</c:v>
                </c:pt>
                <c:pt idx="1717">
                  <c:v>6.4440999999999998E-2</c:v>
                </c:pt>
                <c:pt idx="1718">
                  <c:v>6.4440999999999998E-2</c:v>
                </c:pt>
                <c:pt idx="1719">
                  <c:v>6.4439999999999997E-2</c:v>
                </c:pt>
                <c:pt idx="1720">
                  <c:v>6.4439999999999997E-2</c:v>
                </c:pt>
                <c:pt idx="1721">
                  <c:v>6.4438999999999996E-2</c:v>
                </c:pt>
                <c:pt idx="1722">
                  <c:v>6.4438999999999996E-2</c:v>
                </c:pt>
                <c:pt idx="1723">
                  <c:v>6.4437999999999995E-2</c:v>
                </c:pt>
                <c:pt idx="1724">
                  <c:v>6.4437999999999995E-2</c:v>
                </c:pt>
                <c:pt idx="1725">
                  <c:v>6.4436999999999994E-2</c:v>
                </c:pt>
                <c:pt idx="1726">
                  <c:v>6.4436999999999994E-2</c:v>
                </c:pt>
                <c:pt idx="1727">
                  <c:v>6.4435999999999993E-2</c:v>
                </c:pt>
                <c:pt idx="1728">
                  <c:v>6.4435999999999993E-2</c:v>
                </c:pt>
                <c:pt idx="1729">
                  <c:v>6.4435000000000006E-2</c:v>
                </c:pt>
                <c:pt idx="1730">
                  <c:v>6.4435000000000006E-2</c:v>
                </c:pt>
                <c:pt idx="1731">
                  <c:v>6.4435000000000006E-2</c:v>
                </c:pt>
                <c:pt idx="1732">
                  <c:v>6.4434000000000005E-2</c:v>
                </c:pt>
                <c:pt idx="1733">
                  <c:v>6.4434000000000005E-2</c:v>
                </c:pt>
                <c:pt idx="1734">
                  <c:v>6.4433000000000004E-2</c:v>
                </c:pt>
                <c:pt idx="1735">
                  <c:v>6.4433000000000004E-2</c:v>
                </c:pt>
                <c:pt idx="1736">
                  <c:v>6.4432000000000003E-2</c:v>
                </c:pt>
                <c:pt idx="1737">
                  <c:v>6.4432000000000003E-2</c:v>
                </c:pt>
                <c:pt idx="1738">
                  <c:v>6.4431000000000002E-2</c:v>
                </c:pt>
                <c:pt idx="1739">
                  <c:v>6.4431000000000002E-2</c:v>
                </c:pt>
                <c:pt idx="1740">
                  <c:v>6.4430000000000001E-2</c:v>
                </c:pt>
                <c:pt idx="1741">
                  <c:v>6.4430000000000001E-2</c:v>
                </c:pt>
                <c:pt idx="1742">
                  <c:v>6.4429E-2</c:v>
                </c:pt>
                <c:pt idx="1743">
                  <c:v>6.4429E-2</c:v>
                </c:pt>
                <c:pt idx="1744">
                  <c:v>6.4427999999999999E-2</c:v>
                </c:pt>
                <c:pt idx="1745">
                  <c:v>6.4427999999999999E-2</c:v>
                </c:pt>
                <c:pt idx="1746">
                  <c:v>6.4427999999999999E-2</c:v>
                </c:pt>
                <c:pt idx="1747">
                  <c:v>6.4426999999999998E-2</c:v>
                </c:pt>
                <c:pt idx="1748">
                  <c:v>6.4426999999999998E-2</c:v>
                </c:pt>
                <c:pt idx="1749">
                  <c:v>6.4425999999999997E-2</c:v>
                </c:pt>
                <c:pt idx="1750">
                  <c:v>6.4425999999999997E-2</c:v>
                </c:pt>
                <c:pt idx="1751">
                  <c:v>6.4424999999999996E-2</c:v>
                </c:pt>
                <c:pt idx="1752">
                  <c:v>6.4424999999999996E-2</c:v>
                </c:pt>
                <c:pt idx="1753">
                  <c:v>6.4423999999999995E-2</c:v>
                </c:pt>
                <c:pt idx="1754">
                  <c:v>6.4423999999999995E-2</c:v>
                </c:pt>
                <c:pt idx="1755">
                  <c:v>6.4423999999999995E-2</c:v>
                </c:pt>
                <c:pt idx="1756">
                  <c:v>6.4422999999999994E-2</c:v>
                </c:pt>
                <c:pt idx="1757">
                  <c:v>6.4422999999999994E-2</c:v>
                </c:pt>
                <c:pt idx="1758">
                  <c:v>6.4421999999999993E-2</c:v>
                </c:pt>
                <c:pt idx="1759">
                  <c:v>6.4421999999999993E-2</c:v>
                </c:pt>
                <c:pt idx="1760">
                  <c:v>6.4421999999999993E-2</c:v>
                </c:pt>
                <c:pt idx="1761">
                  <c:v>6.4421000000000006E-2</c:v>
                </c:pt>
                <c:pt idx="1762">
                  <c:v>6.4421000000000006E-2</c:v>
                </c:pt>
                <c:pt idx="1763">
                  <c:v>6.4420000000000005E-2</c:v>
                </c:pt>
                <c:pt idx="1764">
                  <c:v>6.4420000000000005E-2</c:v>
                </c:pt>
                <c:pt idx="1765">
                  <c:v>6.4419000000000004E-2</c:v>
                </c:pt>
                <c:pt idx="1766">
                  <c:v>6.4419000000000004E-2</c:v>
                </c:pt>
                <c:pt idx="1767">
                  <c:v>6.4419000000000004E-2</c:v>
                </c:pt>
                <c:pt idx="1768">
                  <c:v>6.4418000000000003E-2</c:v>
                </c:pt>
                <c:pt idx="1769">
                  <c:v>6.4418000000000003E-2</c:v>
                </c:pt>
                <c:pt idx="1770">
                  <c:v>6.4417000000000002E-2</c:v>
                </c:pt>
                <c:pt idx="1771">
                  <c:v>6.4417000000000002E-2</c:v>
                </c:pt>
                <c:pt idx="1772">
                  <c:v>6.4417000000000002E-2</c:v>
                </c:pt>
                <c:pt idx="1773">
                  <c:v>6.4416000000000001E-2</c:v>
                </c:pt>
                <c:pt idx="1774">
                  <c:v>6.4416000000000001E-2</c:v>
                </c:pt>
                <c:pt idx="1775">
                  <c:v>6.4415E-2</c:v>
                </c:pt>
                <c:pt idx="1776">
                  <c:v>6.4415E-2</c:v>
                </c:pt>
                <c:pt idx="1777">
                  <c:v>6.4415E-2</c:v>
                </c:pt>
                <c:pt idx="1778">
                  <c:v>6.4413999999999999E-2</c:v>
                </c:pt>
                <c:pt idx="1779">
                  <c:v>6.4413999999999999E-2</c:v>
                </c:pt>
                <c:pt idx="1780">
                  <c:v>6.4413999999999999E-2</c:v>
                </c:pt>
                <c:pt idx="1781">
                  <c:v>6.4412999999999998E-2</c:v>
                </c:pt>
                <c:pt idx="1782">
                  <c:v>6.4412999999999998E-2</c:v>
                </c:pt>
                <c:pt idx="1783">
                  <c:v>6.4411999999999997E-2</c:v>
                </c:pt>
                <c:pt idx="1784">
                  <c:v>6.4411999999999997E-2</c:v>
                </c:pt>
                <c:pt idx="1785">
                  <c:v>6.4411999999999997E-2</c:v>
                </c:pt>
                <c:pt idx="1786">
                  <c:v>6.4410999999999996E-2</c:v>
                </c:pt>
                <c:pt idx="1787">
                  <c:v>6.4410999999999996E-2</c:v>
                </c:pt>
                <c:pt idx="1788">
                  <c:v>6.4410999999999996E-2</c:v>
                </c:pt>
                <c:pt idx="1789">
                  <c:v>6.4409999999999995E-2</c:v>
                </c:pt>
                <c:pt idx="1790">
                  <c:v>6.4409999999999995E-2</c:v>
                </c:pt>
                <c:pt idx="1791">
                  <c:v>6.4408999999999994E-2</c:v>
                </c:pt>
                <c:pt idx="1792">
                  <c:v>6.4408999999999994E-2</c:v>
                </c:pt>
                <c:pt idx="1793">
                  <c:v>6.4408999999999994E-2</c:v>
                </c:pt>
                <c:pt idx="1794">
                  <c:v>6.4408000000000007E-2</c:v>
                </c:pt>
                <c:pt idx="1795">
                  <c:v>6.4408000000000007E-2</c:v>
                </c:pt>
                <c:pt idx="1796">
                  <c:v>6.4408000000000007E-2</c:v>
                </c:pt>
                <c:pt idx="1797">
                  <c:v>6.4407000000000006E-2</c:v>
                </c:pt>
                <c:pt idx="1798">
                  <c:v>6.4407000000000006E-2</c:v>
                </c:pt>
                <c:pt idx="1799">
                  <c:v>6.4407000000000006E-2</c:v>
                </c:pt>
                <c:pt idx="1800">
                  <c:v>6.4406000000000005E-2</c:v>
                </c:pt>
                <c:pt idx="1801">
                  <c:v>6.4406000000000005E-2</c:v>
                </c:pt>
                <c:pt idx="1802">
                  <c:v>6.4406000000000005E-2</c:v>
                </c:pt>
                <c:pt idx="1803">
                  <c:v>6.4405000000000004E-2</c:v>
                </c:pt>
                <c:pt idx="1804">
                  <c:v>6.4405000000000004E-2</c:v>
                </c:pt>
                <c:pt idx="1805">
                  <c:v>6.4404000000000003E-2</c:v>
                </c:pt>
                <c:pt idx="1806">
                  <c:v>6.4404000000000003E-2</c:v>
                </c:pt>
                <c:pt idx="1807">
                  <c:v>6.4404000000000003E-2</c:v>
                </c:pt>
                <c:pt idx="1808">
                  <c:v>6.4403000000000002E-2</c:v>
                </c:pt>
                <c:pt idx="1809">
                  <c:v>6.4403000000000002E-2</c:v>
                </c:pt>
                <c:pt idx="1810">
                  <c:v>6.4403000000000002E-2</c:v>
                </c:pt>
                <c:pt idx="1811">
                  <c:v>6.4402000000000001E-2</c:v>
                </c:pt>
                <c:pt idx="1812">
                  <c:v>6.4402000000000001E-2</c:v>
                </c:pt>
                <c:pt idx="1813">
                  <c:v>6.4402000000000001E-2</c:v>
                </c:pt>
                <c:pt idx="1814">
                  <c:v>6.4401E-2</c:v>
                </c:pt>
                <c:pt idx="1815">
                  <c:v>6.4401E-2</c:v>
                </c:pt>
                <c:pt idx="1816">
                  <c:v>6.4401E-2</c:v>
                </c:pt>
                <c:pt idx="1817">
                  <c:v>6.4399999999999999E-2</c:v>
                </c:pt>
                <c:pt idx="1818">
                  <c:v>6.4399999999999999E-2</c:v>
                </c:pt>
                <c:pt idx="1819">
                  <c:v>6.4399999999999999E-2</c:v>
                </c:pt>
                <c:pt idx="1820">
                  <c:v>6.4399999999999999E-2</c:v>
                </c:pt>
                <c:pt idx="1821">
                  <c:v>6.4398999999999998E-2</c:v>
                </c:pt>
                <c:pt idx="1822">
                  <c:v>6.4398999999999998E-2</c:v>
                </c:pt>
                <c:pt idx="1823">
                  <c:v>6.4398999999999998E-2</c:v>
                </c:pt>
                <c:pt idx="1824">
                  <c:v>6.4397999999999997E-2</c:v>
                </c:pt>
                <c:pt idx="1825">
                  <c:v>6.4397999999999997E-2</c:v>
                </c:pt>
                <c:pt idx="1826">
                  <c:v>6.4397999999999997E-2</c:v>
                </c:pt>
                <c:pt idx="1827">
                  <c:v>6.4396999999999996E-2</c:v>
                </c:pt>
                <c:pt idx="1828">
                  <c:v>6.4396999999999996E-2</c:v>
                </c:pt>
                <c:pt idx="1829">
                  <c:v>6.4396999999999996E-2</c:v>
                </c:pt>
                <c:pt idx="1830">
                  <c:v>6.4395999999999995E-2</c:v>
                </c:pt>
                <c:pt idx="1831">
                  <c:v>6.4395999999999995E-2</c:v>
                </c:pt>
                <c:pt idx="1832">
                  <c:v>6.4395999999999995E-2</c:v>
                </c:pt>
                <c:pt idx="1833">
                  <c:v>6.4394999999999994E-2</c:v>
                </c:pt>
                <c:pt idx="1834">
                  <c:v>6.4394999999999994E-2</c:v>
                </c:pt>
                <c:pt idx="1835">
                  <c:v>6.4394999999999994E-2</c:v>
                </c:pt>
                <c:pt idx="1836">
                  <c:v>6.4394999999999994E-2</c:v>
                </c:pt>
                <c:pt idx="1837">
                  <c:v>6.4394000000000007E-2</c:v>
                </c:pt>
                <c:pt idx="1838">
                  <c:v>6.4394000000000007E-2</c:v>
                </c:pt>
                <c:pt idx="1839">
                  <c:v>6.4394000000000007E-2</c:v>
                </c:pt>
                <c:pt idx="1840">
                  <c:v>6.4393000000000006E-2</c:v>
                </c:pt>
                <c:pt idx="1841">
                  <c:v>6.4393000000000006E-2</c:v>
                </c:pt>
                <c:pt idx="1842">
                  <c:v>6.4393000000000006E-2</c:v>
                </c:pt>
                <c:pt idx="1843">
                  <c:v>6.4393000000000006E-2</c:v>
                </c:pt>
                <c:pt idx="1844">
                  <c:v>6.4392000000000005E-2</c:v>
                </c:pt>
                <c:pt idx="1845">
                  <c:v>6.4392000000000005E-2</c:v>
                </c:pt>
                <c:pt idx="1846">
                  <c:v>6.4392000000000005E-2</c:v>
                </c:pt>
                <c:pt idx="1847">
                  <c:v>6.4391000000000004E-2</c:v>
                </c:pt>
                <c:pt idx="1848">
                  <c:v>6.4391000000000004E-2</c:v>
                </c:pt>
                <c:pt idx="1849">
                  <c:v>6.4391000000000004E-2</c:v>
                </c:pt>
                <c:pt idx="1850">
                  <c:v>6.4390000000000003E-2</c:v>
                </c:pt>
                <c:pt idx="1851">
                  <c:v>6.4390000000000003E-2</c:v>
                </c:pt>
                <c:pt idx="1852">
                  <c:v>6.4390000000000003E-2</c:v>
                </c:pt>
                <c:pt idx="1853">
                  <c:v>6.4390000000000003E-2</c:v>
                </c:pt>
                <c:pt idx="1854">
                  <c:v>6.4389000000000002E-2</c:v>
                </c:pt>
                <c:pt idx="1855">
                  <c:v>6.4389000000000002E-2</c:v>
                </c:pt>
                <c:pt idx="1856">
                  <c:v>6.4389000000000002E-2</c:v>
                </c:pt>
                <c:pt idx="1857">
                  <c:v>6.4389000000000002E-2</c:v>
                </c:pt>
                <c:pt idx="1858">
                  <c:v>6.4388000000000001E-2</c:v>
                </c:pt>
                <c:pt idx="1859">
                  <c:v>6.4388000000000001E-2</c:v>
                </c:pt>
                <c:pt idx="1860">
                  <c:v>6.4388000000000001E-2</c:v>
                </c:pt>
                <c:pt idx="1861">
                  <c:v>6.4387E-2</c:v>
                </c:pt>
                <c:pt idx="1862">
                  <c:v>6.4387E-2</c:v>
                </c:pt>
                <c:pt idx="1863">
                  <c:v>6.4387E-2</c:v>
                </c:pt>
                <c:pt idx="1864">
                  <c:v>6.4387E-2</c:v>
                </c:pt>
                <c:pt idx="1865">
                  <c:v>6.4385999999999999E-2</c:v>
                </c:pt>
                <c:pt idx="1866">
                  <c:v>6.4385999999999999E-2</c:v>
                </c:pt>
                <c:pt idx="1867">
                  <c:v>6.4385999999999999E-2</c:v>
                </c:pt>
                <c:pt idx="1868">
                  <c:v>6.4385999999999999E-2</c:v>
                </c:pt>
                <c:pt idx="1869">
                  <c:v>6.4384999999999998E-2</c:v>
                </c:pt>
                <c:pt idx="1870">
                  <c:v>6.4384999999999998E-2</c:v>
                </c:pt>
                <c:pt idx="1871">
                  <c:v>6.4384999999999998E-2</c:v>
                </c:pt>
                <c:pt idx="1872">
                  <c:v>6.4384999999999998E-2</c:v>
                </c:pt>
                <c:pt idx="1873">
                  <c:v>6.4383999999999997E-2</c:v>
                </c:pt>
                <c:pt idx="1874">
                  <c:v>6.4383999999999997E-2</c:v>
                </c:pt>
                <c:pt idx="1875">
                  <c:v>6.4383999999999997E-2</c:v>
                </c:pt>
                <c:pt idx="1876">
                  <c:v>6.4383999999999997E-2</c:v>
                </c:pt>
                <c:pt idx="1877">
                  <c:v>6.4382999999999996E-2</c:v>
                </c:pt>
                <c:pt idx="1878">
                  <c:v>6.4382999999999996E-2</c:v>
                </c:pt>
                <c:pt idx="1879">
                  <c:v>6.4382999999999996E-2</c:v>
                </c:pt>
                <c:pt idx="1880">
                  <c:v>6.4382999999999996E-2</c:v>
                </c:pt>
                <c:pt idx="1881">
                  <c:v>6.4381999999999995E-2</c:v>
                </c:pt>
                <c:pt idx="1882">
                  <c:v>6.4381999999999995E-2</c:v>
                </c:pt>
                <c:pt idx="1883">
                  <c:v>6.4381999999999995E-2</c:v>
                </c:pt>
                <c:pt idx="1884">
                  <c:v>6.4381999999999995E-2</c:v>
                </c:pt>
                <c:pt idx="1885">
                  <c:v>6.4380999999999994E-2</c:v>
                </c:pt>
                <c:pt idx="1886">
                  <c:v>6.4380999999999994E-2</c:v>
                </c:pt>
                <c:pt idx="1887">
                  <c:v>6.4380999999999994E-2</c:v>
                </c:pt>
                <c:pt idx="1888">
                  <c:v>6.4380999999999994E-2</c:v>
                </c:pt>
                <c:pt idx="1889">
                  <c:v>6.4380000000000007E-2</c:v>
                </c:pt>
                <c:pt idx="1890">
                  <c:v>6.4380000000000007E-2</c:v>
                </c:pt>
                <c:pt idx="1891">
                  <c:v>6.4380000000000007E-2</c:v>
                </c:pt>
                <c:pt idx="1892">
                  <c:v>6.4380000000000007E-2</c:v>
                </c:pt>
                <c:pt idx="1893">
                  <c:v>6.4379000000000006E-2</c:v>
                </c:pt>
                <c:pt idx="1894">
                  <c:v>6.4379000000000006E-2</c:v>
                </c:pt>
                <c:pt idx="1895">
                  <c:v>6.4379000000000006E-2</c:v>
                </c:pt>
                <c:pt idx="1896">
                  <c:v>6.4379000000000006E-2</c:v>
                </c:pt>
                <c:pt idx="1897">
                  <c:v>6.4378000000000005E-2</c:v>
                </c:pt>
                <c:pt idx="1898">
                  <c:v>6.4378000000000005E-2</c:v>
                </c:pt>
                <c:pt idx="1899">
                  <c:v>6.4378000000000005E-2</c:v>
                </c:pt>
                <c:pt idx="1900">
                  <c:v>6.4378000000000005E-2</c:v>
                </c:pt>
                <c:pt idx="1901">
                  <c:v>6.4377000000000004E-2</c:v>
                </c:pt>
                <c:pt idx="1902">
                  <c:v>6.4377000000000004E-2</c:v>
                </c:pt>
                <c:pt idx="1903">
                  <c:v>6.4377000000000004E-2</c:v>
                </c:pt>
                <c:pt idx="1904">
                  <c:v>6.4377000000000004E-2</c:v>
                </c:pt>
                <c:pt idx="1905">
                  <c:v>6.4377000000000004E-2</c:v>
                </c:pt>
                <c:pt idx="1906">
                  <c:v>6.4376000000000003E-2</c:v>
                </c:pt>
                <c:pt idx="1907">
                  <c:v>6.4376000000000003E-2</c:v>
                </c:pt>
                <c:pt idx="1908">
                  <c:v>6.4376000000000003E-2</c:v>
                </c:pt>
                <c:pt idx="1909">
                  <c:v>6.4376000000000003E-2</c:v>
                </c:pt>
                <c:pt idx="1910">
                  <c:v>6.4375000000000002E-2</c:v>
                </c:pt>
                <c:pt idx="1911">
                  <c:v>6.4375000000000002E-2</c:v>
                </c:pt>
                <c:pt idx="1912">
                  <c:v>6.4375000000000002E-2</c:v>
                </c:pt>
                <c:pt idx="1913">
                  <c:v>6.4375000000000002E-2</c:v>
                </c:pt>
                <c:pt idx="1914">
                  <c:v>6.4375000000000002E-2</c:v>
                </c:pt>
                <c:pt idx="1915">
                  <c:v>6.4374000000000001E-2</c:v>
                </c:pt>
                <c:pt idx="1916">
                  <c:v>6.4374000000000001E-2</c:v>
                </c:pt>
                <c:pt idx="1917">
                  <c:v>6.4374000000000001E-2</c:v>
                </c:pt>
                <c:pt idx="1918">
                  <c:v>6.4374000000000001E-2</c:v>
                </c:pt>
                <c:pt idx="1919">
                  <c:v>6.4373E-2</c:v>
                </c:pt>
                <c:pt idx="1920">
                  <c:v>6.4373E-2</c:v>
                </c:pt>
                <c:pt idx="1921">
                  <c:v>6.4373E-2</c:v>
                </c:pt>
                <c:pt idx="1922">
                  <c:v>6.4373E-2</c:v>
                </c:pt>
                <c:pt idx="1923">
                  <c:v>6.4373E-2</c:v>
                </c:pt>
                <c:pt idx="1924">
                  <c:v>6.4371999999999999E-2</c:v>
                </c:pt>
                <c:pt idx="1925">
                  <c:v>6.4371999999999999E-2</c:v>
                </c:pt>
                <c:pt idx="1926">
                  <c:v>6.4371999999999999E-2</c:v>
                </c:pt>
                <c:pt idx="1927">
                  <c:v>6.4371999999999999E-2</c:v>
                </c:pt>
                <c:pt idx="1928">
                  <c:v>6.4371999999999999E-2</c:v>
                </c:pt>
                <c:pt idx="1929">
                  <c:v>6.4370999999999998E-2</c:v>
                </c:pt>
                <c:pt idx="1930">
                  <c:v>6.4370999999999998E-2</c:v>
                </c:pt>
                <c:pt idx="1931">
                  <c:v>6.4370999999999998E-2</c:v>
                </c:pt>
                <c:pt idx="1932">
                  <c:v>6.4370999999999998E-2</c:v>
                </c:pt>
                <c:pt idx="1933">
                  <c:v>6.4369999999999997E-2</c:v>
                </c:pt>
                <c:pt idx="1934">
                  <c:v>6.4369999999999997E-2</c:v>
                </c:pt>
                <c:pt idx="1935">
                  <c:v>6.4369999999999997E-2</c:v>
                </c:pt>
                <c:pt idx="1936">
                  <c:v>6.4369999999999997E-2</c:v>
                </c:pt>
                <c:pt idx="1937">
                  <c:v>6.4369999999999997E-2</c:v>
                </c:pt>
                <c:pt idx="1938">
                  <c:v>6.4368999999999996E-2</c:v>
                </c:pt>
                <c:pt idx="1939">
                  <c:v>6.4368999999999996E-2</c:v>
                </c:pt>
                <c:pt idx="1940">
                  <c:v>6.4368999999999996E-2</c:v>
                </c:pt>
                <c:pt idx="1941">
                  <c:v>6.4368999999999996E-2</c:v>
                </c:pt>
                <c:pt idx="1942">
                  <c:v>6.4368999999999996E-2</c:v>
                </c:pt>
                <c:pt idx="1943">
                  <c:v>6.4367999999999995E-2</c:v>
                </c:pt>
                <c:pt idx="1944">
                  <c:v>6.4367999999999995E-2</c:v>
                </c:pt>
                <c:pt idx="1945">
                  <c:v>6.4367999999999995E-2</c:v>
                </c:pt>
                <c:pt idx="1946">
                  <c:v>6.4367999999999995E-2</c:v>
                </c:pt>
                <c:pt idx="1947">
                  <c:v>6.4367999999999995E-2</c:v>
                </c:pt>
                <c:pt idx="1948">
                  <c:v>6.4367999999999995E-2</c:v>
                </c:pt>
                <c:pt idx="1949">
                  <c:v>6.4366999999999994E-2</c:v>
                </c:pt>
                <c:pt idx="1950">
                  <c:v>6.4366999999999994E-2</c:v>
                </c:pt>
                <c:pt idx="1951">
                  <c:v>6.4366999999999994E-2</c:v>
                </c:pt>
                <c:pt idx="1952">
                  <c:v>6.4366999999999994E-2</c:v>
                </c:pt>
                <c:pt idx="1953">
                  <c:v>6.4366999999999994E-2</c:v>
                </c:pt>
                <c:pt idx="1954">
                  <c:v>6.4366000000000007E-2</c:v>
                </c:pt>
                <c:pt idx="1955">
                  <c:v>6.4366000000000007E-2</c:v>
                </c:pt>
                <c:pt idx="1956">
                  <c:v>6.4366000000000007E-2</c:v>
                </c:pt>
                <c:pt idx="1957">
                  <c:v>6.4366000000000007E-2</c:v>
                </c:pt>
                <c:pt idx="1958">
                  <c:v>6.4366000000000007E-2</c:v>
                </c:pt>
                <c:pt idx="1959">
                  <c:v>6.4365000000000006E-2</c:v>
                </c:pt>
                <c:pt idx="1960">
                  <c:v>6.4365000000000006E-2</c:v>
                </c:pt>
                <c:pt idx="1961">
                  <c:v>6.4365000000000006E-2</c:v>
                </c:pt>
                <c:pt idx="1962">
                  <c:v>6.4365000000000006E-2</c:v>
                </c:pt>
                <c:pt idx="1963">
                  <c:v>6.4365000000000006E-2</c:v>
                </c:pt>
                <c:pt idx="1964">
                  <c:v>6.4364000000000005E-2</c:v>
                </c:pt>
                <c:pt idx="1965">
                  <c:v>6.4364000000000005E-2</c:v>
                </c:pt>
                <c:pt idx="1966">
                  <c:v>6.4364000000000005E-2</c:v>
                </c:pt>
                <c:pt idx="1967">
                  <c:v>6.4364000000000005E-2</c:v>
                </c:pt>
                <c:pt idx="1968">
                  <c:v>6.4364000000000005E-2</c:v>
                </c:pt>
                <c:pt idx="1969">
                  <c:v>6.4364000000000005E-2</c:v>
                </c:pt>
                <c:pt idx="1970">
                  <c:v>6.4363000000000004E-2</c:v>
                </c:pt>
                <c:pt idx="1971">
                  <c:v>6.4363000000000004E-2</c:v>
                </c:pt>
                <c:pt idx="1972">
                  <c:v>6.4363000000000004E-2</c:v>
                </c:pt>
                <c:pt idx="1973">
                  <c:v>6.4363000000000004E-2</c:v>
                </c:pt>
                <c:pt idx="1974">
                  <c:v>6.4363000000000004E-2</c:v>
                </c:pt>
                <c:pt idx="1975">
                  <c:v>6.4363000000000004E-2</c:v>
                </c:pt>
                <c:pt idx="1976">
                  <c:v>6.4362000000000003E-2</c:v>
                </c:pt>
                <c:pt idx="1977">
                  <c:v>6.4362000000000003E-2</c:v>
                </c:pt>
                <c:pt idx="1978">
                  <c:v>6.4362000000000003E-2</c:v>
                </c:pt>
                <c:pt idx="1979">
                  <c:v>6.4362000000000003E-2</c:v>
                </c:pt>
                <c:pt idx="1980">
                  <c:v>6.4362000000000003E-2</c:v>
                </c:pt>
                <c:pt idx="1981">
                  <c:v>6.4361000000000002E-2</c:v>
                </c:pt>
                <c:pt idx="1982">
                  <c:v>6.4361000000000002E-2</c:v>
                </c:pt>
                <c:pt idx="1983">
                  <c:v>6.4361000000000002E-2</c:v>
                </c:pt>
                <c:pt idx="1984">
                  <c:v>6.4361000000000002E-2</c:v>
                </c:pt>
                <c:pt idx="1985">
                  <c:v>6.4361000000000002E-2</c:v>
                </c:pt>
                <c:pt idx="1986">
                  <c:v>6.4361000000000002E-2</c:v>
                </c:pt>
                <c:pt idx="1987">
                  <c:v>6.4360000000000001E-2</c:v>
                </c:pt>
                <c:pt idx="1988">
                  <c:v>6.4360000000000001E-2</c:v>
                </c:pt>
                <c:pt idx="1989">
                  <c:v>6.4360000000000001E-2</c:v>
                </c:pt>
                <c:pt idx="1990">
                  <c:v>6.4360000000000001E-2</c:v>
                </c:pt>
                <c:pt idx="1991">
                  <c:v>6.4360000000000001E-2</c:v>
                </c:pt>
                <c:pt idx="1992">
                  <c:v>6.4360000000000001E-2</c:v>
                </c:pt>
                <c:pt idx="1993">
                  <c:v>6.4359E-2</c:v>
                </c:pt>
                <c:pt idx="1994">
                  <c:v>6.4359E-2</c:v>
                </c:pt>
                <c:pt idx="1995">
                  <c:v>6.4359E-2</c:v>
                </c:pt>
                <c:pt idx="1996">
                  <c:v>6.4359E-2</c:v>
                </c:pt>
                <c:pt idx="1997">
                  <c:v>6.4359E-2</c:v>
                </c:pt>
                <c:pt idx="1998">
                  <c:v>6.4359E-2</c:v>
                </c:pt>
                <c:pt idx="1999">
                  <c:v>6.4357999999999999E-2</c:v>
                </c:pt>
                <c:pt idx="2000">
                  <c:v>6.4357999999999999E-2</c:v>
                </c:pt>
                <c:pt idx="2001">
                  <c:v>6.4357999999999999E-2</c:v>
                </c:pt>
                <c:pt idx="2002">
                  <c:v>6.4357999999999999E-2</c:v>
                </c:pt>
                <c:pt idx="2003">
                  <c:v>6.4357999999999999E-2</c:v>
                </c:pt>
                <c:pt idx="2004">
                  <c:v>6.4357999999999999E-2</c:v>
                </c:pt>
                <c:pt idx="2005">
                  <c:v>6.4357999999999999E-2</c:v>
                </c:pt>
                <c:pt idx="2006">
                  <c:v>6.4356999999999998E-2</c:v>
                </c:pt>
                <c:pt idx="2007">
                  <c:v>6.4356999999999998E-2</c:v>
                </c:pt>
                <c:pt idx="2008">
                  <c:v>6.4356999999999998E-2</c:v>
                </c:pt>
                <c:pt idx="2009">
                  <c:v>6.4356999999999998E-2</c:v>
                </c:pt>
                <c:pt idx="2010">
                  <c:v>6.4356999999999998E-2</c:v>
                </c:pt>
                <c:pt idx="2011">
                  <c:v>6.4356999999999998E-2</c:v>
                </c:pt>
                <c:pt idx="2012">
                  <c:v>6.4355999999999997E-2</c:v>
                </c:pt>
                <c:pt idx="2013">
                  <c:v>6.4355999999999997E-2</c:v>
                </c:pt>
                <c:pt idx="2014">
                  <c:v>6.4355999999999997E-2</c:v>
                </c:pt>
                <c:pt idx="2015">
                  <c:v>6.4355999999999997E-2</c:v>
                </c:pt>
                <c:pt idx="2016">
                  <c:v>6.4355999999999997E-2</c:v>
                </c:pt>
                <c:pt idx="2017">
                  <c:v>6.4355999999999997E-2</c:v>
                </c:pt>
                <c:pt idx="2018">
                  <c:v>6.4354999999999996E-2</c:v>
                </c:pt>
                <c:pt idx="2019">
                  <c:v>6.4354999999999996E-2</c:v>
                </c:pt>
                <c:pt idx="2020">
                  <c:v>6.4354999999999996E-2</c:v>
                </c:pt>
                <c:pt idx="2021">
                  <c:v>6.4354999999999996E-2</c:v>
                </c:pt>
                <c:pt idx="2022">
                  <c:v>6.4354999999999996E-2</c:v>
                </c:pt>
                <c:pt idx="2023">
                  <c:v>6.4354999999999996E-2</c:v>
                </c:pt>
                <c:pt idx="2024">
                  <c:v>6.4354999999999996E-2</c:v>
                </c:pt>
                <c:pt idx="2025">
                  <c:v>6.4353999999999995E-2</c:v>
                </c:pt>
                <c:pt idx="2026">
                  <c:v>6.4353999999999995E-2</c:v>
                </c:pt>
                <c:pt idx="2027">
                  <c:v>6.4353999999999995E-2</c:v>
                </c:pt>
                <c:pt idx="2028">
                  <c:v>6.4353999999999995E-2</c:v>
                </c:pt>
                <c:pt idx="2029">
                  <c:v>6.4353999999999995E-2</c:v>
                </c:pt>
                <c:pt idx="2030">
                  <c:v>6.4353999999999995E-2</c:v>
                </c:pt>
                <c:pt idx="2031">
                  <c:v>6.4353999999999995E-2</c:v>
                </c:pt>
                <c:pt idx="2032">
                  <c:v>6.4352999999999994E-2</c:v>
                </c:pt>
                <c:pt idx="2033">
                  <c:v>6.4352999999999994E-2</c:v>
                </c:pt>
                <c:pt idx="2034">
                  <c:v>6.4352999999999994E-2</c:v>
                </c:pt>
                <c:pt idx="2035">
                  <c:v>6.4352999999999994E-2</c:v>
                </c:pt>
                <c:pt idx="2036">
                  <c:v>6.4352999999999994E-2</c:v>
                </c:pt>
                <c:pt idx="2037">
                  <c:v>6.4352999999999994E-2</c:v>
                </c:pt>
                <c:pt idx="2038">
                  <c:v>6.4352999999999994E-2</c:v>
                </c:pt>
                <c:pt idx="2039">
                  <c:v>6.4352000000000006E-2</c:v>
                </c:pt>
                <c:pt idx="2040">
                  <c:v>6.4352000000000006E-2</c:v>
                </c:pt>
                <c:pt idx="2041">
                  <c:v>6.4352000000000006E-2</c:v>
                </c:pt>
                <c:pt idx="2042">
                  <c:v>6.4352000000000006E-2</c:v>
                </c:pt>
                <c:pt idx="2043">
                  <c:v>6.4352000000000006E-2</c:v>
                </c:pt>
                <c:pt idx="2044">
                  <c:v>6.4352000000000006E-2</c:v>
                </c:pt>
                <c:pt idx="2045">
                  <c:v>6.4352000000000006E-2</c:v>
                </c:pt>
                <c:pt idx="2046">
                  <c:v>6.4351000000000005E-2</c:v>
                </c:pt>
                <c:pt idx="2047">
                  <c:v>6.4351000000000005E-2</c:v>
                </c:pt>
                <c:pt idx="2048">
                  <c:v>6.4351000000000005E-2</c:v>
                </c:pt>
                <c:pt idx="2049">
                  <c:v>6.4351000000000005E-2</c:v>
                </c:pt>
                <c:pt idx="2050">
                  <c:v>6.4351000000000005E-2</c:v>
                </c:pt>
                <c:pt idx="2051">
                  <c:v>6.4351000000000005E-2</c:v>
                </c:pt>
                <c:pt idx="2052">
                  <c:v>6.4351000000000005E-2</c:v>
                </c:pt>
                <c:pt idx="2053">
                  <c:v>6.4350000000000004E-2</c:v>
                </c:pt>
                <c:pt idx="2054">
                  <c:v>6.4350000000000004E-2</c:v>
                </c:pt>
                <c:pt idx="2055">
                  <c:v>6.4350000000000004E-2</c:v>
                </c:pt>
                <c:pt idx="2056">
                  <c:v>6.4350000000000004E-2</c:v>
                </c:pt>
                <c:pt idx="2057">
                  <c:v>6.4350000000000004E-2</c:v>
                </c:pt>
                <c:pt idx="2058">
                  <c:v>6.4350000000000004E-2</c:v>
                </c:pt>
                <c:pt idx="2059">
                  <c:v>6.4350000000000004E-2</c:v>
                </c:pt>
                <c:pt idx="2060">
                  <c:v>6.4350000000000004E-2</c:v>
                </c:pt>
                <c:pt idx="2061">
                  <c:v>6.4349000000000003E-2</c:v>
                </c:pt>
                <c:pt idx="2062">
                  <c:v>6.4349000000000003E-2</c:v>
                </c:pt>
                <c:pt idx="2063">
                  <c:v>6.4349000000000003E-2</c:v>
                </c:pt>
                <c:pt idx="2064">
                  <c:v>6.4349000000000003E-2</c:v>
                </c:pt>
                <c:pt idx="2065">
                  <c:v>6.4349000000000003E-2</c:v>
                </c:pt>
                <c:pt idx="2066">
                  <c:v>6.4349000000000003E-2</c:v>
                </c:pt>
                <c:pt idx="2067">
                  <c:v>6.4349000000000003E-2</c:v>
                </c:pt>
                <c:pt idx="2068">
                  <c:v>6.4349000000000003E-2</c:v>
                </c:pt>
                <c:pt idx="2069">
                  <c:v>6.4348000000000002E-2</c:v>
                </c:pt>
                <c:pt idx="2070">
                  <c:v>6.4348000000000002E-2</c:v>
                </c:pt>
                <c:pt idx="2071">
                  <c:v>6.4348000000000002E-2</c:v>
                </c:pt>
                <c:pt idx="2072">
                  <c:v>6.4348000000000002E-2</c:v>
                </c:pt>
                <c:pt idx="2073">
                  <c:v>6.4348000000000002E-2</c:v>
                </c:pt>
                <c:pt idx="2074">
                  <c:v>6.4348000000000002E-2</c:v>
                </c:pt>
                <c:pt idx="2075">
                  <c:v>6.4348000000000002E-2</c:v>
                </c:pt>
                <c:pt idx="2076">
                  <c:v>6.4347000000000001E-2</c:v>
                </c:pt>
                <c:pt idx="2077">
                  <c:v>6.4347000000000001E-2</c:v>
                </c:pt>
                <c:pt idx="2078">
                  <c:v>6.4347000000000001E-2</c:v>
                </c:pt>
                <c:pt idx="2079">
                  <c:v>6.4347000000000001E-2</c:v>
                </c:pt>
                <c:pt idx="2080">
                  <c:v>6.4347000000000001E-2</c:v>
                </c:pt>
                <c:pt idx="2081">
                  <c:v>6.4347000000000001E-2</c:v>
                </c:pt>
                <c:pt idx="2082">
                  <c:v>6.4347000000000001E-2</c:v>
                </c:pt>
                <c:pt idx="2083">
                  <c:v>6.4347000000000001E-2</c:v>
                </c:pt>
                <c:pt idx="2084">
                  <c:v>6.4347000000000001E-2</c:v>
                </c:pt>
                <c:pt idx="2085">
                  <c:v>6.4346E-2</c:v>
                </c:pt>
                <c:pt idx="2086">
                  <c:v>6.4346E-2</c:v>
                </c:pt>
                <c:pt idx="2087">
                  <c:v>6.4346E-2</c:v>
                </c:pt>
                <c:pt idx="2088">
                  <c:v>6.4346E-2</c:v>
                </c:pt>
                <c:pt idx="2089">
                  <c:v>6.4346E-2</c:v>
                </c:pt>
                <c:pt idx="2090">
                  <c:v>6.4346E-2</c:v>
                </c:pt>
                <c:pt idx="2091">
                  <c:v>6.4346E-2</c:v>
                </c:pt>
                <c:pt idx="2092">
                  <c:v>6.4346E-2</c:v>
                </c:pt>
                <c:pt idx="2093">
                  <c:v>6.4344999999999999E-2</c:v>
                </c:pt>
                <c:pt idx="2094">
                  <c:v>6.4344999999999999E-2</c:v>
                </c:pt>
                <c:pt idx="2095">
                  <c:v>6.4344999999999999E-2</c:v>
                </c:pt>
                <c:pt idx="2096">
                  <c:v>6.4344999999999999E-2</c:v>
                </c:pt>
                <c:pt idx="2097">
                  <c:v>6.4344999999999999E-2</c:v>
                </c:pt>
                <c:pt idx="2098">
                  <c:v>6.4344999999999999E-2</c:v>
                </c:pt>
                <c:pt idx="2099">
                  <c:v>6.4344999999999999E-2</c:v>
                </c:pt>
                <c:pt idx="2100">
                  <c:v>6.4344999999999999E-2</c:v>
                </c:pt>
                <c:pt idx="2101">
                  <c:v>6.4343999999999998E-2</c:v>
                </c:pt>
                <c:pt idx="2102">
                  <c:v>6.4343999999999998E-2</c:v>
                </c:pt>
                <c:pt idx="2103">
                  <c:v>6.4343999999999998E-2</c:v>
                </c:pt>
                <c:pt idx="2104">
                  <c:v>6.4343999999999998E-2</c:v>
                </c:pt>
                <c:pt idx="2105">
                  <c:v>6.4343999999999998E-2</c:v>
                </c:pt>
                <c:pt idx="2106">
                  <c:v>6.4343999999999998E-2</c:v>
                </c:pt>
                <c:pt idx="2107">
                  <c:v>6.4343999999999998E-2</c:v>
                </c:pt>
                <c:pt idx="2108">
                  <c:v>6.4343999999999998E-2</c:v>
                </c:pt>
                <c:pt idx="2109">
                  <c:v>6.4343999999999998E-2</c:v>
                </c:pt>
                <c:pt idx="2110">
                  <c:v>6.4342999999999997E-2</c:v>
                </c:pt>
                <c:pt idx="2111">
                  <c:v>6.4342999999999997E-2</c:v>
                </c:pt>
                <c:pt idx="2112">
                  <c:v>6.4342999999999997E-2</c:v>
                </c:pt>
                <c:pt idx="2113">
                  <c:v>6.4342999999999997E-2</c:v>
                </c:pt>
                <c:pt idx="2114">
                  <c:v>6.4342999999999997E-2</c:v>
                </c:pt>
                <c:pt idx="2115">
                  <c:v>6.4342999999999997E-2</c:v>
                </c:pt>
                <c:pt idx="2116">
                  <c:v>6.4342999999999997E-2</c:v>
                </c:pt>
                <c:pt idx="2117">
                  <c:v>6.4342999999999997E-2</c:v>
                </c:pt>
                <c:pt idx="2118">
                  <c:v>6.4342999999999997E-2</c:v>
                </c:pt>
                <c:pt idx="2119">
                  <c:v>6.4341999999999996E-2</c:v>
                </c:pt>
                <c:pt idx="2120">
                  <c:v>6.4341999999999996E-2</c:v>
                </c:pt>
                <c:pt idx="2121">
                  <c:v>6.4341999999999996E-2</c:v>
                </c:pt>
                <c:pt idx="2122">
                  <c:v>6.4341999999999996E-2</c:v>
                </c:pt>
                <c:pt idx="2123">
                  <c:v>6.4341999999999996E-2</c:v>
                </c:pt>
                <c:pt idx="2124">
                  <c:v>6.4341999999999996E-2</c:v>
                </c:pt>
                <c:pt idx="2125">
                  <c:v>6.4341999999999996E-2</c:v>
                </c:pt>
                <c:pt idx="2126">
                  <c:v>6.4341999999999996E-2</c:v>
                </c:pt>
                <c:pt idx="2127">
                  <c:v>6.4341999999999996E-2</c:v>
                </c:pt>
                <c:pt idx="2128">
                  <c:v>6.4340999999999995E-2</c:v>
                </c:pt>
                <c:pt idx="2129">
                  <c:v>6.4340999999999995E-2</c:v>
                </c:pt>
                <c:pt idx="2130">
                  <c:v>6.4340999999999995E-2</c:v>
                </c:pt>
                <c:pt idx="2131">
                  <c:v>6.4340999999999995E-2</c:v>
                </c:pt>
                <c:pt idx="2132">
                  <c:v>6.4340999999999995E-2</c:v>
                </c:pt>
                <c:pt idx="2133">
                  <c:v>6.4340999999999995E-2</c:v>
                </c:pt>
                <c:pt idx="2134">
                  <c:v>6.4340999999999995E-2</c:v>
                </c:pt>
                <c:pt idx="2135">
                  <c:v>6.4340999999999995E-2</c:v>
                </c:pt>
                <c:pt idx="2136">
                  <c:v>6.4340999999999995E-2</c:v>
                </c:pt>
                <c:pt idx="2137">
                  <c:v>6.4340999999999995E-2</c:v>
                </c:pt>
                <c:pt idx="2138">
                  <c:v>6.4339999999999994E-2</c:v>
                </c:pt>
                <c:pt idx="2139">
                  <c:v>6.4339999999999994E-2</c:v>
                </c:pt>
                <c:pt idx="2140">
                  <c:v>6.4339999999999994E-2</c:v>
                </c:pt>
                <c:pt idx="2141">
                  <c:v>6.4339999999999994E-2</c:v>
                </c:pt>
                <c:pt idx="2142">
                  <c:v>6.4339999999999994E-2</c:v>
                </c:pt>
                <c:pt idx="2143">
                  <c:v>6.4339999999999994E-2</c:v>
                </c:pt>
                <c:pt idx="2144">
                  <c:v>6.4339999999999994E-2</c:v>
                </c:pt>
                <c:pt idx="2145">
                  <c:v>6.4339999999999994E-2</c:v>
                </c:pt>
                <c:pt idx="2146">
                  <c:v>6.4339999999999994E-2</c:v>
                </c:pt>
                <c:pt idx="2147">
                  <c:v>6.4339999999999994E-2</c:v>
                </c:pt>
                <c:pt idx="2148">
                  <c:v>6.4338999999999993E-2</c:v>
                </c:pt>
                <c:pt idx="2149">
                  <c:v>6.4338999999999993E-2</c:v>
                </c:pt>
                <c:pt idx="2150">
                  <c:v>6.4338999999999993E-2</c:v>
                </c:pt>
                <c:pt idx="2151">
                  <c:v>6.4338999999999993E-2</c:v>
                </c:pt>
                <c:pt idx="2152">
                  <c:v>6.4338999999999993E-2</c:v>
                </c:pt>
                <c:pt idx="2153">
                  <c:v>6.4338999999999993E-2</c:v>
                </c:pt>
                <c:pt idx="2154">
                  <c:v>6.4338999999999993E-2</c:v>
                </c:pt>
                <c:pt idx="2155">
                  <c:v>6.4338999999999993E-2</c:v>
                </c:pt>
                <c:pt idx="2156">
                  <c:v>6.4338999999999993E-2</c:v>
                </c:pt>
                <c:pt idx="2157">
                  <c:v>6.4338999999999993E-2</c:v>
                </c:pt>
                <c:pt idx="2158">
                  <c:v>6.4338000000000006E-2</c:v>
                </c:pt>
                <c:pt idx="2159">
                  <c:v>6.4338000000000006E-2</c:v>
                </c:pt>
                <c:pt idx="2160">
                  <c:v>6.4338000000000006E-2</c:v>
                </c:pt>
                <c:pt idx="2161">
                  <c:v>6.4338000000000006E-2</c:v>
                </c:pt>
                <c:pt idx="2162">
                  <c:v>6.4338000000000006E-2</c:v>
                </c:pt>
                <c:pt idx="2163">
                  <c:v>6.4338000000000006E-2</c:v>
                </c:pt>
                <c:pt idx="2164">
                  <c:v>6.4338000000000006E-2</c:v>
                </c:pt>
                <c:pt idx="2165">
                  <c:v>6.4338000000000006E-2</c:v>
                </c:pt>
                <c:pt idx="2166">
                  <c:v>6.4338000000000006E-2</c:v>
                </c:pt>
                <c:pt idx="2167">
                  <c:v>6.4338000000000006E-2</c:v>
                </c:pt>
                <c:pt idx="2168">
                  <c:v>6.4337000000000005E-2</c:v>
                </c:pt>
                <c:pt idx="2169">
                  <c:v>6.4337000000000005E-2</c:v>
                </c:pt>
                <c:pt idx="2170">
                  <c:v>6.4337000000000005E-2</c:v>
                </c:pt>
                <c:pt idx="2171">
                  <c:v>6.4337000000000005E-2</c:v>
                </c:pt>
                <c:pt idx="2172">
                  <c:v>6.4337000000000005E-2</c:v>
                </c:pt>
                <c:pt idx="2173">
                  <c:v>6.4337000000000005E-2</c:v>
                </c:pt>
                <c:pt idx="2174">
                  <c:v>6.4337000000000005E-2</c:v>
                </c:pt>
                <c:pt idx="2175">
                  <c:v>6.4337000000000005E-2</c:v>
                </c:pt>
                <c:pt idx="2176">
                  <c:v>6.4337000000000005E-2</c:v>
                </c:pt>
                <c:pt idx="2177">
                  <c:v>6.4337000000000005E-2</c:v>
                </c:pt>
                <c:pt idx="2178">
                  <c:v>6.4337000000000005E-2</c:v>
                </c:pt>
                <c:pt idx="2179">
                  <c:v>6.4336000000000004E-2</c:v>
                </c:pt>
                <c:pt idx="2180">
                  <c:v>6.4336000000000004E-2</c:v>
                </c:pt>
                <c:pt idx="2181">
                  <c:v>6.4336000000000004E-2</c:v>
                </c:pt>
                <c:pt idx="2182">
                  <c:v>6.4336000000000004E-2</c:v>
                </c:pt>
                <c:pt idx="2183">
                  <c:v>6.4336000000000004E-2</c:v>
                </c:pt>
                <c:pt idx="2184">
                  <c:v>6.4336000000000004E-2</c:v>
                </c:pt>
                <c:pt idx="2185">
                  <c:v>6.4336000000000004E-2</c:v>
                </c:pt>
                <c:pt idx="2186">
                  <c:v>6.4336000000000004E-2</c:v>
                </c:pt>
                <c:pt idx="2187">
                  <c:v>6.4336000000000004E-2</c:v>
                </c:pt>
                <c:pt idx="2188">
                  <c:v>6.4336000000000004E-2</c:v>
                </c:pt>
                <c:pt idx="2189">
                  <c:v>6.4336000000000004E-2</c:v>
                </c:pt>
                <c:pt idx="2190">
                  <c:v>6.4335000000000003E-2</c:v>
                </c:pt>
                <c:pt idx="2191">
                  <c:v>6.4335000000000003E-2</c:v>
                </c:pt>
                <c:pt idx="2192">
                  <c:v>6.4335000000000003E-2</c:v>
                </c:pt>
                <c:pt idx="2193">
                  <c:v>6.4335000000000003E-2</c:v>
                </c:pt>
                <c:pt idx="2194">
                  <c:v>6.4335000000000003E-2</c:v>
                </c:pt>
                <c:pt idx="2195">
                  <c:v>6.4335000000000003E-2</c:v>
                </c:pt>
                <c:pt idx="2196">
                  <c:v>6.4335000000000003E-2</c:v>
                </c:pt>
                <c:pt idx="2197">
                  <c:v>6.4335000000000003E-2</c:v>
                </c:pt>
                <c:pt idx="2198">
                  <c:v>6.4335000000000003E-2</c:v>
                </c:pt>
                <c:pt idx="2199">
                  <c:v>6.4335000000000003E-2</c:v>
                </c:pt>
                <c:pt idx="2200">
                  <c:v>6.4335000000000003E-2</c:v>
                </c:pt>
                <c:pt idx="2201">
                  <c:v>6.4335000000000003E-2</c:v>
                </c:pt>
                <c:pt idx="2202">
                  <c:v>6.4334000000000002E-2</c:v>
                </c:pt>
                <c:pt idx="2203">
                  <c:v>6.4334000000000002E-2</c:v>
                </c:pt>
                <c:pt idx="2204">
                  <c:v>6.4334000000000002E-2</c:v>
                </c:pt>
                <c:pt idx="2205">
                  <c:v>6.4334000000000002E-2</c:v>
                </c:pt>
                <c:pt idx="2206">
                  <c:v>6.4334000000000002E-2</c:v>
                </c:pt>
                <c:pt idx="2207">
                  <c:v>6.4334000000000002E-2</c:v>
                </c:pt>
                <c:pt idx="2208">
                  <c:v>6.4334000000000002E-2</c:v>
                </c:pt>
                <c:pt idx="2209">
                  <c:v>6.4334000000000002E-2</c:v>
                </c:pt>
                <c:pt idx="2210">
                  <c:v>6.4334000000000002E-2</c:v>
                </c:pt>
                <c:pt idx="2211">
                  <c:v>6.4334000000000002E-2</c:v>
                </c:pt>
                <c:pt idx="2212">
                  <c:v>6.4334000000000002E-2</c:v>
                </c:pt>
                <c:pt idx="2213">
                  <c:v>6.4333000000000001E-2</c:v>
                </c:pt>
                <c:pt idx="2214">
                  <c:v>6.4333000000000001E-2</c:v>
                </c:pt>
                <c:pt idx="2215">
                  <c:v>6.4333000000000001E-2</c:v>
                </c:pt>
                <c:pt idx="2216">
                  <c:v>6.4333000000000001E-2</c:v>
                </c:pt>
                <c:pt idx="2217">
                  <c:v>6.4333000000000001E-2</c:v>
                </c:pt>
                <c:pt idx="2218">
                  <c:v>6.4333000000000001E-2</c:v>
                </c:pt>
                <c:pt idx="2219">
                  <c:v>6.4333000000000001E-2</c:v>
                </c:pt>
                <c:pt idx="2220">
                  <c:v>6.4333000000000001E-2</c:v>
                </c:pt>
                <c:pt idx="2221">
                  <c:v>6.4333000000000001E-2</c:v>
                </c:pt>
                <c:pt idx="2222">
                  <c:v>6.4333000000000001E-2</c:v>
                </c:pt>
                <c:pt idx="2223">
                  <c:v>6.4333000000000001E-2</c:v>
                </c:pt>
                <c:pt idx="2224">
                  <c:v>6.4333000000000001E-2</c:v>
                </c:pt>
                <c:pt idx="2225">
                  <c:v>6.4333000000000001E-2</c:v>
                </c:pt>
                <c:pt idx="2226">
                  <c:v>6.4332E-2</c:v>
                </c:pt>
                <c:pt idx="2227">
                  <c:v>6.4332E-2</c:v>
                </c:pt>
                <c:pt idx="2228">
                  <c:v>6.4332E-2</c:v>
                </c:pt>
                <c:pt idx="2229">
                  <c:v>6.4332E-2</c:v>
                </c:pt>
                <c:pt idx="2230">
                  <c:v>6.4332E-2</c:v>
                </c:pt>
                <c:pt idx="2231">
                  <c:v>6.4332E-2</c:v>
                </c:pt>
                <c:pt idx="2232">
                  <c:v>6.4332E-2</c:v>
                </c:pt>
                <c:pt idx="2233">
                  <c:v>6.4332E-2</c:v>
                </c:pt>
                <c:pt idx="2234">
                  <c:v>6.4332E-2</c:v>
                </c:pt>
                <c:pt idx="2235">
                  <c:v>6.4332E-2</c:v>
                </c:pt>
                <c:pt idx="2236">
                  <c:v>6.4332E-2</c:v>
                </c:pt>
                <c:pt idx="2237">
                  <c:v>6.4332E-2</c:v>
                </c:pt>
                <c:pt idx="2238">
                  <c:v>6.4330999999999999E-2</c:v>
                </c:pt>
                <c:pt idx="2239">
                  <c:v>6.4330999999999999E-2</c:v>
                </c:pt>
                <c:pt idx="2240">
                  <c:v>6.4330999999999999E-2</c:v>
                </c:pt>
                <c:pt idx="2241">
                  <c:v>6.4330999999999999E-2</c:v>
                </c:pt>
                <c:pt idx="2242">
                  <c:v>6.4330999999999999E-2</c:v>
                </c:pt>
                <c:pt idx="2243">
                  <c:v>6.4330999999999999E-2</c:v>
                </c:pt>
                <c:pt idx="2244">
                  <c:v>6.4330999999999999E-2</c:v>
                </c:pt>
                <c:pt idx="2245">
                  <c:v>6.4330999999999999E-2</c:v>
                </c:pt>
                <c:pt idx="2246">
                  <c:v>6.4330999999999999E-2</c:v>
                </c:pt>
                <c:pt idx="2247">
                  <c:v>6.4330999999999999E-2</c:v>
                </c:pt>
                <c:pt idx="2248">
                  <c:v>6.4330999999999999E-2</c:v>
                </c:pt>
                <c:pt idx="2249">
                  <c:v>6.4330999999999999E-2</c:v>
                </c:pt>
                <c:pt idx="2250">
                  <c:v>6.4330999999999999E-2</c:v>
                </c:pt>
                <c:pt idx="2251">
                  <c:v>6.4330999999999999E-2</c:v>
                </c:pt>
                <c:pt idx="2252">
                  <c:v>6.4329999999999998E-2</c:v>
                </c:pt>
                <c:pt idx="2253">
                  <c:v>6.4329999999999998E-2</c:v>
                </c:pt>
                <c:pt idx="2254">
                  <c:v>6.4329999999999998E-2</c:v>
                </c:pt>
                <c:pt idx="2255">
                  <c:v>6.4329999999999998E-2</c:v>
                </c:pt>
                <c:pt idx="2256">
                  <c:v>6.4329999999999998E-2</c:v>
                </c:pt>
                <c:pt idx="2257">
                  <c:v>6.4329999999999998E-2</c:v>
                </c:pt>
                <c:pt idx="2258">
                  <c:v>6.4329999999999998E-2</c:v>
                </c:pt>
                <c:pt idx="2259">
                  <c:v>6.4329999999999998E-2</c:v>
                </c:pt>
                <c:pt idx="2260">
                  <c:v>6.4329999999999998E-2</c:v>
                </c:pt>
                <c:pt idx="2261">
                  <c:v>6.4329999999999998E-2</c:v>
                </c:pt>
                <c:pt idx="2262">
                  <c:v>6.4329999999999998E-2</c:v>
                </c:pt>
                <c:pt idx="2263">
                  <c:v>6.4329999999999998E-2</c:v>
                </c:pt>
                <c:pt idx="2264">
                  <c:v>6.4329999999999998E-2</c:v>
                </c:pt>
                <c:pt idx="2265">
                  <c:v>6.4328999999999997E-2</c:v>
                </c:pt>
                <c:pt idx="2266">
                  <c:v>6.4328999999999997E-2</c:v>
                </c:pt>
                <c:pt idx="2267">
                  <c:v>6.4328999999999997E-2</c:v>
                </c:pt>
                <c:pt idx="2268">
                  <c:v>6.4328999999999997E-2</c:v>
                </c:pt>
                <c:pt idx="2269">
                  <c:v>6.4328999999999997E-2</c:v>
                </c:pt>
                <c:pt idx="2270">
                  <c:v>6.4328999999999997E-2</c:v>
                </c:pt>
                <c:pt idx="2271">
                  <c:v>6.4328999999999997E-2</c:v>
                </c:pt>
                <c:pt idx="2272">
                  <c:v>6.4328999999999997E-2</c:v>
                </c:pt>
                <c:pt idx="2273">
                  <c:v>6.4328999999999997E-2</c:v>
                </c:pt>
                <c:pt idx="2274">
                  <c:v>6.4328999999999997E-2</c:v>
                </c:pt>
                <c:pt idx="2275">
                  <c:v>6.4328999999999997E-2</c:v>
                </c:pt>
                <c:pt idx="2276">
                  <c:v>6.4328999999999997E-2</c:v>
                </c:pt>
                <c:pt idx="2277">
                  <c:v>6.4328999999999997E-2</c:v>
                </c:pt>
                <c:pt idx="2278">
                  <c:v>6.4328999999999997E-2</c:v>
                </c:pt>
                <c:pt idx="2279">
                  <c:v>6.4328999999999997E-2</c:v>
                </c:pt>
                <c:pt idx="2280">
                  <c:v>6.4327999999999996E-2</c:v>
                </c:pt>
                <c:pt idx="2281">
                  <c:v>6.4327999999999996E-2</c:v>
                </c:pt>
                <c:pt idx="2282">
                  <c:v>6.4327999999999996E-2</c:v>
                </c:pt>
                <c:pt idx="2283">
                  <c:v>6.4327999999999996E-2</c:v>
                </c:pt>
                <c:pt idx="2284">
                  <c:v>6.4327999999999996E-2</c:v>
                </c:pt>
                <c:pt idx="2285">
                  <c:v>6.4327999999999996E-2</c:v>
                </c:pt>
                <c:pt idx="2286">
                  <c:v>6.4327999999999996E-2</c:v>
                </c:pt>
                <c:pt idx="2287">
                  <c:v>6.4327999999999996E-2</c:v>
                </c:pt>
                <c:pt idx="2288">
                  <c:v>6.4327999999999996E-2</c:v>
                </c:pt>
                <c:pt idx="2289">
                  <c:v>6.4327999999999996E-2</c:v>
                </c:pt>
                <c:pt idx="2290">
                  <c:v>6.4327999999999996E-2</c:v>
                </c:pt>
                <c:pt idx="2291">
                  <c:v>6.4327999999999996E-2</c:v>
                </c:pt>
                <c:pt idx="2292">
                  <c:v>6.4327999999999996E-2</c:v>
                </c:pt>
                <c:pt idx="2293">
                  <c:v>6.4327999999999996E-2</c:v>
                </c:pt>
                <c:pt idx="2294">
                  <c:v>6.4327999999999996E-2</c:v>
                </c:pt>
                <c:pt idx="2295">
                  <c:v>6.4326999999999995E-2</c:v>
                </c:pt>
                <c:pt idx="2296">
                  <c:v>6.4326999999999995E-2</c:v>
                </c:pt>
                <c:pt idx="2297">
                  <c:v>6.4326999999999995E-2</c:v>
                </c:pt>
                <c:pt idx="2298">
                  <c:v>6.4326999999999995E-2</c:v>
                </c:pt>
                <c:pt idx="2299">
                  <c:v>6.4326999999999995E-2</c:v>
                </c:pt>
                <c:pt idx="2300">
                  <c:v>6.4326999999999995E-2</c:v>
                </c:pt>
                <c:pt idx="2301">
                  <c:v>6.4326999999999995E-2</c:v>
                </c:pt>
                <c:pt idx="2302">
                  <c:v>6.4326999999999995E-2</c:v>
                </c:pt>
                <c:pt idx="2303">
                  <c:v>6.4326999999999995E-2</c:v>
                </c:pt>
                <c:pt idx="2304">
                  <c:v>6.4326999999999995E-2</c:v>
                </c:pt>
                <c:pt idx="2305">
                  <c:v>6.4326999999999995E-2</c:v>
                </c:pt>
                <c:pt idx="2306">
                  <c:v>6.4326999999999995E-2</c:v>
                </c:pt>
                <c:pt idx="2307">
                  <c:v>6.4326999999999995E-2</c:v>
                </c:pt>
                <c:pt idx="2308">
                  <c:v>6.4326999999999995E-2</c:v>
                </c:pt>
                <c:pt idx="2309">
                  <c:v>6.4326999999999995E-2</c:v>
                </c:pt>
                <c:pt idx="2310">
                  <c:v>6.4325999999999994E-2</c:v>
                </c:pt>
                <c:pt idx="2311">
                  <c:v>6.4325999999999994E-2</c:v>
                </c:pt>
                <c:pt idx="2312">
                  <c:v>6.4325999999999994E-2</c:v>
                </c:pt>
                <c:pt idx="2313">
                  <c:v>6.4325999999999994E-2</c:v>
                </c:pt>
                <c:pt idx="2314">
                  <c:v>6.4325999999999994E-2</c:v>
                </c:pt>
                <c:pt idx="2315">
                  <c:v>6.4325999999999994E-2</c:v>
                </c:pt>
                <c:pt idx="2316">
                  <c:v>6.4325999999999994E-2</c:v>
                </c:pt>
                <c:pt idx="2317">
                  <c:v>6.4325999999999994E-2</c:v>
                </c:pt>
                <c:pt idx="2318">
                  <c:v>6.4325999999999994E-2</c:v>
                </c:pt>
                <c:pt idx="2319">
                  <c:v>6.4325999999999994E-2</c:v>
                </c:pt>
                <c:pt idx="2320">
                  <c:v>6.4325999999999994E-2</c:v>
                </c:pt>
                <c:pt idx="2321">
                  <c:v>6.4325999999999994E-2</c:v>
                </c:pt>
                <c:pt idx="2322">
                  <c:v>6.4325999999999994E-2</c:v>
                </c:pt>
                <c:pt idx="2323">
                  <c:v>6.4325999999999994E-2</c:v>
                </c:pt>
                <c:pt idx="2324">
                  <c:v>6.4325999999999994E-2</c:v>
                </c:pt>
                <c:pt idx="2325">
                  <c:v>6.4325999999999994E-2</c:v>
                </c:pt>
                <c:pt idx="2326">
                  <c:v>6.4324999999999993E-2</c:v>
                </c:pt>
                <c:pt idx="2327">
                  <c:v>6.4324999999999993E-2</c:v>
                </c:pt>
                <c:pt idx="2328">
                  <c:v>6.4324999999999993E-2</c:v>
                </c:pt>
                <c:pt idx="2329">
                  <c:v>6.4324999999999993E-2</c:v>
                </c:pt>
                <c:pt idx="2330">
                  <c:v>6.4324999999999993E-2</c:v>
                </c:pt>
                <c:pt idx="2331">
                  <c:v>6.4324999999999993E-2</c:v>
                </c:pt>
                <c:pt idx="2332">
                  <c:v>6.4324999999999993E-2</c:v>
                </c:pt>
                <c:pt idx="2333">
                  <c:v>6.4324999999999993E-2</c:v>
                </c:pt>
                <c:pt idx="2334">
                  <c:v>6.4324999999999993E-2</c:v>
                </c:pt>
                <c:pt idx="2335">
                  <c:v>6.4324999999999993E-2</c:v>
                </c:pt>
                <c:pt idx="2336">
                  <c:v>6.4324999999999993E-2</c:v>
                </c:pt>
                <c:pt idx="2337">
                  <c:v>6.4324999999999993E-2</c:v>
                </c:pt>
                <c:pt idx="2338">
                  <c:v>6.4324999999999993E-2</c:v>
                </c:pt>
                <c:pt idx="2339">
                  <c:v>6.4324999999999993E-2</c:v>
                </c:pt>
                <c:pt idx="2340">
                  <c:v>6.4324999999999993E-2</c:v>
                </c:pt>
                <c:pt idx="2341">
                  <c:v>6.4324999999999993E-2</c:v>
                </c:pt>
                <c:pt idx="2342">
                  <c:v>6.4324999999999993E-2</c:v>
                </c:pt>
                <c:pt idx="2343">
                  <c:v>6.4324000000000006E-2</c:v>
                </c:pt>
                <c:pt idx="2344">
                  <c:v>6.4324000000000006E-2</c:v>
                </c:pt>
                <c:pt idx="2345">
                  <c:v>6.4324000000000006E-2</c:v>
                </c:pt>
                <c:pt idx="2346">
                  <c:v>6.4324000000000006E-2</c:v>
                </c:pt>
                <c:pt idx="2347">
                  <c:v>6.4324000000000006E-2</c:v>
                </c:pt>
                <c:pt idx="2348">
                  <c:v>6.4324000000000006E-2</c:v>
                </c:pt>
                <c:pt idx="2349">
                  <c:v>6.4324000000000006E-2</c:v>
                </c:pt>
                <c:pt idx="2350">
                  <c:v>6.4324000000000006E-2</c:v>
                </c:pt>
                <c:pt idx="2351">
                  <c:v>6.4324000000000006E-2</c:v>
                </c:pt>
                <c:pt idx="2352">
                  <c:v>6.4324000000000006E-2</c:v>
                </c:pt>
                <c:pt idx="2353">
                  <c:v>6.4324000000000006E-2</c:v>
                </c:pt>
                <c:pt idx="2354">
                  <c:v>6.4324000000000006E-2</c:v>
                </c:pt>
                <c:pt idx="2355">
                  <c:v>6.4324000000000006E-2</c:v>
                </c:pt>
                <c:pt idx="2356">
                  <c:v>6.4324000000000006E-2</c:v>
                </c:pt>
                <c:pt idx="2357">
                  <c:v>6.4324000000000006E-2</c:v>
                </c:pt>
                <c:pt idx="2358">
                  <c:v>6.4324000000000006E-2</c:v>
                </c:pt>
                <c:pt idx="2359">
                  <c:v>6.4324000000000006E-2</c:v>
                </c:pt>
                <c:pt idx="2360">
                  <c:v>6.4324000000000006E-2</c:v>
                </c:pt>
                <c:pt idx="2361">
                  <c:v>6.4323000000000005E-2</c:v>
                </c:pt>
                <c:pt idx="2362">
                  <c:v>6.4323000000000005E-2</c:v>
                </c:pt>
                <c:pt idx="2363">
                  <c:v>6.4323000000000005E-2</c:v>
                </c:pt>
                <c:pt idx="2364">
                  <c:v>6.4323000000000005E-2</c:v>
                </c:pt>
                <c:pt idx="2365">
                  <c:v>6.4323000000000005E-2</c:v>
                </c:pt>
                <c:pt idx="2366">
                  <c:v>6.4323000000000005E-2</c:v>
                </c:pt>
                <c:pt idx="2367">
                  <c:v>6.4323000000000005E-2</c:v>
                </c:pt>
                <c:pt idx="2368">
                  <c:v>6.4323000000000005E-2</c:v>
                </c:pt>
                <c:pt idx="2369">
                  <c:v>6.4323000000000005E-2</c:v>
                </c:pt>
                <c:pt idx="2370">
                  <c:v>6.4323000000000005E-2</c:v>
                </c:pt>
                <c:pt idx="2371">
                  <c:v>6.4323000000000005E-2</c:v>
                </c:pt>
                <c:pt idx="2372">
                  <c:v>6.4323000000000005E-2</c:v>
                </c:pt>
                <c:pt idx="2373">
                  <c:v>6.4323000000000005E-2</c:v>
                </c:pt>
                <c:pt idx="2374">
                  <c:v>6.4323000000000005E-2</c:v>
                </c:pt>
                <c:pt idx="2375">
                  <c:v>6.4323000000000005E-2</c:v>
                </c:pt>
                <c:pt idx="2376">
                  <c:v>6.4323000000000005E-2</c:v>
                </c:pt>
                <c:pt idx="2377">
                  <c:v>6.4323000000000005E-2</c:v>
                </c:pt>
                <c:pt idx="2378">
                  <c:v>6.4323000000000005E-2</c:v>
                </c:pt>
                <c:pt idx="2379">
                  <c:v>6.4323000000000005E-2</c:v>
                </c:pt>
                <c:pt idx="2380">
                  <c:v>6.4322000000000004E-2</c:v>
                </c:pt>
                <c:pt idx="2381">
                  <c:v>6.4322000000000004E-2</c:v>
                </c:pt>
                <c:pt idx="2382">
                  <c:v>6.4322000000000004E-2</c:v>
                </c:pt>
                <c:pt idx="2383">
                  <c:v>6.4322000000000004E-2</c:v>
                </c:pt>
                <c:pt idx="2384">
                  <c:v>6.4322000000000004E-2</c:v>
                </c:pt>
                <c:pt idx="2385">
                  <c:v>6.4322000000000004E-2</c:v>
                </c:pt>
                <c:pt idx="2386">
                  <c:v>6.4322000000000004E-2</c:v>
                </c:pt>
                <c:pt idx="2387">
                  <c:v>6.4322000000000004E-2</c:v>
                </c:pt>
                <c:pt idx="2388">
                  <c:v>6.4322000000000004E-2</c:v>
                </c:pt>
                <c:pt idx="2389">
                  <c:v>6.4322000000000004E-2</c:v>
                </c:pt>
                <c:pt idx="2390">
                  <c:v>6.4322000000000004E-2</c:v>
                </c:pt>
                <c:pt idx="2391">
                  <c:v>6.4322000000000004E-2</c:v>
                </c:pt>
                <c:pt idx="2392">
                  <c:v>6.4322000000000004E-2</c:v>
                </c:pt>
                <c:pt idx="2393">
                  <c:v>6.4322000000000004E-2</c:v>
                </c:pt>
                <c:pt idx="2394">
                  <c:v>6.4322000000000004E-2</c:v>
                </c:pt>
                <c:pt idx="2395">
                  <c:v>6.4322000000000004E-2</c:v>
                </c:pt>
                <c:pt idx="2396">
                  <c:v>6.4322000000000004E-2</c:v>
                </c:pt>
                <c:pt idx="2397">
                  <c:v>6.4322000000000004E-2</c:v>
                </c:pt>
                <c:pt idx="2398">
                  <c:v>6.4322000000000004E-2</c:v>
                </c:pt>
                <c:pt idx="2399">
                  <c:v>6.4321000000000003E-2</c:v>
                </c:pt>
                <c:pt idx="2400">
                  <c:v>6.4321000000000003E-2</c:v>
                </c:pt>
                <c:pt idx="2401">
                  <c:v>6.4321000000000003E-2</c:v>
                </c:pt>
                <c:pt idx="2402">
                  <c:v>6.4321000000000003E-2</c:v>
                </c:pt>
                <c:pt idx="2403">
                  <c:v>6.4321000000000003E-2</c:v>
                </c:pt>
                <c:pt idx="2404">
                  <c:v>6.4321000000000003E-2</c:v>
                </c:pt>
                <c:pt idx="2405">
                  <c:v>6.4321000000000003E-2</c:v>
                </c:pt>
                <c:pt idx="2406">
                  <c:v>6.4321000000000003E-2</c:v>
                </c:pt>
                <c:pt idx="2407">
                  <c:v>6.4321000000000003E-2</c:v>
                </c:pt>
                <c:pt idx="2408">
                  <c:v>6.4321000000000003E-2</c:v>
                </c:pt>
                <c:pt idx="2409">
                  <c:v>6.4321000000000003E-2</c:v>
                </c:pt>
                <c:pt idx="2410">
                  <c:v>6.4321000000000003E-2</c:v>
                </c:pt>
                <c:pt idx="2411">
                  <c:v>6.4321000000000003E-2</c:v>
                </c:pt>
                <c:pt idx="2412">
                  <c:v>6.4321000000000003E-2</c:v>
                </c:pt>
                <c:pt idx="2413">
                  <c:v>6.4321000000000003E-2</c:v>
                </c:pt>
                <c:pt idx="2414">
                  <c:v>6.4321000000000003E-2</c:v>
                </c:pt>
                <c:pt idx="2415">
                  <c:v>6.4321000000000003E-2</c:v>
                </c:pt>
                <c:pt idx="2416">
                  <c:v>6.4321000000000003E-2</c:v>
                </c:pt>
                <c:pt idx="2417">
                  <c:v>6.4321000000000003E-2</c:v>
                </c:pt>
                <c:pt idx="2418">
                  <c:v>6.4321000000000003E-2</c:v>
                </c:pt>
                <c:pt idx="2419">
                  <c:v>6.4321000000000003E-2</c:v>
                </c:pt>
                <c:pt idx="2420">
                  <c:v>6.4320000000000002E-2</c:v>
                </c:pt>
                <c:pt idx="2421">
                  <c:v>6.4320000000000002E-2</c:v>
                </c:pt>
                <c:pt idx="2422">
                  <c:v>6.4320000000000002E-2</c:v>
                </c:pt>
                <c:pt idx="2423">
                  <c:v>6.4320000000000002E-2</c:v>
                </c:pt>
                <c:pt idx="2424">
                  <c:v>6.4320000000000002E-2</c:v>
                </c:pt>
                <c:pt idx="2425">
                  <c:v>6.4320000000000002E-2</c:v>
                </c:pt>
                <c:pt idx="2426">
                  <c:v>6.4320000000000002E-2</c:v>
                </c:pt>
                <c:pt idx="2427">
                  <c:v>6.4320000000000002E-2</c:v>
                </c:pt>
                <c:pt idx="2428">
                  <c:v>6.4320000000000002E-2</c:v>
                </c:pt>
                <c:pt idx="2429">
                  <c:v>6.4320000000000002E-2</c:v>
                </c:pt>
                <c:pt idx="2430">
                  <c:v>6.4320000000000002E-2</c:v>
                </c:pt>
                <c:pt idx="2431">
                  <c:v>6.4320000000000002E-2</c:v>
                </c:pt>
                <c:pt idx="2432">
                  <c:v>6.4320000000000002E-2</c:v>
                </c:pt>
                <c:pt idx="2433">
                  <c:v>6.4320000000000002E-2</c:v>
                </c:pt>
                <c:pt idx="2434">
                  <c:v>6.4320000000000002E-2</c:v>
                </c:pt>
                <c:pt idx="2435">
                  <c:v>6.4320000000000002E-2</c:v>
                </c:pt>
                <c:pt idx="2436">
                  <c:v>6.4320000000000002E-2</c:v>
                </c:pt>
                <c:pt idx="2437">
                  <c:v>6.4320000000000002E-2</c:v>
                </c:pt>
                <c:pt idx="2438">
                  <c:v>6.4320000000000002E-2</c:v>
                </c:pt>
                <c:pt idx="2439">
                  <c:v>6.4320000000000002E-2</c:v>
                </c:pt>
                <c:pt idx="2440">
                  <c:v>6.4320000000000002E-2</c:v>
                </c:pt>
                <c:pt idx="2441">
                  <c:v>6.4320000000000002E-2</c:v>
                </c:pt>
                <c:pt idx="2442">
                  <c:v>6.4319000000000001E-2</c:v>
                </c:pt>
                <c:pt idx="2443">
                  <c:v>6.4319000000000001E-2</c:v>
                </c:pt>
                <c:pt idx="2444">
                  <c:v>6.4319000000000001E-2</c:v>
                </c:pt>
                <c:pt idx="2445">
                  <c:v>6.4319000000000001E-2</c:v>
                </c:pt>
                <c:pt idx="2446">
                  <c:v>6.4319000000000001E-2</c:v>
                </c:pt>
                <c:pt idx="2447">
                  <c:v>6.4319000000000001E-2</c:v>
                </c:pt>
                <c:pt idx="2448">
                  <c:v>6.4319000000000001E-2</c:v>
                </c:pt>
                <c:pt idx="2449">
                  <c:v>6.4319000000000001E-2</c:v>
                </c:pt>
                <c:pt idx="2450">
                  <c:v>6.4319000000000001E-2</c:v>
                </c:pt>
                <c:pt idx="2451">
                  <c:v>6.4319000000000001E-2</c:v>
                </c:pt>
                <c:pt idx="2452">
                  <c:v>6.4319000000000001E-2</c:v>
                </c:pt>
                <c:pt idx="2453">
                  <c:v>6.4319000000000001E-2</c:v>
                </c:pt>
                <c:pt idx="2454">
                  <c:v>6.4319000000000001E-2</c:v>
                </c:pt>
                <c:pt idx="2455">
                  <c:v>6.4319000000000001E-2</c:v>
                </c:pt>
                <c:pt idx="2456">
                  <c:v>6.4319000000000001E-2</c:v>
                </c:pt>
                <c:pt idx="2457">
                  <c:v>6.4319000000000001E-2</c:v>
                </c:pt>
                <c:pt idx="2458">
                  <c:v>6.4319000000000001E-2</c:v>
                </c:pt>
                <c:pt idx="2459">
                  <c:v>6.4319000000000001E-2</c:v>
                </c:pt>
                <c:pt idx="2460">
                  <c:v>6.4319000000000001E-2</c:v>
                </c:pt>
                <c:pt idx="2461">
                  <c:v>6.4319000000000001E-2</c:v>
                </c:pt>
                <c:pt idx="2462">
                  <c:v>6.4319000000000001E-2</c:v>
                </c:pt>
                <c:pt idx="2463">
                  <c:v>6.4319000000000001E-2</c:v>
                </c:pt>
                <c:pt idx="2464">
                  <c:v>6.4319000000000001E-2</c:v>
                </c:pt>
                <c:pt idx="2465">
                  <c:v>6.4318E-2</c:v>
                </c:pt>
                <c:pt idx="2466">
                  <c:v>6.4318E-2</c:v>
                </c:pt>
                <c:pt idx="2467">
                  <c:v>6.4318E-2</c:v>
                </c:pt>
                <c:pt idx="2468">
                  <c:v>6.4318E-2</c:v>
                </c:pt>
                <c:pt idx="2469">
                  <c:v>6.4318E-2</c:v>
                </c:pt>
                <c:pt idx="2470">
                  <c:v>6.4318E-2</c:v>
                </c:pt>
                <c:pt idx="2471">
                  <c:v>6.4318E-2</c:v>
                </c:pt>
                <c:pt idx="2472">
                  <c:v>6.4318E-2</c:v>
                </c:pt>
                <c:pt idx="2473">
                  <c:v>6.4318E-2</c:v>
                </c:pt>
                <c:pt idx="2474">
                  <c:v>6.4318E-2</c:v>
                </c:pt>
                <c:pt idx="2475">
                  <c:v>6.4318E-2</c:v>
                </c:pt>
                <c:pt idx="2476">
                  <c:v>6.4318E-2</c:v>
                </c:pt>
                <c:pt idx="2477">
                  <c:v>6.4318E-2</c:v>
                </c:pt>
                <c:pt idx="2478">
                  <c:v>6.4318E-2</c:v>
                </c:pt>
                <c:pt idx="2479">
                  <c:v>6.4318E-2</c:v>
                </c:pt>
                <c:pt idx="2480">
                  <c:v>6.4318E-2</c:v>
                </c:pt>
                <c:pt idx="2481">
                  <c:v>6.4318E-2</c:v>
                </c:pt>
                <c:pt idx="2482">
                  <c:v>6.4318E-2</c:v>
                </c:pt>
                <c:pt idx="2483">
                  <c:v>6.4318E-2</c:v>
                </c:pt>
                <c:pt idx="2484">
                  <c:v>6.4318E-2</c:v>
                </c:pt>
                <c:pt idx="2485">
                  <c:v>6.4318E-2</c:v>
                </c:pt>
                <c:pt idx="2486">
                  <c:v>6.4318E-2</c:v>
                </c:pt>
                <c:pt idx="2487">
                  <c:v>6.4318E-2</c:v>
                </c:pt>
                <c:pt idx="2488">
                  <c:v>6.4318E-2</c:v>
                </c:pt>
                <c:pt idx="2489">
                  <c:v>6.4316999999999999E-2</c:v>
                </c:pt>
                <c:pt idx="2490">
                  <c:v>6.4316999999999999E-2</c:v>
                </c:pt>
                <c:pt idx="2491">
                  <c:v>6.4316999999999999E-2</c:v>
                </c:pt>
                <c:pt idx="2492">
                  <c:v>6.4316999999999999E-2</c:v>
                </c:pt>
                <c:pt idx="2493">
                  <c:v>6.4316999999999999E-2</c:v>
                </c:pt>
                <c:pt idx="2494">
                  <c:v>6.4316999999999999E-2</c:v>
                </c:pt>
                <c:pt idx="2495">
                  <c:v>6.4316999999999999E-2</c:v>
                </c:pt>
                <c:pt idx="2496">
                  <c:v>6.4316999999999999E-2</c:v>
                </c:pt>
                <c:pt idx="2497">
                  <c:v>6.4316999999999999E-2</c:v>
                </c:pt>
                <c:pt idx="2498">
                  <c:v>6.4316999999999999E-2</c:v>
                </c:pt>
                <c:pt idx="2499">
                  <c:v>6.4316999999999999E-2</c:v>
                </c:pt>
                <c:pt idx="2500">
                  <c:v>6.4316999999999999E-2</c:v>
                </c:pt>
                <c:pt idx="2501">
                  <c:v>6.4316999999999999E-2</c:v>
                </c:pt>
                <c:pt idx="2502">
                  <c:v>6.4316999999999999E-2</c:v>
                </c:pt>
                <c:pt idx="2503">
                  <c:v>6.4316999999999999E-2</c:v>
                </c:pt>
                <c:pt idx="2504">
                  <c:v>6.4316999999999999E-2</c:v>
                </c:pt>
                <c:pt idx="2505">
                  <c:v>6.4316999999999999E-2</c:v>
                </c:pt>
                <c:pt idx="2506">
                  <c:v>6.4316999999999999E-2</c:v>
                </c:pt>
                <c:pt idx="2507">
                  <c:v>6.4316999999999999E-2</c:v>
                </c:pt>
                <c:pt idx="2508">
                  <c:v>6.4316999999999999E-2</c:v>
                </c:pt>
                <c:pt idx="2509">
                  <c:v>6.4316999999999999E-2</c:v>
                </c:pt>
                <c:pt idx="2510">
                  <c:v>6.4316999999999999E-2</c:v>
                </c:pt>
                <c:pt idx="2511">
                  <c:v>6.4316999999999999E-2</c:v>
                </c:pt>
                <c:pt idx="2512">
                  <c:v>6.4316999999999999E-2</c:v>
                </c:pt>
                <c:pt idx="2513">
                  <c:v>6.4316999999999999E-2</c:v>
                </c:pt>
                <c:pt idx="2514">
                  <c:v>6.4316999999999999E-2</c:v>
                </c:pt>
                <c:pt idx="2515">
                  <c:v>6.4316999999999999E-2</c:v>
                </c:pt>
                <c:pt idx="2516">
                  <c:v>6.4315999999999998E-2</c:v>
                </c:pt>
                <c:pt idx="2517">
                  <c:v>6.4315999999999998E-2</c:v>
                </c:pt>
                <c:pt idx="2518">
                  <c:v>6.4315999999999998E-2</c:v>
                </c:pt>
                <c:pt idx="2519">
                  <c:v>6.4315999999999998E-2</c:v>
                </c:pt>
                <c:pt idx="2520">
                  <c:v>6.4315999999999998E-2</c:v>
                </c:pt>
                <c:pt idx="2521">
                  <c:v>6.4315999999999998E-2</c:v>
                </c:pt>
                <c:pt idx="2522">
                  <c:v>6.4315999999999998E-2</c:v>
                </c:pt>
                <c:pt idx="2523">
                  <c:v>6.4315999999999998E-2</c:v>
                </c:pt>
                <c:pt idx="2524">
                  <c:v>6.4315999999999998E-2</c:v>
                </c:pt>
                <c:pt idx="2525">
                  <c:v>6.4315999999999998E-2</c:v>
                </c:pt>
                <c:pt idx="2526">
                  <c:v>6.4315999999999998E-2</c:v>
                </c:pt>
                <c:pt idx="2527">
                  <c:v>6.4315999999999998E-2</c:v>
                </c:pt>
                <c:pt idx="2528">
                  <c:v>6.4315999999999998E-2</c:v>
                </c:pt>
                <c:pt idx="2529">
                  <c:v>6.4315999999999998E-2</c:v>
                </c:pt>
                <c:pt idx="2530">
                  <c:v>6.4315999999999998E-2</c:v>
                </c:pt>
                <c:pt idx="2531">
                  <c:v>6.4315999999999998E-2</c:v>
                </c:pt>
                <c:pt idx="2532">
                  <c:v>6.4315999999999998E-2</c:v>
                </c:pt>
                <c:pt idx="2533">
                  <c:v>6.4315999999999998E-2</c:v>
                </c:pt>
                <c:pt idx="2534">
                  <c:v>6.4315999999999998E-2</c:v>
                </c:pt>
                <c:pt idx="2535">
                  <c:v>6.4315999999999998E-2</c:v>
                </c:pt>
                <c:pt idx="2536">
                  <c:v>6.4315999999999998E-2</c:v>
                </c:pt>
                <c:pt idx="2537">
                  <c:v>6.4315999999999998E-2</c:v>
                </c:pt>
                <c:pt idx="2538">
                  <c:v>6.4315999999999998E-2</c:v>
                </c:pt>
                <c:pt idx="2539">
                  <c:v>6.4315999999999998E-2</c:v>
                </c:pt>
                <c:pt idx="2540">
                  <c:v>6.4315999999999998E-2</c:v>
                </c:pt>
                <c:pt idx="2541">
                  <c:v>6.4315999999999998E-2</c:v>
                </c:pt>
                <c:pt idx="2542">
                  <c:v>6.4315999999999998E-2</c:v>
                </c:pt>
                <c:pt idx="2543">
                  <c:v>6.4315999999999998E-2</c:v>
                </c:pt>
                <c:pt idx="2544">
                  <c:v>6.4314999999999997E-2</c:v>
                </c:pt>
                <c:pt idx="2545">
                  <c:v>6.4314999999999997E-2</c:v>
                </c:pt>
                <c:pt idx="2546">
                  <c:v>6.4314999999999997E-2</c:v>
                </c:pt>
                <c:pt idx="2547">
                  <c:v>6.4314999999999997E-2</c:v>
                </c:pt>
                <c:pt idx="2548">
                  <c:v>6.4314999999999997E-2</c:v>
                </c:pt>
                <c:pt idx="2549">
                  <c:v>6.4314999999999997E-2</c:v>
                </c:pt>
                <c:pt idx="2550">
                  <c:v>6.4314999999999997E-2</c:v>
                </c:pt>
                <c:pt idx="2551">
                  <c:v>6.4314999999999997E-2</c:v>
                </c:pt>
                <c:pt idx="2552">
                  <c:v>6.4314999999999997E-2</c:v>
                </c:pt>
                <c:pt idx="2553">
                  <c:v>6.4314999999999997E-2</c:v>
                </c:pt>
                <c:pt idx="2554">
                  <c:v>6.4314999999999997E-2</c:v>
                </c:pt>
                <c:pt idx="2555">
                  <c:v>6.4314999999999997E-2</c:v>
                </c:pt>
                <c:pt idx="2556">
                  <c:v>6.4314999999999997E-2</c:v>
                </c:pt>
                <c:pt idx="2557">
                  <c:v>6.4314999999999997E-2</c:v>
                </c:pt>
                <c:pt idx="2558">
                  <c:v>6.4314999999999997E-2</c:v>
                </c:pt>
                <c:pt idx="2559">
                  <c:v>6.4314999999999997E-2</c:v>
                </c:pt>
                <c:pt idx="2560">
                  <c:v>6.4314999999999997E-2</c:v>
                </c:pt>
                <c:pt idx="2561">
                  <c:v>6.4314999999999997E-2</c:v>
                </c:pt>
                <c:pt idx="2562">
                  <c:v>6.4314999999999997E-2</c:v>
                </c:pt>
                <c:pt idx="2563">
                  <c:v>6.4314999999999997E-2</c:v>
                </c:pt>
                <c:pt idx="2564">
                  <c:v>6.4314999999999997E-2</c:v>
                </c:pt>
                <c:pt idx="2565">
                  <c:v>6.4314999999999997E-2</c:v>
                </c:pt>
                <c:pt idx="2566">
                  <c:v>6.4314999999999997E-2</c:v>
                </c:pt>
                <c:pt idx="2567">
                  <c:v>6.4314999999999997E-2</c:v>
                </c:pt>
                <c:pt idx="2568">
                  <c:v>6.4314999999999997E-2</c:v>
                </c:pt>
                <c:pt idx="2569">
                  <c:v>6.4314999999999997E-2</c:v>
                </c:pt>
                <c:pt idx="2570">
                  <c:v>6.4314999999999997E-2</c:v>
                </c:pt>
                <c:pt idx="2571">
                  <c:v>6.4314999999999997E-2</c:v>
                </c:pt>
                <c:pt idx="2572">
                  <c:v>6.4314999999999997E-2</c:v>
                </c:pt>
                <c:pt idx="2573">
                  <c:v>6.4314999999999997E-2</c:v>
                </c:pt>
                <c:pt idx="2574">
                  <c:v>6.4313999999999996E-2</c:v>
                </c:pt>
                <c:pt idx="2575">
                  <c:v>6.4313999999999996E-2</c:v>
                </c:pt>
                <c:pt idx="2576">
                  <c:v>6.4313999999999996E-2</c:v>
                </c:pt>
                <c:pt idx="2577">
                  <c:v>6.4313999999999996E-2</c:v>
                </c:pt>
                <c:pt idx="2578">
                  <c:v>6.4313999999999996E-2</c:v>
                </c:pt>
                <c:pt idx="2579">
                  <c:v>6.4313999999999996E-2</c:v>
                </c:pt>
                <c:pt idx="2580">
                  <c:v>6.4313999999999996E-2</c:v>
                </c:pt>
                <c:pt idx="2581">
                  <c:v>6.4313999999999996E-2</c:v>
                </c:pt>
                <c:pt idx="2582">
                  <c:v>6.4313999999999996E-2</c:v>
                </c:pt>
                <c:pt idx="2583">
                  <c:v>6.4313999999999996E-2</c:v>
                </c:pt>
                <c:pt idx="2584">
                  <c:v>6.4313999999999996E-2</c:v>
                </c:pt>
                <c:pt idx="2585">
                  <c:v>6.4313999999999996E-2</c:v>
                </c:pt>
                <c:pt idx="2586">
                  <c:v>6.4313999999999996E-2</c:v>
                </c:pt>
                <c:pt idx="2587">
                  <c:v>6.4313999999999996E-2</c:v>
                </c:pt>
                <c:pt idx="2588">
                  <c:v>6.4313999999999996E-2</c:v>
                </c:pt>
                <c:pt idx="2589">
                  <c:v>6.4313999999999996E-2</c:v>
                </c:pt>
                <c:pt idx="2590">
                  <c:v>6.4313999999999996E-2</c:v>
                </c:pt>
                <c:pt idx="2591">
                  <c:v>6.4313999999999996E-2</c:v>
                </c:pt>
                <c:pt idx="2592">
                  <c:v>6.4313999999999996E-2</c:v>
                </c:pt>
                <c:pt idx="2593">
                  <c:v>6.4313999999999996E-2</c:v>
                </c:pt>
                <c:pt idx="2594">
                  <c:v>6.4313999999999996E-2</c:v>
                </c:pt>
                <c:pt idx="2595">
                  <c:v>6.4313999999999996E-2</c:v>
                </c:pt>
                <c:pt idx="2596">
                  <c:v>6.4313999999999996E-2</c:v>
                </c:pt>
                <c:pt idx="2597">
                  <c:v>6.4313999999999996E-2</c:v>
                </c:pt>
                <c:pt idx="2598">
                  <c:v>6.4313999999999996E-2</c:v>
                </c:pt>
                <c:pt idx="2599">
                  <c:v>6.4313999999999996E-2</c:v>
                </c:pt>
                <c:pt idx="2600">
                  <c:v>6.4313999999999996E-2</c:v>
                </c:pt>
                <c:pt idx="2601">
                  <c:v>6.4313999999999996E-2</c:v>
                </c:pt>
                <c:pt idx="2602">
                  <c:v>6.4313999999999996E-2</c:v>
                </c:pt>
                <c:pt idx="2603">
                  <c:v>6.4313999999999996E-2</c:v>
                </c:pt>
                <c:pt idx="2604">
                  <c:v>6.4313999999999996E-2</c:v>
                </c:pt>
                <c:pt idx="2605">
                  <c:v>6.4313999999999996E-2</c:v>
                </c:pt>
                <c:pt idx="2606">
                  <c:v>6.4313999999999996E-2</c:v>
                </c:pt>
                <c:pt idx="2607">
                  <c:v>6.4312999999999995E-2</c:v>
                </c:pt>
                <c:pt idx="2608">
                  <c:v>6.4312999999999995E-2</c:v>
                </c:pt>
                <c:pt idx="2609">
                  <c:v>6.4312999999999995E-2</c:v>
                </c:pt>
                <c:pt idx="2610">
                  <c:v>6.4312999999999995E-2</c:v>
                </c:pt>
                <c:pt idx="2611">
                  <c:v>6.4312999999999995E-2</c:v>
                </c:pt>
                <c:pt idx="2612">
                  <c:v>6.4312999999999995E-2</c:v>
                </c:pt>
                <c:pt idx="2613">
                  <c:v>6.4312999999999995E-2</c:v>
                </c:pt>
                <c:pt idx="2614">
                  <c:v>6.4312999999999995E-2</c:v>
                </c:pt>
                <c:pt idx="2615">
                  <c:v>6.4312999999999995E-2</c:v>
                </c:pt>
                <c:pt idx="2616">
                  <c:v>6.4312999999999995E-2</c:v>
                </c:pt>
                <c:pt idx="2617">
                  <c:v>6.4312999999999995E-2</c:v>
                </c:pt>
                <c:pt idx="2618">
                  <c:v>6.4312999999999995E-2</c:v>
                </c:pt>
                <c:pt idx="2619">
                  <c:v>6.4312999999999995E-2</c:v>
                </c:pt>
                <c:pt idx="2620">
                  <c:v>6.4312999999999995E-2</c:v>
                </c:pt>
                <c:pt idx="2621">
                  <c:v>6.4312999999999995E-2</c:v>
                </c:pt>
                <c:pt idx="2622">
                  <c:v>6.4312999999999995E-2</c:v>
                </c:pt>
                <c:pt idx="2623">
                  <c:v>6.4312999999999995E-2</c:v>
                </c:pt>
                <c:pt idx="2624">
                  <c:v>6.4312999999999995E-2</c:v>
                </c:pt>
                <c:pt idx="2625">
                  <c:v>6.4312999999999995E-2</c:v>
                </c:pt>
                <c:pt idx="2626">
                  <c:v>6.4312999999999995E-2</c:v>
                </c:pt>
                <c:pt idx="2627">
                  <c:v>6.4312999999999995E-2</c:v>
                </c:pt>
                <c:pt idx="2628">
                  <c:v>6.4312999999999995E-2</c:v>
                </c:pt>
                <c:pt idx="2629">
                  <c:v>6.4312999999999995E-2</c:v>
                </c:pt>
                <c:pt idx="2630">
                  <c:v>6.4312999999999995E-2</c:v>
                </c:pt>
                <c:pt idx="2631">
                  <c:v>6.4312999999999995E-2</c:v>
                </c:pt>
                <c:pt idx="2632">
                  <c:v>6.4312999999999995E-2</c:v>
                </c:pt>
                <c:pt idx="2633">
                  <c:v>6.4312999999999995E-2</c:v>
                </c:pt>
                <c:pt idx="2634">
                  <c:v>6.4312999999999995E-2</c:v>
                </c:pt>
                <c:pt idx="2635">
                  <c:v>6.4312999999999995E-2</c:v>
                </c:pt>
                <c:pt idx="2636">
                  <c:v>6.4312999999999995E-2</c:v>
                </c:pt>
                <c:pt idx="2637">
                  <c:v>6.4312999999999995E-2</c:v>
                </c:pt>
                <c:pt idx="2638">
                  <c:v>6.4312999999999995E-2</c:v>
                </c:pt>
                <c:pt idx="2639">
                  <c:v>6.4312999999999995E-2</c:v>
                </c:pt>
                <c:pt idx="2640">
                  <c:v>6.4312999999999995E-2</c:v>
                </c:pt>
                <c:pt idx="2641">
                  <c:v>6.4312999999999995E-2</c:v>
                </c:pt>
                <c:pt idx="2642">
                  <c:v>6.4312999999999995E-2</c:v>
                </c:pt>
                <c:pt idx="2643">
                  <c:v>6.4311999999999994E-2</c:v>
                </c:pt>
                <c:pt idx="2644">
                  <c:v>6.4311999999999994E-2</c:v>
                </c:pt>
                <c:pt idx="2645">
                  <c:v>6.4311999999999994E-2</c:v>
                </c:pt>
                <c:pt idx="2646">
                  <c:v>6.4311999999999994E-2</c:v>
                </c:pt>
                <c:pt idx="2647">
                  <c:v>6.4311999999999994E-2</c:v>
                </c:pt>
                <c:pt idx="2648">
                  <c:v>6.4311999999999994E-2</c:v>
                </c:pt>
                <c:pt idx="2649">
                  <c:v>6.4311999999999994E-2</c:v>
                </c:pt>
                <c:pt idx="2650">
                  <c:v>6.4311999999999994E-2</c:v>
                </c:pt>
                <c:pt idx="2651">
                  <c:v>6.4311999999999994E-2</c:v>
                </c:pt>
                <c:pt idx="2652">
                  <c:v>6.4311999999999994E-2</c:v>
                </c:pt>
                <c:pt idx="2653">
                  <c:v>6.4311999999999994E-2</c:v>
                </c:pt>
                <c:pt idx="2654">
                  <c:v>6.4311999999999994E-2</c:v>
                </c:pt>
                <c:pt idx="2655">
                  <c:v>6.4311999999999994E-2</c:v>
                </c:pt>
                <c:pt idx="2656">
                  <c:v>6.4311999999999994E-2</c:v>
                </c:pt>
                <c:pt idx="2657">
                  <c:v>6.4311999999999994E-2</c:v>
                </c:pt>
                <c:pt idx="2658">
                  <c:v>6.4311999999999994E-2</c:v>
                </c:pt>
                <c:pt idx="2659">
                  <c:v>6.4311999999999994E-2</c:v>
                </c:pt>
                <c:pt idx="2660">
                  <c:v>6.4311999999999994E-2</c:v>
                </c:pt>
                <c:pt idx="2661">
                  <c:v>6.4311999999999994E-2</c:v>
                </c:pt>
                <c:pt idx="2662">
                  <c:v>6.4311999999999994E-2</c:v>
                </c:pt>
                <c:pt idx="2663">
                  <c:v>6.4311999999999994E-2</c:v>
                </c:pt>
                <c:pt idx="2664">
                  <c:v>6.4311999999999994E-2</c:v>
                </c:pt>
                <c:pt idx="2665">
                  <c:v>6.4311999999999994E-2</c:v>
                </c:pt>
                <c:pt idx="2666">
                  <c:v>6.4311999999999994E-2</c:v>
                </c:pt>
                <c:pt idx="2667">
                  <c:v>6.4311999999999994E-2</c:v>
                </c:pt>
                <c:pt idx="2668">
                  <c:v>6.4311999999999994E-2</c:v>
                </c:pt>
                <c:pt idx="2669">
                  <c:v>6.4311999999999994E-2</c:v>
                </c:pt>
                <c:pt idx="2670">
                  <c:v>6.4311999999999994E-2</c:v>
                </c:pt>
                <c:pt idx="2671">
                  <c:v>6.4311999999999994E-2</c:v>
                </c:pt>
                <c:pt idx="2672">
                  <c:v>6.4311999999999994E-2</c:v>
                </c:pt>
                <c:pt idx="2673">
                  <c:v>6.4311999999999994E-2</c:v>
                </c:pt>
                <c:pt idx="2674">
                  <c:v>6.4311999999999994E-2</c:v>
                </c:pt>
                <c:pt idx="2675">
                  <c:v>6.4311999999999994E-2</c:v>
                </c:pt>
                <c:pt idx="2676">
                  <c:v>6.4311999999999994E-2</c:v>
                </c:pt>
                <c:pt idx="2677">
                  <c:v>6.4311999999999994E-2</c:v>
                </c:pt>
                <c:pt idx="2678">
                  <c:v>6.4311999999999994E-2</c:v>
                </c:pt>
                <c:pt idx="2679">
                  <c:v>6.4311999999999994E-2</c:v>
                </c:pt>
                <c:pt idx="2680">
                  <c:v>6.4311999999999994E-2</c:v>
                </c:pt>
                <c:pt idx="2681">
                  <c:v>6.4311999999999994E-2</c:v>
                </c:pt>
                <c:pt idx="2682">
                  <c:v>6.4311999999999994E-2</c:v>
                </c:pt>
                <c:pt idx="2683">
                  <c:v>6.4310999999999993E-2</c:v>
                </c:pt>
                <c:pt idx="2684">
                  <c:v>6.4310999999999993E-2</c:v>
                </c:pt>
                <c:pt idx="2685">
                  <c:v>6.4310999999999993E-2</c:v>
                </c:pt>
                <c:pt idx="2686">
                  <c:v>6.4310999999999993E-2</c:v>
                </c:pt>
                <c:pt idx="2687">
                  <c:v>6.4310999999999993E-2</c:v>
                </c:pt>
                <c:pt idx="2688">
                  <c:v>6.4310999999999993E-2</c:v>
                </c:pt>
                <c:pt idx="2689">
                  <c:v>6.4310999999999993E-2</c:v>
                </c:pt>
                <c:pt idx="2690">
                  <c:v>6.4310999999999993E-2</c:v>
                </c:pt>
                <c:pt idx="2691">
                  <c:v>6.4310999999999993E-2</c:v>
                </c:pt>
                <c:pt idx="2692">
                  <c:v>6.4310999999999993E-2</c:v>
                </c:pt>
                <c:pt idx="2693">
                  <c:v>6.4310999999999993E-2</c:v>
                </c:pt>
                <c:pt idx="2694">
                  <c:v>6.4310999999999993E-2</c:v>
                </c:pt>
                <c:pt idx="2695">
                  <c:v>6.4310999999999993E-2</c:v>
                </c:pt>
                <c:pt idx="2696">
                  <c:v>6.4310999999999993E-2</c:v>
                </c:pt>
                <c:pt idx="2697">
                  <c:v>6.4310999999999993E-2</c:v>
                </c:pt>
                <c:pt idx="2698">
                  <c:v>6.4310999999999993E-2</c:v>
                </c:pt>
                <c:pt idx="2699">
                  <c:v>6.4310999999999993E-2</c:v>
                </c:pt>
                <c:pt idx="2700">
                  <c:v>6.4310999999999993E-2</c:v>
                </c:pt>
                <c:pt idx="2701">
                  <c:v>6.4310999999999993E-2</c:v>
                </c:pt>
                <c:pt idx="2702">
                  <c:v>6.4310999999999993E-2</c:v>
                </c:pt>
                <c:pt idx="2703">
                  <c:v>6.4310999999999993E-2</c:v>
                </c:pt>
                <c:pt idx="2704">
                  <c:v>6.4310999999999993E-2</c:v>
                </c:pt>
                <c:pt idx="2705">
                  <c:v>6.4310999999999993E-2</c:v>
                </c:pt>
                <c:pt idx="2706">
                  <c:v>6.4310999999999993E-2</c:v>
                </c:pt>
                <c:pt idx="2707">
                  <c:v>6.4310999999999993E-2</c:v>
                </c:pt>
                <c:pt idx="2708">
                  <c:v>6.4310999999999993E-2</c:v>
                </c:pt>
                <c:pt idx="2709">
                  <c:v>6.4310999999999993E-2</c:v>
                </c:pt>
                <c:pt idx="2710">
                  <c:v>6.4310999999999993E-2</c:v>
                </c:pt>
                <c:pt idx="2711">
                  <c:v>6.4310999999999993E-2</c:v>
                </c:pt>
                <c:pt idx="2712">
                  <c:v>6.4310999999999993E-2</c:v>
                </c:pt>
                <c:pt idx="2713">
                  <c:v>6.4310999999999993E-2</c:v>
                </c:pt>
                <c:pt idx="2714">
                  <c:v>6.4310999999999993E-2</c:v>
                </c:pt>
                <c:pt idx="2715">
                  <c:v>6.4310999999999993E-2</c:v>
                </c:pt>
                <c:pt idx="2716">
                  <c:v>6.4310999999999993E-2</c:v>
                </c:pt>
                <c:pt idx="2717">
                  <c:v>6.4310999999999993E-2</c:v>
                </c:pt>
                <c:pt idx="2718">
                  <c:v>6.4310999999999993E-2</c:v>
                </c:pt>
                <c:pt idx="2719">
                  <c:v>6.4310999999999993E-2</c:v>
                </c:pt>
                <c:pt idx="2720">
                  <c:v>6.4310999999999993E-2</c:v>
                </c:pt>
                <c:pt idx="2721">
                  <c:v>6.4310999999999993E-2</c:v>
                </c:pt>
                <c:pt idx="2722">
                  <c:v>6.4310999999999993E-2</c:v>
                </c:pt>
                <c:pt idx="2723">
                  <c:v>6.4310999999999993E-2</c:v>
                </c:pt>
                <c:pt idx="2724">
                  <c:v>6.4310999999999993E-2</c:v>
                </c:pt>
                <c:pt idx="2725">
                  <c:v>6.4310999999999993E-2</c:v>
                </c:pt>
                <c:pt idx="2726">
                  <c:v>6.4310999999999993E-2</c:v>
                </c:pt>
                <c:pt idx="2727">
                  <c:v>6.4310000000000006E-2</c:v>
                </c:pt>
                <c:pt idx="2728">
                  <c:v>6.4310000000000006E-2</c:v>
                </c:pt>
                <c:pt idx="2729">
                  <c:v>6.4310000000000006E-2</c:v>
                </c:pt>
                <c:pt idx="2730">
                  <c:v>6.4310000000000006E-2</c:v>
                </c:pt>
                <c:pt idx="2731">
                  <c:v>6.4310000000000006E-2</c:v>
                </c:pt>
                <c:pt idx="2732">
                  <c:v>6.4310000000000006E-2</c:v>
                </c:pt>
                <c:pt idx="2733">
                  <c:v>6.4310000000000006E-2</c:v>
                </c:pt>
                <c:pt idx="2734">
                  <c:v>6.4310000000000006E-2</c:v>
                </c:pt>
                <c:pt idx="2735">
                  <c:v>6.4310000000000006E-2</c:v>
                </c:pt>
                <c:pt idx="2736">
                  <c:v>6.4310000000000006E-2</c:v>
                </c:pt>
                <c:pt idx="2737">
                  <c:v>6.4310000000000006E-2</c:v>
                </c:pt>
                <c:pt idx="2738">
                  <c:v>6.4310000000000006E-2</c:v>
                </c:pt>
                <c:pt idx="2739">
                  <c:v>6.4310000000000006E-2</c:v>
                </c:pt>
                <c:pt idx="2740">
                  <c:v>6.4310000000000006E-2</c:v>
                </c:pt>
                <c:pt idx="2741">
                  <c:v>6.4310000000000006E-2</c:v>
                </c:pt>
                <c:pt idx="2742">
                  <c:v>6.4310000000000006E-2</c:v>
                </c:pt>
                <c:pt idx="2743">
                  <c:v>6.4310000000000006E-2</c:v>
                </c:pt>
                <c:pt idx="2744">
                  <c:v>6.4310000000000006E-2</c:v>
                </c:pt>
                <c:pt idx="2745">
                  <c:v>6.4310000000000006E-2</c:v>
                </c:pt>
                <c:pt idx="2746">
                  <c:v>6.4310000000000006E-2</c:v>
                </c:pt>
                <c:pt idx="2747">
                  <c:v>6.4310000000000006E-2</c:v>
                </c:pt>
                <c:pt idx="2748">
                  <c:v>6.4310000000000006E-2</c:v>
                </c:pt>
                <c:pt idx="2749">
                  <c:v>6.4310000000000006E-2</c:v>
                </c:pt>
                <c:pt idx="2750">
                  <c:v>6.4310000000000006E-2</c:v>
                </c:pt>
                <c:pt idx="2751">
                  <c:v>6.4310000000000006E-2</c:v>
                </c:pt>
                <c:pt idx="2752">
                  <c:v>6.4310000000000006E-2</c:v>
                </c:pt>
                <c:pt idx="2753">
                  <c:v>6.4310000000000006E-2</c:v>
                </c:pt>
                <c:pt idx="2754">
                  <c:v>6.4310000000000006E-2</c:v>
                </c:pt>
                <c:pt idx="2755">
                  <c:v>6.4310000000000006E-2</c:v>
                </c:pt>
                <c:pt idx="2756">
                  <c:v>6.4310000000000006E-2</c:v>
                </c:pt>
                <c:pt idx="2757">
                  <c:v>6.4310000000000006E-2</c:v>
                </c:pt>
                <c:pt idx="2758">
                  <c:v>6.4310000000000006E-2</c:v>
                </c:pt>
                <c:pt idx="2759">
                  <c:v>6.4310000000000006E-2</c:v>
                </c:pt>
                <c:pt idx="2760">
                  <c:v>6.4310000000000006E-2</c:v>
                </c:pt>
                <c:pt idx="2761">
                  <c:v>6.4310000000000006E-2</c:v>
                </c:pt>
                <c:pt idx="2762">
                  <c:v>6.4310000000000006E-2</c:v>
                </c:pt>
                <c:pt idx="2763">
                  <c:v>6.4310000000000006E-2</c:v>
                </c:pt>
                <c:pt idx="2764">
                  <c:v>6.4310000000000006E-2</c:v>
                </c:pt>
                <c:pt idx="2765">
                  <c:v>6.4310000000000006E-2</c:v>
                </c:pt>
                <c:pt idx="2766">
                  <c:v>6.4310000000000006E-2</c:v>
                </c:pt>
                <c:pt idx="2767">
                  <c:v>6.4310000000000006E-2</c:v>
                </c:pt>
                <c:pt idx="2768">
                  <c:v>6.4310000000000006E-2</c:v>
                </c:pt>
                <c:pt idx="2769">
                  <c:v>6.4310000000000006E-2</c:v>
                </c:pt>
                <c:pt idx="2770">
                  <c:v>6.4310000000000006E-2</c:v>
                </c:pt>
                <c:pt idx="2771">
                  <c:v>6.4310000000000006E-2</c:v>
                </c:pt>
                <c:pt idx="2772">
                  <c:v>6.4310000000000006E-2</c:v>
                </c:pt>
                <c:pt idx="2773">
                  <c:v>6.4310000000000006E-2</c:v>
                </c:pt>
                <c:pt idx="2774">
                  <c:v>6.4310000000000006E-2</c:v>
                </c:pt>
                <c:pt idx="2775">
                  <c:v>6.4310000000000006E-2</c:v>
                </c:pt>
                <c:pt idx="2776">
                  <c:v>6.4310000000000006E-2</c:v>
                </c:pt>
                <c:pt idx="2777">
                  <c:v>6.4309000000000005E-2</c:v>
                </c:pt>
                <c:pt idx="2778">
                  <c:v>6.4309000000000005E-2</c:v>
                </c:pt>
                <c:pt idx="2779">
                  <c:v>6.4309000000000005E-2</c:v>
                </c:pt>
                <c:pt idx="2780">
                  <c:v>6.4309000000000005E-2</c:v>
                </c:pt>
                <c:pt idx="2781">
                  <c:v>6.4309000000000005E-2</c:v>
                </c:pt>
                <c:pt idx="2782">
                  <c:v>6.4309000000000005E-2</c:v>
                </c:pt>
                <c:pt idx="2783">
                  <c:v>6.4309000000000005E-2</c:v>
                </c:pt>
                <c:pt idx="2784">
                  <c:v>6.4309000000000005E-2</c:v>
                </c:pt>
                <c:pt idx="2785">
                  <c:v>6.4309000000000005E-2</c:v>
                </c:pt>
                <c:pt idx="2786">
                  <c:v>6.4309000000000005E-2</c:v>
                </c:pt>
                <c:pt idx="2787">
                  <c:v>6.4309000000000005E-2</c:v>
                </c:pt>
                <c:pt idx="2788">
                  <c:v>6.4309000000000005E-2</c:v>
                </c:pt>
                <c:pt idx="2789">
                  <c:v>6.4309000000000005E-2</c:v>
                </c:pt>
                <c:pt idx="2790">
                  <c:v>6.4309000000000005E-2</c:v>
                </c:pt>
                <c:pt idx="2791">
                  <c:v>6.4309000000000005E-2</c:v>
                </c:pt>
                <c:pt idx="2792">
                  <c:v>6.4309000000000005E-2</c:v>
                </c:pt>
                <c:pt idx="2793">
                  <c:v>6.4309000000000005E-2</c:v>
                </c:pt>
                <c:pt idx="2794">
                  <c:v>6.4309000000000005E-2</c:v>
                </c:pt>
                <c:pt idx="2795">
                  <c:v>6.4309000000000005E-2</c:v>
                </c:pt>
                <c:pt idx="2796">
                  <c:v>6.4309000000000005E-2</c:v>
                </c:pt>
                <c:pt idx="2797">
                  <c:v>6.4309000000000005E-2</c:v>
                </c:pt>
                <c:pt idx="2798">
                  <c:v>6.4309000000000005E-2</c:v>
                </c:pt>
                <c:pt idx="2799">
                  <c:v>6.4309000000000005E-2</c:v>
                </c:pt>
                <c:pt idx="2800">
                  <c:v>6.4309000000000005E-2</c:v>
                </c:pt>
                <c:pt idx="2801">
                  <c:v>6.4309000000000005E-2</c:v>
                </c:pt>
                <c:pt idx="2802">
                  <c:v>6.4309000000000005E-2</c:v>
                </c:pt>
                <c:pt idx="2803">
                  <c:v>6.4309000000000005E-2</c:v>
                </c:pt>
                <c:pt idx="2804">
                  <c:v>6.4309000000000005E-2</c:v>
                </c:pt>
                <c:pt idx="2805">
                  <c:v>6.4309000000000005E-2</c:v>
                </c:pt>
                <c:pt idx="2806">
                  <c:v>6.4309000000000005E-2</c:v>
                </c:pt>
                <c:pt idx="2807">
                  <c:v>6.4309000000000005E-2</c:v>
                </c:pt>
                <c:pt idx="2808">
                  <c:v>6.4309000000000005E-2</c:v>
                </c:pt>
                <c:pt idx="2809">
                  <c:v>6.4309000000000005E-2</c:v>
                </c:pt>
                <c:pt idx="2810">
                  <c:v>6.4309000000000005E-2</c:v>
                </c:pt>
                <c:pt idx="2811">
                  <c:v>6.4309000000000005E-2</c:v>
                </c:pt>
                <c:pt idx="2812">
                  <c:v>6.4309000000000005E-2</c:v>
                </c:pt>
                <c:pt idx="2813">
                  <c:v>6.4309000000000005E-2</c:v>
                </c:pt>
                <c:pt idx="2814">
                  <c:v>6.4309000000000005E-2</c:v>
                </c:pt>
                <c:pt idx="2815">
                  <c:v>6.4309000000000005E-2</c:v>
                </c:pt>
                <c:pt idx="2816">
                  <c:v>6.4309000000000005E-2</c:v>
                </c:pt>
                <c:pt idx="2817">
                  <c:v>6.4309000000000005E-2</c:v>
                </c:pt>
                <c:pt idx="2818">
                  <c:v>6.4309000000000005E-2</c:v>
                </c:pt>
                <c:pt idx="2819">
                  <c:v>6.4309000000000005E-2</c:v>
                </c:pt>
                <c:pt idx="2820">
                  <c:v>6.4309000000000005E-2</c:v>
                </c:pt>
                <c:pt idx="2821">
                  <c:v>6.4309000000000005E-2</c:v>
                </c:pt>
                <c:pt idx="2822">
                  <c:v>6.4309000000000005E-2</c:v>
                </c:pt>
                <c:pt idx="2823">
                  <c:v>6.4309000000000005E-2</c:v>
                </c:pt>
                <c:pt idx="2824">
                  <c:v>6.4309000000000005E-2</c:v>
                </c:pt>
                <c:pt idx="2825">
                  <c:v>6.4309000000000005E-2</c:v>
                </c:pt>
                <c:pt idx="2826">
                  <c:v>6.4309000000000005E-2</c:v>
                </c:pt>
                <c:pt idx="2827">
                  <c:v>6.4309000000000005E-2</c:v>
                </c:pt>
                <c:pt idx="2828">
                  <c:v>6.4309000000000005E-2</c:v>
                </c:pt>
                <c:pt idx="2829">
                  <c:v>6.4309000000000005E-2</c:v>
                </c:pt>
                <c:pt idx="2830">
                  <c:v>6.4309000000000005E-2</c:v>
                </c:pt>
                <c:pt idx="2831">
                  <c:v>6.4309000000000005E-2</c:v>
                </c:pt>
                <c:pt idx="2832">
                  <c:v>6.4309000000000005E-2</c:v>
                </c:pt>
                <c:pt idx="2833">
                  <c:v>6.4309000000000005E-2</c:v>
                </c:pt>
                <c:pt idx="2834">
                  <c:v>6.4309000000000005E-2</c:v>
                </c:pt>
                <c:pt idx="2835">
                  <c:v>6.4308000000000004E-2</c:v>
                </c:pt>
                <c:pt idx="2836">
                  <c:v>6.4308000000000004E-2</c:v>
                </c:pt>
                <c:pt idx="2837">
                  <c:v>6.4308000000000004E-2</c:v>
                </c:pt>
                <c:pt idx="2838">
                  <c:v>6.4308000000000004E-2</c:v>
                </c:pt>
                <c:pt idx="2839">
                  <c:v>6.4308000000000004E-2</c:v>
                </c:pt>
                <c:pt idx="2840">
                  <c:v>6.4308000000000004E-2</c:v>
                </c:pt>
                <c:pt idx="2841">
                  <c:v>6.4308000000000004E-2</c:v>
                </c:pt>
                <c:pt idx="2842">
                  <c:v>6.4308000000000004E-2</c:v>
                </c:pt>
                <c:pt idx="2843">
                  <c:v>6.4308000000000004E-2</c:v>
                </c:pt>
                <c:pt idx="2844">
                  <c:v>6.4308000000000004E-2</c:v>
                </c:pt>
                <c:pt idx="2845">
                  <c:v>6.4308000000000004E-2</c:v>
                </c:pt>
                <c:pt idx="2846">
                  <c:v>6.4308000000000004E-2</c:v>
                </c:pt>
                <c:pt idx="2847">
                  <c:v>6.4308000000000004E-2</c:v>
                </c:pt>
                <c:pt idx="2848">
                  <c:v>6.4308000000000004E-2</c:v>
                </c:pt>
                <c:pt idx="2849">
                  <c:v>6.4308000000000004E-2</c:v>
                </c:pt>
                <c:pt idx="2850">
                  <c:v>6.4308000000000004E-2</c:v>
                </c:pt>
                <c:pt idx="2851">
                  <c:v>6.4308000000000004E-2</c:v>
                </c:pt>
                <c:pt idx="2852">
                  <c:v>6.4308000000000004E-2</c:v>
                </c:pt>
                <c:pt idx="2853">
                  <c:v>6.4308000000000004E-2</c:v>
                </c:pt>
                <c:pt idx="2854">
                  <c:v>6.4308000000000004E-2</c:v>
                </c:pt>
                <c:pt idx="2855">
                  <c:v>6.4308000000000004E-2</c:v>
                </c:pt>
                <c:pt idx="2856">
                  <c:v>6.4308000000000004E-2</c:v>
                </c:pt>
                <c:pt idx="2857">
                  <c:v>6.4308000000000004E-2</c:v>
                </c:pt>
                <c:pt idx="2858">
                  <c:v>6.4308000000000004E-2</c:v>
                </c:pt>
                <c:pt idx="2859">
                  <c:v>6.4308000000000004E-2</c:v>
                </c:pt>
                <c:pt idx="2860">
                  <c:v>6.4308000000000004E-2</c:v>
                </c:pt>
                <c:pt idx="2861">
                  <c:v>6.4308000000000004E-2</c:v>
                </c:pt>
                <c:pt idx="2862">
                  <c:v>6.4308000000000004E-2</c:v>
                </c:pt>
                <c:pt idx="2863">
                  <c:v>6.4308000000000004E-2</c:v>
                </c:pt>
                <c:pt idx="2864">
                  <c:v>6.4308000000000004E-2</c:v>
                </c:pt>
                <c:pt idx="2865">
                  <c:v>6.4308000000000004E-2</c:v>
                </c:pt>
                <c:pt idx="2866">
                  <c:v>6.4308000000000004E-2</c:v>
                </c:pt>
                <c:pt idx="2867">
                  <c:v>6.4308000000000004E-2</c:v>
                </c:pt>
                <c:pt idx="2868">
                  <c:v>6.4308000000000004E-2</c:v>
                </c:pt>
                <c:pt idx="2869">
                  <c:v>6.4308000000000004E-2</c:v>
                </c:pt>
                <c:pt idx="2870">
                  <c:v>6.4308000000000004E-2</c:v>
                </c:pt>
                <c:pt idx="2871">
                  <c:v>6.4308000000000004E-2</c:v>
                </c:pt>
                <c:pt idx="2872">
                  <c:v>6.4308000000000004E-2</c:v>
                </c:pt>
                <c:pt idx="2873">
                  <c:v>6.4308000000000004E-2</c:v>
                </c:pt>
                <c:pt idx="2874">
                  <c:v>6.4308000000000004E-2</c:v>
                </c:pt>
                <c:pt idx="2875">
                  <c:v>6.4308000000000004E-2</c:v>
                </c:pt>
                <c:pt idx="2876">
                  <c:v>6.4308000000000004E-2</c:v>
                </c:pt>
                <c:pt idx="2877">
                  <c:v>6.4308000000000004E-2</c:v>
                </c:pt>
                <c:pt idx="2878">
                  <c:v>6.4308000000000004E-2</c:v>
                </c:pt>
                <c:pt idx="2879">
                  <c:v>6.4308000000000004E-2</c:v>
                </c:pt>
                <c:pt idx="2880">
                  <c:v>6.4308000000000004E-2</c:v>
                </c:pt>
                <c:pt idx="2881">
                  <c:v>6.4308000000000004E-2</c:v>
                </c:pt>
                <c:pt idx="2882">
                  <c:v>6.4308000000000004E-2</c:v>
                </c:pt>
                <c:pt idx="2883">
                  <c:v>6.4308000000000004E-2</c:v>
                </c:pt>
                <c:pt idx="2884">
                  <c:v>6.4308000000000004E-2</c:v>
                </c:pt>
                <c:pt idx="2885">
                  <c:v>6.4308000000000004E-2</c:v>
                </c:pt>
                <c:pt idx="2886">
                  <c:v>6.4308000000000004E-2</c:v>
                </c:pt>
                <c:pt idx="2887">
                  <c:v>6.4308000000000004E-2</c:v>
                </c:pt>
                <c:pt idx="2888">
                  <c:v>6.4308000000000004E-2</c:v>
                </c:pt>
                <c:pt idx="2889">
                  <c:v>6.4308000000000004E-2</c:v>
                </c:pt>
                <c:pt idx="2890">
                  <c:v>6.4308000000000004E-2</c:v>
                </c:pt>
                <c:pt idx="2891">
                  <c:v>6.4308000000000004E-2</c:v>
                </c:pt>
                <c:pt idx="2892">
                  <c:v>6.4308000000000004E-2</c:v>
                </c:pt>
                <c:pt idx="2893">
                  <c:v>6.4308000000000004E-2</c:v>
                </c:pt>
                <c:pt idx="2894">
                  <c:v>6.4308000000000004E-2</c:v>
                </c:pt>
                <c:pt idx="2895">
                  <c:v>6.4308000000000004E-2</c:v>
                </c:pt>
                <c:pt idx="2896">
                  <c:v>6.4308000000000004E-2</c:v>
                </c:pt>
                <c:pt idx="2897">
                  <c:v>6.4308000000000004E-2</c:v>
                </c:pt>
                <c:pt idx="2898">
                  <c:v>6.4308000000000004E-2</c:v>
                </c:pt>
                <c:pt idx="2899">
                  <c:v>6.4308000000000004E-2</c:v>
                </c:pt>
                <c:pt idx="2900">
                  <c:v>6.4308000000000004E-2</c:v>
                </c:pt>
                <c:pt idx="2901">
                  <c:v>6.4308000000000004E-2</c:v>
                </c:pt>
                <c:pt idx="2902">
                  <c:v>6.4308000000000004E-2</c:v>
                </c:pt>
                <c:pt idx="2903">
                  <c:v>6.4307000000000003E-2</c:v>
                </c:pt>
                <c:pt idx="2904">
                  <c:v>6.4307000000000003E-2</c:v>
                </c:pt>
                <c:pt idx="2905">
                  <c:v>6.4307000000000003E-2</c:v>
                </c:pt>
                <c:pt idx="2906">
                  <c:v>6.4307000000000003E-2</c:v>
                </c:pt>
                <c:pt idx="2907">
                  <c:v>6.4307000000000003E-2</c:v>
                </c:pt>
                <c:pt idx="2908">
                  <c:v>6.4307000000000003E-2</c:v>
                </c:pt>
                <c:pt idx="2909">
                  <c:v>6.4307000000000003E-2</c:v>
                </c:pt>
                <c:pt idx="2910">
                  <c:v>6.4307000000000003E-2</c:v>
                </c:pt>
                <c:pt idx="2911">
                  <c:v>6.4307000000000003E-2</c:v>
                </c:pt>
                <c:pt idx="2912">
                  <c:v>6.4307000000000003E-2</c:v>
                </c:pt>
                <c:pt idx="2913">
                  <c:v>6.4307000000000003E-2</c:v>
                </c:pt>
                <c:pt idx="2914">
                  <c:v>6.4307000000000003E-2</c:v>
                </c:pt>
                <c:pt idx="2915">
                  <c:v>6.4307000000000003E-2</c:v>
                </c:pt>
                <c:pt idx="2916">
                  <c:v>6.4307000000000003E-2</c:v>
                </c:pt>
                <c:pt idx="2917">
                  <c:v>6.4307000000000003E-2</c:v>
                </c:pt>
                <c:pt idx="2918">
                  <c:v>6.4307000000000003E-2</c:v>
                </c:pt>
                <c:pt idx="2919">
                  <c:v>6.4307000000000003E-2</c:v>
                </c:pt>
                <c:pt idx="2920">
                  <c:v>6.4307000000000003E-2</c:v>
                </c:pt>
                <c:pt idx="2921">
                  <c:v>6.4307000000000003E-2</c:v>
                </c:pt>
                <c:pt idx="2922">
                  <c:v>6.4307000000000003E-2</c:v>
                </c:pt>
                <c:pt idx="2923">
                  <c:v>6.4307000000000003E-2</c:v>
                </c:pt>
                <c:pt idx="2924">
                  <c:v>6.4307000000000003E-2</c:v>
                </c:pt>
                <c:pt idx="2925">
                  <c:v>6.4307000000000003E-2</c:v>
                </c:pt>
                <c:pt idx="2926">
                  <c:v>6.4307000000000003E-2</c:v>
                </c:pt>
                <c:pt idx="2927">
                  <c:v>6.4307000000000003E-2</c:v>
                </c:pt>
                <c:pt idx="2928">
                  <c:v>6.4307000000000003E-2</c:v>
                </c:pt>
                <c:pt idx="2929">
                  <c:v>6.4307000000000003E-2</c:v>
                </c:pt>
                <c:pt idx="2930">
                  <c:v>6.4307000000000003E-2</c:v>
                </c:pt>
                <c:pt idx="2931">
                  <c:v>6.4307000000000003E-2</c:v>
                </c:pt>
                <c:pt idx="2932">
                  <c:v>6.4307000000000003E-2</c:v>
                </c:pt>
                <c:pt idx="2933">
                  <c:v>6.4307000000000003E-2</c:v>
                </c:pt>
                <c:pt idx="2934">
                  <c:v>6.4307000000000003E-2</c:v>
                </c:pt>
                <c:pt idx="2935">
                  <c:v>6.4307000000000003E-2</c:v>
                </c:pt>
                <c:pt idx="2936">
                  <c:v>6.4307000000000003E-2</c:v>
                </c:pt>
                <c:pt idx="2937">
                  <c:v>6.4307000000000003E-2</c:v>
                </c:pt>
                <c:pt idx="2938">
                  <c:v>6.4307000000000003E-2</c:v>
                </c:pt>
                <c:pt idx="2939">
                  <c:v>6.4307000000000003E-2</c:v>
                </c:pt>
                <c:pt idx="2940">
                  <c:v>6.4307000000000003E-2</c:v>
                </c:pt>
                <c:pt idx="2941">
                  <c:v>6.4307000000000003E-2</c:v>
                </c:pt>
                <c:pt idx="2942">
                  <c:v>6.4307000000000003E-2</c:v>
                </c:pt>
                <c:pt idx="2943">
                  <c:v>6.4307000000000003E-2</c:v>
                </c:pt>
                <c:pt idx="2944">
                  <c:v>6.4307000000000003E-2</c:v>
                </c:pt>
                <c:pt idx="2945">
                  <c:v>6.4307000000000003E-2</c:v>
                </c:pt>
                <c:pt idx="2946">
                  <c:v>6.4307000000000003E-2</c:v>
                </c:pt>
                <c:pt idx="2947">
                  <c:v>6.4307000000000003E-2</c:v>
                </c:pt>
                <c:pt idx="2948">
                  <c:v>6.4307000000000003E-2</c:v>
                </c:pt>
                <c:pt idx="2949">
                  <c:v>6.4307000000000003E-2</c:v>
                </c:pt>
                <c:pt idx="2950">
                  <c:v>6.4307000000000003E-2</c:v>
                </c:pt>
                <c:pt idx="2951">
                  <c:v>6.4307000000000003E-2</c:v>
                </c:pt>
                <c:pt idx="2952">
                  <c:v>6.4307000000000003E-2</c:v>
                </c:pt>
                <c:pt idx="2953">
                  <c:v>6.4307000000000003E-2</c:v>
                </c:pt>
                <c:pt idx="2954">
                  <c:v>6.4307000000000003E-2</c:v>
                </c:pt>
                <c:pt idx="2955">
                  <c:v>6.4307000000000003E-2</c:v>
                </c:pt>
                <c:pt idx="2956">
                  <c:v>6.4307000000000003E-2</c:v>
                </c:pt>
                <c:pt idx="2957">
                  <c:v>6.4307000000000003E-2</c:v>
                </c:pt>
                <c:pt idx="2958">
                  <c:v>6.4307000000000003E-2</c:v>
                </c:pt>
                <c:pt idx="2959">
                  <c:v>6.4307000000000003E-2</c:v>
                </c:pt>
                <c:pt idx="2960">
                  <c:v>6.4307000000000003E-2</c:v>
                </c:pt>
                <c:pt idx="2961">
                  <c:v>6.4307000000000003E-2</c:v>
                </c:pt>
                <c:pt idx="2962">
                  <c:v>6.4307000000000003E-2</c:v>
                </c:pt>
                <c:pt idx="2963">
                  <c:v>6.4307000000000003E-2</c:v>
                </c:pt>
                <c:pt idx="2964">
                  <c:v>6.4307000000000003E-2</c:v>
                </c:pt>
                <c:pt idx="2965">
                  <c:v>6.4307000000000003E-2</c:v>
                </c:pt>
                <c:pt idx="2966">
                  <c:v>6.4307000000000003E-2</c:v>
                </c:pt>
                <c:pt idx="2967">
                  <c:v>6.4307000000000003E-2</c:v>
                </c:pt>
                <c:pt idx="2968">
                  <c:v>6.4307000000000003E-2</c:v>
                </c:pt>
                <c:pt idx="2969">
                  <c:v>6.4307000000000003E-2</c:v>
                </c:pt>
                <c:pt idx="2970">
                  <c:v>6.4307000000000003E-2</c:v>
                </c:pt>
                <c:pt idx="2971">
                  <c:v>6.4307000000000003E-2</c:v>
                </c:pt>
                <c:pt idx="2972">
                  <c:v>6.4307000000000003E-2</c:v>
                </c:pt>
                <c:pt idx="2973">
                  <c:v>6.4307000000000003E-2</c:v>
                </c:pt>
                <c:pt idx="2974">
                  <c:v>6.4307000000000003E-2</c:v>
                </c:pt>
                <c:pt idx="2975">
                  <c:v>6.4307000000000003E-2</c:v>
                </c:pt>
                <c:pt idx="2976">
                  <c:v>6.4307000000000003E-2</c:v>
                </c:pt>
                <c:pt idx="2977">
                  <c:v>6.4307000000000003E-2</c:v>
                </c:pt>
                <c:pt idx="2978">
                  <c:v>6.4307000000000003E-2</c:v>
                </c:pt>
                <c:pt idx="2979">
                  <c:v>6.4307000000000003E-2</c:v>
                </c:pt>
                <c:pt idx="2980">
                  <c:v>6.4307000000000003E-2</c:v>
                </c:pt>
                <c:pt idx="2981">
                  <c:v>6.4307000000000003E-2</c:v>
                </c:pt>
                <c:pt idx="2982">
                  <c:v>6.4307000000000003E-2</c:v>
                </c:pt>
                <c:pt idx="2983">
                  <c:v>6.4307000000000003E-2</c:v>
                </c:pt>
                <c:pt idx="2984">
                  <c:v>6.4307000000000003E-2</c:v>
                </c:pt>
                <c:pt idx="2985">
                  <c:v>6.4307000000000003E-2</c:v>
                </c:pt>
                <c:pt idx="2986">
                  <c:v>6.4307000000000003E-2</c:v>
                </c:pt>
                <c:pt idx="2987">
                  <c:v>6.4307000000000003E-2</c:v>
                </c:pt>
                <c:pt idx="2988">
                  <c:v>6.4307000000000003E-2</c:v>
                </c:pt>
                <c:pt idx="2989">
                  <c:v>6.4306000000000002E-2</c:v>
                </c:pt>
                <c:pt idx="2990">
                  <c:v>6.4306000000000002E-2</c:v>
                </c:pt>
                <c:pt idx="2991">
                  <c:v>6.4306000000000002E-2</c:v>
                </c:pt>
                <c:pt idx="2992">
                  <c:v>6.4306000000000002E-2</c:v>
                </c:pt>
                <c:pt idx="2993">
                  <c:v>6.4306000000000002E-2</c:v>
                </c:pt>
                <c:pt idx="2994">
                  <c:v>6.4306000000000002E-2</c:v>
                </c:pt>
                <c:pt idx="2995">
                  <c:v>6.4306000000000002E-2</c:v>
                </c:pt>
                <c:pt idx="2996">
                  <c:v>6.4306000000000002E-2</c:v>
                </c:pt>
                <c:pt idx="2997">
                  <c:v>6.4306000000000002E-2</c:v>
                </c:pt>
                <c:pt idx="2998">
                  <c:v>6.4306000000000002E-2</c:v>
                </c:pt>
                <c:pt idx="2999">
                  <c:v>6.4306000000000002E-2</c:v>
                </c:pt>
                <c:pt idx="3000">
                  <c:v>6.4306000000000002E-2</c:v>
                </c:pt>
                <c:pt idx="3001">
                  <c:v>6.4306000000000002E-2</c:v>
                </c:pt>
                <c:pt idx="3002">
                  <c:v>6.4306000000000002E-2</c:v>
                </c:pt>
                <c:pt idx="3003">
                  <c:v>6.4306000000000002E-2</c:v>
                </c:pt>
                <c:pt idx="3004">
                  <c:v>6.4306000000000002E-2</c:v>
                </c:pt>
                <c:pt idx="3005">
                  <c:v>6.4306000000000002E-2</c:v>
                </c:pt>
                <c:pt idx="3006">
                  <c:v>6.4306000000000002E-2</c:v>
                </c:pt>
                <c:pt idx="3007">
                  <c:v>6.4306000000000002E-2</c:v>
                </c:pt>
                <c:pt idx="3008">
                  <c:v>6.4306000000000002E-2</c:v>
                </c:pt>
                <c:pt idx="3009">
                  <c:v>6.4306000000000002E-2</c:v>
                </c:pt>
                <c:pt idx="3010">
                  <c:v>6.4306000000000002E-2</c:v>
                </c:pt>
                <c:pt idx="3011">
                  <c:v>6.4306000000000002E-2</c:v>
                </c:pt>
                <c:pt idx="3012">
                  <c:v>6.4306000000000002E-2</c:v>
                </c:pt>
                <c:pt idx="3013">
                  <c:v>6.4306000000000002E-2</c:v>
                </c:pt>
                <c:pt idx="3014">
                  <c:v>6.4306000000000002E-2</c:v>
                </c:pt>
                <c:pt idx="3015">
                  <c:v>6.4306000000000002E-2</c:v>
                </c:pt>
                <c:pt idx="3016">
                  <c:v>6.4306000000000002E-2</c:v>
                </c:pt>
                <c:pt idx="3017">
                  <c:v>6.4306000000000002E-2</c:v>
                </c:pt>
                <c:pt idx="3018">
                  <c:v>6.4306000000000002E-2</c:v>
                </c:pt>
                <c:pt idx="3019">
                  <c:v>6.4306000000000002E-2</c:v>
                </c:pt>
                <c:pt idx="3020">
                  <c:v>6.4306000000000002E-2</c:v>
                </c:pt>
                <c:pt idx="3021">
                  <c:v>6.4306000000000002E-2</c:v>
                </c:pt>
                <c:pt idx="3022">
                  <c:v>6.4306000000000002E-2</c:v>
                </c:pt>
                <c:pt idx="3023">
                  <c:v>6.4306000000000002E-2</c:v>
                </c:pt>
                <c:pt idx="3024">
                  <c:v>6.4306000000000002E-2</c:v>
                </c:pt>
                <c:pt idx="3025">
                  <c:v>6.4306000000000002E-2</c:v>
                </c:pt>
                <c:pt idx="3026">
                  <c:v>6.4306000000000002E-2</c:v>
                </c:pt>
                <c:pt idx="3027">
                  <c:v>6.4306000000000002E-2</c:v>
                </c:pt>
                <c:pt idx="3028">
                  <c:v>6.4306000000000002E-2</c:v>
                </c:pt>
                <c:pt idx="3029">
                  <c:v>6.4306000000000002E-2</c:v>
                </c:pt>
                <c:pt idx="3030">
                  <c:v>6.4306000000000002E-2</c:v>
                </c:pt>
                <c:pt idx="3031">
                  <c:v>6.4306000000000002E-2</c:v>
                </c:pt>
                <c:pt idx="3032">
                  <c:v>6.4306000000000002E-2</c:v>
                </c:pt>
                <c:pt idx="3033">
                  <c:v>6.4306000000000002E-2</c:v>
                </c:pt>
                <c:pt idx="3034">
                  <c:v>6.4306000000000002E-2</c:v>
                </c:pt>
                <c:pt idx="3035">
                  <c:v>6.4306000000000002E-2</c:v>
                </c:pt>
                <c:pt idx="3036">
                  <c:v>6.4306000000000002E-2</c:v>
                </c:pt>
                <c:pt idx="3037">
                  <c:v>6.4306000000000002E-2</c:v>
                </c:pt>
                <c:pt idx="3038">
                  <c:v>6.4306000000000002E-2</c:v>
                </c:pt>
                <c:pt idx="3039">
                  <c:v>6.4306000000000002E-2</c:v>
                </c:pt>
                <c:pt idx="3040">
                  <c:v>6.4306000000000002E-2</c:v>
                </c:pt>
                <c:pt idx="3041">
                  <c:v>6.4306000000000002E-2</c:v>
                </c:pt>
                <c:pt idx="3042">
                  <c:v>6.4306000000000002E-2</c:v>
                </c:pt>
                <c:pt idx="3043">
                  <c:v>6.4306000000000002E-2</c:v>
                </c:pt>
                <c:pt idx="3044">
                  <c:v>6.4306000000000002E-2</c:v>
                </c:pt>
                <c:pt idx="3045">
                  <c:v>6.4306000000000002E-2</c:v>
                </c:pt>
                <c:pt idx="3046">
                  <c:v>6.4306000000000002E-2</c:v>
                </c:pt>
                <c:pt idx="3047">
                  <c:v>6.4306000000000002E-2</c:v>
                </c:pt>
                <c:pt idx="3048">
                  <c:v>6.4306000000000002E-2</c:v>
                </c:pt>
                <c:pt idx="3049">
                  <c:v>6.4306000000000002E-2</c:v>
                </c:pt>
                <c:pt idx="3050">
                  <c:v>6.4306000000000002E-2</c:v>
                </c:pt>
                <c:pt idx="3051">
                  <c:v>6.4306000000000002E-2</c:v>
                </c:pt>
                <c:pt idx="3052">
                  <c:v>6.4306000000000002E-2</c:v>
                </c:pt>
                <c:pt idx="3053">
                  <c:v>6.4306000000000002E-2</c:v>
                </c:pt>
                <c:pt idx="3054">
                  <c:v>6.4306000000000002E-2</c:v>
                </c:pt>
                <c:pt idx="3055">
                  <c:v>6.4306000000000002E-2</c:v>
                </c:pt>
                <c:pt idx="3056">
                  <c:v>6.4306000000000002E-2</c:v>
                </c:pt>
                <c:pt idx="3057">
                  <c:v>6.4306000000000002E-2</c:v>
                </c:pt>
                <c:pt idx="3058">
                  <c:v>6.4306000000000002E-2</c:v>
                </c:pt>
                <c:pt idx="3059">
                  <c:v>6.4306000000000002E-2</c:v>
                </c:pt>
                <c:pt idx="3060">
                  <c:v>6.4306000000000002E-2</c:v>
                </c:pt>
                <c:pt idx="3061">
                  <c:v>6.4306000000000002E-2</c:v>
                </c:pt>
                <c:pt idx="3062">
                  <c:v>6.4306000000000002E-2</c:v>
                </c:pt>
                <c:pt idx="3063">
                  <c:v>6.4306000000000002E-2</c:v>
                </c:pt>
                <c:pt idx="3064">
                  <c:v>6.4306000000000002E-2</c:v>
                </c:pt>
                <c:pt idx="3065">
                  <c:v>6.4306000000000002E-2</c:v>
                </c:pt>
                <c:pt idx="3066">
                  <c:v>6.4306000000000002E-2</c:v>
                </c:pt>
                <c:pt idx="3067">
                  <c:v>6.4306000000000002E-2</c:v>
                </c:pt>
                <c:pt idx="3068">
                  <c:v>6.4306000000000002E-2</c:v>
                </c:pt>
                <c:pt idx="3069">
                  <c:v>6.4306000000000002E-2</c:v>
                </c:pt>
                <c:pt idx="3070">
                  <c:v>6.4306000000000002E-2</c:v>
                </c:pt>
                <c:pt idx="3071">
                  <c:v>6.4306000000000002E-2</c:v>
                </c:pt>
                <c:pt idx="3072">
                  <c:v>6.4306000000000002E-2</c:v>
                </c:pt>
                <c:pt idx="3073">
                  <c:v>6.4306000000000002E-2</c:v>
                </c:pt>
                <c:pt idx="3074">
                  <c:v>6.4306000000000002E-2</c:v>
                </c:pt>
                <c:pt idx="3075">
                  <c:v>6.4306000000000002E-2</c:v>
                </c:pt>
                <c:pt idx="3076">
                  <c:v>6.4306000000000002E-2</c:v>
                </c:pt>
                <c:pt idx="3077">
                  <c:v>6.4306000000000002E-2</c:v>
                </c:pt>
                <c:pt idx="3078">
                  <c:v>6.4306000000000002E-2</c:v>
                </c:pt>
                <c:pt idx="3079">
                  <c:v>6.4306000000000002E-2</c:v>
                </c:pt>
                <c:pt idx="3080">
                  <c:v>6.4306000000000002E-2</c:v>
                </c:pt>
                <c:pt idx="3081">
                  <c:v>6.4306000000000002E-2</c:v>
                </c:pt>
                <c:pt idx="3082">
                  <c:v>6.4306000000000002E-2</c:v>
                </c:pt>
                <c:pt idx="3083">
                  <c:v>6.4306000000000002E-2</c:v>
                </c:pt>
                <c:pt idx="3084">
                  <c:v>6.4306000000000002E-2</c:v>
                </c:pt>
                <c:pt idx="3085">
                  <c:v>6.4306000000000002E-2</c:v>
                </c:pt>
                <c:pt idx="3086">
                  <c:v>6.4306000000000002E-2</c:v>
                </c:pt>
                <c:pt idx="3087">
                  <c:v>6.4306000000000002E-2</c:v>
                </c:pt>
                <c:pt idx="3088">
                  <c:v>6.4306000000000002E-2</c:v>
                </c:pt>
                <c:pt idx="3089">
                  <c:v>6.4306000000000002E-2</c:v>
                </c:pt>
                <c:pt idx="3090">
                  <c:v>6.4306000000000002E-2</c:v>
                </c:pt>
                <c:pt idx="3091">
                  <c:v>6.4306000000000002E-2</c:v>
                </c:pt>
                <c:pt idx="3092">
                  <c:v>6.4306000000000002E-2</c:v>
                </c:pt>
                <c:pt idx="3093">
                  <c:v>6.4306000000000002E-2</c:v>
                </c:pt>
                <c:pt idx="3094">
                  <c:v>6.4306000000000002E-2</c:v>
                </c:pt>
                <c:pt idx="3095">
                  <c:v>6.4306000000000002E-2</c:v>
                </c:pt>
                <c:pt idx="3096">
                  <c:v>6.4306000000000002E-2</c:v>
                </c:pt>
                <c:pt idx="3097">
                  <c:v>6.4306000000000002E-2</c:v>
                </c:pt>
                <c:pt idx="3098">
                  <c:v>6.4306000000000002E-2</c:v>
                </c:pt>
                <c:pt idx="3099">
                  <c:v>6.4306000000000002E-2</c:v>
                </c:pt>
                <c:pt idx="3100">
                  <c:v>6.4306000000000002E-2</c:v>
                </c:pt>
                <c:pt idx="3101">
                  <c:v>6.4306000000000002E-2</c:v>
                </c:pt>
                <c:pt idx="3102">
                  <c:v>6.4306000000000002E-2</c:v>
                </c:pt>
                <c:pt idx="3103">
                  <c:v>6.4306000000000002E-2</c:v>
                </c:pt>
                <c:pt idx="3104">
                  <c:v>6.4306000000000002E-2</c:v>
                </c:pt>
                <c:pt idx="3105">
                  <c:v>6.4306000000000002E-2</c:v>
                </c:pt>
                <c:pt idx="3106">
                  <c:v>6.4306000000000002E-2</c:v>
                </c:pt>
                <c:pt idx="3107">
                  <c:v>6.4305000000000001E-2</c:v>
                </c:pt>
                <c:pt idx="3108">
                  <c:v>6.4305000000000001E-2</c:v>
                </c:pt>
                <c:pt idx="3109">
                  <c:v>6.4305000000000001E-2</c:v>
                </c:pt>
                <c:pt idx="3110">
                  <c:v>6.4305000000000001E-2</c:v>
                </c:pt>
                <c:pt idx="3111">
                  <c:v>6.4305000000000001E-2</c:v>
                </c:pt>
                <c:pt idx="3112">
                  <c:v>6.4305000000000001E-2</c:v>
                </c:pt>
                <c:pt idx="3113">
                  <c:v>6.4305000000000001E-2</c:v>
                </c:pt>
                <c:pt idx="3114">
                  <c:v>6.4305000000000001E-2</c:v>
                </c:pt>
                <c:pt idx="3115">
                  <c:v>6.4305000000000001E-2</c:v>
                </c:pt>
                <c:pt idx="3116">
                  <c:v>6.4305000000000001E-2</c:v>
                </c:pt>
                <c:pt idx="3117">
                  <c:v>6.4305000000000001E-2</c:v>
                </c:pt>
                <c:pt idx="3118">
                  <c:v>6.4305000000000001E-2</c:v>
                </c:pt>
                <c:pt idx="3119">
                  <c:v>6.4305000000000001E-2</c:v>
                </c:pt>
                <c:pt idx="3120">
                  <c:v>6.4305000000000001E-2</c:v>
                </c:pt>
                <c:pt idx="3121">
                  <c:v>6.4305000000000001E-2</c:v>
                </c:pt>
                <c:pt idx="3122">
                  <c:v>6.4305000000000001E-2</c:v>
                </c:pt>
                <c:pt idx="3123">
                  <c:v>6.4305000000000001E-2</c:v>
                </c:pt>
                <c:pt idx="3124">
                  <c:v>6.4305000000000001E-2</c:v>
                </c:pt>
                <c:pt idx="3125">
                  <c:v>6.4305000000000001E-2</c:v>
                </c:pt>
                <c:pt idx="3126">
                  <c:v>6.4305000000000001E-2</c:v>
                </c:pt>
                <c:pt idx="3127">
                  <c:v>6.4305000000000001E-2</c:v>
                </c:pt>
                <c:pt idx="3128">
                  <c:v>6.4305000000000001E-2</c:v>
                </c:pt>
                <c:pt idx="3129">
                  <c:v>6.4305000000000001E-2</c:v>
                </c:pt>
                <c:pt idx="3130">
                  <c:v>6.4305000000000001E-2</c:v>
                </c:pt>
                <c:pt idx="3131">
                  <c:v>6.4305000000000001E-2</c:v>
                </c:pt>
                <c:pt idx="3132">
                  <c:v>6.4305000000000001E-2</c:v>
                </c:pt>
                <c:pt idx="3133">
                  <c:v>6.4305000000000001E-2</c:v>
                </c:pt>
                <c:pt idx="3134">
                  <c:v>6.4305000000000001E-2</c:v>
                </c:pt>
                <c:pt idx="3135">
                  <c:v>6.4305000000000001E-2</c:v>
                </c:pt>
                <c:pt idx="3136">
                  <c:v>6.4305000000000001E-2</c:v>
                </c:pt>
                <c:pt idx="3137">
                  <c:v>6.4305000000000001E-2</c:v>
                </c:pt>
                <c:pt idx="3138">
                  <c:v>6.4305000000000001E-2</c:v>
                </c:pt>
                <c:pt idx="3139">
                  <c:v>6.4305000000000001E-2</c:v>
                </c:pt>
                <c:pt idx="3140">
                  <c:v>6.4305000000000001E-2</c:v>
                </c:pt>
                <c:pt idx="3141">
                  <c:v>6.4305000000000001E-2</c:v>
                </c:pt>
                <c:pt idx="3142">
                  <c:v>6.4305000000000001E-2</c:v>
                </c:pt>
                <c:pt idx="3143">
                  <c:v>6.4305000000000001E-2</c:v>
                </c:pt>
                <c:pt idx="3144">
                  <c:v>6.4305000000000001E-2</c:v>
                </c:pt>
                <c:pt idx="3145">
                  <c:v>6.4305000000000001E-2</c:v>
                </c:pt>
                <c:pt idx="3146">
                  <c:v>6.4305000000000001E-2</c:v>
                </c:pt>
                <c:pt idx="3147">
                  <c:v>6.4305000000000001E-2</c:v>
                </c:pt>
                <c:pt idx="3148">
                  <c:v>6.4305000000000001E-2</c:v>
                </c:pt>
                <c:pt idx="3149">
                  <c:v>6.4305000000000001E-2</c:v>
                </c:pt>
                <c:pt idx="3150">
                  <c:v>6.4305000000000001E-2</c:v>
                </c:pt>
                <c:pt idx="3151">
                  <c:v>6.4305000000000001E-2</c:v>
                </c:pt>
                <c:pt idx="3152">
                  <c:v>6.4305000000000001E-2</c:v>
                </c:pt>
                <c:pt idx="3153">
                  <c:v>6.4305000000000001E-2</c:v>
                </c:pt>
                <c:pt idx="3154">
                  <c:v>6.4305000000000001E-2</c:v>
                </c:pt>
                <c:pt idx="3155">
                  <c:v>6.4305000000000001E-2</c:v>
                </c:pt>
                <c:pt idx="3156">
                  <c:v>6.4305000000000001E-2</c:v>
                </c:pt>
                <c:pt idx="3157">
                  <c:v>6.4305000000000001E-2</c:v>
                </c:pt>
                <c:pt idx="3158">
                  <c:v>6.4305000000000001E-2</c:v>
                </c:pt>
                <c:pt idx="3159">
                  <c:v>6.4305000000000001E-2</c:v>
                </c:pt>
                <c:pt idx="3160">
                  <c:v>6.4305000000000001E-2</c:v>
                </c:pt>
                <c:pt idx="3161">
                  <c:v>6.4305000000000001E-2</c:v>
                </c:pt>
                <c:pt idx="3162">
                  <c:v>6.4305000000000001E-2</c:v>
                </c:pt>
                <c:pt idx="3163">
                  <c:v>6.4305000000000001E-2</c:v>
                </c:pt>
                <c:pt idx="3164">
                  <c:v>6.4305000000000001E-2</c:v>
                </c:pt>
                <c:pt idx="3165">
                  <c:v>6.4305000000000001E-2</c:v>
                </c:pt>
                <c:pt idx="3166">
                  <c:v>6.4305000000000001E-2</c:v>
                </c:pt>
                <c:pt idx="3167">
                  <c:v>6.4305000000000001E-2</c:v>
                </c:pt>
                <c:pt idx="3168">
                  <c:v>6.4305000000000001E-2</c:v>
                </c:pt>
                <c:pt idx="3169">
                  <c:v>6.4305000000000001E-2</c:v>
                </c:pt>
                <c:pt idx="3170">
                  <c:v>6.4305000000000001E-2</c:v>
                </c:pt>
                <c:pt idx="3171">
                  <c:v>6.4305000000000001E-2</c:v>
                </c:pt>
                <c:pt idx="3172">
                  <c:v>6.4305000000000001E-2</c:v>
                </c:pt>
                <c:pt idx="3173">
                  <c:v>6.4305000000000001E-2</c:v>
                </c:pt>
                <c:pt idx="3174">
                  <c:v>6.4305000000000001E-2</c:v>
                </c:pt>
                <c:pt idx="3175">
                  <c:v>6.4305000000000001E-2</c:v>
                </c:pt>
                <c:pt idx="3176">
                  <c:v>6.4305000000000001E-2</c:v>
                </c:pt>
                <c:pt idx="3177">
                  <c:v>6.4305000000000001E-2</c:v>
                </c:pt>
                <c:pt idx="3178">
                  <c:v>6.4305000000000001E-2</c:v>
                </c:pt>
                <c:pt idx="3179">
                  <c:v>6.4305000000000001E-2</c:v>
                </c:pt>
                <c:pt idx="3180">
                  <c:v>6.4305000000000001E-2</c:v>
                </c:pt>
                <c:pt idx="3181">
                  <c:v>6.4305000000000001E-2</c:v>
                </c:pt>
                <c:pt idx="3182">
                  <c:v>6.4305000000000001E-2</c:v>
                </c:pt>
                <c:pt idx="3183">
                  <c:v>6.4305000000000001E-2</c:v>
                </c:pt>
                <c:pt idx="3184">
                  <c:v>6.4305000000000001E-2</c:v>
                </c:pt>
                <c:pt idx="3185">
                  <c:v>6.4305000000000001E-2</c:v>
                </c:pt>
                <c:pt idx="3186">
                  <c:v>6.4305000000000001E-2</c:v>
                </c:pt>
                <c:pt idx="3187">
                  <c:v>6.4305000000000001E-2</c:v>
                </c:pt>
                <c:pt idx="3188">
                  <c:v>6.4305000000000001E-2</c:v>
                </c:pt>
                <c:pt idx="3189">
                  <c:v>6.4305000000000001E-2</c:v>
                </c:pt>
                <c:pt idx="3190">
                  <c:v>6.4305000000000001E-2</c:v>
                </c:pt>
                <c:pt idx="3191">
                  <c:v>6.4305000000000001E-2</c:v>
                </c:pt>
                <c:pt idx="3192">
                  <c:v>6.4305000000000001E-2</c:v>
                </c:pt>
                <c:pt idx="3193">
                  <c:v>6.4305000000000001E-2</c:v>
                </c:pt>
                <c:pt idx="3194">
                  <c:v>6.4305000000000001E-2</c:v>
                </c:pt>
                <c:pt idx="3195">
                  <c:v>6.4305000000000001E-2</c:v>
                </c:pt>
                <c:pt idx="3196">
                  <c:v>6.4305000000000001E-2</c:v>
                </c:pt>
                <c:pt idx="3197">
                  <c:v>6.4305000000000001E-2</c:v>
                </c:pt>
                <c:pt idx="3198">
                  <c:v>6.4305000000000001E-2</c:v>
                </c:pt>
                <c:pt idx="3199">
                  <c:v>6.4305000000000001E-2</c:v>
                </c:pt>
                <c:pt idx="3200">
                  <c:v>6.4305000000000001E-2</c:v>
                </c:pt>
                <c:pt idx="3201">
                  <c:v>6.4305000000000001E-2</c:v>
                </c:pt>
                <c:pt idx="3202">
                  <c:v>6.4305000000000001E-2</c:v>
                </c:pt>
                <c:pt idx="3203">
                  <c:v>6.4305000000000001E-2</c:v>
                </c:pt>
                <c:pt idx="3204">
                  <c:v>6.4305000000000001E-2</c:v>
                </c:pt>
                <c:pt idx="3205">
                  <c:v>6.4305000000000001E-2</c:v>
                </c:pt>
                <c:pt idx="3206">
                  <c:v>6.4305000000000001E-2</c:v>
                </c:pt>
                <c:pt idx="3207">
                  <c:v>6.4305000000000001E-2</c:v>
                </c:pt>
                <c:pt idx="3208">
                  <c:v>6.4305000000000001E-2</c:v>
                </c:pt>
                <c:pt idx="3209">
                  <c:v>6.4305000000000001E-2</c:v>
                </c:pt>
                <c:pt idx="3210">
                  <c:v>6.4305000000000001E-2</c:v>
                </c:pt>
                <c:pt idx="3211">
                  <c:v>6.4305000000000001E-2</c:v>
                </c:pt>
                <c:pt idx="3212">
                  <c:v>6.4305000000000001E-2</c:v>
                </c:pt>
                <c:pt idx="3213">
                  <c:v>6.4305000000000001E-2</c:v>
                </c:pt>
                <c:pt idx="3214">
                  <c:v>6.4305000000000001E-2</c:v>
                </c:pt>
                <c:pt idx="3215">
                  <c:v>6.4305000000000001E-2</c:v>
                </c:pt>
                <c:pt idx="3216">
                  <c:v>6.4305000000000001E-2</c:v>
                </c:pt>
                <c:pt idx="3217">
                  <c:v>6.4305000000000001E-2</c:v>
                </c:pt>
                <c:pt idx="3218">
                  <c:v>6.4305000000000001E-2</c:v>
                </c:pt>
                <c:pt idx="3219">
                  <c:v>6.4305000000000001E-2</c:v>
                </c:pt>
                <c:pt idx="3220">
                  <c:v>6.4305000000000001E-2</c:v>
                </c:pt>
                <c:pt idx="3221">
                  <c:v>6.4305000000000001E-2</c:v>
                </c:pt>
                <c:pt idx="3222">
                  <c:v>6.4305000000000001E-2</c:v>
                </c:pt>
                <c:pt idx="3223">
                  <c:v>6.4305000000000001E-2</c:v>
                </c:pt>
                <c:pt idx="3224">
                  <c:v>6.4305000000000001E-2</c:v>
                </c:pt>
                <c:pt idx="3225">
                  <c:v>6.4305000000000001E-2</c:v>
                </c:pt>
                <c:pt idx="3226">
                  <c:v>6.4305000000000001E-2</c:v>
                </c:pt>
                <c:pt idx="3227">
                  <c:v>6.4305000000000001E-2</c:v>
                </c:pt>
                <c:pt idx="3228">
                  <c:v>6.4305000000000001E-2</c:v>
                </c:pt>
                <c:pt idx="3229">
                  <c:v>6.4305000000000001E-2</c:v>
                </c:pt>
                <c:pt idx="3230">
                  <c:v>6.4305000000000001E-2</c:v>
                </c:pt>
                <c:pt idx="3231">
                  <c:v>6.4305000000000001E-2</c:v>
                </c:pt>
                <c:pt idx="3232">
                  <c:v>6.4305000000000001E-2</c:v>
                </c:pt>
                <c:pt idx="3233">
                  <c:v>6.4305000000000001E-2</c:v>
                </c:pt>
                <c:pt idx="3234">
                  <c:v>6.4305000000000001E-2</c:v>
                </c:pt>
                <c:pt idx="3235">
                  <c:v>6.4305000000000001E-2</c:v>
                </c:pt>
                <c:pt idx="3236">
                  <c:v>6.4305000000000001E-2</c:v>
                </c:pt>
                <c:pt idx="3237">
                  <c:v>6.4305000000000001E-2</c:v>
                </c:pt>
                <c:pt idx="3238">
                  <c:v>6.4305000000000001E-2</c:v>
                </c:pt>
                <c:pt idx="3239">
                  <c:v>6.4305000000000001E-2</c:v>
                </c:pt>
                <c:pt idx="3240">
                  <c:v>6.4305000000000001E-2</c:v>
                </c:pt>
                <c:pt idx="3241">
                  <c:v>6.4305000000000001E-2</c:v>
                </c:pt>
                <c:pt idx="3242">
                  <c:v>6.4305000000000001E-2</c:v>
                </c:pt>
                <c:pt idx="3243">
                  <c:v>6.4305000000000001E-2</c:v>
                </c:pt>
                <c:pt idx="3244">
                  <c:v>6.4305000000000001E-2</c:v>
                </c:pt>
                <c:pt idx="3245">
                  <c:v>6.4305000000000001E-2</c:v>
                </c:pt>
                <c:pt idx="3246">
                  <c:v>6.4305000000000001E-2</c:v>
                </c:pt>
                <c:pt idx="3247">
                  <c:v>6.4305000000000001E-2</c:v>
                </c:pt>
                <c:pt idx="3248">
                  <c:v>6.4305000000000001E-2</c:v>
                </c:pt>
                <c:pt idx="3249">
                  <c:v>6.4305000000000001E-2</c:v>
                </c:pt>
                <c:pt idx="3250">
                  <c:v>6.4305000000000001E-2</c:v>
                </c:pt>
                <c:pt idx="3251">
                  <c:v>6.4305000000000001E-2</c:v>
                </c:pt>
                <c:pt idx="3252">
                  <c:v>6.4305000000000001E-2</c:v>
                </c:pt>
                <c:pt idx="3253">
                  <c:v>6.4305000000000001E-2</c:v>
                </c:pt>
                <c:pt idx="3254">
                  <c:v>6.4305000000000001E-2</c:v>
                </c:pt>
                <c:pt idx="3255">
                  <c:v>6.4305000000000001E-2</c:v>
                </c:pt>
                <c:pt idx="3256">
                  <c:v>6.4305000000000001E-2</c:v>
                </c:pt>
                <c:pt idx="3257">
                  <c:v>6.4305000000000001E-2</c:v>
                </c:pt>
                <c:pt idx="3258">
                  <c:v>6.4305000000000001E-2</c:v>
                </c:pt>
                <c:pt idx="3259">
                  <c:v>6.4305000000000001E-2</c:v>
                </c:pt>
                <c:pt idx="3260">
                  <c:v>6.4305000000000001E-2</c:v>
                </c:pt>
                <c:pt idx="3261">
                  <c:v>6.4305000000000001E-2</c:v>
                </c:pt>
                <c:pt idx="3262">
                  <c:v>6.4305000000000001E-2</c:v>
                </c:pt>
                <c:pt idx="3263">
                  <c:v>6.4305000000000001E-2</c:v>
                </c:pt>
                <c:pt idx="3264">
                  <c:v>6.4305000000000001E-2</c:v>
                </c:pt>
                <c:pt idx="3265">
                  <c:v>6.4305000000000001E-2</c:v>
                </c:pt>
                <c:pt idx="3266">
                  <c:v>6.4305000000000001E-2</c:v>
                </c:pt>
                <c:pt idx="3267">
                  <c:v>6.4305000000000001E-2</c:v>
                </c:pt>
                <c:pt idx="3268">
                  <c:v>6.4305000000000001E-2</c:v>
                </c:pt>
                <c:pt idx="3269">
                  <c:v>6.4305000000000001E-2</c:v>
                </c:pt>
                <c:pt idx="3270">
                  <c:v>6.4305000000000001E-2</c:v>
                </c:pt>
                <c:pt idx="3271">
                  <c:v>6.4305000000000001E-2</c:v>
                </c:pt>
                <c:pt idx="3272">
                  <c:v>6.4305000000000001E-2</c:v>
                </c:pt>
                <c:pt idx="3273">
                  <c:v>6.4305000000000001E-2</c:v>
                </c:pt>
                <c:pt idx="3274">
                  <c:v>6.4305000000000001E-2</c:v>
                </c:pt>
                <c:pt idx="3275">
                  <c:v>6.4305000000000001E-2</c:v>
                </c:pt>
                <c:pt idx="3276">
                  <c:v>6.4305000000000001E-2</c:v>
                </c:pt>
                <c:pt idx="3277">
                  <c:v>6.4305000000000001E-2</c:v>
                </c:pt>
                <c:pt idx="3278">
                  <c:v>6.4305000000000001E-2</c:v>
                </c:pt>
                <c:pt idx="3279">
                  <c:v>6.4305000000000001E-2</c:v>
                </c:pt>
                <c:pt idx="3280">
                  <c:v>6.4305000000000001E-2</c:v>
                </c:pt>
                <c:pt idx="3281">
                  <c:v>6.4305000000000001E-2</c:v>
                </c:pt>
                <c:pt idx="3282">
                  <c:v>6.4305000000000001E-2</c:v>
                </c:pt>
                <c:pt idx="3283">
                  <c:v>6.4305000000000001E-2</c:v>
                </c:pt>
                <c:pt idx="3284">
                  <c:v>6.4305000000000001E-2</c:v>
                </c:pt>
                <c:pt idx="3285">
                  <c:v>6.4305000000000001E-2</c:v>
                </c:pt>
                <c:pt idx="3286">
                  <c:v>6.4305000000000001E-2</c:v>
                </c:pt>
                <c:pt idx="3287">
                  <c:v>6.4305000000000001E-2</c:v>
                </c:pt>
                <c:pt idx="3288">
                  <c:v>6.4305000000000001E-2</c:v>
                </c:pt>
                <c:pt idx="3289">
                  <c:v>6.4305000000000001E-2</c:v>
                </c:pt>
                <c:pt idx="3290">
                  <c:v>6.4305000000000001E-2</c:v>
                </c:pt>
                <c:pt idx="3291">
                  <c:v>6.4305000000000001E-2</c:v>
                </c:pt>
                <c:pt idx="3292">
                  <c:v>6.4305000000000001E-2</c:v>
                </c:pt>
                <c:pt idx="3293">
                  <c:v>6.4305000000000001E-2</c:v>
                </c:pt>
                <c:pt idx="3294">
                  <c:v>6.4305000000000001E-2</c:v>
                </c:pt>
                <c:pt idx="3295">
                  <c:v>6.4305000000000001E-2</c:v>
                </c:pt>
                <c:pt idx="3296">
                  <c:v>6.4305000000000001E-2</c:v>
                </c:pt>
                <c:pt idx="3297">
                  <c:v>6.4305000000000001E-2</c:v>
                </c:pt>
                <c:pt idx="3298">
                  <c:v>6.4305000000000001E-2</c:v>
                </c:pt>
                <c:pt idx="3299">
                  <c:v>6.4305000000000001E-2</c:v>
                </c:pt>
                <c:pt idx="3300">
                  <c:v>6.4305000000000001E-2</c:v>
                </c:pt>
                <c:pt idx="3301">
                  <c:v>6.4305000000000001E-2</c:v>
                </c:pt>
                <c:pt idx="3302">
                  <c:v>6.4305000000000001E-2</c:v>
                </c:pt>
                <c:pt idx="3303">
                  <c:v>6.4305000000000001E-2</c:v>
                </c:pt>
                <c:pt idx="3304">
                  <c:v>6.4305000000000001E-2</c:v>
                </c:pt>
                <c:pt idx="3305">
                  <c:v>6.4305000000000001E-2</c:v>
                </c:pt>
                <c:pt idx="3306">
                  <c:v>6.4305000000000001E-2</c:v>
                </c:pt>
                <c:pt idx="3307">
                  <c:v>6.4305000000000001E-2</c:v>
                </c:pt>
                <c:pt idx="3308">
                  <c:v>6.4305000000000001E-2</c:v>
                </c:pt>
                <c:pt idx="3309">
                  <c:v>6.4305000000000001E-2</c:v>
                </c:pt>
                <c:pt idx="3310">
                  <c:v>6.4305000000000001E-2</c:v>
                </c:pt>
                <c:pt idx="3311">
                  <c:v>6.4305000000000001E-2</c:v>
                </c:pt>
                <c:pt idx="3312">
                  <c:v>6.4305000000000001E-2</c:v>
                </c:pt>
                <c:pt idx="3313">
                  <c:v>6.4305000000000001E-2</c:v>
                </c:pt>
                <c:pt idx="3314">
                  <c:v>6.4305000000000001E-2</c:v>
                </c:pt>
                <c:pt idx="3315">
                  <c:v>6.4305000000000001E-2</c:v>
                </c:pt>
                <c:pt idx="3316">
                  <c:v>6.4305000000000001E-2</c:v>
                </c:pt>
                <c:pt idx="3317">
                  <c:v>6.4305000000000001E-2</c:v>
                </c:pt>
                <c:pt idx="3318">
                  <c:v>6.4305000000000001E-2</c:v>
                </c:pt>
                <c:pt idx="3319">
                  <c:v>6.4305000000000001E-2</c:v>
                </c:pt>
                <c:pt idx="3320">
                  <c:v>6.4305000000000001E-2</c:v>
                </c:pt>
                <c:pt idx="3321">
                  <c:v>6.4305000000000001E-2</c:v>
                </c:pt>
                <c:pt idx="3322">
                  <c:v>6.4305000000000001E-2</c:v>
                </c:pt>
                <c:pt idx="3323">
                  <c:v>6.4305000000000001E-2</c:v>
                </c:pt>
                <c:pt idx="3324">
                  <c:v>6.4305000000000001E-2</c:v>
                </c:pt>
                <c:pt idx="3325">
                  <c:v>6.4305000000000001E-2</c:v>
                </c:pt>
                <c:pt idx="3326">
                  <c:v>6.4305000000000001E-2</c:v>
                </c:pt>
                <c:pt idx="3327">
                  <c:v>6.4305000000000001E-2</c:v>
                </c:pt>
                <c:pt idx="3328">
                  <c:v>6.4305000000000001E-2</c:v>
                </c:pt>
                <c:pt idx="3329">
                  <c:v>6.4305000000000001E-2</c:v>
                </c:pt>
                <c:pt idx="3330">
                  <c:v>6.4305000000000001E-2</c:v>
                </c:pt>
                <c:pt idx="3331">
                  <c:v>6.4305000000000001E-2</c:v>
                </c:pt>
                <c:pt idx="3332">
                  <c:v>6.4305000000000001E-2</c:v>
                </c:pt>
                <c:pt idx="3333">
                  <c:v>6.4305000000000001E-2</c:v>
                </c:pt>
                <c:pt idx="3334">
                  <c:v>6.4305000000000001E-2</c:v>
                </c:pt>
                <c:pt idx="3335">
                  <c:v>6.4305000000000001E-2</c:v>
                </c:pt>
                <c:pt idx="3336">
                  <c:v>6.4305000000000001E-2</c:v>
                </c:pt>
                <c:pt idx="3337">
                  <c:v>6.4305000000000001E-2</c:v>
                </c:pt>
                <c:pt idx="3338">
                  <c:v>6.4305000000000001E-2</c:v>
                </c:pt>
                <c:pt idx="3339">
                  <c:v>6.4305000000000001E-2</c:v>
                </c:pt>
                <c:pt idx="3340">
                  <c:v>6.4305000000000001E-2</c:v>
                </c:pt>
                <c:pt idx="3341">
                  <c:v>6.4305000000000001E-2</c:v>
                </c:pt>
                <c:pt idx="3342">
                  <c:v>6.4305000000000001E-2</c:v>
                </c:pt>
                <c:pt idx="3343">
                  <c:v>6.4305000000000001E-2</c:v>
                </c:pt>
                <c:pt idx="3344">
                  <c:v>6.4305000000000001E-2</c:v>
                </c:pt>
                <c:pt idx="3345">
                  <c:v>6.4305000000000001E-2</c:v>
                </c:pt>
                <c:pt idx="3346">
                  <c:v>6.4305000000000001E-2</c:v>
                </c:pt>
                <c:pt idx="3347">
                  <c:v>6.4305000000000001E-2</c:v>
                </c:pt>
                <c:pt idx="3348">
                  <c:v>6.4305000000000001E-2</c:v>
                </c:pt>
                <c:pt idx="3349">
                  <c:v>6.4305000000000001E-2</c:v>
                </c:pt>
                <c:pt idx="3350">
                  <c:v>6.4305000000000001E-2</c:v>
                </c:pt>
                <c:pt idx="3351">
                  <c:v>6.4305000000000001E-2</c:v>
                </c:pt>
                <c:pt idx="3352">
                  <c:v>6.4305000000000001E-2</c:v>
                </c:pt>
                <c:pt idx="3353">
                  <c:v>6.4305000000000001E-2</c:v>
                </c:pt>
                <c:pt idx="3354">
                  <c:v>6.4305000000000001E-2</c:v>
                </c:pt>
                <c:pt idx="3355">
                  <c:v>6.4305000000000001E-2</c:v>
                </c:pt>
                <c:pt idx="3356">
                  <c:v>6.4305000000000001E-2</c:v>
                </c:pt>
                <c:pt idx="3357">
                  <c:v>6.4305000000000001E-2</c:v>
                </c:pt>
                <c:pt idx="3358">
                  <c:v>6.4305000000000001E-2</c:v>
                </c:pt>
                <c:pt idx="3359">
                  <c:v>6.4305000000000001E-2</c:v>
                </c:pt>
                <c:pt idx="3360">
                  <c:v>6.4305000000000001E-2</c:v>
                </c:pt>
                <c:pt idx="3361">
                  <c:v>6.4305000000000001E-2</c:v>
                </c:pt>
                <c:pt idx="3362">
                  <c:v>6.4305000000000001E-2</c:v>
                </c:pt>
                <c:pt idx="3363">
                  <c:v>6.4305000000000001E-2</c:v>
                </c:pt>
                <c:pt idx="3364">
                  <c:v>6.4305000000000001E-2</c:v>
                </c:pt>
                <c:pt idx="3365">
                  <c:v>6.4305000000000001E-2</c:v>
                </c:pt>
                <c:pt idx="3366">
                  <c:v>6.4305000000000001E-2</c:v>
                </c:pt>
                <c:pt idx="3367">
                  <c:v>6.4305000000000001E-2</c:v>
                </c:pt>
                <c:pt idx="3368">
                  <c:v>6.4305000000000001E-2</c:v>
                </c:pt>
                <c:pt idx="3369">
                  <c:v>6.4305000000000001E-2</c:v>
                </c:pt>
                <c:pt idx="3370">
                  <c:v>6.4305000000000001E-2</c:v>
                </c:pt>
                <c:pt idx="3371">
                  <c:v>6.4305000000000001E-2</c:v>
                </c:pt>
                <c:pt idx="3372">
                  <c:v>6.4305000000000001E-2</c:v>
                </c:pt>
                <c:pt idx="3373">
                  <c:v>6.4305000000000001E-2</c:v>
                </c:pt>
                <c:pt idx="3374">
                  <c:v>6.4305000000000001E-2</c:v>
                </c:pt>
                <c:pt idx="3375">
                  <c:v>6.4305000000000001E-2</c:v>
                </c:pt>
                <c:pt idx="3376">
                  <c:v>6.4305000000000001E-2</c:v>
                </c:pt>
                <c:pt idx="3377">
                  <c:v>6.4305000000000001E-2</c:v>
                </c:pt>
                <c:pt idx="3378">
                  <c:v>6.4305000000000001E-2</c:v>
                </c:pt>
                <c:pt idx="3379">
                  <c:v>6.4305000000000001E-2</c:v>
                </c:pt>
                <c:pt idx="3380">
                  <c:v>6.4305000000000001E-2</c:v>
                </c:pt>
                <c:pt idx="3381">
                  <c:v>6.4305000000000001E-2</c:v>
                </c:pt>
                <c:pt idx="3382">
                  <c:v>6.4305000000000001E-2</c:v>
                </c:pt>
                <c:pt idx="3383">
                  <c:v>6.4305000000000001E-2</c:v>
                </c:pt>
                <c:pt idx="3384">
                  <c:v>6.4305000000000001E-2</c:v>
                </c:pt>
                <c:pt idx="3385">
                  <c:v>6.4305000000000001E-2</c:v>
                </c:pt>
                <c:pt idx="3386">
                  <c:v>6.4305000000000001E-2</c:v>
                </c:pt>
                <c:pt idx="3387">
                  <c:v>6.4305000000000001E-2</c:v>
                </c:pt>
                <c:pt idx="3388">
                  <c:v>6.4305000000000001E-2</c:v>
                </c:pt>
                <c:pt idx="3389">
                  <c:v>6.4305000000000001E-2</c:v>
                </c:pt>
                <c:pt idx="3390">
                  <c:v>6.4305000000000001E-2</c:v>
                </c:pt>
                <c:pt idx="3391">
                  <c:v>6.4305000000000001E-2</c:v>
                </c:pt>
                <c:pt idx="3392">
                  <c:v>6.4305000000000001E-2</c:v>
                </c:pt>
                <c:pt idx="3393">
                  <c:v>6.4305000000000001E-2</c:v>
                </c:pt>
                <c:pt idx="3394">
                  <c:v>6.4305000000000001E-2</c:v>
                </c:pt>
                <c:pt idx="3395">
                  <c:v>6.4305000000000001E-2</c:v>
                </c:pt>
                <c:pt idx="3396">
                  <c:v>6.4305000000000001E-2</c:v>
                </c:pt>
                <c:pt idx="3397">
                  <c:v>6.4305000000000001E-2</c:v>
                </c:pt>
                <c:pt idx="3398">
                  <c:v>6.4305000000000001E-2</c:v>
                </c:pt>
                <c:pt idx="3399">
                  <c:v>6.4305000000000001E-2</c:v>
                </c:pt>
                <c:pt idx="3400">
                  <c:v>6.43050000000000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0A3-4C47-8723-2B366FB99E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4897551"/>
        <c:axId val="1379906639"/>
      </c:scatterChart>
      <c:valAx>
        <c:axId val="1384897551"/>
        <c:scaling>
          <c:orientation val="minMax"/>
          <c:max val="0.60000000000000009"/>
          <c:min val="-0.3000000000000000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stance from media (mm)</a:t>
                </a:r>
              </a:p>
            </c:rich>
          </c:tx>
          <c:layout>
            <c:manualLayout>
              <c:xMode val="edge"/>
              <c:yMode val="edge"/>
              <c:x val="0.36283296220625483"/>
              <c:y val="0.925854625630560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9906639"/>
        <c:crosses val="autoZero"/>
        <c:crossBetween val="midCat"/>
      </c:valAx>
      <c:valAx>
        <c:axId val="1379906639"/>
        <c:scaling>
          <c:orientation val="minMax"/>
          <c:max val="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xygen Tension [mmHg]</a:t>
                </a:r>
              </a:p>
            </c:rich>
          </c:tx>
          <c:layout>
            <c:manualLayout>
              <c:xMode val="edge"/>
              <c:yMode val="edge"/>
              <c:x val="0"/>
              <c:y val="0.256381011007593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48975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DEC40-40D2-62C1-53B1-84F903197D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53A85B-9903-E9B8-43D0-F6B32431D4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71092E-7BD5-ADD2-759F-A5E90D60A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BD5E9D-B080-93F8-422D-BC19ED1EC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1FB676-E49F-DF1A-AA49-0C4BBE1FE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9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2F4622-46D4-CC58-FC6E-601F635C0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118191-30A6-5E16-B014-7976FCE07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A111BF-2A6A-8D80-B287-356723C67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092D73-952F-2157-AD86-4E07204D8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5CA39-3E3D-2743-D3FD-7BC7B2CFC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7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F15183-44B8-80A3-3116-56C65D0E92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996E77-5222-488C-E4D6-5F864CEADC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8BE82-C0FC-55A6-1D5D-E60EE2D5C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A55ED-5338-70E9-7F0A-868C23AAA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203394-8ADE-3721-C85B-F0744ACFB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458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555E78-96F4-BF2E-8FD4-003BF4872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5FDD40-5FDA-7B27-C1A2-CA34EE44D0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9D3567-B26A-E426-C7C3-2368AB61D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CFBF6-A2C3-E856-56DB-E9B317E6B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FB93FF-1124-FE10-4186-CE479AAAB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247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79BF7C-BD48-6547-49ED-4B75E7FD6E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EA11CB-4FA4-6AA4-74F4-6E4D27FBD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79F850-631A-B974-E1EA-988B203FE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256A56-5420-BC6A-ECE0-C0CDF6CE2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35765-096A-73C9-A295-8ACC547F3C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939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EA334-45FF-03AA-8FE7-DA544DAEC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D00745-BCA7-F38C-4634-208EFC972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F45FF5-E3F6-B36F-A87D-A10B64CF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5F816D-8E4F-F776-A37F-7D598998C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B0F8B3-5925-BE5D-ED84-53E500F58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61F482-96C2-1C32-C3AD-FA2DA9C4B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568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DA2F4-82C7-6021-387B-24C667CD5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BC3A4F-B947-1FDD-29B7-AA375FFCB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F97D3E-3BF7-6C61-00A0-231E476308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208843-44B0-D1D1-1949-D4CEB9F3B5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C7E69E-844D-C83F-EB52-DBD3C19E7B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7461C0-B87E-94B3-3923-C41FDE230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820B47-DDBD-B320-8117-8B1C21F49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C81B19-57B8-2E0C-CF4D-192D8BA75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505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2258C-7BD5-571F-C928-8AF14C2C5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2CB376-CE17-77E3-5EFD-D51FC6B24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2D3FBF-324B-C0DA-BDFF-010501627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ABFD81-D7D5-C398-C60E-831D11411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821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563AE0-15A8-50EA-E29B-8334428B0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313ADD-7534-6A0A-6691-80D45C44F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D81BFB-2E8B-3132-FE5B-51689C722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31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8E8CD-3E29-29EC-C8CB-772D11BF1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E73FB8-F0DB-050D-DF1C-7C5F3F0E9B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5E0D5E-81EF-13B7-3251-686813100E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170113-E1EB-8944-B8B0-CF4D34C5D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0D7B4A-DBDE-F9AD-DD84-82807F2D6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473CDE-445F-E3F9-1CC8-08C1850F7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626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0B094-3C08-712D-790A-BDEB3EC22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CBD4BD-DE88-7335-85A6-5441923F16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BF6FFC-6BA6-C4A7-BBDC-70757E3209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C21017-BFF0-FC7D-AFE1-BE9BF1072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1BDC7F-6F0D-D3B3-B155-72B49BEBA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6775B4-3D17-7C5E-C052-0BD58C7D3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167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71975A-39A1-86B1-76E8-085A3F7DC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4D982E-9507-1DC0-EC18-9E22265406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99AE6C-024A-6D40-34EF-88810EC1FF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B56AF-9E5E-414F-BDED-C1B0059F23C4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C9725F-F090-F35C-127E-87B975ACAD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922879-56F5-EDAE-8225-4AC834533C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C3207-76CF-435B-A62C-2D4ECA2A5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763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5AE628E1-D343-A897-5CC8-4DBBE2396E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4874" y="1306564"/>
            <a:ext cx="4136669" cy="424487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490BA22-06C3-D3B8-4FEB-33C0D8B61A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48197" y="1306563"/>
            <a:ext cx="483872" cy="4244873"/>
          </a:xfrm>
          <a:prstGeom prst="rect">
            <a:avLst/>
          </a:prstGeom>
        </p:spPr>
      </p:pic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1F3D2CBD-CC0E-57B3-F268-2CFB02909A8D}"/>
              </a:ext>
            </a:extLst>
          </p:cNvPr>
          <p:cNvCxnSpPr/>
          <p:nvPr/>
        </p:nvCxnSpPr>
        <p:spPr>
          <a:xfrm>
            <a:off x="6438893" y="1501372"/>
            <a:ext cx="0" cy="1110343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61D8C74-54CE-7D8A-FE1A-1C0D59E64420}"/>
              </a:ext>
            </a:extLst>
          </p:cNvPr>
          <p:cNvCxnSpPr>
            <a:cxnSpLocks/>
          </p:cNvCxnSpPr>
          <p:nvPr/>
        </p:nvCxnSpPr>
        <p:spPr>
          <a:xfrm>
            <a:off x="6438893" y="2677228"/>
            <a:ext cx="0" cy="274206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1E2B9D7B-693B-5ED6-B530-8E759F0BD51F}"/>
              </a:ext>
            </a:extLst>
          </p:cNvPr>
          <p:cNvCxnSpPr>
            <a:cxnSpLocks/>
          </p:cNvCxnSpPr>
          <p:nvPr/>
        </p:nvCxnSpPr>
        <p:spPr>
          <a:xfrm>
            <a:off x="6281647" y="2611715"/>
            <a:ext cx="0" cy="240542"/>
          </a:xfrm>
          <a:prstGeom prst="straightConnector1">
            <a:avLst/>
          </a:prstGeom>
          <a:ln>
            <a:solidFill>
              <a:srgbClr val="00B0F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E41A445-C8F9-2B1C-5A75-A25C231EEFC7}"/>
              </a:ext>
            </a:extLst>
          </p:cNvPr>
          <p:cNvSpPr txBox="1"/>
          <p:nvPr/>
        </p:nvSpPr>
        <p:spPr>
          <a:xfrm rot="5400000">
            <a:off x="10199665" y="3244333"/>
            <a:ext cx="2634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xygen Tension [mmHg]</a:t>
            </a:r>
          </a:p>
        </p:txBody>
      </p: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5F1324C9-62B9-5226-5982-F3BE7F9961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8166345"/>
              </p:ext>
            </p:extLst>
          </p:nvPr>
        </p:nvGraphicFramePr>
        <p:xfrm>
          <a:off x="232191" y="1776133"/>
          <a:ext cx="5520917" cy="3775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1" name="Rectangle 30">
            <a:extLst>
              <a:ext uri="{FF2B5EF4-FFF2-40B4-BE49-F238E27FC236}">
                <a16:creationId xmlns:a16="http://schemas.microsoft.com/office/drawing/2014/main" id="{D96AF431-5EB9-5593-5F00-36A939B1F0DA}"/>
              </a:ext>
            </a:extLst>
          </p:cNvPr>
          <p:cNvSpPr/>
          <p:nvPr/>
        </p:nvSpPr>
        <p:spPr>
          <a:xfrm>
            <a:off x="478862" y="1847354"/>
            <a:ext cx="1660849" cy="3116424"/>
          </a:xfrm>
          <a:prstGeom prst="rect">
            <a:avLst/>
          </a:prstGeom>
          <a:solidFill>
            <a:schemeClr val="accent3">
              <a:alpha val="12000"/>
            </a:schemeClr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10941F9-0893-4772-3912-9D6BF8D81280}"/>
              </a:ext>
            </a:extLst>
          </p:cNvPr>
          <p:cNvSpPr/>
          <p:nvPr/>
        </p:nvSpPr>
        <p:spPr>
          <a:xfrm>
            <a:off x="2205330" y="1847354"/>
            <a:ext cx="3267125" cy="3116424"/>
          </a:xfrm>
          <a:prstGeom prst="rect">
            <a:avLst/>
          </a:prstGeom>
          <a:solidFill>
            <a:schemeClr val="accent6">
              <a:alpha val="12000"/>
            </a:schemeClr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1537133-AF3D-4E31-8E6D-7C3EBCD77CC2}"/>
              </a:ext>
            </a:extLst>
          </p:cNvPr>
          <p:cNvSpPr txBox="1"/>
          <p:nvPr/>
        </p:nvSpPr>
        <p:spPr>
          <a:xfrm>
            <a:off x="4034933" y="4273994"/>
            <a:ext cx="1003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ginat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FEB342-9291-E4EB-04E4-F6811797A2B6}"/>
              </a:ext>
            </a:extLst>
          </p:cNvPr>
          <p:cNvSpPr txBox="1"/>
          <p:nvPr/>
        </p:nvSpPr>
        <p:spPr>
          <a:xfrm>
            <a:off x="759323" y="4273994"/>
            <a:ext cx="1003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di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4492C8A-46B5-D40A-B8E1-282F8A67BCED}"/>
              </a:ext>
            </a:extLst>
          </p:cNvPr>
          <p:cNvSpPr txBox="1"/>
          <p:nvPr/>
        </p:nvSpPr>
        <p:spPr>
          <a:xfrm rot="16200000">
            <a:off x="5735143" y="1818543"/>
            <a:ext cx="1003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di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D445D5C-1D3D-D5F5-D544-C0E8158CE8D0}"/>
              </a:ext>
            </a:extLst>
          </p:cNvPr>
          <p:cNvSpPr txBox="1"/>
          <p:nvPr/>
        </p:nvSpPr>
        <p:spPr>
          <a:xfrm rot="16200000">
            <a:off x="5729163" y="3972164"/>
            <a:ext cx="1003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ginate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735CE2C8-A160-E797-FC48-69443FB969D4}"/>
              </a:ext>
            </a:extLst>
          </p:cNvPr>
          <p:cNvCxnSpPr>
            <a:cxnSpLocks/>
          </p:cNvCxnSpPr>
          <p:nvPr/>
        </p:nvCxnSpPr>
        <p:spPr>
          <a:xfrm flipH="1">
            <a:off x="6574874" y="5663881"/>
            <a:ext cx="265332" cy="0"/>
          </a:xfrm>
          <a:prstGeom prst="straightConnector1">
            <a:avLst/>
          </a:prstGeom>
          <a:ln>
            <a:solidFill>
              <a:srgbClr val="00B0F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13402016-8D52-9F1D-63ED-C3CD94585707}"/>
              </a:ext>
            </a:extLst>
          </p:cNvPr>
          <p:cNvSpPr txBox="1"/>
          <p:nvPr/>
        </p:nvSpPr>
        <p:spPr>
          <a:xfrm>
            <a:off x="6792137" y="5509992"/>
            <a:ext cx="4212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heoretical necrotic cutoff (0.1 mmHg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564F578-5741-0DB1-AF23-BFEC6F569D51}"/>
              </a:ext>
            </a:extLst>
          </p:cNvPr>
          <p:cNvSpPr txBox="1"/>
          <p:nvPr/>
        </p:nvSpPr>
        <p:spPr>
          <a:xfrm rot="16200000">
            <a:off x="5475496" y="2357760"/>
            <a:ext cx="129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65um</a:t>
            </a:r>
          </a:p>
        </p:txBody>
      </p:sp>
    </p:spTree>
    <p:extLst>
      <p:ext uri="{BB962C8B-B14F-4D97-AF65-F5344CB8AC3E}">
        <p14:creationId xmlns:p14="http://schemas.microsoft.com/office/powerpoint/2010/main" val="1382567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8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Bates</dc:creator>
  <cp:lastModifiedBy>Kevin Bates</cp:lastModifiedBy>
  <cp:revision>1</cp:revision>
  <dcterms:created xsi:type="dcterms:W3CDTF">2022-09-12T18:44:49Z</dcterms:created>
  <dcterms:modified xsi:type="dcterms:W3CDTF">2022-09-12T19:01:28Z</dcterms:modified>
</cp:coreProperties>
</file>